
<file path=[Content_Types].xml><?xml version="1.0" encoding="utf-8"?>
<Types xmlns="http://schemas.openxmlformats.org/package/2006/content-types">
  <Default Extension="jpeg" ContentType="image/jpeg"/>
  <Default Extension="emf" ContentType="image/x-emf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ink/ink1.xml" ContentType="application/inkml+xml"/>
  <Override PartName="/ppt/ink/ink2.xml" ContentType="application/inkml+xml"/>
  <Override PartName="/ppt/ink/ink3.xml" ContentType="application/inkml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60" r:id="rId3"/>
    <p:sldId id="262" r:id="rId4"/>
    <p:sldId id="258" r:id="rId5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07" d="100"/>
          <a:sy n="107" d="100"/>
        </p:scale>
        <p:origin x="672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H:\Catalasa%20nuevo\CORDOBA\Resultados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s-E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stacked"/>
        <c:varyColors val="0"/>
        <c:ser>
          <c:idx val="0"/>
          <c:order val="0"/>
          <c:tx>
            <c:strRef>
              <c:f>Hoja8!$B$5</c:f>
              <c:strCache>
                <c:ptCount val="1"/>
                <c:pt idx="0">
                  <c:v>Non-nitroalkylated His 108</c:v>
                </c:pt>
              </c:strCache>
            </c:strRef>
          </c:tx>
          <c:spPr>
            <a:solidFill>
              <a:srgbClr val="D6DCE5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8!$C$4:$D$4</c:f>
              <c:strCache>
                <c:ptCount val="2"/>
                <c:pt idx="0">
                  <c:v>CONTROL</c:v>
                </c:pt>
                <c:pt idx="1">
                  <c:v>h2o2</c:v>
                </c:pt>
              </c:strCache>
            </c:strRef>
          </c:cat>
          <c:val>
            <c:numRef>
              <c:f>Hoja8!$C$5:$D$5</c:f>
              <c:numCache>
                <c:formatCode>General</c:formatCode>
                <c:ptCount val="2"/>
                <c:pt idx="0">
                  <c:v>21.674214146156</c:v>
                </c:pt>
                <c:pt idx="1">
                  <c:v>10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EC9-464F-AC95-F4C5A327042D}"/>
            </c:ext>
          </c:extLst>
        </c:ser>
        <c:ser>
          <c:idx val="1"/>
          <c:order val="1"/>
          <c:tx>
            <c:strRef>
              <c:f>Hoja8!$B$6</c:f>
              <c:strCache>
                <c:ptCount val="1"/>
                <c:pt idx="0">
                  <c:v>Nitroalkylated His 108 </c:v>
                </c:pt>
              </c:strCache>
            </c:strRef>
          </c:tx>
          <c:spPr>
            <a:solidFill>
              <a:srgbClr val="0066FF"/>
            </a:solidFill>
            <a:ln>
              <a:solidFill>
                <a:schemeClr val="tx1"/>
              </a:solidFill>
            </a:ln>
            <a:effectLst/>
          </c:spPr>
          <c:invertIfNegative val="0"/>
          <c:cat>
            <c:strRef>
              <c:f>Hoja8!$C$4:$D$4</c:f>
              <c:strCache>
                <c:ptCount val="2"/>
                <c:pt idx="0">
                  <c:v>CONTROL</c:v>
                </c:pt>
                <c:pt idx="1">
                  <c:v>h2o2</c:v>
                </c:pt>
              </c:strCache>
            </c:strRef>
          </c:cat>
          <c:val>
            <c:numRef>
              <c:f>Hoja8!$C$6:$D$6</c:f>
              <c:numCache>
                <c:formatCode>General</c:formatCode>
                <c:ptCount val="2"/>
                <c:pt idx="0">
                  <c:v>78.325785853843996</c:v>
                </c:pt>
                <c:pt idx="1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EC9-464F-AC95-F4C5A327042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overlap val="100"/>
        <c:axId val="515229040"/>
        <c:axId val="515229368"/>
      </c:barChart>
      <c:catAx>
        <c:axId val="515229040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15229368"/>
        <c:crosses val="autoZero"/>
        <c:auto val="1"/>
        <c:lblAlgn val="ctr"/>
        <c:lblOffset val="100"/>
        <c:noMultiLvlLbl val="0"/>
      </c:catAx>
      <c:valAx>
        <c:axId val="515229368"/>
        <c:scaling>
          <c:orientation val="minMax"/>
          <c:max val="100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1" i="0" u="none" strike="noStrike" kern="1200" baseline="0">
                    <a:solidFill>
                      <a:schemeClr val="tx1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 sz="1200" b="1"/>
                  <a:t>Peptide spectrum matchs</a:t>
                </a:r>
                <a:r>
                  <a:rPr lang="en-GB" sz="1200" b="1"/>
                  <a:t> (%)</a:t>
                </a:r>
                <a:endParaRPr lang="es-ES" sz="1200" b="1"/>
              </a:p>
            </c:rich>
          </c:tx>
          <c:layout/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200" b="1" i="0" u="none" strike="noStrike" kern="1200" baseline="0">
                  <a:solidFill>
                    <a:schemeClr val="tx1"/>
                  </a:solidFill>
                  <a:latin typeface="Arial" panose="020B0604020202020204" pitchFamily="34" charset="0"/>
                  <a:ea typeface="+mn-ea"/>
                  <a:cs typeface="Arial" panose="020B0604020202020204" pitchFamily="34" charset="0"/>
                </a:defRPr>
              </a:pPr>
              <a:endParaRPr lang="es-ES"/>
            </a:p>
          </c:tx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s-ES"/>
          </a:p>
        </c:txPr>
        <c:crossAx val="515229040"/>
        <c:crosses val="autoZero"/>
        <c:crossBetween val="between"/>
        <c:majorUnit val="20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100">
          <a:solidFill>
            <a:schemeClr val="tx1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s-E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97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ink/ink1.xml><?xml version="1.0" encoding="utf-8"?>
<inkml:ink xmlns:inkml="http://www.w3.org/2003/InkML">
  <inkml:definitions>
    <inkml:context xml:id="ctx0">
      <inkml:inkSource xml:id="inkSrc0">
        <inkml:traceFormat>
          <inkml:channel name="X" type="integer" max="32767" units="cm"/>
          <inkml:channel name="Y" type="integer" max="32767" units="cm"/>
          <inkml:channel name="F" type="integer" max="8191" units="dev"/>
          <inkml:channel name="T" type="integer" max="2.14748E9" units="dev"/>
        </inkml:traceFormat>
        <inkml:channelProperties>
          <inkml:channelProperty channel="X" name="resolution" value="1290.54749" units="1/cm"/>
          <inkml:channelProperty channel="Y" name="resolution" value="2151.47729" units="1/cm"/>
          <inkml:channelProperty channel="F" name="resolution" value="0" units="1/dev"/>
          <inkml:channelProperty channel="T" name="resolution" value="1" units="1/dev"/>
        </inkml:channelProperties>
      </inkml:inkSource>
      <inkml:timestamp xml:id="ts0" timeString="2022-10-31T18:19:48.735"/>
    </inkml:context>
    <inkml:brush xml:id="br0">
      <inkml:brushProperty name="width" value="0.06667" units="cm"/>
      <inkml:brushProperty name="height" value="0.06667" units="cm"/>
      <inkml:brushProperty name="color" value="#ED1C24"/>
      <inkml:brushProperty name="fitToCurve" value="1"/>
    </inkml:brush>
    <inkml:brush xml:id="br1">
      <inkml:brushProperty name="width" value="0.06667" units="cm"/>
      <inkml:brushProperty name="height" value="0.06667" units="cm"/>
      <inkml:brushProperty name="fitToCurve" value="1"/>
    </inkml:brush>
  </inkml:definitions>
  <inkml:trace contextRef="#ctx0" brushRef="#br0">-1 10 244 0,'0'0'-8'0,"0"0"41"16,0 0-27-16,0 0-9 0,0 0 21 0,0 0-5 16,0 0 4-16,0 0 34 0,0 0-39 0,0 0 11 15,0 0-5-15,0 0 51 0,0 0-12 0,0 0-33 16,0 0 27-16,0 0-66 0,0 0 12 15,0-11 9-15,0 11-3 0,0 0 4 16,0 0 49-16,0 0-48 0,0 0 0 0,0 0-7 16,0 0 15-16,0 0-12 0,0 0 3 0,0 0-6 15,0 0-11-15,0 0 0 0,0 0 60 0,0 0-60 16,0 0 4-16,0 0-5 0,0 0 2 16,0 0 14-16,0 0 47 0,0 0-51 0,0 0 39 15,0 0-1-15,0 0-45 0,0 0-13 16,0 0 58-16,0 0-60 0,0 0 31 0,0 0-2 15,0 0 10-15,0 0-42 0,0 0 19 0,0 0 11 16,0 0 24-16,15 4-60 0,-13-2 45 0,-1 0 20 16,2-2-25-16,-3 2 3 0,3-1-37 15,-3-1 29-15,1 2 48 0,-1 0-64 0,1-1 8 16,1 1-2-16,-1-1 22 0,1 1-2 16,-1 0-1-16,0 1-13 0,1-3 16 0,-2 1-12 15,2 0-8-15,0 1 30 0,1-1-12 0,-3 0 1 16,3 3-25-16,-2-3 32 0,1 3-4 15,0-2-40-15,1-1 3 0,-1 1 23 0,-1 1 27 16,1-2-6-16,2 2-34 0,-3-2 1 0,-1 1 2 16,3 2 19-16,-2-3-10 0,1 3 6 15,3-1 4-15,-5 0-2 0,3-2-21 0,-3 3 36 16,2-1-8-16,-1-1-16 0,2-1-12 0,-2 2 9 16,1 0 22-16,-1-2-3 0,0 2-1 15,1-1 9-15,-2 1 2 0,3-1-2 0,-2 0-4 16,0 1-13-16,1-1 37 0,-1 1-32 0,2-2-2 15,-3 2-2-15,4 0 26 0,-2 1-1 0,-1-1-17 16,1 0-3-16,-1 0 0 0,2-1-21 16,-1-2-5-16,1 3 14 0,-3-1-9 0,3 0 21 15,-1 2-4-15,0-2 0 0,1 2-3 16,0-1-21-16,0 0 16 0,0 0-1 0,-1 0 1 16,0-2-2-16,-1 2-27 0,2-2 1 0,-2 2 46 15,1-1 5-15,-1-1-1 0,2-1-51 16,-3 0 3-16,0 0 58 0,0 0-33 0,0 0 20 15,0 0-24-15,0 0 5 0,4 0 4 16,-4 0 31-16,10 9 4 0,-7-9-33 0,-2 0 27 16,1 0-24-16,0 0-6 0,0 0-19 15,-1 0 23-15,-1 0-5 0,0 0-38 0,0 0 45 16,0 0-19-16,0 0 12 0,0 0-35 0,5 0 31 16,-5 0 16-16,0 0-29 0,0 0-20 15,0 0 36-15,0 0-30 0,11 8 47 0,-10-8-5 16,1 1 5-16,-1 0-1 0,2 0-22 15,-3 0-19-15,1-1 23 0,-1 1 28 0,2 0-31 16,-2 0-18-16,1 1 0 0,1 0 1 0,-1-2-8 16,-1 2 40-16,3 0-14 0,-2 1 15 0,0-1-9 15,1 0-33-15,-2 0 36 0,1 0-3 16,0 2 2-16,0-1-2 0,0 0-45 0,0 0 2 16,1 1 5-16,-1-3 3 0,-1 2 30 0,2 1 16 15,-1 0-18-15,-1-1 14 0,2 0 3 16,-1 2-1-16,2-3 0 0,-2 1-12 0,-1 2-7 15,0-3 9-15,0 1-21 0,2 0-9 16,-1 0 52-16,-1 0-14 0,3 1-28 0,-3-1 4 16,1 0 28-16,2-1 11 0,-2 2-19 15,1-1-6-15,-1-1-31 0,-1 3 0 0,2-2 34 16,-2 0 29-16,1-1-54 0,1 1 15 0,0-2 1 16,-2 3 0-16,2-2 2 0,-1 1-1 15,-1-1-27-15,2 1 45 0,-1-1-7 0,0 0-29 16,2 1 27-16,-2-1-6 0,1 1 17 15,-1-1 5-15,2 1-2 0,-3-1-2 0,3 1-19 16,-2-1 22-16,1 0-20 0,-1 1 26 0,2-2-64 16,-1 3 35-16,0-1-31 0,0-2 27 15,0 2-3-15,1-2 14 0,-1 0 4 0,0 2 2 16,1-1-8-16,-1 0-34 0,-1 0 29 16,2-1 26-16,-1 2-61 0,0-2 33 0,-1 0 9 15,2 1-14-15,-1 0 23 0,-1-2-11 0,1 0-22 16,0 2 19-16,0 0-1 0,-1-1 1 15,1 0 3-15,-1-1-24 0,0 1 1 0,2 0 32 16,-3 0-4-16,0-1-16 0,1 1-3 16,2 1 24-16,-3-2-49 0,1 0 30 0,1 2 2 15,-2-2-1-15,0 0 8 0,0 0 15 0,0 0-54 16,0 0 46-16,0 0 22 0,0 0-8 0,0 0-47 16,11 8 50-16,-11-7-24 0,3 0-17 0,0 1 14 15,-2 1-1-15,2-1 16 0,0-1-11 16,-2 2-4-16,2-1 8 0,-2 1-12 0,1-2 10 15,-1 2-8-15,2-1 18 0,-2 3 5 0,1-3-64 16,-1 2 62-16,2-2-10 0,-3 1-21 16,4-1-30-16,-4 2 44 0,3-2 1 15,-3 2 5-15,2-2 14 0,-2 2-13 0,2-3-54 16,-2 3 10-16,2-3 0 0,-1 3 75 0,-1-1-27 16,1-1-13-16,1-1-23 0,-2 3 28 0,0-4 3 15,0 0 0-15,0 0-49 0,0 4 35 16,0-4 15-16,0 0 3 0,0 6-13 0,0-6 0 15,0 4 9-15,8 3-17 0,-8-5-26 0,0 1-1 16,3-1 61-16,-3-1-13 0,2 1-31 16,-1 1 1-16,-1 0 58 0,2 0-22 0,0-2-13 15,-1 1-7-15,1 1 6 0,-2-1 2 0,1 0 3 16,1 0-5-16,-1 0-2 0,1-1 6 0,0 1-39 16,-2-1 35-16,2 2-4 0,-1-2-27 15,-1 1 15-15,2 1 18 0,-1-3-1 0,-1 1 31 16,2 0-17-16,0 1-13 0,-1 1 10 0,-1-3-58 15,2 1 62-15,-1 0-23 0,-1 0 13 16,0 0 5-16,2-1-23 0,-2 0 21 0,1 0-47 16,1 2 45-16,-2-2 2 0,2 0-4 15,-2 0-39-15,1 0 38 0,0 0-36 0,0 1 40 16,-1-1-47-16,0 0 63 0,0 0 0 0,0 0-21 16,0 0 3-16,0 0-24 0,0 0-27 15,0 0 51-15,0 0-7 0,6 0 7 0,-6 0-26 16,0 0 40-16,0 0-16 0,5 0-11 15,-5 0-12-15,0 0 47 0,0 0-60 0,5 0 35 0,-5 0-16 16,0 0 15-16,0 0-1 0,6 0-40 16,-6 0 54-16,0 0 8 0,5 0-32 0,-5 0-4 15,0 0 9-15,0 0-36 0,5 0 44 16,-5 0 19-16,0 0-34 0,0 0-24 0,5 0 11 16,-5 0 12-16,0 0 15 0,0 0-44 0,6 0 44 15,2 11 22-15,-7-10-23 0,1 0-16 16,1 2 6-16,-1-1 10 0,1-1-40 0,-1 0 44 15,-1 1 20-15,2 0-35 0,1 0-11 0,-3-2 22 16,-1 3 3-16,3-1-31 0,-1-1 51 16,0 1-31-16,1 1-1 0,-1-2-21 0,0 1 38 15,1 1-8-15,0-2-42 0,-3 1 10 16,4 1 30-16,-2-2 8 0,0 1-7 0,1 1-18 16,-3-1-14-16,3 0 41 0,-1-1-25 0,0 1-2 15,-1-1-21-15,1 1 48 0,1 1-12 0,-2-2-14 16,2 1 48-16,0 0-23 0,-2 1-11 0,2-2 10 15,-3 2-1-15,3-2-44 0,1 0 20 16,-3 2 17-16,1-1-17 0,1 0-18 16,-2 1 53-16,3-2-19 0,-2-1-1 0,-1 2 19 15,2 2 9-15,1-3-30 0,-2 1 17 0,-1 0-19 16,2 2-31-16,2-2 33 0,-3 1 20 0,1-2-44 16,-2 1 34-16,3 1 0 0,5 2 12 15,-6-2-23-15,2 2-7 0,-2-5-33 0,1 3 44 16,0 0 1-16,-2-2 26 0,2 0-5 0,-1 0-28 15,0 1 8-15,-2-1-4 0,2 0 4 16,-2 1-19-16,4 0 3 0,-4 0-5 0,3-1-14 16,-2 0 40-16,0 0-2 0,1-1-7 0,0 3-36 15,-2-3 45-15,2 1-44 0,-1-1 24 16,-1 1 44-16,2 0-19 0,-2-1-4 0,-1 0-25 16,0 0 20-16,0 0 22 0,0 0-31 0,0 0-17 15,6 0-5-15,-6 0 21 0,0 0-42 16,4 0 31-16,-4 0 2 0,0 0 50 0,6 0-33 15,-6 0 5-15,0 5-6 0,5-5-4 16,-5 0 9-16,10 11-9 0,-7-10 0 0,-3 2 29 0,3-1-30 16,-2-2 5-16,0 2-3 0,2-1-15 15,-1 2-22-15,-1-2 29 0,1 1 29 16,-1 1 5-16,1-2-20 0,0 0-9 0,-2 2 13 16,3-1-55-16,-3-1 49 0,3 3-24 0,-3-3 22 15,0 0-24-15,2 1 24 0,-2 0-37 0,1 1 41 16,1-2 6-16,-2 3-17 0,2-3 19 15,-1 1-10-15,1 2-25 0,-2-4 28 0,0 0-7 16,0 0 10-16,0 4-11 0,0-4-35 0,0 5 30 16,0-5 41-16,0 5-36 0,0-5 10 15,0 5-2-15,0-5-4 0,0 7-43 0,0-7 43 16,0 6 12-16,7 1-9 0,-7-6-5 0,1 3-40 16,-1-2 47-16,0 2 2 0,0-2-34 0,0 0 37 15,0 0-8-15,0 2-4 0,3-3 11 16,-3 2-47-16,0-1 2 0,0-1 34 0,0 2 12 15,2-2 8-15,-1 1-59 0,-1-2 24 16,2 2 29-16,-1 0 14 0,0-1-28 0,0 0 20 16,1 3-12-16,-1-4-13 0,-1 1-24 0,1 2 38 15,0-1-8-15,0-2 20 0,2 1-26 0,-2 1-8 16,-1-1-13-16,3 0 19 0,-3-1 8 0,3 2-16 16,0 0 8-16,-3-2 9 0,0 0-7 15,0 0 6-15,0 0-9 0,7 4 39 0,-3-2-40 16,-2-1 10-16,0 1-18 0,1-1 27 15,0 0-5-15,0-1-20 0,-2 1 12 0,2-1-25 16,0 1 1-16,-1-1 25 0,0 0-25 0,1 2 45 16,-1-2-6-16,-2 0 15 0,0 0-37 0,0 0 28 15,0 0-26-15,0 0 33 0,6 0-73 16,-6 0 19-16,5 0 14 0,-5 0 16 0,0 0 0 16,6 0-18-16,-6 0-13 0,0 0 47 15,6 0-17-15,-6 0-23 0,0 0 16 0,4 0 4 16,-4 0 37-16,0 0-15 0,7 0 6 0,-7 0-73 15,5 0 56-15,-5 0-17 0,0 0 4 16,0 0 5-16,5 0 12 0,-5 0 12 0,0 0-21 16,6 0 26-16,-1-6-22 0,-5 6 18 0,0 0-37 15,0 0 5-15,0 0-33 0,0 0 34 16,0 0 5-16,0 0-14 0,0 0-6 0,0 0 18 16,0 0 5-16,6 0-23 0,-6 0 33 0,0 0-2 15,0 0-35-15,5 0 26 0,-5 0-29 16,0 0-1-16,0 0 31 0,5 0 11 0,-5 0-9 15,0 0-35-15,4 0 46 0,-4 0-10 16,0 0 15-16,7 0 10 0,-7 0-24 0,0 0 5 0,5-5-15 16,-5 5-6-16,5 0 17 0,-5 0-42 15,4 0 8-15,3-8 52 0,-4 8-16 0,0-1-14 16,-1 1 6-16,0 0-35 0,0-1 25 16,-1-1 35-16,3 1-15 0,-2 1-2 0,-1 0 21 15,2-1-9-15,-2 0-11 0,3-2-6 0,-3 3 3 16,2-1-36-16,-1 1 34 0,1 0-42 0,1-4 62 15,-3 3 2-15,2 0-62 0,0 1 37 16,-2-1-16-16,3 0 27 0,-2 0-11 0,1 0-2 16,0-1-38-16,-1 2 23 0,1-1 22 15,1 0-3-15,-3-1-3 0,2 1 9 0,-1-1 5 16,0 1-41-16,1-1 5 0,-1 1 31 16,1 0 10-16,-3 0-21 0,1-1 32 0,2 1-1 15,0 1-17-15,-2-2-39 0,0 1 22 0,1-1 1 16,-1 0 14-16,0 0 10 0,2 0-1 15,-3 2-1-15,2-3-58 0,1 1 27 0,-3 2 7 16,3-2 6-16,-3-1-28 0,2 2 35 0,1 1-32 16,-3-1 25-16,3-3 12 0,-3 2-2 15,2 0-18-15,2-1 14 0,-4-1-13 16,2 3 15-16,-2-2-9 0,2 1-1 0,-2 0-19 16,0-1 44-16,1 1-21 0,1-1-13 0,1 2 10 15,-2 0 26-15,0-3-23 0,-1 3-11 16,3 0 31-16,-3-1-25 0,3 0-29 0,-3 1 30 0,1 1-6 15,1-3-2-15,0 1 14 0,-1 0-1 16,0 1-8-16,0 0 0 0,1 0 4 16,1-1-10-16,-1 0-5 0,1 2-23 0,-1-1 57 15,1 1-18-15,0-1-12 0,1 1 14 0,-2 0-4 16,2 0 6-16,-1 0 6 0,0-1-23 16,0 0 15-16,-1 1-11 0,1-1 25 0,0 1-40 15,-1 0 21-15,0-1-1 0,0 0 15 0,0 1-38 16,0 0 24-16,-2 0-42 0,4-1 39 15,-2 1 0-15,-1-1 17 0,0 0-16 0,1 0 14 16,0 1-21-16,-2-2 5 0,3 2-10 0,-1 0 11 16,-1-4-13-16,2 3 9 0,-2 0 6 15,1 1-6-15,-1-2-4 0,2 2 22 0,-2-1-6 16,0-1-7-16,1 1-12 0,0 1 25 16,-1-1-12-16,1-3 17 0,-2 3-21 0,2 0-23 15,-1 0 45-15,0-2-60 0,1 2 18 0,-1 0 27 16,1 0 7-16,-2-1-5 0,2 1 21 15,-1-1-26-15,1 0 2 0,-2 0 16 16,0 0-32-16,1 1-21 0,0-1 36 0,-1 0 4 16,1-3-26-16,0 4 44 0,0 0-20 0,-1-1-8 15,3-3 21-15,-3 4-28 0,2-4 21 16,-2 4-4-16,0 0-7 0,1-2 0 0,1 2 12 16,0-2-47-16,0 2 29 0,0-1-5 15,0 0 38-15,1 0-14 0,-3 1-43 0,2-1 58 16,1 1-24-16,-1-1 10 0,-2 1-9 0,3 0 22 15,-3-1-50-15,2 1 38 0,1-1-8 16,-3-1 12-16,2 2-1 0,-1 1-21 0,0-3 3 16,-1 2-20-16,2 0 44 0,-1 1-16 15,1-1 4-15,-1-1-15 0,0 0 7 0,-1 1 7 16,2 1 0-16,1-2-1 0,-3 1-13 0,1-1-17 16,1 1 31-16,-2-2 2 0,0 3-3 0,3-2 11 15,-3 0-26-15,1-1 13 0,-1 2-12 0,0-1 14 16,0-1-21-16,0 3 23 0,1-3-25 15,-1 1 34-15,0 2-50 0,0-3 4 0,0 3 58 16,0 0-40-16,0 0-6 0,0 0 43 16,0 0-14-16,0-5-3 0,0 5 8 0,0 0-10 15,0-4-8-15,0 4-11 0,0 0 6 0,0 0 5 16,0-5-1-16,0 5-7 0,9-7-23 0,-9 5 38 16,2 1-10-16,-2-1 2 0,0 2 0 15,3-2 7-15,-1 2-33 0,0-3 27 0,-1 2 5 16,2 0 8-16,-1 0-41 0,1 0 34 0,0 1-14 15,-1-2 2-15,1 0 15 0,-1 1-38 16,1 0 40-16,0 0 12 0,-1 1-17 0,0-1 8 16,1-1 7-16,-1 1-25 0,2 0 5 0,-2 0 5 15,1 0 4-15,-3-2-15 0,3 3 25 16,-2-1-15-16,1 1-6 0,-2 0-20 0,1-2 45 16,1 0-22-16,0 1-6 0,-1 0-4 0,0 1-2 15,-1-2-11-15,2 2 45 0,-2-1-20 16,1-1-10-16,0 1 18 0,-1 0-46 0,2 1 27 15,-1-2 26-15,1-1-39 0,-1 2 11 16,0 1 25-16,0-1-18 0,0 1 18 0,0 0-11 16,0-3-1-16,-1 2-21 0,2 0 21 0,0-2 18 15,-2 3-32-15,3 0 10 0,-3-1-10 0,2 0 33 16,-1-1-5-16,0 0-20 0,0 1-12 0,1-1 9 16,0 0-9-16,0 1 10 0,-1 0-13 15,0 0 30-15,0-1-43 0,0 0 36 0,0-1-11 16,1 3-9-16,-1-2 18 0,1 1 2 15,-1-3-9-15,1 4 6 0,-1-2 14 0,2 0-13 16,-2 1-34-16,2-2 1 0,-3 0 27 0,1 3-5 16,2-3-18-16,-1 0 33 0,0 1-7 15,3 0 9-15,-5 0 9 0,3 1-46 0,-1-3 45 0,1 3-28 16,-1-3 16-16,0 3-33 0,1-3 28 16,-1 3-15-16,0-1 6 0,0-1 11 0,-1 3-16 15,2-3 24-15,-2 1 2 0,2 0-2 16,-3 1-12-16,2-3-22 0,-1 4 43 0,2-1-9 15,-2-2-25-15,0 2-9 0,0 1 20 0,1-1-5 16,-1 0 16-16,0 0-10 0,0-1 2 16,1 2 1-16,1-1-2 0,-3-2 2 0,1 2-10 15,0 1 37-15,1-1-44 0,-1 1 3 0,-1-1 22 16,2 1 17-16,-1-3-21 0,0 3-22 16,0-1 27-16,0 0-45 0,1 1 26 15,-1-2 14-15,-1 2-8 0,1-2 5 0,0 1 6 16,0 0 2-16,-1 1-21 0,1-1 19 15,0 1 10-15,-1-1-27 0,1 0 22 0,0 1-10 16,-1-1-3-16,1 0-40 0,0 1 0 0,0 0 19 16,-1-2 26-16,2 1 15 0,0 1-41 15,-2 0 41-15,1 0-54 0,-1 0-2 0,3-1 34 16,-3 1-10-16,0 0 20 0,2-1-32 0,-1 0 16 16,-1 1 34-16,0 0-59 0,2 0 55 0,-2 0-20 15,0 0-4-15,0 0 16 0,0 0-2 16,0 0-10-16,0 0 13 0,0 0-11 0,8-3-3 15,-7 3 1-15,0 0-28 0,1 0-9 16,0 0 41-16,0 0-42 0,-1 0 33 16,1 0 18-16,-1 0-6 0,0 0-18 0,0 0 11 15,-1 0-5-15,4 0 12 0,-4-1 13 0,1 2-58 16,0-2 13-16,0 1 55 0,1 0-24 0,-2 0-13 16,1 0-26-16,-1 0 39 0,0 0-42 15,1 0 41-15,0 0 2 0,-1 0-16 16,0 1 23-16,1-1-16 0,-1 0 6 0,0 0-9 15,2 0-9-15,-2 0 29 0,0 0-55 0,0 0 42 16,1-1 14-16,-1 1-23 0,0 0 7 16,0 0 20-16,0 0-25 0,2 0-2 0,-2 1 6 15,0-1 1-15,0 0-2 0,0 0-16 0,0 0 22 16,0 0-5-16,0 0-12 0,3 7-9 16,-3-5-5-16,2-1 32 0,0 1-16 0,-1 0-4 15,1-1 21-15,-2 0-47 0,2 1 47 0,-1 0 2 16,-1 0-26-16,4 1-1 0,-2-2 14 15,0 1 4-15,-1 1 20 0,1-1-27 0,-1 0 30 16,1 0-29-16,-1 1 1 0,0-1-40 16,2 0 10-16,-1 2 37 0,-2-3-17 0,0 1 4 15,2 1 9-15,0 1 7 0,-1-3-14 0,0 3-12 16,0-2 20-16,-1 0 32 0,1 1-35 16,0 0-14-16,-1-2-22 0,2 0 69 0,-2 2-22 15,0-1-3-15,0-1-46 0,0 2 46 16,1-1-7-16,-1-1-10 0,0 0 42 0,2 2-22 15,-2-1 17-15,1 0-50 0,-1 0 10 0,1 2 6 16,-1-3 10-16,0 0-5 0,0 3 19 0,2-2 15 16,-2 1-27-16,0-1-2 0,1-1-8 15,-1 1 4-15,2 1 8 0,-2-1-17 0,1 0 13 16,1 0-14-16,-2 1 42 0,1-1-32 16,-1-1-26-16,1 1 50 0,0 1-33 0,0 1 13 15,0-3-26-15,-1 2 18 0,2-2 12 0,-1 1 2 16,0 0-19-16,1 2 18 0,0-4 1 0,-2 1 23 15,1 2-44-15,1-2 37 0,-2 2-52 16,3-1 34-16,-3-1-1 0,0 0-26 0,0 0 47 16,2 0-14-16,-1 0-23 0,0 1-4 0,-1-1 0 15,2 0 11-15,-2 0 2 0,0 0-6 16,2 0-36-16,-2 2 72 0,1-3-20 0,0 2-2 16,1-2-41-16,-1 2 44 0,1-1 1 15,-1 1-10-15,-1-2 21 0,2 2-26 0,-1 0-21 16,0 0 36-16,0-1-4 0,1 1-10 0,0-1 8 15,0 1-37-15,0-1 37 0,-1 0 9 16,-1 3-1-16,2-4-12 0,-1 1 7 0,0 1 21 16,1 0-38-16,-1-1 8 0,0 1 22 0,0 1-33 15,0-3 18-15,1 2-1 0,0 0 4 16,-2-1 16-16,2 2-69 0,0-1 42 0,-2 0-16 16,1 1 45-16,0-1-11 0,-1 0 5 0,2 1-17 15,-1 0-15-15,-1 0 22 0,1-1 6 16,-1 1-60-16,1 1 62 0,-1-2 5 0,3 1-31 15,-3-1 10-15,1 1-13 0,-1 0-1 0,1 1 38 16,0-2-64-16,-1 2 19 0,0-3 4 16,0 3 49-16,2-3-39 0,-2 3 14 0,0-2-4 15,1 1 16-15,-1 0-13 0,0-3-10 0,0 0 16 16,0 0 11-16,0 5-60 0,0-5 38 0,0 0-4 16,0 5-18-16,0-5 30 0,0 5 8 15,0-5-50-15,0 5 53 0,0-5-13 0,0 5-12 16,0-5 26-16,0 0-23 0,0 6 9 15,0-6-12-15,0 4 17 0,0-4-10 0,0 5-30 16,0-5 42-16,9 10 12 0,-9-8-27 0,0-2-1 16,0 0-3-16,0 0 15 0,0 0-6 0,0 5-14 15,0-5 7-15,0 5 9 0,0-5 5 16,9 8-29-16,-8-6 30 0,0 1-1 0,0-1-45 16,-1-1 40-16,3 1-4 0,-1 1 7 15,-1-2-13-15,2 1-2 0,-2 1 31 0,0-2-6 16,1 1-1-16,1 1-26 0,-3-1 2 0,1 0-2 15,1-1-22-15,-2 1 29 0,3-2-34 16,-3 3 33-16,2-2 8 0,0 0 3 0,-1 0-14 16,2 2-14-16,0-3 32 0,-3 2-13 0,3 0-29 15,-2-2 33-15,0 2 9 0,1-2-15 16,-1 1 3-16,1-1 29 0,-2 3-24 0,4-2-12 16,-4-1-8-16,1 0 37 0,1 1-52 0,-1 0 37 15,-1 1 7-15,3-1-23 0,-3 0 12 16,1-1-19-16,0 1 10 0,2 2 8 0,-2-2 16 15,1 0-56-15,-2 1 30 0,2 1 17 0,1-2-14 16,-1 1-32-16,0 0 45 0,-2-1 8 16,1 3 3-16,1-1-19 0,1-2 3 0,-2 2-13 15,1 0 3-15,-1-1 0 0,0 0 10 16,1 0-7-16,-1 0 28 0,0 3-25 0,1-5-37 0,0 5 40 16,-1-4 3-16,0 2-26 0,1-1 13 15,-1 0-6-15,0 1 23 0,-1 0 8 0,2 0-28 16,-2 0-31-16,2 0 41 0,0 0 10 15,-2-1-37-15,1 3 16 0,0-4 24 0,0 3-24 16,0-1 27-16,0 1-29 0,0-3 13 16,-1 4-17-16,0-4 32 0,1 2 11 0,-1 0-25 15,0-1-11-15,0 2 17 0,2-3 1 0,-1 2-18 16,-1 0-5-16,0-1 30 0,1 2-28 0,0-2 12 16,-1 1-16-16,1 0-23 0,0-2 44 15,-1 3 4-15,0-4-19 0,1 2-7 0,-1 1 28 16,0-1-21-16,2 0 18 0,-2 1-3 0,1-2-13 15,2 1-33-15,-3 0 1 0,0-1 35 16,0 2 35-16,1-1-22 0,0 0 0 0,0 0-2 16,1-1-17-16,-1 3 40 0,1-3-38 0,-2 1 7 15,1 1-4-15,0-2 0 0,1 0 13 0,-1 3-13 16,0-4 18-16,0 2-11 0,1 2 5 16,-1-3-8-16,2 1 11 0,-3 1-14 0,1-3 9 15,1 2-14-15,-2 0 9 0,0 0-6 16,2-1 13-16,-1 1-8 0,1-1-4 0,0 1 29 15,-1 0 3-15,0-1-16 0,0 0-24 0,-1 0 8 16,2 1 7-16,-1-1 10 0,-1-1-19 16,2 1-26-16,0 0 52 0,-1 2 5 0,-1-1-13 15,1-2-43-15,1 3 54 0,-1-1-19 0,1-1-14 16,-2 0-17-16,2 2-8 0,0-1 42 16,-1-2 6-16,-1 1-15 0,2 2 3 0,-2-2 0 15,2 2 23-15,-1 0-25 0,0-1-16 16,0 1 39-16,1-2-19 0,-1 2-6 0,-1-2-21 0,0 2 33 15,0-1-4-15,0-2-43 0,0 0-1 16,0 0 59-16,0 0 11 0,0 6-40 0,0-6 16 16,0 6-32-16,0-6 39 0,0 3-7 15,0-3-4-15,0 6-8 0,0-6 4 0,0 5 11 16,0-5-49-16,0 6 48 0,0-6 22 0,0 6-14 16,0-1-11-16,0-5-7 0,0 6-26 15,0-6 38-15,0 6-43 0,0-6 3 0,0 5 66 16,0 0-24-16,0-5-13 0,0 5 9 0,-5-5-13 15,5 6-17-15,0-6 35 0,0 6-7 0,0-1-12 16,0-5-13-16,0 5 31 0,0-5-6 16,0 5-13-16,0-5 23 0,0 6 1 0,0-6-48 15,0 5 28-15,0-5 7 0,0 0 12 16,0 6 4-16,0-6-37 0,0 0 33 0,0 5-17 16,0-5 7-16,0 5 28 0,0-5-25 15,4 11-41-15,-4-11 33 0,1 2 12 16,-1 0-2-16,1-1-2 0,1 1-1 0,-2 0-10 15,1 0 7-15,1-1-41 0,-1 2 38 0,0-1-37 16,1-1 35-16,-1 1 15 0,1 0-5 0,-1-1 7 16,1 2-19-16,-1-1-22 0,1 0 29 15,2 2 13-15,-3-1-34 0,2-1 28 0,-2 0 0 16,2 1-13-16,-3-1-10 0,3-1 27 16,-2 2-14-16,1-2-2 0,-1 0-4 0,1 0 15 15,1 2-11-15,-2-1-1 0,0 0 26 0,1-1-30 16,-1 0-15-16,0 3 23 0,1-2-4 15,2 0 14-15,-4 0 5 0,1 1-56 0,2 0 33 16,-1 0 31-16,-2-1 3 0,3 2-24 0,-2-2-15 16,0 2 13-16,1-2-12 0,-1 2 14 15,1-3-10-15,-2 1-30 0,1 2 63 0,-1-1-17 16,3 0-14-16,-3 1 22 0,2-1-18 0,-1-1 0 16,0 0-8-16,0 1-5 0,-1 1 11 0,0 0 17 15,2 0-16-15,-2-2-3 0,0 2-2 16,0-1 11-16,1 2-37 0,-1 0 34 0,2-1 19 15,-1 0-47-15,0 0 37 0,-1 0-7 16,0-4-8-16,0 0 10 0,0 6 4 0,0-2-16 16,0-4 24-16,0 8-15 0,0-2 3 0,0-2-6 15,0-4-22-15,0 7 40 0,0-3-8 16,0-4-7-16,0 5-10 0,0 0-13 0,0-5 25 16,0 7-11-16,0-2 24 0,6-5-31 0,-6 7 25 15,6 3-9-15,-5-5-22 0,0-1 2 16,1-2 25-16,-2 3-5 0,1-3-3 0,-1 2-17 15,3-1 27-15,-3 0 16 0,0 1-13 16,1-1-7-16,1 1-13 0,0-1 29 0,-1 0-51 16,0 0 26-16,0-1-8 0,1 2 8 15,-2-3 0-15,0 4 23 0,2-4-2 0,-1 2-20 16,1 0-2-16,-2-1 15 0,2 0-13 0,-2 0 3 16,1 0-28-16,1 2 13 0,-1-3 17 15,-1 1-14-15,1 1 29 0,0 0-16 0,0-1-9 16,0-1 29-16,-1 2-55 0,1-2 17 0,-1 2-1 15,0-2 21-15,1 0 10 0,-1 1-49 16,0-2 45-16,0 0 8 0,0 0-22 0,0 0 6 16,0 0-29-16,0 5 27 0,0-5 22 0,0 0-19 15,0 0-10-15,0 4 0 0,0-4 6 16,0 0-11-16,0 0-24 0,0 6 57 0,0-6-31 16,0 0-28-16,0 0 14 0,0 6 22 15,0-6-8-15,0 0 18 0,0 7-7 0,0-7 27 16,0 5-18-16,0-5-3 0,1 9 1 0,2-4 0 15,2 2-18-15,1 2 23 0,0-2-45 16,-4-1 30-16,6 4 24 0,-1-4-23 0,-1-1-4 16,0 2 8-16,-4-4-22 0,3 0 37 15,-3 0 3-15,1 0-19 0,-2-1-9 16,0 0 31-16,1 1-27 0,1-2 26 0,-1 1-2 0,0 0-13 16,-1-1-10-16,-1 1-7 0,2-1 25 15,0 1-47-15,0 0 50 0,-2 0 3 0,0 1-6 16,1-1-23-16,-1-2 14 0,3 2-21 0,-3 1 11 15,0-3 6-15,2 1 24 0,-1 1-58 16,-1 0 45-16,2-1-33 0,-1 0-15 0,0 0 43 16,-1-1-7-16,0 0-1 0,0 0 3 15,0 0 9-15,0 6-18 0,0-6 12 0,0 6-26 16,0 0 37-16,0-6-26 0,0 5 24 0,0-1 8 16,0-4-32-16,0 6-14 0,0-6-5 15,0 5 36-15,0 0 4 0,0 0-38 0,0-5 34 16,4 7-2-16,-4-7-9 0,0 6 2 0,0-2 10 15,0-4-5-15,0 6-39 0,0-2 44 16,0-4-9-16,8 13 25 0,-7-8-3 0,-1-4-35 16,0 2 5-16,0 0-32 0,0-1 37 15,0 1-3-15,0-1 20 0,0-1-27 0,0 0 12 16,0 2-23-16,0-2 26 0,1 0-3 0,-1-1 21 16,0 0-33-16,0 0 11 0,0 6-31 0,0-6 36 15,0 0-1-15,0 5-26 0,0-5 3 16,0 0-13-16,0 5 35 0,0-5-12 0,0 4 19 15,0-4-2-15,0 0-3 0,0 6-23 0,8 2 15 16,-6-5-27-16,-2-2 31 0,1 0-6 16,0 2 25-16,0-2 2 0,2 0-18 0,-2 0-19 15,-1 0-3-15,2 1-20 0,-1-2 24 16,0 3 3-16,1-3-19 0,-2 0 21 0,1 0-4 16,2 1 16-16,-3 0-20 0,2 2 20 0,-1-3 22 15,0 1-78-15,-1-1 52 0,2 1-42 0,-1 0 62 16,2 1-13-16,-3-1-1 0,0 0-28 0,2 0-10 15,0 2-2-15,-2-3 42 0,2 0 18 16,-1 2 6-16,0 2-11 0,-1-2-22 16,3 0-18-16,-2 0 0 0,1 0-3 0,-2 1 63 15,2-1-58-15,-1 1 47 0,-1-1 6 0,1 2-26 16,0-3-40-16,-1 2 1 0,1-1 48 0,1 3-7 16,-2-2 2-16,1 1 25 0,-1 1-15 15,1-4 8-15,0 4-1 0,-1-2-24 0,1 1-12 16,0-1 22-16,-1 1 16 0,1-2-20 15,-1 3 17-15,0-4-29 0,2 4 12 0,-2-3 2 16,0 3-13-16,0-2 35 0,2 1-5 0,-2-1-31 16,1 2 6-16,1-1 18 0,-2-2-18 15,1 2-13-15,-1-2 17 0,2 3-16 0,-2-1 2 16,0-1 4-16,2-1 6 0,-2 0-20 16,3 0 18-16,-3 2 16 0,2-1-25 0,-1 1 15 15,-1-1 10-15,1 0-25 0,0 0-1 0,0-2 19 16,0 3-3-16,0-2-11 0,1 1-10 0,-1 0 2 15,1 0 16-15,-1-1-1 0,1 1-21 16,-2-1 28-16,3 0-13 0,-3 1 2 0,2-1-2 16,1 2-9-16,-3-4 12 0,2 3-3 15,1-1 6-15,-2 1-2 0,3-1 8 0,-3 1-19 16,1 0 8-16,1-1-13 0,-1 2 5 0,1-4-33 16,-1 4 45-16,-1-2-8 0,1 1 5 15,-2-1 16-15,3 0-25 0,-1 1 10 0,0-1-19 16,-1 0 34-16,0 0-18 0,1 0-13 0,-1 1 18 15,2-2-36-15,-3 1 37 0,1 1-40 16,1-3 39-16,-1 1-8 0,-1 1 11 0,2 0 17 16,-1-1-64-16,-1-1 29 0,0 2 19 0,2-2-2 15,-2 2-33-15,1-1 40 0,0 2 8 16,0-1-21-16,-1-1 0 0,1 2-3 16,-1-1 10-16,0 0-9 0,1 1 7 0,-1-1-24 15,2 1 33-15,-1 1 0 0,-1-2-32 0,1 1 31 16,1 1 3-16,-1-1-19 0,1-1 4 15,-1 3 3-15,0-2 11 0,2 0 4 0,-3-1-5 16,2 2 3-16,-1-1-13 0,1-1 5 0,-1 2-11 16,0-1-12-16,0-1 24 0,0 1-17 15,0-2 12-15,-1 2 4 0,3-1-5 0,-3 0 4 16,0 0-10-16,0 0 7 0,2 0-9 0,0 0 17 16,-2-2-15-16,0 2-13 0,2 0 16 0,-1 0 2 15,0-1-3-15,-1 0-31 0,3 0 13 16,-2 0 36-16,0 0-18 0,0 1-12 15,1 0 14-15,0 0 2 0,-1-2 10 0,0 2-5 16,0-1-11-16,2 2-19 0,-2-1 7 0,0-1 22 16,1 0-26-16,0 0-15 0,0 0 38 0,1 2-6 15,-2-2-10-15,0 1 31 0,0 0-22 16,2 0-9-16,-1-1-2 0,0 1 12 16,-1 0-6-16,2 0 12 0,-1 0 7 0,0 0-8 15,1-1 0-15,-3 2 0 0,2-1-13 0,1-1 6 16,-2 0 23-16,1 2-30 0,0-1 0 15,-1-1 16-15,2 1-9 0,-3-1-11 0,2 0 6 16,0 0-8-16,-1 0 19 0,1 1 13 16,-1-1-20-16,-1 2 4 0,0-2-14 0,3 0 2 15,-3-1-6-15,0 2 3 0,2 1 6 0,-1-2 26 16,-1 1-19-16,2 1 4 0,-2-3-1 0,2 3 25 16,-1 0-42-16,-1-1 17 0,0 1 7 15,2-1-5-15,-2 2-14 0,0-2 6 16,1 1 7-16,1 0 4 0,-2 0 1 0,0-1-10 15,0 2 12-15,3 0-4 0,-2-2-8 16,0 1 21-16,-1 1-1 0,2-1-25 0,-2 0 16 16,1 0-3-16,-1 0 3 0,0-1-18 0,1 2 22 15,1-2-4-15,-2 2-3 0,0-2 4 0,3 2-13 16,-3-2 6-16,1 0-23 0,-1 1 35 16,0 0-10-16,1 0 15 0,2-1-19 15,-3 1 20-15,0 0-20 0,2-2-6 0,-2 2-2 16,1-1 21-16,3 2-31 0,-3-2 27 0,0 0-35 15,0 0 9-15,2 1 7 0,-3-1 7 0,3 1 13 16,-2-2-2-16,0 2-3 0,1-1-21 16,-1 1 22-16,1 1 10 0,1-3-31 0,-2 2 4 15,1-1-5-15,0 2 32 0,-2-2-26 16,2 2 23-16,-1 0-20 0,2-2 16 0,-2 1-4 16,-1-2-31-16,2 1 25 0,-1 2 9 0,2-3-7 15,-2 4-18-15,1-4 23 0,-1 2-4 16,0-1 14-16,0 0-11 0,1 1 3 0,0 1-9 15,-1-2 4-15,1 0 19 0,-1-1-35 0,1 1 18 16,-1 2-2-16,0-4 7 0,0 2-13 16,0 2-1-16,0-3 13 0,0 0-12 0,0 4 3 15,1-5 3-15,-2 1-5 0,0 2-4 16,2-2 0-16,-1 0 10 0,-1 0-9 0,0 0 1 16,1 0 6-16,1 0-1 0,-1 0-2 0,0-1-14 15,0 0-5-15,0 2 34 0,0-1-6 16,-1 0-33-16,2 0 14 0,-2 0-18 15,0 0 37-15,0-1-15 0,2 0 1 0,-2 0 6 0,1 1 0 16,-1-1-17-16,1 2 33 0,0-1-20 16,2-1 5-16,-3 0-6 0,0 0-17 0,1 2 23 15,0-1-1-15,0-1-2 0,-1 1 1 0,0-1-2 16,0 1-1-16,2 0-4 0,-2-1-30 16,0 0 49-16,0 0-43 0,1 0 42 0,0 2-30 15,0-2 10-15,1 1-2 0,-2 0 26 16,3 0-10-16,-3 0 8 0,0 3-15 0,3-4 20 15,-3 1-50-15,0-1 22 0,1 3 20 0,0-2-2 16,0 0-25-16,0 0 40 0,-1 1-24 0,0-2 9 16,0 0-11-16,0 0-24 0,0 0 25 15,0 0-18-15,0 0 26 0,0 0 0 0,5 8-10 16,-4-7 14-16,-1 0-13 0,1 1 16 16,-1 0 5-16,1 0-24 0,0 0-2 0,0 0 13 15,-1-1 4-15,0 0 4 0,0 0-28 0,2 1 15 16,-2 0 14-16,2 0 1 0,-2-1-44 15,0 0 55-15,0 2-38 0,0-2 17 16,1 0-31-16,1 1 40 0,-2 0 14 0,0-1-5 16,0 0-15-16,0 0-12 0,3 1-14 0,-3 0 22 15,1-1 7-15,-1 1-16 0,1 1 5 16,1-2 9-16,-1 0 17 0,-1 0-23 0,2-1 7 16,-1 3-15-16,-1-1 22 0,2-2-18 15,-1 1 1-15,0 1-6 0,2-1 0 0,-2 1 10 16,1-2-9-16,-2 0 10 0,0 1-3 15,1 0 13-15,1-1-18 0,-2 2 2 0,1-1 4 16,1 0-32-16,-1 0 22 0,0 1 16 0,1-2-13 16,-1 2 5-16,-1 0-10 0,2-1 0 15,-1-1-14-15,0 0 20 0,1 0 20 0,-1 1-27 16,1 2 15-16,-1-2-21 0,-1-1 4 16,3 0 29-16,-3 2 0 0,3 1-44 0,-1-2 43 15,-2-1-16-15,3 1 10 0,-3 0-39 0,2 2 27 16,-1-2 17-16,1-1-9 0,-1 1-3 15,0 0-23-15,1 0 29 0,-2 1-39 0,2-1 38 16,0 1-3-16,-2 0-3 0,3 1-1 16,-1-1 23-16,-1 1-20 0,0 0-24 0,0 0 22 15,2 0-2-15,-1 1 8 0,-1-2-27 0,0 3 7 16,1-3-1-16,-1 2 36 0,-1-2-36 16,1 2 33-16,0-1-37 0,0 1 27 0,0-2-8 0,0 2-1 15,0-2-4-15,-1 2 7 0,1-2-13 16,0 2 18-16,0-2-1 0,0-1-1 15,0 4 5-15,0-3-11 0,1 1 2 0,-2-3-4 16,0 3 8-16,2 0-9 0,-1-1 7 0,-1 0-7 16,0 1 13-16,2-1 0 0,-2-2-4 0,0 2-29 15,2 1 33-15,-2-3-30 0,2 2-7 16,-1-1 20-16,-1-1 0 0,2 2-17 0,-1-1 21 16,-1-1-14-16,3 1-3 0,-2-1-3 0,1 0-3 15,1 0 10-15,-2 0-13 0,-1 0 10 16,0 0-16-16,0 0 46 0,0 0 2 0,5 0-27 15,-5 0-24-15,0 0 27 0,6 0 30 16,-6 0-33-16,0 0-16 0,5 0-5 0,-5 0 29 16,0 0 8-16,5 0-13 0,-5 0 17 15,8-8-3-15,-6 8-10 0,2 0 5 0,-3-1-26 0,-1 1 43 16,3-1-11-16,-2 1 11 0,1-1-9 0,2 1-15 16,-4 0 32-16,3 0 9 0,-2-1-19 15,1 1-18-15,1 0 22 0,-1 0-40 0,-2 0 44 16,0 0-7-16,0 0-12 0,0 0 12 15,0 0 5-15,5 0-32 0,-5 0 27 0,0 0-5 16,0 0 1-16,0 0-30 0,7 0 32 16,-7 0 5-16,0 0-7 0,0 0-10 0,4 0-1 15,-4 0 25-15,10 10-3 0,-10-9-12 0,1 0 5 16,2 1-14-16,-2-2 0 0,1 2 6 0,-1 0 0 16,1-1-3-16,-1 0 19 0,0 1-37 15,2-1 24-15,-1 1-32 0,0-1 31 0,0 3-12 16,-1-3-19-16,2 0 22 0,-1 1 3 15,0 0 18-15,1 0-34 0,1 0 36 0,-1-1-56 16,0 1 13-16,1-1 5 0,-2 2 21 0,2-1-8 16,0 0 23-16,0 1-26 0,-1-1 3 0,0 0 3 15,0-1 11-15,1 0-15 0,-1 2-4 0,-1-3 1 16,1 1-13-16,0 3 30 0,0-3-20 16,-2 0 30-16,2 2-4 0,-1-2-8 0,0-1-17 15,0 2-9-15,-1-1 34 0,2 0-8 16,-2 1-16-16,1-2 15 0,-1 2-12 0,2-1 4 15,-2 2 20-15,2-2-40 0,-2 0 6 0,1 0 27 16,2 2 12-16,-4-2-40 0,3 1 11 16,-3 0 14-16,3 0-35 0,-2 0 29 0,-1 0-6 15,3 2-11-15,-3-3 23 0,4 3-11 0,-4-2 4 16,2 1 11-16,-1 0 1 0,-1-2-7 16,2 3 2-16,-1-2-2 0,2 1-6 0,-2 0 2 15,0 0-3-15,-1 1 25 0,2-3-25 0,-2 2 19 16,3 0-25-16,-3 0 12 0,1-1 2 15,-1 1-18-15,0 0 3 0,3-2 3 0,-2 2 8 16,-1-1-4-16,2 3 10 0,-2-4-42 16,1 3 27-16,-1 1 27 0,0-3-35 0,3 0 17 15,-3 1-12-15,3-1 16 0,-2 2-9 0,0 0 5 16,1-2-10-16,-2 1 27 0,1 0-48 0,-1 0 38 16,2-1-15-16,-2 2-9 0,1-1 26 15,2-1-7-15,-2 1-32 0,-1-1 36 0,1 1-11 16,0 0-7-16,0 0 4 0,-1-1 2 15,0 0-15-15,2 2 21 0,-1-3 0 0,-1 1-22 16,0 2-3-16,0-4 32 0,3 5-6 0,-3-3-1 16,1 1 13-16,0 0-6 0,1-1-22 15,-1 0 7-15,-1 1 13 0,1 1-8 0,0-2-15 16,-1 2 17-16,0-3 1 0,1 2-12 0,1 2 0 16,-1-4 5-16,1 4 22 0,0-4-19 15,-2 3 11-15,2-3-13 0,-2 2-4 0,1-1 0 16,-1-1 13-16,2 2-40 0,-1-1 29 0,0 0-15 15,-1 1-3-15,1-1 29 0,0-1-4 16,-1-1 10-16,1 3 2 0,0-1-16 0,0 0 8 16,1-1-12-16,-2-1 10 0,0 4-19 15,2-2 19-15,-1-1 15 0,1 0-34 0,-1 1-4 16,0 0 33-16,-1-2-22 0,2 2-10 16,-1 0 16-16,1-2 6 0,-1 1-32 0,0 1 30 15,1-1-6-15,-1 0 4 0,1 0-8 16,-1 0-7-16,-1 0 27 0,2 1-13 0,0-1-10 15,-2 0 0-15,2 0-2 0,-2 1 16 0,1-1-12 16,0 0-15-16,-1-1 21 0,1 1 9 0,1 1-5 16,-2-1 4-16,2-1-25 0,-1 3 7 15,2-1 43-15,-3-1-31 0,1 1-14 0,0 1 26 16,1-1 6-16,-1-1-49 0,0-1 24 0,1 3-5 16,0-1 3-16,-2-2 14 0,1 2 2 15,0 1-10-15,1-2 9 0,-2 0-18 0,2 3 23 16,-1-4-4-16,0 3-5 0,-1 0 9 0,2 0-35 15,-1-3 34-15,-1 3-1 0,0-1 2 16,0 1 5-16,3 1 4 0,-2-2-29 0,0 2 14 16,0-2-15-16,0 1-7 0,2 0 34 15,-2 1-5-15,-1-1-11 0,2 1 2 0,-1-2-6 16,0 1 7-16,1 2-24 0,-1-1 27 16,2-1 8-16,-3 1-24 0,3 1 16 0,-3-3-21 0,1 3 20 15,1-2-11-15,-2-1 10 0,1 3 18 16,1-3-35-16,-1 1 15 0,0 1 0 15,-1 0-35-15,0-1 44 0,3 0-36 0,-3 0 34 16,0-3-45-16,0 0 36 0,0 5 16 16,0-5-10-16,0 4-6 0,0-4 10 0,0 0-2 15,0 7-5-15,0-7-29 0,0 5 36 0,0-5-38 16,0 5 32-16,9 4-26 0,-9-6 28 0,0-2-32 16,2 3 32-16,-2-2-20 0,0-1 17 15,0 0 9-15,1 2-6 0,1-2 13 0,-2 0-17 16,0 2 4-16,1-1-15 0,-1-1 20 15,3 0-13-15,-2 1 10 0,1-2-22 0,-1 2 20 16,-1-2-23-16,0 1 28 0,2-1-13 16,-2 3-10-16,1-3 3 0,2 0 18 0,-2 2 0 15,0-2-6-15,1 1-12 0,-2 0-1 0,2 1-13 16,-1-2 27-16,-1 0 4 0,3 2-11 0,-3-2 10 16,0 0-43-16,0 0 19 0,0 0 31 0,0 0-20 15,5 0 4-15,-5 0-1 0,5 0 4 16,-5 0 12-16,5 0 5 0,3 6-19 15,-6-4 12-15,1-2 4 0,-2 1-4 0,1-1-9 16,0 1 9-16,0-1-21 0,-1 0 12 0,0 0-8 16,1 0 1-16,-2 2 3 0,1-1 20 15,0-1-12-15,0 0-11 0,0 2-7 0,1-2 4 16,-2 0 3-16,0 1 3 0,0 0-6 16,1-1 9-16,1 2 11 0,-1-2-21 0,-1 1 19 15,1-1-24-15,-1 0 11 0,0 1-8 0,0 0-1 16,2 1 28-16,-1-1-18 0,0 0 4 15,1 0 13-15,-1 1-49 0,0 0 30 0,0 0 1 16,0 1 6-16,1 0-2 0,-1 1-1 0,3-3-6 16,0 3 4-16,-3 1 20 0,4 6-25 0,0-5 25 15,0 0-11-15,-4-1 3 0,9 0-6 16,-6 2-2-16,1-2 8 0,-1 0-8 0,-1-2-5 16,-2 1-3-16,3 0 7 0,-4-2 1 0,3 2 3 15,-1-2-38-15,0 1 49 0,-2 0-14 0,3-1 15 16,-2 1-12-16,1 0-15 0,-1-2 17 15,-1 3 8-15,2-3-18 0,-1 2-1 0,2-1-8 16,-2-1 15-16,-1 3-16 0,3-3 14 16,-3 2-18-16,0-1 13 0,3-1-18 0,-3 2 26 15,4-1-10-15,-3 0 6 0,1 1 14 16,1 0-16-16,-2-1-4 0,3 2 6 0,-1-1-9 16,6 3-14-16,-5 0 15 0,-1-1 6 0,1-1 3 15,0-2-7-15,0 1 18 0,0 1-9 0,-1 0-1 16,1-2-37-16,-1 0 39 0,0-1-7 0,0 1-3 15,0-1 19-15,0 0-24 0,-1 0 10 16,1 1 1-16,0-1-7 0,-2 0 7 0,2 0-8 16,-1 0 4-16,-1 0 18 0,2 0-18 15,-2 0-4-15,1-1-35 0,0 3 24 0,-2-3 13 16,0 0-3-16,0 0-13 0,0 0 27 0,0 0-3 16,0 0 6-16,6 0-27 0,-6 0 26 0,0 0-9 15,0 0 4-15,4 0 14 0,-4 0-14 16,0 0-1-16,0 0 11 0,0 0-9 0,6 0 2 15,-6 0-8-15,0 0 11 0,0 0 15 0,0 0-18 16,0 0-21-16,0 0 37 0,0 0-17 16,0 0-15-16,0 0 17 0,4 0 0 15,-4 0-14-15,0 0 25 0,0 0-21 0,0 0 8 16,0 0-8-16,0 0 15 0,7 0-9 0,-7 0-10 16,6 7-7-16,-5-6 22 0,0 1-26 0,1-1 32 15,-2-1-33-15,3 0 25 0,-2 0-10 16,-1 1 8-16,2 0-3 0,-2 2 12 0,0-2-10 15,1 0 5-15,-1-1 9 0,3 1-21 0,-2 0 8 16,-1 2-7-16,2-2 17 0,-4 0-14 16,2 0-12-16,3 0 5 0,-3-1 19 0,2 1-3 15,-2 1-13-15,1 0 10 0,0-1-6 0,0 1-4 16,-1-2-11-16,0 2 14 0,-1-1-19 0,1-1 14 16,0 0 5-16,0 0 0 0,0 0 4 15,0 0-17-15,0 0 19 0,0 0 10 0,0 6-11 16,0-6 14-16,0 0-39 0,0 4 20 0,0-4 3 15,0 3-8-15,10 3-2 0,-8-2 21 16,-2-4-12-16,0 1 4 0,0 0 4 0,2 0-7 16,-2 2-9-16,0-3 0 0,0 0 17 0,0 0-24 15,0 0 16-15,0 0 11 0,0 0-15 16,0 0 8-16,0 0-4 0,0 0-12 16,0 0 1-16,0 0 9 0,0 0-3 0,0 3-6 15,0-3 1-15,0 0 5 0,0 0-8 0,0 0-7 16,0 0 13-16,6 5-5 0,-6-7-8 0,0 2 8 15,2-2 7-15,1-1-23 0,-3 2 25 16,0 1-7-16,2-4-14 0,-1 2 3 0,1 0 4 16,-2-1 1-16,1 1 20 0,-1-2-5 15,2 2 13-15,-2-1-17 0,2 1-9 0,-2-1 7 16,2 1 3-16,-1-1-8 0,-1 1 18 0,2 1 13 16,-1-1-14-16,-1 1-4 0,0-1-21 15,0 1 16-15,2 0 13 0,-2 0-25 0,2 0 32 0,-2-1-23 16,1 0 5-16,0 1-12 0,-1 1 3 15,0-1 23-15,1 1-11 0,-1-1-8 0,0-2 26 16,0 3-22-16,1-1 3 0,0 1-10 16,-1-1 11-16,1 1-9 0,-1 0 8 0,0-1-16 15,3-1 14-15,-3 1 16 0,0 1 6 16,2 0-24-16,-2 0 24 0,0 0-7 0,0 0-3 16,0 0-9-16,0 0 2 0,0 0 0 0,0 0 3 15,0 0 18-15,0 0-6 0,0 0-30 0,0 0 20 16,0 0-4-16,0 0 11 0,5 0-4 0,-5 0-7 15,0 0 6-15,0 0 2 0,4 0-13 16,-4 0 1-16,0 0-9 0,10 7 18 0,-7-4-10 16,-2-2-4-16,-1-1 16 0,2 1-1 15,0 3-1-15,1-3-3 0,0 0-2 0,-2 1 3 16,3 0 2-16,-3 1-16 0,1 0 32 0,2-1-15 16,-1-1-4-16,-1 3-20 0,2-2 15 15,-1-1-8-15,-1 1 22 0,1 0 1 0,-1-1-7 16,1 0-27-16,-1 2 19 0,0-1 3 15,-1-2-10-15,2 1 8 0,-2 0-14 0,1-1-11 16,-1 3 6-16,1-3-5 0,-1 1 9 0,3-1 5 16,-4 0-12-16,2 1 12 0,-1-1-2 0,2 1 18 15,-1-1-14-15,0 0-1 0,1 2 8 16,-3-2-8-16,0 0-11 0,0 0 16 0,0 0-26 16,5 0 20-16,-5 0 0 0,0 0-11 0,6 0 25 15,-6 0 2-15,10-10-4 0,-10 10-14 16,3 0 12-16,-2-2-4 0,1-1-10 0,1 2 18 15,-2-1-19-15,0 1 11 0,-1-1-11 0,2 0 10 16,-2-1 0-16,1 1-2 0,1-1-3 16,-1 3 10-16,1-2-1 0,-2-1-8 0,2 1-2 15,-2 0 15-15,0 0-27 0,3 1 12 16,-3-2-19-16,0 1 25 0,0 1-8 0,2-2 15 16,-1 2-8-16,-1-1-4 0,2 2-4 0,-2 0-11 15,0 0 30-15,0 0-7 0,0 0-3 16,0 0 19-16,0 0-17 0,0 0 7 0,0 0-6 15,0 0-8-15,0 0 8 0,0 0-2 0,0 0-18 16,0 0 16-16,0 0 3 0,0-5 2 0,0 5-6 16,0 0 4-16,0 0 7 0,8-5-5 15,-8 6-1-15,1 1-6 0,-1-1 11 0,2 0-1 16,-1-1-5-16,1 1 18 0,-2 3-27 0,2-3 8 16,-2 3-12-16,2-2 21 0,-1 0-1 15,2 1-12-15,-3-1-14 0,1 0 13 0,0 0 11 16,1 1-14-16,-1 0 10 0,0-1-10 0,1-1 12 15,-2 3 9-15,2-2-26 0,0-1 18 0,-2 0-8 16,1 2 4-16,0-2 2 0,1-1-8 16,-1 2-1-16,0 0 11 0,2 0 0 0,-1-2-17 15,0 0-5-15,-1 2-1 0,1-2 19 0,1 1-7 16,-2 1 13-16,0-2-26 0,2 0-1 16,-1 1-5-16,-2-1 24 0,1 0-3 0,-1 0-2 15,0 0 2-15,0 0-2 0,0 0 8 16,6 0 9-16,-6 0-13 0,0 0 9 0,5 0-35 15,-5 0 20-15,0 0 10 0,6 0-6 16,-6 0-5-16,0 0-2 0,5 0 9 0,-5 0 6 16,0 0-5-16,5 0 13 0,-5 0-26 0,0 0 12 15,5 0 7-15,-5 0-35 0,6 0 12 16,-6 0-5-16,6 0 18 0,-6 0 1 0,5 0 5 16,-5 0 4-16,7 0-3 0,2-10-17 0,-5 9 21 15,-1 0-16-15,4 1 19 0,-5 0 6 0,3-2-1 16,-2 2 6-16,0-1-37 0,-1 1 22 15,1-1-17-15,1 0 10 0,-1 1 11 0,-2 0 0 16,-1 0 3-16,0 0-28 0,0 0 27 16,0 0-15-16,0 0 21 0,0 0-17 0,6 0 5 15,-6 0-9-15,0 0 8 0,0 0-4 0,6 0-6 16,-6 0 9-16,0 0 0 0,0 0 17 16,4 0-15-16,-4 0-10 0,8 5 8 0,-6-4 0 15,-1 2 1-15,1-2-4 0,-1 0 14 16,1-1-15-16,0 1-5 0,1 0-29 0,-2 0 35 15,2 1-15-15,-1-2 8 0,0 1-16 16,2 0 6-16,0 0 19 0,-1 1-27 0,2-1 21 16,0-1 4-16,-1 1-3 0,2-1-8 0,0 0 22 15,-1 2-10-15,6 3-28 0,-1-5 25 0,-1 1 8 16,-1 1-7-16,-2-1 8 0,0-1 5 16,-1 1-8-16,-1-1-11 0,1 0 8 15,-1 0-5-15,-4 0 8 0,0 0 0 0,4 0-2 16,-4 0-2-16,7 0-12 0,-7 0-8 0,4 0 3 15,-4 0 31-15,13-9-1 0,-10 8-23 0,-1-1 1 16,0 1 11-16,0 1 9 0,0-3-17 16,-2 1 0-16,3 1 23 0,-1-4-16 0,-2 5-10 15,3-2 10-15,-2-2-22 0,0 2 22 0,1 0-1 16,0 0 2-16,-1-2 15 0,-1 2-35 16,1-1 1-16,0-2 24 0,1 3-3 15,-1 0 3-15,-1-1 11 0,1-1-13 0,2 3-7 16,-2-5-6-16,1 4 22 0,-1-2-23 0,0 2-4 15,-1-2 1-15,2-1 15 0,-1 2-15 0,0-1 17 16,1 3 9-16,0-3-10 0,-2 1 5 0,1 0-27 16,0-1 12-16,0 1 9 0,0 0-13 15,1 1 2-15,0-2-3 0,0 3 16 0,-1-3-15 16,1 2-4-16,-1 0 1 0,0-2 18 16,0 3-5-16,0-2-12 0,0 1 21 0,0-1-9 15,1 1-12-15,-1 0 23 0,-1 1-4 0,2 0-14 16,-2-2 13-16,2 2-24 0,-2 0 22 15,0 0-6-15,0-1 9 0,1-1-6 0,0 3-14 16,-1 0 27-16,3 0-30 0,-2-1 18 0,-1 0-12 16,1 0 11-16,1 1 10 0,0-2-20 15,-2 2 0-15,0 0 11 0,0 0 16 0,6 0-24 16,-6 0-14-16,0 0 19 0,5 0-4 16,-5 0 5-16,12 10-2 0,-10-10-3 0,0 1 1 15,0 0-4-15,1 0-2 0,0 1 26 16,-2-1-14-16,2 1-16 0,0 0 16 0,-2 2 6 15,3-2-19-15,-1 0 17 0,-2 1 10 0,2 0-23 16,0 0 21-16,3 6-39 0,0-3 34 16,-2-1 11-16,-2-1-6 0,3-1-12 0,-3 1-32 15,1-2 36-15,-1-1-29 0,-1 1 27 16,1 0-8-16,-1 0 5 0,0 1-11 0,1 0 5 16,-2-3-19-16,1 4 28 0,0-3-32 0,0 0 25 15,-1-1-12-15,0 1 16 0,1 2-9 16,-1-2 8-16,0-1-35 0,1 2 32 0,-1 1 12 15,1-1 8-15,-1-1 3 0,0 3-39 0,1-4 15 16,-1 3-27-16,0-2 31 0,0-1-15 16,0 0-4-16,0 0 24 0,0 6-2 0,0-1-12 15,0-5 8-15,0 6 12 0,8 0-7 16,-7-2-20-16,0-2 10 0,2 3 0 0,-2-4 10 16,7 7-9-16,-3-2-4 0,0-1 16 0,2 1-29 15,-2 0 2-15,-1-3 7 0,1 2 21 16,-2-3-6-16,0 3 10 0,1-4-18 0,-1 3 21 15,1-3-9-15,-1 2 12 0,1-1-32 0,-1 0 11 16,1 0 18-16,-1-1-16 0,0 1-9 16,1-1-9-16,-1-1 30 0,1 1-44 0,-1-1 33 0,-1 1-18 15,3-1 13-15,-4 0 3 0,4 1-13 16,-3 0 9-16,0-1 20 0,0 1-46 16,0-1 32-16,-2 0-1 0,0 0 17 0,0 0-26 15,0 0 9-15,5 0-34 0,-5 0 30 0,0 0-10 16,5 0 30-16,-5 0-19 0,0 0 10 0,6 0-27 15,-6 0 30-15,0 0 6 0,0 0-22 0,6 0 0 16,-6 0 18-16,0 0-14 0,5 0 21 16,-5 0-4-16,0 0-16 0,0 0 11 0,4 0-9 15,-4 0-4-15,0 0 13 0,0 0 5 16,6 0-2-16,-6 0 7 0,0 0-23 16,0 0 6-16,11 2-16 0,-9 1 30 0,-1-2 10 15,1 0-50-15,-1 1 12 0,0 1 9 0,1-1 14 16,-1 0-5-16,1 0 6 0,0 0-21 15,2 3 10-15,2 4 19 0,-1-5-11 0,3 7-1 16,-3-4 7-16,-2-2-13 0,2-1 1 0,-2 1 2 16,4 2-33-16,-1 1 34 0,1 0-27 0,-4-2 23 15,2-2 21-15,-2 1-14 0,0 0 0 16,1-3 4-16,-3 1-10 0,1 1 11 0,-1-2-9 16,1 1-5-16,0 0-7 0,0-1 12 15,0 2-13-15,-1-2 25 0,1 1-6 0,0 1-33 16,-2-2 24-16,1 3-12 0,2-3 15 0,-3 1-7 15,2 1-20-15,-2-2 27 0,2 2-26 0,-2-1 25 16,1 0-5-16,-1 0 25 0,2 0-32 16,-2 0 14-16,1-1-3 0,-1-1-5 15,2 3 1-15,-1-2-25 0,0-1 34 0,-1 3-5 16,1-3 6-16,0 0-23 0,-1 1 14 0,2 0-9 16,-1 1 0-16,1 0 12 0,0 0-24 0,1 0 25 15,1-1-41-15,-3 1 42 0,3 0-1 16,0-1-23-16,4 8 15 0,-3-5-26 15,1 1 42-15,2 1-27 0,0-1 7 0,-1-1 18 16,1 2 4-16,-4-2-17 0,3-4 29 16,-4 3-20-16,-1-1-11 0,1-1 16 0,0-1 4 15,-1 3-9-15,1-3-8 0,1 0-1 0,-3 1-17 16,2 0 28-16,0-2-4 0,-2 1-12 16,2 0 22-16,0 0-9 0,-2 2-12 0,1-3-9 15,-1 2 8-15,3-1 14 0,-2 0-14 0,-1 1 14 16,2 0 5-16,-2 0 0 0,2-1 4 0,0 0-14 15,-2 1-5-15,2-1 3 0,1 1 21 16,-2-2-24-16,-1 2-2 0,2 0 15 0,0-2-8 16,0 1 1-16,-1 0-39 0,0-1 49 15,1 2 8-15,-1-1-28 0,0 1 7 0,-1-2-5 16,1 1 19-16,-1-1-14 0,2 2-14 0,-1-1 16 16,-2 0-19-16,2 0 34 0,-2-1-14 0,1 0 3 15,-1 0-34-15,2 1 22 0,-2-1 27 16,1 0-27-16,-1 2 6 0,0-1-31 0,2 0 32 15,-2-1-24-15,0 1 38 0,0 1-9 16,2-1-27-16,-2 0 24 0,0 0 15 0,0-1-9 16,0 0-1-16,0 0-4 0,0 0-15 0,0 6 14 15,0-6 2-15,0 4-18 0,0-4 17 16,0 6 11-16,0-1-11 0,0-5-32 0,0 6 23 16,0-6 6-16,0 4 1 0,0-4-2 0,0 6 26 15,0-6-25-15,0 6 5 0,0-6 10 0,0 7-16 16,0-3-2-16,-7 3-14 0,7-3 24 15,0-1 7-15,-1-1-8 0,0 1 7 0,1-1-15 16,0 1 6-16,0-1-9 0,0-2 7 16,0 0-18-16,0 0 34 0,0 5-9 0,0-5-1 15,0 5-8-15,0-5-7 0,0 4 7 0,0-4 13 16,7 10-22-16,-5-8 7 0,0 1 10 0,0-1-11 16,0 0 5-16,-1 2-7 0,1-3-13 15,-2 2 27-15,3-2-9 0,-2 4 0 0,1-2 11 16,2-2 11-16,-1 1-37 0,0 3 23 0,-1-4-16 15,1 1-1-15,1 2 14 0,0-4 0 16,-1 1-5-16,0 3 8 0,0-4-6 0,0 1-8 16,-1 2 0-16,1-2 8 0,-1 2 1 0,1-2-10 15,2 1 14-15,-5-2 11 0,3 2-14 0,-1-1-4 16,-1-1-6-16,2 0-8 0,-1 0 21 16,1 3-3-16,-1-2 9 0,-1 1-11 15,2-2-3-15,-2 0 0 0,1 1 1 0,-1 1 1 16,1 1-1-16,1-2 3 0,0 1 3 0,-1 2 2 15,1-3-3-15,0 2-9 0,-1-1 8 16,1 2-14-16,7 3 18 0,-4-2-7 0,-2-1 6 16,0-2 1-16,1 2-11 0,0 0 2 0,-2-1-4 15,1-2 10-15,-3 3 0 0,2-1-3 16,0-3 16-16,-3 2-19 0,3-1 0 0,0 2-1 16,-1 0-1-16,0-2 8 0,-2 2-6 15,3-1 7-15,-1 0-26 0,0 1 17 0,-1-1-6 16,1 1 15-16,-2 1-21 0,1-2 23 15,-1 1-17-15,3 0 16 0,-3 0-17 0,0-1 7 16,1 0-5-16,0 2 16 0,0-1-11 0,0 0 1 16,0 1 13-16,1-2-12 0,-2 2 11 0,0-1-2 15,3 1-7-15,-3-2-4 0,1 2-14 16,0-1 10-16,-1-1 20 0,1 3-13 0,0-1 1 16,0-2 3-16,0 1-3 0,0 0 4 15,-1-3-7-15,0 0 11 0,0 0-10 0,0 4-16 16,0-4-10-16,0 0 9 0,0 5 21 0,0-5-8 15,0 5 3-15,0-5-7 0,0 0 2 0,0 0-12 16,0 5 28-16,0-5-29 0,0 0-2 16,10 7 13-16,-9-5 19 0,0 0-17 0,2-1 6 15,-3 0 0-15,0 0-7 0,1-1 7 0,0 3-23 16,0-3 17-16,1 0-17 0,-1 0 14 16,3 0 6-16,-4-2 6 0,3 2 18 0,-2 0-33 15,0 0-14-15,0 0 31 0,1 0 9 16,1 2-9-16,-3-2-2 0,2 0-39 0,-2 0 40 15,3 0-1-15,-3 0 2 0,0 0 20 0,0 0-25 16,0 0 0-16,0 0-2 0,0 0 23 0,0 0-24 16,0 0 4-16,0 0-12 0,0 0 15 0,5 0 1 15,-5 0-16-15,0 0 17 0,0 0 17 16,10 11-17-16,-7-10-10 0,-2 0-3 0,-1 1-1 16,2 1-1-16,-2 0 22 0,2-1-6 15,-1 0 14-15,2 0-8 0,-1 1-4 0,-1 0-34 16,1-1 34-16,1 1 4 0,-3-1-12 0,3-1 6 15,-2 2-11-15,0-2 0 0,2 0 8 16,-3-1 7-16,2 3-9 0,-2-2 14 0,0 1-17 16,3-1-8-16,-2 0 9 0,0 1 10 0,-1 0-7 15,2-1 4-15,-1-1-33 0,0 1 15 16,1 0 9-16,0 2-5 0,0-2-11 0,1 0 0 16,-2 0-3-16,4 1 8 0,-2 0 12 0,1-1 8 15,-1 2-20-15,1 0 18 0,6 2-5 16,-2-2-10-16,0-1 15 0,0-1-19 0,4 2 12 15,-5 1-13-15,1-3-1 0,0 0 14 16,-2 0 1-16,0-1-1 0,0 1-8 0,-1-1 20 16,-1 0-11-16,-4 0 8 0,0 0-8 0,7 0 10 15,-2 0-10-15,0 0 18 0,-5 0-28 16,6 0 13-16,-6 0-2 0,13-9-22 0,-12 7 17 16,3-1-13-16,-1 1 18 0,-1 0-4 15,-1-1 1-15,3 1-9 0,-2-2 32 0,-1 1-18 16,1 1-28-16,0 0 20 0,-2 1 2 0,3 0 1 15,-2-3-1-15,0 3-17 0,2 0 30 16,-3-3-6-16,2 3 6 0,-2 0 7 0,1 0-38 16,2-1 43-16,-3-1-47 0,2 3 47 15,-2-1-10-15,1 1-19 0,-1-3 24 0,0 2-13 16,1 1-1-16,1-1 13 0,-1 1-12 0,-1-1 10 16,0 0 7-16,1-1-13 0,-1 1-31 0,2 0 18 15,-1 0 15-15,-1 0-1 0,1 0-14 16,0 0 20-16,0-1-9 0,0 0-1 0,1 1 11 15,-1 0-6-15,2 0-11 0,-3 0-13 16,2 0 32-16,0 1-27 0,1-2 29 0,-1 1-49 16,2 0 25-16,-2 0-7 0,1-2 20 0,0 3 9 15,0 0-13-15,0-1 6 0,0 0 9 16,1 1-23-16,-2-1 2 0,2-1-25 0,1 2 17 16,-2-1 17-16,2 1-15 0,-2-1 6 0,0 0 19 15,0 1 2-15,1-1-16 0,-3 0 4 16,2 1-9-16,-1-1 4 0,2 1-4 0,-3 0 23 15,1 0-23-15,0 0 7 0,0 0-10 16,1-2 28-16,-2 2-14 0,2 0-5 0,-3 0 7 16,0 0-24-16,3 0 34 0,-3 0-42 0,0 0 21 15,0 0 2-15,0 0-27 0,0 0 30 16,0 0-8-16,0 0 14 0,7 7-4 0,-6-7-6 16,1 4-1-16,-2-3 13 0,3 0-15 15,-2 2-4-15,0 0 7 0,1-1-1 0,-1 0-20 16,0 0 11-16,1-1 12 0,1 0-1 0,-2 2-16 15,0-1-7-15,2-1 30 0,0 0-18 0,1 0 8 16,-1 0-8-16,0 1-28 0,1-1 38 0,-1 0-4 16,1 0 8-16,-4-1 10 0,0 0-23 15,0 0 0-15,7 0 13 0,-2 0-16 0,-5 0-24 16,5 0 11-16,2 0 17 0,-7 0 10 16,4 0-25-16,-4 0 32 0,6 0-6 0,0 0-7 15,-6 0 8-15,12-7-3 0,-6 6-18 0,-4 0 18 16,0 0 1-16,1-2-13 0,0 2-2 15,-1 0 16-15,0 0 0 0,3 0-9 0,-3-1 12 16,2 1-16-16,-2-1 8 0,0-1 16 16,1 0-20-16,0 2 11 0,-3-1-27 0,2-1 17 15,2 2 14-15,-2-2-3 0,0 2-32 16,-2 0 33-16,3-2-14 0,0 1 24 0,-1 1-8 16,0-3-8-16,-1 3-7 0,2 0 17 0,-3 0-31 15,1-2 11-15,2 3 36 0,-2-2-24 16,1 1 2-16,-1-1-14 0,1-2-11 0,1 2 41 15,-1 1-11-15,1-2 1 0,0 1-4 0,1 2-5 16,0-3 6-16,-2 2 12 0,2-2-7 16,0 2-14-16,1-1 6 0,-1 2-20 0,1-1 23 15,-2 0 1-15,2-2-6 0,-1 2 14 0,0 1-9 16,0 0-6-16,0-1 1 0,1 1-1 16,-3-4 6-16,4 4-7 0,-5-1-13 0,2 1 30 15,0 0-14-15,0-1 10 0,-2 1-30 16,2 0 19-16,-1-2 4 0,-2 2-10 0,0 0-3 0,0 0 8 15,0 0 4-15,5 0-25 0,-5 0 17 16,0 0 0-16,4 0 1 0,-4 0-2 16,0 0-15-16,7 0 3 0,-7 0 21 0,4 0 3 15,-4 0 2-15,0 0-3 0,6 0-18 0,-6 0 9 16,0 0 7-16,6 0-3 0,-6 0 7 0,5 0-24 16,-5 0 17-16,3 0-25 0,-3-6 29 0,7 6-23 15,-7 0 22-15,6 0 13 0,-6 0-23 16,5 0 8-16,0 0-24 0,-5 0 26 0,8 0 6 15,-4-5-17-15,2 5 4 0,-2 0 17 16,2 0-13-16,-6 0-20 0,7 0 33 0,-2 0-26 16,2 0 30-16,-1 0-44 0,-2 0 38 15,-4 0-10-15,7 0-14 0,0 0 13 0,-7 0-11 16,6 0 10-16,-1 0-3 0,-5 0-2 16,6 0 2-16,-6 0 0 0,7 0-5 0,-7 0-1 15,7 0 6-15,-7 0-15 0,6 0 8 0,-6 0 14 16,5 0 2-16,-5 0-30 0,5 0 24 0,-5 0 8 15,5 0-11-15,-5 0 2 0,5 0 17 16,-5 0-15-16,0 0 1 0,6 0-14 0,-6 0 25 16,6 0-19-16,-6 0-1 0,4 0-2 15,-4 0 22-15,5 0-16 0,-5 0-19 0,0 0-3 16,7 0 34-16,-7 0-32 0,5 0 6 0,-5 0 17 16,7 0-17-16,-1 0 5 0,-2 0 15 15,2 0 1-15,4 9-6 0,-5-9-18 0,-2 1 26 16,14 2-23-16,-17-3 20 0,9 0-39 0,-2 0 19 15,0 0 10-15,0 0 1 0,-1 0 0 16,-6 0 15-16,7 0-11 0,-3 0 7 0,-4 0-13 16,7 0 15-16,-7 0 1 0,12 6 0 0,-9-6 5 15,-3 0-7-15,0 0-2 0,0 0-17 16,6 0 8-16,-6 0 3 0,6 0-2 0,4-8-9 16,-7 7 1-16,-1-1 12 0,0 0-12 0,1 0 30 15,1 1-21-15,-1-1-21 0,0 1 27 16,-2 1-2-16,4-4-2 0,-4 1-6 0,1 3 7 15,1-2 3-15,1-1-25 0,-1 2 31 0,0 0-21 16,-1-4 8-16,1 5 9 0,0-3 13 16,-1 0-19-16,1 2 2 0,-1-2-24 0,0 0 13 15,-1-1-5-15,2 2 16 0,-1 0 4 0,0-1-2 16,0 0-33-16,-1 2 6 0,2-3 20 16,0 1 8-16,-1-1-1 0,1 2-10 0,-1-2 6 15,-1 1-16-15,2 1-1 0,-2-3 25 16,2 3-4-16,-3-4-3 0,2 5-12 0,0-3 21 15,0 2 2-15,-2-2 2 0,3 0-27 0,-1 0 13 16,0 1-13-16,0-1 24 0,0 0-40 16,1 2 41-16,-2-2 11 0,1 1-26 0,0 0-4 15,0 0 0-15,1 0 15 0,-2 0-9 0,1 0-13 16,-2-2-1-16,2 4 24 0,-1-4-8 16,1 4-7-16,0-3 18 0,0 4-9 0,0-6-1 15,-1 5 7-15,1-2-15 0,-1 1 11 0,3 0-8 16,-4-1-15-16,2 1 15 0,0-1 3 15,1 1-12-15,-3 0-2 0,3 0 18 0,0 1-8 16,0-3 3-16,-2 3 14 0,2-2-5 0,-2 2-4 16,2-1-30-16,-1 0 14 0,-1 0-6 15,2 1 21-15,-2 0 2 0,2-2-9 0,-3 1 6 16,3 1-1-16,-2-2-2 0,3 3-20 0,-3-1 27 16,1 0-26-16,0-1 16 0,1 1 4 15,0 0 9-15,-1 0-31 0,1 1 32 0,-3-3-8 16,4 2-11-16,-1 0-16 0,0 1 37 15,-2-2-30-15,1 0 24 0,-2 2-13 0,0 0 13 16,0 0-1-16,6 0 20 0,-6 0-23 0,7 0-19 16,-7 0 10-16,4 0-7 0,-4 0 20 0,6 0-8 15,-6 0 2-15,0 0-8 0,6 0 14 16,-6 0-10-16,3 0 2 0,-3 0 0 0,0 0-9 16,7 0 26-16,-7 0-22 0,0 0 13 0,5 0-20 15,-5 0 18-15,0 0 1 0,0 0 2 16,5 0-5-16,-5 0-1 0,0 0-3 0,0 0 11 15,0 0-12-15,0 0-8 0,4 0-8 0,-4 0 16 16,0 0-3-16,0 0 12 0,6 0-24 16,-6 0 20-16,9 7-3 0,-8-5-12 0,1-2 24 15,0 2-11-15,0 1-4 0,0-2 13 0,-2 0-16 16,1-1 1-16,1 3-10 0,-1-2 4 16,1 1 16-16,-1 1 0 0,0-2-11 0,2 0-22 15,-3 2 39-15,3-2-9 0,-2 0-4 0,-1 2 7 16,3-2-13-16,-2 0-19 0,1-1 26 15,-1 2-12-15,2-2 12 0,-1 3-3 0,0-2 7 16,0-1 5-16,-1 0-11 0,2 1-37 0,-2-1 38 16,2 0-7-16,1 1 12 0,-1-1-24 15,-3 0 12-15,0 0 20 0,0 0-8 0,7 0 3 16,-2 0-10-16,-5 0 2 0,6 0 4 16,-6 0-36-16,6 0 44 0,0 0-14 0,-6 0 11 15,4 0-13-15,3 0 3 0,-7 0 9 0,11-8 4 16,-8 6-16-16,0 0-8 0,2 0 4 15,-1 1 20-15,0 0-37 0,-1-1 6 0,-1 1 16 16,1 0 6-16,1-2 14 0,-2 1-9 16,1 2-6-16,1-4 10 0,-2 4-33 0,1-1 32 15,-1 0-8-15,2-2 10 0,-3 1 12 0,3 2-19 16,-4-2 7-16,3 1 0 0,-1 0-7 16,1 0-4-16,-2 1 12 0,1-2-25 0,0 0 12 15,-1 2 7-15,1-1-2 0,1 1-19 0,-2-1 18 16,0 0 18-16,2 0-19 0,0 0-22 15,-1 0 41-15,-2 1-6 0,2 0-35 0,1-2 17 16,0 2-36-16,-1-1 48 0,0 1 7 16,0-1-26-16,1 0 17 0,1 0 6 0,-1 1-25 15,-3 0-9-15,0 0 23 0,5 0-13 16,-1 0 12-16,-4 0 3 0,8 0-1 0,-4 0-10 16,-4 0 1-16,6 0 21 0,-6 0-11 0,6 0 1 15,-6 0-4-15,7 0 4 0,-7 0-17 0,6 0 23 16,-6 0-21-16,6 0 20 0,-6 0-29 15,4 0 17-15,-4 0 17 0,0 0-9 0,11 10-3 16,-11-10-16-16,0 0 12 0,0 0 22 16,0 0-26-16,0 0 24 0,0 0-42 0,0 0 23 15,5 0-17-15,-5 0 31 0,11 8-13 0,-9-5 6 16,0-1-35-16,-2 1 19 0,2-1 8 16,-2 1 22-16,3-1-36 0,-2 3 30 0,1-2-24 15,0-1-4-15,0 2 14 0,1-2 1 0,0 0-3 16,-2 2-5-16,1-2-10 0,1 1 8 15,-1 0 24-15,2-1-33 0,-1 0 16 0,1 8 2 16,2-7-32-16,-2 0 27 0,-1-3-5 0,-2 0-1 16,3 1 20-16,-1 0 0 0,0-1-27 0,-1 0 19 15,0 2-1-15,1-1 9 0,0-1-19 16,0 0 1-16,-2 0 5 0,-1 0-28 16,0 0 43-16,0 0-10 0,0 0-46 0,6 0 68 15,-6 0-21-15,6 0-41 0,2-9 31 0,-7 7 16 16,1 1-7-16,2 0-7 0,-3-2-7 0,1 1 4 15,-1 0 13-15,1 1 3 0,1-1-21 16,-1 1 16-16,1-3 4 0,-1 1-2 0,-1 1-26 16,-1 2 31-16,4-5-4 0,-2 4-9 15,0-1-3-15,-2-1-31 0,3 2 59 0,-3-1-15 16,5-1-7-16,-4 3-3 0,0-3 30 0,-1 0-57 16,3 2 29-16,0-2 7 0,-3 3 2 15,2-1-35-15,2 0 34 0,-3-2 11 0,0 2 4 16,1 0-39-16,-1 1 26 0,0-2 11 0,0 1-29 15,0 1 21-15,0-2-48 0,1 2 17 0,-1 0 9 16,2 0 10-16,-3-3-13 0,1 3 26 16,0 0-8-16,1-1 9 0,-1 1-27 0,-1 0 26 15,0 0-11-15,0 0 0 0,0 0-17 16,0 0 45-16,0 0-31 0,0 0 11 0,0 0-1 0,0 0-18 16,0 0-10-16,0 0 29 0,0 0 4 15,0 0 1-15,5 0-17 0,-5 0 6 0,0 0-1 16,6 0-10-16,-6 0-3 0,10 7-19 15,-7-4 26-15,8 2 8 0,-3-1-21 0,-3-3 18 16,-1 4-4-16,6 0-14 0,2 0-27 0,-5-2 30 16,0-1 8-16,-2 1 2 0,3-2 26 15,-4 0-4-15,3 1-19 0,-3-1 7 0,-1 0 0 16,2 1-9-16,-2-2 17 0,0 0-50 0,-3 0 49 16,0 0 6-16,0 0-7 0,6 0-30 0,-6 0 33 15,7 0-23-15,-7 0 14 0,4 0-36 16,-4 0 32-16,0 0-10 0,0 0 14 15,6 0-3-15,-6 0 3 0,0 0 3 0,6 0-6 16,-6 0 0-16,0 0 1 0,6 0-1 0,1-8-22 16,-5 8 30-16,0 0-29 0,0-3 41 0,0 1-11 15,0 1-10-15,0 1 9 0,-2-2 0 16,3 0-51-16,0 0 50 0,-2 0-26 0,2 0 1 16,-1 1 11-16,1-3 15 0,0 1-15 15,0 0 5-15,-1 2-3 0,1-2 0 0,0 0 9 16,0 0 19-16,-1 1-14 0,3-3-12 0,-3 2-5 15,1 2-2-15,0-2 19 0,1 0-29 0,-1 1 27 16,0 0-8-16,0-2-10 0,0 3 11 16,2-1-10-16,-3 0 20 0,0 2-31 0,3-2 18 15,-3 0-12-15,1 0-6 0,0 1 13 16,0 0 3-16,0 0 17 0,-2-1-17 0,2 1 10 16,0 0-6-16,0-1-13 0,-1 2 24 0,0-2-25 15,1 2-6-15,0-2 15 0,-1 1 2 16,0 1 6-16,-1 0 2 0,2 0 9 0,0 0-25 15,-2 0-3-15,1 0 12 0,0 0 20 0,1 0-29 16,-1 0 7-16,-2 0-15 0,0 0 26 0,0 0-2 16,0 0-25-16,5 0 3 0,-5 0 35 15,6 0-24-15,-6 0-4 0,0 0-8 0,5 0 11 16,5 7 12-16,-8-7-25 0,2 2 34 0,-3-1-25 16,1 1-11-16,1-2 11 0,-1 1-15 15,0 2 36-15,1-2 5 0,-1 2-23 0,0-3 11 16,2 2-18-16,-1 0 2 0,-2 0 16 0,2 1-7 15,1-1-23-15,-1-1 3 0,-1 1 28 16,2 0-21-16,0 0-9 0,-4 0 18 0,3-1-3 16,1 1-28-16,-3-1 14 0,1-1 24 15,0 2-13-15,0 0 13 0,2-1-2 0,-1 0-16 16,0-1 19-16,0 3-4 0,-1-3 11 0,1 1-2 16,0-1-15-16,0 2 1 0,1 0 25 0,-1-2-11 15,1 1-10-15,-1 0 1 0,0-1 6 16,0 0-44-16,1 0 36 0,-1 0 8 0,1 3 15 15,-2-3-11-15,1 0-7 0,0 1 0 0,-1-1-17 16,1 0 16-16,1 1 16 0,-4 0-23 16,3-1-5-16,1 0 16 0,-4 3-4 0,0-3-22 15,0 0 29-15,0 0-7 0,7 0 15 16,-7 0-22-16,5 0 20 0,-5 0-18 0,8 0 3 16,-8 0-5-16,5 0-10 0,-5 0 22 0,8 0-9 15,-8 0-6-15,6 0-22 0,-6 0 37 0,5 0 5 16,-5 0-48-16,5 0 39 0,4-9 4 15,-7 9-31-15,-1-1 36 0,2 0-15 0,0-1 3 16,0 1-13-16,-1-1 18 0,1 0 9 0,0 1-31 16,-2 0 28-16,1 0 2 0,-1 1-38 15,2 0 51-15,-2-3-33 0,-1 2 18 0,2 1 4 16,-2-1-28-16,3 0 7 0,-2 0 8 0,2 0-11 16,-2 0 32-16,1 0-2 0,-1 1-9 0,2 0-24 15,-3-2 24-15,1 2-15 0,1-2 9 16,0 0-3-16,0 1-5 0,-1 1 25 0,1-2-7 15,2 1-12-15,-2-1-2 0,-1 1 5 16,2 0-14-16,-1-1 20 0,1 0-4 0,-1 2-4 16,2-2 5-16,-3 0 2 0,3 0-31 15,-2 1 20-15,-1 0-7 0,2 0-3 16,1 0 32-16,-2-2-18 0,1 2 7 0,-1 0-15 16,3-1-23-16,-1 0 30 0,-3 1-10 0,2-1 3 15,0 2-25-15,0-3 34 0,0 0 9 16,-1 3 0-16,2-2-22 0,-3 0 19 0,2 0-24 15,0 0 26-15,-1 0 4 0,1 0-13 0,-3 1-30 16,2 0 37-16,-1-1-12 0,3 0 6 16,-4 1 1-16,3 0-9 0,-1-1-1 0,0 1-14 15,2-1 17-15,-4-1-15 0,1 3 30 0,1-1-3 16,-1-2-9-16,1 3 1 0,0-1-9 16,0 1 7-16,-1 0-10 0,1 0-3 0,-2-1 23 15,3-1-3-15,-2 0-5 0,2 1 6 16,-2 1-5-16,0 0-3 0,1-1 26 0,-1 1-46 15,1 0 26-15,-1 0-9 0,0-1-1 0,1 0 11 16,2 1-14-16,-4 0 14 0,2 0-15 0,0 0-10 16,0 0 0-16,1 0 29 0,-2-2-15 15,-1 2-1-15,0 0 20 0,0 0-22 0,0 0 26 16,7 0-16-16,-7 0-9 0,4 0 2 16,-4 0 7-16,6 0 0 0,-6 0 1 0,10 9-4 15,-6-7-15-15,-1-2 16 0,-2 1 8 0,1-1-3 16,1 3 12-16,-1-2-17 0,0-1 0 15,-1 1-27-15,0 1 32 0,1-1-4 0,0 1-2 0,0 0-7 16,-1-1 11-16,2 0-12 0,-3-1 12 16,4 2 12-16,-2 0-16 0,0-1 2 0,0 0-22 15,1 0 17-15,-1 2-14 0,0-3 41 16,1 3-29-16,-2-1 10 0,3 1-13 0,-2-3 8 16,1 4 0-16,-3-2 17 0,3 0-24 15,1-2 21-15,-2 3-17 0,0-1-3 0,1 0 3 16,1 1 12-16,-2-2 1 0,1 1-11 15,-1-1-2-15,1 1-7 0,0 0 3 0,-1 0 7 16,1-2-6-16,0 1-12 0,0 0-1 0,0 1 22 16,-1 0-4-16,1-1-17 0,-1 1 8 15,2 0 27-15,0-2-15 0,-1 0 7 0,-1 1-20 16,1 1 1-16,0-1 15 0,-1 0 7 0,1 0-12 16,-1-1 9-16,1 1-2 0,0-1 6 0,0 1-2 15,-1 0-9-15,2-1-6 0,-2 1 3 16,1 0-5-16,-1 0 12 0,3 0-13 0,-2 0 12 15,0 2-5-15,1-2 0 0,-3 0 3 0,4-1 13 16,-2 1-32-16,1 1 10 0,0-2 15 16,-1 1-8-16,1 0-13 0,1-1 22 0,-1 1-15 15,-2-1 16-15,4 2-22 0,-2-2 18 16,-1 0-18-16,2 1 36 0,-1 0-6 0,-2-1-27 16,4 0 25-16,-4 0-20 0,3 0 7 0,-3 0 10 15,2 0-20-15,-1 0 3 0,0 0 12 16,0 0 3-16,-3 0-8 0,0 0 5 0,0 0-16 0,7 0 18 15,-7 0-19-15,4 0 14 0,-4 0-6 16,6 0-1-16,-6 0 8 0,4 0-2 16,-4 0-1-16,0 0-8 0,6 0 15 0,-6 0-15 15,5 0-9-15,-5 0 7 0,6 0 12 16,-6 0 0-16,0 0 5 0,4 0-16 0,-4 0 20 16,5 0-17-16,-5 0-3 0,5 0 0 0,-5-4 13 15,5 4 7-15,-5 0-8 0,0 0-17 0,6 0 6 16,-6 0 1-16,0 0-10 0,5 0 9 0,-5 0 11 15,5-5-6-15,-5 5-9 0,0 0-3 16,5 0 3-16,-5 0 0 0,0 0 13 0,7 0-11 16,-7 0-1-16,0 0 10 0,6 0 2 15,-6 0 8-15,9-9 13 0,-6 9-22 0,-3 0 3 16,0 0-5-16,0 0-23 0,0 0 27 16,5 0-9-16,-5 0 2 0,0 0-3 0,6 0 11 15,-6 0-6-15,4 0 3 0,-4 0-2 0,0 0-7 16,6 0 1-16,-6 0-6 0,0 0 20 0,7 0-13 15,-7 0 3-15,4 0-20 0,-4 0 14 16,0 0 14-16,5 0-9 0,-5 0-2 0,0 0 17 16,0 0-38-16,13 7 18 0,-10-7 4 15,-3 1 3-15,3-1 6 0,-3 1-12 0,2-1-9 16,0 2 25-16,-2-2-2 0,2 1-22 0,-2-1-1 16,2 1 29-16,-2-1-26 0,0 0 2 15,0 0 17-15,0 0-4 0,0 0-16 0,5 0 9 16,-5 0 6-16,0 0 1 0,6 0-13 0,-6 0 5 15,5 0-10-15,-5 0 12 0,0 0-9 0,0 0 8 16,5 0 8-16,-5 0-15 0,0 0 10 16,6 0 1-16,-6 0 0 0,0 0 6 15,0 0-1-15,5 0-10 0,-5 0 9 0,0 0-13 16,5 0 14-16,-5 0-5 0,0 0 0 0,0 0 4 16,6 0-9-16,-6 0 2 0,0 0-4 15,0 0 1-15,0 0 0 0,5 0 1 0,-5 0-14 16,0 0 26-16,0 0-10 0,5 0 6 0,-5 0-11 15,0 0 9-15,0 0-9 0,0 0-7 0,5 0 4 16,-5 0 20-16,0 0-4 0,0 0-21 16,6 0 22-16,-6 0-7 0,5 0-4 0,-5 0 18 15,5 0-14-15,-5 0 2 0,0 0-29 16,6 0 34-16,-6 0-22 0,5 0 13 0,-5 0-17 16,5 0 34-16,-5 0-18 0,0 0 11 0,7 0-20 15,-7 0-1-15,0 0 12 0,4 0-5 0,-4 0 8 16,6 0-5-16,-6 0 7 0,10-6-6 0,-8 5-19 15,0 1 19-15,1-3 5 0,-2 3 5 16,2-1-10-16,0 0 0 0,0 0-3 0,1-1 6 16,-3 2 11-16,2-1-2 0,-2 0-16 15,1-1 11-15,0 1-1 0,0 0-12 0,0 0 2 16,0 0 6-16,0 0-7 0,-1 1 11 0,2 0-15 16,-3-3 26-16,3 3-14 0,-3-1-11 15,0-1 14-15,1 1 9 0,1 1-34 0,-1-2 21 16,1 1-13-16,0 0 8 0,-2 1 0 0,2 0-20 15,-1 0 26-15,-1 0 18 0,1-2-30 16,0 1 9-16,0 1-14 0,-1 0 14 0,1-1 11 16,0-1 12-16,0 1-28 0,1 0 10 0,0 0-2 15,-2 1-10-15,0-1-4 0,3 1 13 16,-3-1 0-16,0 1 0 0,2-2 2 0,-2 1-7 16,3 0-9-16,-3-1-3 0,0 2 17 0,2-1-1 15,-1-1-3-15,-1 2-10 0,0 0 32 16,1 0-31-16,1-2 22 0,-2 1 0 0,2 1-9 15,-1-2-12-15,1-1 14 0,-2 3-4 0,1-2 6 16,0 0-6-16,2 1 10 0,-3 0-15 16,3-1 13-16,-2 2-23 0,2-2 32 0,-2 0-15 15,1 2-8-15,-1-1-10 0,0 0 23 0,0 1-25 16,0-1 24-16,-1 0 7 0,3 0-5 16,-2 0-8-16,1 1 8 0,-1-1-23 0,-1 1 9 15,3-1 17-15,-3-1-9 0,0 2-13 16,3-1 14-16,-1 0-2 0,-2 1-15 0,2-1 16 15,-1 1 0-15,-1-2-12 0,2 1 15 0,-1 1-2 16,-1 0-5-16,3-1 12 0,-2 0-21 0,0-1 16 16,0 2 1-16,0-1-19 0,0 1 3 15,1 0 8-15,-2 0 5 0,3-2 6 0,-2 2-5 16,1-3 3-16,0 3-20 0,-2-1 8 0,2 1 21 16,-1-1-18-16,2 1 0 0,-2-2-1 15,0 2 8-15,0-2-8 0,0 1 12 0,1 0 0 16,-1 1 2-16,0 0-21 0,1-2 12 0,-1 1-16 15,1 0 24-15,-1 1-14 0,-1 0 5 16,0 0 5-16,0 0-6 0,0 0 6 16,0 0 10-16,0 0-12 0,7 0-13 0,-7 0 4 15,0 0 0-15,0 0-15 0,4 0 27 0,3-6 0 16,-7 6-20-16,2-1 22 0,-1 1-15 16,0-2 2-16,0 2 8 0,1 0-12 0,-2-1 23 15,3 1-14-15,0-1 0 0,-3 1 13 0,0 0-6 16,0 0-11-16,0 0-9 0,0 0 8 0,0 0-7 15,0 0 10-15,0 0 1 0,0 0 10 16,5 0-17-16,-5 0-6 0,0 0 2 0,0 0 7 16,6 0 9-16,-6 0-7 0,0 0 6 15,0 0 10-15,4 0-31 0,-4 0 21 0,0 0-5 0,0 0-9 16,6 0-1-16,-6 0 24 0,0-6 5 16,10 0-9-16,-10 6-1 0,2 0-12 15,0 0-7-15,-2-2 2 0,2 2 12 0,-1-1-19 16,0 1 32-16,1 0-12 0,-1 0-20 0,0 0 15 15,1 0-5-15,-2-1 2 0,1 0 10 0,0 1 3 16,1 0-6-16,-2 0 6 0,1 0-3 0,-1 0-1 16,2 0-8-16,-1 0 8 0,-1 0-6 15,0 0-18-15,0 0 24 0,0 0-3 0,0 0-16 16,0 0 19-16,0 0-8 0,0 0 2 16,0 0 0-16,0 0-3 0,4 0 13 0,-4 0-12 15,0 0-8-15,0 0 30 0,0 0-25 0,0 0 12 16,6 0-9-16,-6 0-3 0,0 0 7 15,0 0 0-15,0 0 20 0,0 0-14 0,0 0-7 16,4 0 4-16,-4 0-1 0,0 0-4 0,0 0-5 16,0 0 10-16,0 0 0 0,0 0-14 0,0 0 8 15,0 0 10-15,0 0-5 0,0 0-18 16,7 0 27-16,-7 0-20 0,0 0-15 0,0 0 28 16,0 0-20-16,0 0 8 0,0 0-8 15,0 0 13-15,0 0-16 0,9 10 14 0,-8-9-11 16,0 1 11-16,0 0 18 0,0 0-13 0,-1-1-8 15,0 0-5-15,1 2 10 0,1-2 10 16,-2 0-8-16,0 1 6 0,0 0-8 0,3-1-9 16,-2 1-7-16,-1-1 11 0,0 0 12 15,2 0-7-15,-1 1 7 0,0 0-17 0,-1-1 12 16,0 0 7-16,0 2 7 0,0-2-6 0,2 0-31 16,-2 0 20-16,0 2 12 0,0-2-9 0,0 2-1 15,0-2 2-15,1 1-1 0,1 1 1 16,-2-2 5-16,1 1-6 0,0 1-14 0,-1-2 16 15,2 1-11-15,-2 0 7 0,1 0 13 0,-1 1-15 16,0 0-5-16,0-1 3 0,2 1 10 16,-2 0-12-16,1-2 14 0,-1 3-2 0,0-3-18 15,1 3 15-15,1-1-14 0,-1 0 21 16,0-1-10-16,0 0 14 0,0 0 1 0,0 1-9 16,-1 1-17-16,0-2 23 0,3 1-16 15,-3 0 2-15,0 0 7 0,2 0-17 0,0-1 17 16,-2 1 5-16,0-1-16 0,1 1 8 0,0-1 12 15,-1-1-14-15,1 2-11 0,-1-2 18 16,0-1 4-16,0 3-3 0,1-2 7 0,0-1-14 16,-1 2-2-16,1 1-6 0,-1-2-5 0,0-1 24 15,0 1-24-15,0-1 23 0,0 0-2 16,0 0-14-16,0 0 12 0,0 0 3 0,0 0-7 16,0 0 2-16,0 0-2 0,0 5 3 15,0-5 4-15,0 0 5 0,0 0-12 0,0 0 2 16,0 0-17-16,0 5 14 0,0-5-3 0,0 0-5 15,10 8 2-15,-9-6 1 0,-1-2-2 16,0 1 10-16,3-1 0 0,-3 1-2 0,2 1 1 16,0-2-8-16,-1 2-1 0,0-1 13 0,0 0-18 15,0 0 6-15,0 0 7 0,1 0-9 16,0 0 11-16,-2-1-19 0,0 0 18 0,1 1-8 16,1 0 10-16,-1-1-1 0,-1 3-14 0,2-3 1 15,0 0 11-15,-2 0 1 0,0 1-8 16,0-1 6-16,0 0 2 0,0 1-1 0,0 0 5 15,1 0-8-15,0-1 11 0,0 0-11 0,-1 3-7 16,0-3 25-16,0 0-24 0,0 0 3 16,1 0 6-16,1 0-3 0,-2 1 6 0,0 2 3 15,1-2-9-15,-1-1-4 0,0 0 17 16,2 0-21-16,-1 3 2 0,-1-1 8 0,0-1 0 16,0 1 0-16,3 0-3 0,-3-1-10 15,0 1 7-15,0-1 8 0,1 1-10 0,-1-1 11 16,1 0-21-16,0 1 17 0,-1-2 12 0,1 2-27 15,-1-1 10-15,1 1 1 0,0-1 7 0,-1-1-23 16,0 2 14-16,1-1 13 0,0 0-6 0,-1 2-3 16,0-2 2-16,0 0 8 0,2 2-8 15,-2-2-6-15,1 3 20 0,-1-2-15 0,1 0 8 16,0-1-1-16,-1 1-6 0,1 0 0 16,-1 0 4-16,0 0 0 0,1-1-1 0,0 0 3 15,1 1-13-15,-2-1 6 0,0-1-4 0,0 2 11 16,0-2-19-16,1 1 20 0,1 0 8 0,-2 0-8 15,0 0-8-15,0-1 1 0,0 2 2 16,3 0 0-16,-3-2 0 0,1 0-11 0,-1 0 14 16,0 0-10-16,2 1 7 0,-1-1-3 0,-1 1 13 15,1-1-11-15,2 2 5 0,-1-2-8 16,-2 0-5-16,0 0 1 0,0 0 7 0,0 0 7 16,0 0-21-16,4 0 5 0,-4 0 18 0,0 0-7 15,5 0-4-15,-5 0-20 0,10-9 37 16,-8 7-28-16,-1 1 24 0,0-1-6 15,1 1-2-15,-1 0-19 0,3 0 22 0,-3 0-8 16,0-1 3-16,0-1 6 0,2 3-4 0,-1-1 4 16,0-1-7-16,0-1 10 0,-1 2-13 0,1-1 7 15,-1 0-4-15,3 1-5 0,-3 0 10 16,2 0-8-16,-3-3 4 0,2 3-9 0,1 1 23 16,-1-5-20-16,0 4-4 0,-1-1 7 0,1-1 8 15,-1 1-19-15,-1 2-9 0,3-2 24 16,0 1-2-16,-2 0 19 0,1-1-40 15,0 1 25-15,-2-1-14 0,0 0 27 0,3-1 2 0,-2 2-23 16,2 1-20-16,-3-1 16 0,0-2 16 16,2 3-21-16,-1-1 11 0,-1 1 9 0,2 0 1 15,-2 0-8-15,2 0 9 0,-2 0 9 16,1 0-5-16,-1-1-13 0,1-1-6 0,-1 1 9 16,0 1-5-16,0-1 0 0,1 1 3 0,-1 0-4 15,0 0-3-15,0 0 10 0,0 0-3 16,2 0 4-16,0 0-17 0,-2 0-2 0,0 0 8 15,2 0 10-15,-2 0-5 0,1 0-10 0,-1-3 20 16,1 6-19-16,0-3 6 0,0 0-7 16,-1 0 19-16,1-3-4 0,0 3-2 0,0 0-10 15,0-1 14-15,1 1-25 0,-1 0 30 16,2-2 0-16,-2 2-2 0,0 0-22 0,1-1 14 16,-1 1 4-16,2-1-12 0,-3-1 18 0,2 2-17 15,-1-1-4-15,0 1 25 0,1-1-10 16,-1 1-9-16,0 0 9 0,0 0 8 0,0 0-31 15,2-1 2-15,-3 1 13 0,1-1 12 0,-1 1-11 16,0 0 14-16,0 0-6 0,0 0 9 16,0 0-25-16,0 0 22 0,0 0-13 0,6 0 11 15,-6 0-20-15,0 0 20 0,5 0 5 0,-5 0 4 16,0 0-14-16,0 0-1 0,0 0-4 16,5 0-4-16,-5 0-1 0,0 0 5 0,0 0 7 15,0 0-15-15,5 0 23 0,-5 0-22 16,0 0 12-16,0 0 12 0,0 0-25 0,5 0 1 15,-5 0-6-15,0 0 8 0,0 0 3 0,0 0 4 16,6 0 5-16,-6 0-3 0,0 0 0 0,0 0-4 16,0 0-21-16,0 0 38 0,4 0-11 15,2-4 5-15,-6 4-9 0,0 0 17 0,0 1-20 16,0-1-13-16,0 0-2 0,0 0 20 0,3 0 9 16,-3 0-12-16,0 1-5 0,1-1 9 15,2 0-9-15,-3 1 11 0,4-2-6 0,-4 2 10 16,2-1-10-16,-1 1 3 0,1-1 4 15,-1 0-6-15,2 0 13 0,-1 0-13 0,-1 0 10 16,0 0-4-16,-1 1-12 0,3-1 14 0,-3 0-12 16,3 0-5-16,-1 1 7 0,-2-1 12 15,2 0-23-15,-1 1 22 0,1-1-1 0,-1 0-32 16,-1 0 28-16,0 0-2 0,0 0-5 0,0 0 10 16,0 0-1-16,0 0-25 0,7 5 32 15,-6-5-15-15,0 1 15 0,0 0-18 0,-1 0 8 16,0-1-20-16,3 3 13 0,-2-3 2 0,0 0 2 15,-1 0-19-15,1 0 27 0,0 1-24 16,-1 0 6-16,1-1 1 0,-1 2 8 0,0-2-9 16,0 1 9-16,2-1-3 0,-1 0 8 0,-1 0-1 15,0 0-19-15,0 0 20 0,0 0 5 16,0 0-10-16,0 0-7 0,0 0 8 0,0 0-11 16,0 0 5-16,0 0-8 0,0 0 13 0,0 0-2 15,0 0 2-15,0 0 6 0,0 0 3 16,0 0-5-16,0 0 3 0,0 0-27 0,0 0 18 15,7 0-10-15,-1 6 19 0,-5-6-26 16,-1 0 25-16,0 2-1 0,0-2-4 0,1 0 4 16,-1 0 10-16,1 2-6 0,1-2-1 0,-2 0-14 15,1 1 15-15,-1-1-3 0,0 0-2 0,0 0 5 16,0 0-20-16,0 0 13 0,0 0 11 16,0 0-12-16,0 0-10 0,0 0 9 0,0 0-5 15,4 2 18-15,-3-1-18 0,0-1 7 16,-1 0-5-16,1 0-16 0,-1 0 17 0,2 0 7 15,-2 0 6-15,0 3-22 0,0-3 14 0,1 0-2 16,-1 0 1-16,1 1 8 0,-1-1-1 16,1 2-8-16,-1-2 5 0,1 0-6 0,0 0 5 15,-1 0-11-15,1 1-7 0,-1 0 13 16,1-1-18-16,-1 1 10 0,0-1-6 0,0 0 19 16,0 2 5-16,0-2-12 0,2 1 12 0,-2-2-25 15,0 2 11-15,0 0 4 0,1-2 4 0,-1 2-1 16,0 0 1-16,2 0-6 0,-2-1 8 15,0 1 9-15,2 2-4 0,-2-3-23 0,0 1 18 16,1-1-10-16,0 1-3 0,-1 1 0 16,1-2 20-16,-1 1-10 0,0 0 4 0,0-1-11 15,0 0 17-15,1 1-34 0,1 0 28 0,-2-1-24 16,0 2 2-16,1-1 16 0,-1 0-22 16,1-1 4-16,0 1 18 0,-1 1 5 0,1 0-8 15,-1-1-6-15,0-1 5 0,1 0 13 0,-2 1-2 16,3-1-20-16,-1 0 11 0,0 2 2 15,-1-1-2-15,0 0-8 0,0 0 7 0,2-1-4 16,-2 1 18-16,0-1 2 0,0 0 0 0,0 0 3 16,0 0-13-16,1 1-2 0,-1-1 6 15,0 1-12-15,2-1 11 0,-2 1-7 0,0-1 1 16,0 0 11-16,0 0 9 0,1 2-24 16,-1-1 4-16,0-1-11 0,0 1 7 0,2-1 6 15,-1 1-2-15,0-1-4 0,-1 1 11 0,0-1-10 16,0 0 0-16,3 0 11 0,-3 0-14 0,0 2 15 15,0-2 11-15,2 0-24 0,-1 2 12 16,0-2-17-16,1 1 25 0,-1 0-5 0,0 2-24 16,1-3 0-16,-1 1 11 0,1 0 3 15,-2 0 15-15,2 1-19 0,-1-1 10 0,1 0-22 16,0 0 3-16,-1 1 8 0,1-1-2 16,-1-1 6-16,-1 2 0 0,1-2 0 0,1 1-8 15,-2-1 13-15,1 3-16 0,-1-3-1 16,2 1 27-16,-1 1-17 0,-1-2-8 0,1 0-8 15,-1 2 24-15,0-2 4 0,2 0-4 0,-1 1-4 16,-1 0 7-16,0-1-13 0,2 1 10 0,-1-1-21 16,-1 2 13-16,1-2 0 0,1 2 3 15,-1-1-1-15,-1-1-6 0,0 0 1 0,2 3 10 16,-2-3-3-16,1 0-1 0,-1 0-4 0,0 0-3 16,0 0-2-16,0 0 6 0,1 0 2 15,1 1 4-15,-1 0-5 0,-1-1-6 0,0 0 7 16,2 0-2-16,-2 2-12 0,0-2 12 15,1 2-1-15,0-2 13 0,-1 0-21 0,1 0-5 16,0 1 11-16,0-1 0 0,-1 0 20 16,2 0-20-16,-2 0 3 0,0 0-17 0,0 0 20 15,0 0 7-15,0 0-18 0,0 0-5 0,0 0 17 16,0 0 5-16,0 0-7 0,0 0 2 16,5 0 2-16,1 6 16 0,-6-6 3 0,4 1-26 15,-2 1 0-15,-1 0-7 0,-1-2 10 16,0 0 9-16,0 0-8 0,0 0 0 0,0 0 13 15,0 0-27-15,0 0 20 0,0 0-15 0,0 0 5 16,4 0 3-16,-4 0 0 0,0 0 22 0,0 0-24 16,0 0 17-16,0 0-19 0,0 0 14 15,0 0-4-15,6 0-17 0,-6 0 7 0,0 0 11 16,0 0 6-16,0 0-2 0,0 0-19 16,0 0 2-16,0 0-2 0,0 0 18 0,0 0-16 15,0 0 17-15,4 0-7 0,-4 0 12 0,0 0-22 16,0 0-8-16,0 0 38 0,0 0-26 0,0 0-5 15,0 0-1-15,0 0 19 0,0 0-30 16,8 7 17-16,-8-8-3 0,0 1 30 0,0 0-16 16,0 1-17-16,0-1 12 0,0 0-11 0,0 0-8 15,0 0 22-15,0 0-11 0,1 0 9 16,-1 0 13-16,-1 0-26 0,3 0 12 0,-2 0 9 16,-1 0-22-16,2 0 11 0,-1 0-5 15,1 0 24-15,-1 0-10 0,0 0-11 0,0 0 21 16,0 0-30-16,-1 0-3 0,2 0 3 15,-2-1 1-15,1-1-8 0,1 2 29 0,-1 3-16 16,0-3-5-16,0-1 2 0,0 1 12 0,0 0 13 16,0 0-19-16,0 0-2 0,0 0 28 15,0-2-8-15,0 1-7 0,0 1-6 0,0 0 25 16,0 0-39-16,0 0 6 0,0 0 21 16,0 1-18-16,0-1 2 0,0-1 35 0,-1-1-46 15,2 2 49-15,-2 0-47 0,2 0-5 0,-1 0 27 16,0 2-17-16,-1-2 0 0,2 0-3 15,-1 0-11-15,-1-2 9 0,1 4 8 0,0-1-5 16,0-1 28-16,0-3-22 0,-1 6-4 16,2-3 4-16,-2 0-12 0,2 0 26 0,-1 0-18 15,1 0 30-15,-2-1-13 0,1 1 16 0,0-2-40 16,0 4 16-16,0-4 12 0,-1 2-16 16,2 0-3-16,-1 0-18 0,0 0 15 0,0 0-9 15,0 0-4-15,0 0 25 0,1 0-25 16,-1 0 4-16,0 0-8 0,0 0 22 0,-1 2 32 15,2-2-22-15,-1 1-29 0,0 1 38 0,0-2-9 16,0-2-28-16,0 2 0 0,2-3 13 0,-2 3 15 16,0 0-25-16,0 0 3 0,-2 0 22 15,2 0-33-15,2 0 26 0,-2 0-14 0,0 0 13 16,0 0 31-16,0 0-48 0,0 0 0 16,0 0 32-16,0 0-24 0,0 0-11 0,0 0 18 15,0 0 20-15,0 0-36 0,0 0 15 0,0 0 18 16,1 0-30-16,0 0-16 0,-1 0 35 0,0 0-20 15,0 0-11-15,0 2 29 0,0-2 13 16,0 1-33-16,0-1 20 0,0 0-6 0,0 2-18 16,0-2 26-16,0 0 15 0,0 0-45 15,0-3-2-15,0 4 9 0,0-1 20 0,0-1-10 16,0-1 25-16,0 2-31 0,0 0 1 0,0 0 3 16,0 0-9-16,0 0 47 0,0 0-41 0,0 0 21 15,0 0-3-15,0 0 0 0,0 0-3 16,0 0 9-16,0 0-13 0,0 0-16 0,0 0 0 15,0 0-5-15,0 0 21 0,0 0-30 16,0 0 19-16,0 0-11 0,0 0 4 0,0 0 14 16,0 0 48-16,0 0-29 0,0 0 7 0,0 0 1 15,0 0-11-15,0 0 20 0,0 0-23 16,0 0 15-16,0 0 0 0,0 0 15 0,0 0-2 16,0 0-11-16,0 0-3 0,0 0 4 15,0 0 9-15,0 0-4 0,0 0 7 0,0 0-1 16,0 0 10-16,0 0 15 0,0 0 2 15,0 0-20-15,0 0 33 0,0 0-18 0,0 0-22 16,0 0 1-16,0 0 25 0,0 0-19 16,0 0-39-16,0 0 23 0,0 0-19 0,0 0 27 15,0 0-1-15,0 0-18 0,0 0-15 16,0 0 23-16,0 0-6 0,0 0-19 0,0 0-21 16,0 0-10-16,0 0 4 0,0 0-64 0,0 0-37 15,0 0-49-15,0 0-15 0,0 0-75 0,3-18 23 16,-3 4-202-16,0 7 34 0,0-6 19 15,0-2 3-15,0-1 54 0,9-13 13 0,-4 13 0 16,2 4 30-16,0 2 15 0,3-1 26 16</inkml:trace>
  <inkml:trace contextRef="#ctx0" brushRef="#br1" timeOffset="1">24 137 383 0,'0'0'108'0,"0"0"-14"0,0 0-56 16,0 0-7-16,0-9-1 0,0 9 33 0,0 0-6 16,0 0 33-16,0 0-25 0,0 0 18 0,0 0-10 15,0 0-8-15,0 0-4 0,0 0 6 16,0 0-44-16,0 0 1 0,0 0-1 0,0 0-4 15,0 0-2-15,0 0 23 0,0 0-30 0,0 0 25 16,0 0-20-16,0 0 29 0,0 0-20 16,0 0-19-16,0 0-2 0,0 0 2 0,0 0 5 15,0 0 5-15,0 0-2 0,0 0-49 16,0 0 1-16,0 0 55 0,0 0 6 0,0 0-34 16,0 0 33-16,0 0-13 0,0 0-3 0,8 2 0 15,-4-1-17-15,-2 2 11 0,-2-1 7 0,3 1 0 16,0 0-3-16,-2 0 5 0,2 0-2 15,1-1-2-15,-2 1-6 0,1 0 30 16,1 1-37-16,-2-1 35 0,7 4-26 0,-5-2-16 16,2 1 28-16,-2-4-1 0,-1 3-3 0,5 1-44 15,-3 0 38-15,-1 0 8 0,-1-1 8 0,-2-3-53 16,2 2 1-16,-1-1 26 0,1-1 28 16,-1 2-39-16,-1 0 6 0,3-3 9 0,-2 1-20 15,0 1 1-15,0 0 2 0,-2 0 9 16,4 0 11-16,-3-1 33 0,2 0-31 0,-2 0-8 15,1 0 10-15,0 2-1 0,-1-3 1 0,0 1-7 16,2 3-26-16,-2-4 27 0,1 3 32 16,0-3-54-16,0 2 34 0,0-1-2 0,0 2-1 15,0-2 2-15,-1 0-3 0,1 1-1 0,-2 1 0 16,2-2-19-16,-2 1-22 0,2-1 14 16,-1 2-8-16,0-3 37 0,0 3 12 0,0-2-22 15,0 1-6-15,0-1-3 0,0 2 15 16,2-1-2-16,-2 1 1 0,0-2 25 0,1 2-29 15,0-1-6-15,0 2 20 0,-1-2 13 16,1 2-23-16,0-2-12 0,0 0 2 0,0 1 1 0,-1 1-1 16,2-1-35-16,3 2 2 0,-2 3 4 15,0-5 38-15,-2-1 13 0,0 0-34 0,1-1 30 16,-3 0 2-16,1 0 12 0,-1 0-13 16,2 0-5-16,-2 0 10 0,1-1-25 0,1 0-7 15,-1 1-8-15,2 1 40 0,-2-2 1 16,2 2 11-16,-2-1-35 0,1 2 32 0,1-1-5 15,-1 0-3-15,0 0-13 0,-1-1-32 0,1 0 50 16,-1 2-11-16,2-4-35 0,0 2 55 16,-2 2-15-16,-1-3-39 0,3 1-6 0,-1 0 18 15,1 0 29-15,-1 0 1 0,-1 0-8 0,-1-1 17 16,3 1-20-16,-3 0-38 0,4-1 32 16,-3 0-25-16,1 2 34 0,-2-2-39 0,3 1 64 15,-3 1-35-15,2-2 3 0,0 2 18 0,-1-2-16 16,0 0-16-16,0 3 24 0,0-2 2 0,2 0-14 15,-1 1-32-15,0 0 23 0,0-1 1 16,-1 0 1-16,1 1 7 0,-1-2-38 0,2 3 41 16,-2-2 5-16,1-1-10 0,-1 3-4 0,-1-2-6 15,1-1 20-15,1 1-13 0,-1 1-2 16,-1 0 25-16,1-1-16 0,0 2 1 0,0-1 11 16,0-1-1-16,0 1-19 0,-1 0-42 0,1-1 13 15,0 2 11-15,-1-1 51 0,1 0-14 0,0-1 10 16,0 2-62-16,-1-1 31 0,0 1-9 15,2-1 28-15,-2-3-6 0,0 0 13 0,0 0-21 16,0 6 20-16,0-6 2 0,0 5 1 0,0-5-13 16,0 6 9-16,0-6-44 0,8 10 47 15,-7-8 14-15,-1 0-15 0,2 0-2 0,-1 0-12 16,-1 1 6-16,2-1-9 0,-1 0 14 0,-1 0-32 16,2-1 26-16,0-1-22 0,-1 2 26 15,2-1-4-15,0 1-23 0,0-2 30 0,-1 0-7 16,1 3 3-16,1-2 5 0,-1-1-6 0,0 2-9 15,0-2 19-15,1 3-28 0,2-2-23 0,-2 0 33 16,-1 0-14-16,-3-1 9 0,0 0 9 16,7 0 8-16,-3 0-10 0,-4 0-6 0,7 0 5 15,-2 0-34-15,-5 0 33 0,6 0-18 16,0 0 21-16,-6 0-23 0,11 7 28 0,-11-7-5 16,0 0-8-16,0 0-10 0,6 0 4 0,-6 0 10 15,5 0-20-15,-5 0-10 0,6 0 37 0,-6 0-7 16,8 0-3-16,-4 0 19 0,-4 0-32 15,6 0 5-15,-6 0 21 0,5 0-22 0,-5 0-24 16,6 0 38-16,-6 0-8 0,5 0-8 16,-5 0 19-16,5 0-25 0,-5 0 18 0,0 0 12 15,6 0 1-15,-6 0-6 0,0 6-37 0,6-6 22 16,-6 0 11-16,5 0-25 0,-5 0 18 16,0 3-1-16,5-3-7 0,3 8-10 15,-7-7 12-15,1-1 16 0,-1 1-6 0,1 0-3 16,0-1 0-16,0 2-4 0,-1-1-6 0,1 1 23 15,-1-1-37-15,3 1 30 0,-2 1-28 16,-1 1 3-16,2-2 43 0,-2-1-17 0,2 2-31 16,1 0 35-16,-4 0 4 0,3 1-19 0,0-1 3 15,-2 0-19-15,2-1 19 0,0 1-3 16,0-1-21-16,-1 0 44 0,1 2-4 0,0-4-8 16,-1 3 13-16,-1 0-17 0,1-1-8 0,0-2 25 15,-1 3-22-15,1-2-3 0,1 0-27 16,-2 1 50-16,1-2-19 0,0 3-29 0,0-3 32 15,-1 1 1-15,2 0-31 0,-3 0 46 0,2 0-35 16,2 2 3-16,-3-3-14 0,2 2 38 16,-1-1-12-16,-1 1-4 0,3 0 23 0,-2-1-13 15,0 2-28-15,2-2 42 0,-2 0-16 0,0 1-14 16,0-1-3-16,-2 0 13 0,3 1 0 16,-1-2-14-16,0 1 13 0,1 1-19 0,-2-1 43 15,1 1-47-15,-1-1 5 0,2-1 14 0,-1 2 22 16,1 1-3-16,-1-3-5 0,1 3-12 15,-1 1 6-15,1-3 20 0,7 6-11 0,-7-4-29 16,3 1 18-16,-4 1-11 0,1-3 21 0,1 1-10 16,-1-1-29-16,0 2 27 0,0-3 14 15,1 1-20-15,-2 2 0 0,0-4 13 0,-1 2 22 16,1 0-14-16,2 0-13 0,-2-1 2 16,-1 2-19-16,2-2 33 0,-2 0-20 0,1 2 19 15,-1-2-24-15,1 1 10 0,-1 0 3 0,1 0-12 16,0-1-1-16,-2 3 20 0,3-4-27 15,0 1 26-15,-2 2-1 0,1-2-4 0,0 0-14 16,0 1 2-16,-1 1 14 0,-1-3-16 16,3 2 6-16,-3 2 10 0,2-4 8 0,0 1 6 15,-2 1-33-15,0 0 11 0,3-1-5 0,-3 2 18 16,3-1-43-16,-3 1 29 0,2-3-17 16,1 3 22-16,-1 1-24 0,1-3 29 0,-3 2-25 15,3-1 20-15,1 4 6 0,-3-6 1 0,-1 5-15 16,3-4 0-16,2 3 12 0,-3-3-4 15,1 2-31-15,-2 0 12 0,0-1 34 16,1 0-39-16,1 1 36 0,-2-1 2 0,1 0-22 16,-1 1 13-16,2-1-11 0,0 3-1 0,-1-4 22 15,1 3-14-15,-1-2-30 0,7 4 26 0,-4-1 12 16,-1-1-30-16,-1 0 24 0,0 1 10 16,1-3-43-16,0 1 12 0,-3-2 5 0,2 1 2 15,0-1 15-15,0 3-29 0,-1-3 36 16,0 1 0-16,0 1 4 0,0-1-12 0,1-2 1 15,0 1-19-15,0 2 17 0,0-3-7 0,0 1 11 16,-1-1-17-16,1 0 23 0,1 0-11 16,-1 0 1-16,-3 0-17 0,0 0 24 0,0 0-11 15,7 0 2-15,-7 0 13 0,7 0-13 0,-7 0-2 16,5 0-8-16,0 0-14 0,-5 0 23 16,6 0-6-16,-1 0 4 0,-5 0-3 0,6 0 2 15,0 0-7-15,-6 0 23 0,5 0-47 0,2 0 45 16,1-7-24-16,-6 6 24 0,2 0-8 15,0 0-32-15,0 0 46 0,-2 0-28 0,2 0 20 16,-2 0-11-16,0-2-14 0,0 3-5 16,3-2 26-16,-3 1 4 0,0-1-18 0,1 0 15 15,0 1-19-15,1-1-10 0,-2-1 21 0,1 1-3 16,0 1 3-16,-1-2 13 0,1 1-15 0,1 1-2 16,-1-3-15-16,1 3 23 0,-2 0-33 15,2-1 30-15,-1 1 20 0,-1-1-5 0,1 0-14 16,0-1-13-16,-1 2 17 0,1 0 3 15,0-3-11-15,-1 3 19 0,1-1-21 0,0 1 14 16,-2-1-43-16,3 0 31 0,-2 0-11 0,0 0 25 16,0-1-22-16,1 2 22 0,-1-1-16 15,0 1-6-15,-1-3 11 0,1 4 4 0,3-2-18 0,-5-1 16 16,3 2 6-16,1-3-4 0,0 3-2 16,-2-3-14-16,9 1 28 0,-3 0-11 15,1-4-8-15,1 5-3 0,-6-3 6 0,1 2-1 16,0 1-17-16,-1 1 10 0,0-1-9 0,-1 1 32 15,2-1-9-15,-3 0 10 0,1 0-44 0,1 2 52 16,-1-4-34-16,-2 3 6 0,2 0 2 16,0-2 11-16,-2 1-4 0,2 2 0 0,-1-5-27 15,-1 5 33-15,1-2 1 0,0-2-19 0,-1 3 14 16,1-3 2-16,-1 1-15 0,1 2 17 16,-2-2 2-16,3 1-9 0,-3 0-22 0,1 0 12 15,0 0 1-15,-1 0-6 0,2 1 2 16,-1-3 21-16,-1 3-14 0,2-2 5 0,-1 1 17 15,-1-1-13-15,0 0-25 0,0 0 43 16,2 0-18-16,-1 0 6 0,0 1-2 16,1-1-7-16,-1 1 5 0,1-2-7 0,-2 2 3 0,2 0-22 15,0-1 34-15,1 2-7 0,-2-2-9 16,2 1-27-16,4-6 33 0,-3 3-17 16,0 4-10-16,-2-2 20 0,1 3-17 0,-1-2 25 15,1 1-5-15,-1-3-8 0,-1 2 12 0,1 1-23 16,2-2 25-16,-4 2-9 0,1 0 13 15,1-1-6-15,-1-1-7 0,0 2 6 0,1 0-4 16,-1-2-8-16,1 0 6 0,-2 1 5 16,2-2-11-16,-2 2 1 0,0-1 8 0,3 2 0 15,-3 0-27-15,2-2 39 0,-2 0-22 0,2 1 7 16,-1-1-6-16,-1-1 25 0,2 2-35 16,-2-1 23-16,1 1-31 0,-1-2 7 0,1 0 12 15,-1 2-10-15,3-2 19 0,-3 2 13 0,2-2-20 16,-2 2 7-16,1-2-22 0,0 1 25 15,-1-1-28-15,0 0 31 0,0 1-4 0,0 1-19 16,2-2 30-16,-1 0-20 0,-1 2-20 16,1 0 29-16,0-2-22 0,-1 3 13 0,0-3-10 15,0 2 9-15,0-2 15 0,0 2-7 0,0-2 3 16,0 2 10-16,0-1-14 0,4 0-7 0,-3 0 10 16,-1 1 13-16,1-2-16 0,-1-1-16 15,2 4 11-15,-2-4-7 0,0 2 10 0,0 3 1 16,0 0 6-16,0-5 1 0,0 5-26 0,0-7 13 15,0 7-1-15,0-6-4 0,0 6 11 0,0-7-1 16,0 2-9-16,0 5 3 0,0-5 4 16,0 5-10-16,0-6-4 0,7-3 1 0,-6 7 17 15,1-1 15-15,-1 0-27 0,0 1 13 16,1-2-28-16,-1 3 29 0,2-1-5 0,-2-2-5 16,0 3-4-16,0-1 7 0,0 0 3 0,1-1 1 15,-1 1 3-15,3 1-8 0,-4 0 1 16,2 1-15-16,0-4 27 0,-1 4-18 0,1 0 10 15,0-2-10-15,1 2 5 0,-1 0-1 0,0-2 7 16,1 1-5-16,-1 1-5 0,1 0-8 16,-1 0 12-16,0 0 17 0,1 0-18 0,-2 0-17 15,2-1 22-15,-3 1 13 0,0 0-18 0,0 0-7 16,0 0 10-16,0 0-1 0,5 0-9 16,-5 0 8-16,0 0-1 0,5 0 7 0,-5 0-14 15,11-7 20-15,-8 5 5 0,0 0-19 0,-1 1 5 16,3 0-19-16,-4-2 25 0,2 2-9 0,0 0 9 15,-2-2-20-15,2 2 14 0,0-1 6 0,-2 1 5 16,1 0-23-16,2 0 13 0,-3-2 6 16,2 1 14-16,-1 1-21 0,0-1 2 15,1-1-8-15,-1 2 13 0,1 0-7 0,-2-1-15 16,2 1 15-16,-2 0 3 0,2-2-18 0,-1 1 34 16,0 1 0-16,1 0-23 0,-2-2 17 0,1 1-31 15,1-1 20-15,-1 3 7 0,0-3 0 16,0 2-10-16,-1-1 15 0,1 0-15 0,-1 1 2 15,1-1 1-15,0-1-1 0,-1 3-15 0,0-2 19 16,1 0-17-16,0 1-2 0,0 1 24 16,-2-1-8-16,1-1-8 0,1 2 18 0,-1-2-18 15,0 1-9-15,0 0-6 0,2-1 24 0,-1 0-4 16,-1 2-7-16,0-2-5 0,0 1 18 16,0 1-11-16,0-2-8 0,1 1 29 0,-2 0-27 15,3-1 16-15,-3 2-20 0,0-1 26 0,1 0-7 16,1-1 3-16,-2 1-22 0,1 0 6 0,0 0 8 15,0-1 9-15,-1 1 2 0,4 0-7 16,-4 1 1-16,0-2 6 0,1 2-18 0,0-1-9 16,0 0 11-16,-1 0 10 0,1 0 9 15,0-1-8-15,0 2 4 0,-1 0-30 0,0 0 15 16,2 0 12-16,-2-1-5 0,1 1 4 0,-1 0-19 16,0-1 6-16,0 1-5 0,0 0 16 15,0 0 5-15,0 0-15 0,0 0 16 0,0 0-6 16,0 0-8-16,0 0 8 0,0 0 5 0,0 0-10 15,0 0 0-15,0 0-7 0,5 0 16 16,-5 0-6-16,0 0-2 0,11 6-6 0,-10-4 18 16,1 0-13-16,1 1-17 0,-2-1 18 0,2 1 17 15,-2-1-16-15,1-1 1 0,1 3-15 0,-1-1 2 16,1 0 6-16,-1 0-4 0,-1 0 19 16,2 0-20-16,0-1 10 0,-2 2-4 0,2 0-1 15,-2-1 20-15,1 0-13 0,2 1-12 0,-3-1 18 16,1 2-7-16,1-2-1 0,-2 1-22 15,2-1 22-15,-2-1-5 0,1 2 19 16,-1-1-5-16,0 2-6 0,1-2-6 0,0 0-6 16,-1 1 28-16,0 1-29 0,0-2-2 0,2 8-3 15,1-4 13-15,-3-2 7 0,0 1-8 16,-1-4 16-16,1 3-10 0,0-1-4 0,0-1 0 16,0 1 16-16,-1-1-15 0,2 0 10 0,-2-2-12 15,1 4-11-15,0-3 13 0,0 2 10 16,0-1-6-16,-1-1-17 0,2 2-1 0,-2-1 12 15,1 0-15-15,-1-1 11 0,0 2 0 0,2-2-8 16,-2 1 27-16,2 0-1 0,0 0 2 0,-1-1-3 16,0 3-22-16,0-4 0 0,-1 4 13 15,2-4-5-15,-2 2 3 0,1-1 12 0,0 1 3 16,0-1-11-16,-1 1-13 0,1 1-12 16,0-1 30-16,0-1-12 0,0 2-10 0,-1-1 5 15,0 0 6-15,0 0 6 0,2 0 0 16,-2 2-17-16,0-3 17 0,1 2-26 0,-1-1 15 15,0 1 14-15,1 0-16 0,1 1 10 0,-1-1 16 16,-1 0-22-16,2 1 9 0,2 5-16 16,-1-1 25-16,-2-3-11 0,3 1 0 0,-3-2-6 15,1 0-14-15,0-1 14 0,-1-2 6 0,-1 2 5 16,2-2-23-16,1 3 28 0,-2-3-20 0,-1-2 7 16,0 0 4-16,0 0 9 0,0 5 3 15,0-5-15-15,0 6-1 0,0-6-11 0,0 4 15 16,0-4-18-16,0 5 13 0,0-5-10 15,0 0 12-15,0 5-20 0,0-5 23 0,0 6 14 16,0-6-32-16,0 6 27 0,0-6-9 0,0 4 0 16,0-4 2-16,0 5-10 0,0-5-1 15,0 6-5-15,0-6 20 0,0 6 0 0,0-6-32 16,0 5 28-16,0-5-25 0,0 6 11 16,0-6 34-16,0 7-19 0,0-7-1 0,0 6-1 15,0-1-15-15,0-5 6 0,5 5 10 0,-5 0 2 16,0-5-6-16,0 5 0 0,10 5-16 15,-5-6 18-15,-4 0-3 0,0-3 0 0,1 3 1 16,-2-2-4-16,1 0-1 0,-1 1 11 0,1 0-25 16,0 0 23-16,0-1 1 0,1-1 12 15,-1 1-12-15,0 1-10 0,-1-1-12 0,0 1 11 16,2-2 9-16,-2-1 2 0,1 3 1 16,1 0-14-16,-2-2-5 0,0 1 9 0,0 0-13 15,0 0 21-15,1-1-1 0,2 4 4 16,-3-5-6-16,1 2 0 0,1 2 1 0,-1-3 11 15,-1 2-14-15,1-2 0 0,1 3-5 0,-1-1 14 16,1-2 6-16,0 3-14 0,-2-1 3 16,2-1-15-16,1 1 11 0,-3-1-2 0,1 1-5 15,2-1 11-15,-3 0-1 0,3 2-12 0,-2-3 13 16,2 2 6-16,-3-1-7 0,0 1-20 16,1 0 17-16,0-2-1 0,1 4 7 0,0-4-2 15,-2 2-20-15,2 1 15 0,-2-3 0 0,2 3 19 16,-2-3-15-16,0 1 4 0,0 3-2 15,1-2-7-15,-1 1 9 0,0-1-14 0,0-3 19 16,0 0 2-16,0 0-13 0,0 5 5 0,0-5-2 16,0 6 8-16,0-1-20 0,0-5-4 0,0 5 12 15,0 1-10-15,0-6 7 0,0 7 15 16,0-2-5-16,0-5-22 0,0 7 13 0,0-2 13 16,0-5-18-16,0 6-1 0,0-3 14 15,0-3-8-15,0 7 18 0,0-7-10 0,0 6-6 0,0-1-13 16,0-5-9-16,0 7 15 0,0-7 11 15,0 6-14-15,0-6 24 0,0 5-5 0,0-5-12 16,0 4-2-16,0-4 5 0,0 6-19 16,0-6 22-16,0 5 17 0,0-5-15 0,0 6 1 15,0-6 12-15,0 5-5 0,0-5-13 0,0 4-26 16,0-4 46-16,0 5-8 0,0-5-14 16,0 5-2-16,0-5-28 0,0 5 40 0,6-5-8 15,1 9-14-15,-7-7 17 0,2 1 14 0,-2-2-5 16,1 1 2-16,-1 0-13 0,2 0 0 15,-2 0-22-15,2 0 16 0,-2 0 2 0,1-1 9 16,1 1-27-16,-2 0 17 0,3 0 9 0,-2-1-9 16,1 1 23-16,-1 0-14 0,0-1-24 15,1 0 32-15,0 3-12 0,-1-3 2 0,0 2 1 16,1-2-4-16,-1 0-1 0,1 0-5 16,-1 1 16-16,0 1-6 0,-1-3-10 0,3 1 23 15,-2 0-22-15,1 1 6 0,-1 0-2 0,-1-1-7 16,1 0 3-16,1 2 12 0,-1-1-26 15,-1-1 18-15,3-1-2 0,-2 2 20 0,0-1-9 16,0 1 0-16,1-1-15 0,-1 0 2 0,-1 4 6 16,2-5-2-16,-2 1 3 0,1 2-6 15,0-2-1-15,0 0 8 0,1 1 2 0,0 1 3 16,-2-2-3-16,1 0-19 0,0 0 20 16,0 1-30-16,-1 0 42 0,0-1-16 0,3 2 7 15,-3-2-6-15,1 2 4 0,1 0-14 0,-2-2 4 16,0 2-7-16,2-2-6 0,-2 1 26 0,1 1 9 15,0 0-27-15,0 0 26 0,1-2-32 16,-2 2 21-16,0-1-27 0,1-2 34 0,-1 3-24 16,0-1 26-16,0-1-37 0,0 2 20 0,1-1 14 15,-1 0-12-15,0 1-1 0,1-2-2 16,-1 2 0-16,0-3 5 0,0 0 11 0,0 0-13 16,0 5 6-16,0-5-19 0,0 5 11 0,0-5-16 15,0 6 28-15,0-6-5 0,0 6-12 16,0-6 17-16,0 5-12 0,0-5 1 15,0 6-2-15,0-6 7 0,0 7-15 0,0-7 17 16,0 6-17-16,11 2 14 0,-11-5-16 0,0 0 9 16,1 0-9-16,1-1 17 0,-2 1-4 0,1 0-9 15,0 0 9-15,1 0 2 0,-2 0-8 0,1-2 0 16,-1 2-2-16,2-2 9 0,-2 0 3 16,1 1 5-16,1 1-15 0,0 0 9 0,1 0 3 15,-3-1-27-15,1 1 25 0,1-2 1 16,-1 3-20-16,1-3 11 0,-1 1 21 0,0 2-24 15,2-1 26-15,-1 0-39 0,-1 0 6 0,1-2 29 16,-2 1-12-16,3 2 18 0,0-2-17 16,-1-1-1-16,-1 2-4 0,1 2 14 0,-1-4-10 15,2 3-30-15,0-3 28 0,-2 3 0 0,1-3-7 16,-1 2-2-16,1 0 6 0,-2 0-3 16,4 0 17-16,-2-3-20 0,-1 5 10 0,0-2-13 15,0-1 13-15,1-1 15 0,0 1-18 0,0 1-2 16,-2 1-16-16,1-3 20 0,1 1 4 15,-2 2-11-15,1-2-1 0,1 2 18 0,-2-2-8 16,0 0-13-16,2 1 4 0,-2 0 22 0,1 0-16 16,0 0-18-16,-1 0 28 0,1 0 4 15,-1 1-20-15,0-2-1 0,0 3 6 0,2-3-13 16,-2-2 17-16,0 0 2 0,0 5-10 16,0 0 12-16,0-5 6 0,0 5 2 0,0 0-12 15,0-5-2-15,0 7-6 0,0-2-2 0,0-5 10 16,0 5 1-16,0 1 0 0,0-6-13 0,0 7 21 15,0-2-38-15,0 1 10 0,0-2 15 16,0 2 5-16,0-6 9 0,0 5-14 0,0 0-11 16,0 1 12-16,0-2 6 0,0-1-5 15,0-3-9-15,0 8 13 0,0-2-2 0,7 3 4 16,-5-7-12-16,-1 3-14 0,0-3 11 0,-1 1 14 16,1 0-3-16,2 1 10 0,-3-2 1 0,3 2-11 15,-2-1-1-15,1 0 1 0,1 0 0 16,-2-1-7-16,2 1 6 0,0 0-4 0,0 0-28 15,-2 0 25-15,3 1-10 0,6 4 20 16,-6-2-19-16,2-1 12 0,-3-1 16 0,1-1-30 16,0 0 10-16,-1 0 11 0,0 0-9 0,-1 0 6 15,1-1-7-15,-2 1 16 0,2-1-9 16,0 0 9-16,1 2-2 0,-2-3-35 16,-1 3 29-16,1-2-22 0,0 0 26 0,-1 1-2 15,1-2-24-15,1 1 15 0,-3 1 9 0,3 0 12 16,-2 0-13-16,-1-1-25 0,3 2 27 0,-2-1 13 15,1 2-23-15,-1-3 7 0,1 3-9 16,-1-3 18-16,1 3-9 0,0-1-9 0,0-1 10 16,-1 1 6-16,1 2-15 0,4 4 8 15,-4-1-18-15,-1-3 0 0,1 1 14 0,1-2 2 16,-3 1-7-16,0-6-6 0,0 0 11 0,0 5-4 16,0 1 12-16,0-1 1 0,0 0 0 0,0 0 6 15,0 0-13-15,0 0-17 0,0-5 17 16,0 6 10-16,0-1-3 0,0 0 0 0,0 0-30 15,0-1 26-15,0 1-3 0,0 0-25 16,0 0 33-16,0-5-20 0,0 7 14 0,0-3 0 16,0 2-17-16,0-1 20 0,0-1 1 0,0-4-31 15,0 9 36-15,0-3-10 0,0-2-1 16,0-4 2-16,0 7 7 0,0-2-8 0,0-1 13 16,0-4-22-16,0 6 5 0,0 0-21 15,0-6 24-15,0 6-6 0,0-6 12 0,0 6 8 16,0-6-16-16,0 4 0 0,0-4 7 0,5 0-5 15,-5 6 6-15,0-6 3 0,0 4-9 16,0-4-23-16,0 5 21 0,0-5 9 0,11 10-14 0,-9-7-5 16,-1-1 5-16,1 1 2 0,-1-1-1 15,2-1-3-15,-2 1 0 0,1 0 10 0,1-1 1 16,-2-1-3-16,2 3 2 0,-1-3-12 16,0 2 12-16,1-1 15 0,-2-1-43 0,2 0 6 15,-1 2 43-15,-1 0-17 0,0-1-1 16,0 1-10-16,1-2-3 0,1 1-7 0,-3 0 16 15,2-1 10-15,-1 2-10 0,0-2-2 0,1 1 7 16,-1 0-16-16,2-1 9 0,-3 0 2 16,1 2-5-16,1-1 20 0,-1-1-22 0,1 2-12 15,-1-1 30-15,-1-1-10 0,4 1-3 0,-3 1 1 16,1-2 17-16,-2 0-30 0,2 2 17 16,-1-2-25-16,-1 0 7 0,2 1 13 0,-1 0-9 15,1-1 5-15,-2 1 2 0,2 0 12 0,-2 0-7 16,2 1 17-16,-1-2-19 0,0 1-7 0,1 0 8 15,0 1 11-15,-1 0-27 0,1 0 17 16,-1-1-7-16,1 2 21 0,-1-1-11 0,1 0-10 16,0 0 3-16,1 0-6 0,-2 2 5 15,0-2 2-15,1 1 0 0,1-1 6 0,-2 0-14 16,1 1 19-16,1-1-10 0,0-1-3 0,-1 3 0 16,1-3-20-16,-1 0 25 0,0 2-14 0,0 1 12 15,2-4 5-15,-3 2-7 0,2 2 17 16,-1-4-16-16,0 4-6 0,0-3 16 0,-1 1-29 15,2 2 10-15,-3-3 15 0,2 1 1 0,1 1-5 16,-1-1-10-16,1 1 3 0,-2-1 0 16,1 1 3-16,2 0 11 0,-4 0-1 0,3 0-7 15,0 0 1-15,-2-1 16 0,2 1-41 16,0 1 15-16,5 4-3 0,-5-3 15 0,1 0 18 16,-1-1-24-16,0-2 7 0,0 2-1 0,-2 0-3 15,2-2 3-15,1 0-9 0,-2 1 16 0,-1-1-35 16,3 2 24-16,-4-2 10 0,1 1-5 15,1 0-12-15,0-1 14 0,0 0-1 16,-2 3-3-16,2-1 14 0,-1-1-19 0,3 8-15 0,0-6 23 16,-1 2-28-16,-2-4 24 0,1 0-4 15,0 1 6-15,-2 1 1 0,1-2-4 0,0 0-2 16,-1 0 6-16,1 0-17 0,-1 1 4 16,1 0 16-16,1 0-19 0,-2 0 9 0,2-1 19 15,-2 1-16-15,0 1-14 0,1-1 23 0,1-1-9 16,-1 1 8-16,0 0-9 0,2 8-7 15,-2-4 11-15,1-3-8 0,-2-5 4 0,0 0-17 16,0 5 12-16,0-5 6 0,0 6 14 0,0-6-18 16,8 10 7-16,-8-6-21 0,2-3 17 15,-1 1 13-15,-1-1-8 0,3 2-5 0,-1-2 3 16,0 1-1-16,2 1-3 0,-3-3 5 16,1 3 1-16,-1-1-13 0,1 1 16 0,3-2-41 15,-3 0 37-15,1 0-17 0,-2 1 0 0,3-1 10 16,-1 0-14-16,0 0 27 0,0-1-14 0,1 0-6 15,-1 3-3-15,1-3 12 0,-4 0 5 0,0 0 3 16,4 0-9-16,-4 0 7 0,7 0-15 16,-7 0 20-16,4 0-24 0,-4 0 17 0,6 0 16 15,-6 0-19-15,6 0 9 0,-6 0-15 16,5 0 6-16,-5 0-7 0,0 0 5 0,5 0 21 16,-5 0-16-16,5 0 7 0,-5 0-18 0,0 0 0 15,5 0 13-15,-5 0 0 0,5 0-14 0,-5 0 18 16,0 0-10-16,6 0 17 0,2 9-15 15,-7-7 5-15,1 0-2 0,1-1-9 0,-1-1 23 16,0 1-18-16,0 1 1 0,0 0 1 0,0-1 14 16,0 0-23-16,1 0 17 0,-2 1-29 15,1-1 16-15,-1 1 6 0,1 0 2 0,-1-1 3 16,2 2-16-16,-2 0 4 0,1 0 3 16,0 0 19-16,0 2-25 0,-2-3 14 0,3 2-25 15,-2 1 11-15,0-3 7 0,0 3 0 0,0-3 4 16,0 1-1-16,0 0 8 0,0 2-9 0,1-1 18 15,0 1-15-15,-1-2-12 0,1-1-11 0,-2 3 32 16,3-2 3-16,-2 0-17 0,-1 1 26 16,1-2-25-16,2 3-6 0,-3-2-9 0,2 0 31 15,-1 0-20-15,-1-1 20 0,0 2-25 16,2-2 24-16,-1 2-5 0,0-3-3 0,1 2-24 16,-1 0 31-16,0 1-19 0,1-2-18 0,1 3 15 15,-3-3 6-15,7 7 6 0,-6-3-17 16,2 2 19-16,0-2-5 0,0-3-7 0,-2 2 3 15,2 0 12-15,-2-1-9 0,2 0 1 16,-2-1 3-16,1 0-24 0,-1 0 24 0,2 1-15 16,-3 0 9-16,3-1-5 0,-2 1 11 0,1-2-5 15,-1 1-1-15,1 0 17 0,-1 2-30 16,2-4 16-16,-2 2 11 0,0 0-1 0,2-2-18 16,-3 2 15-16,2 0-17 0,-1-2 8 0,1 2 5 15,-1-1-6-15,1-1-5 0,0 1 8 16,0 2-6-16,-1-3 21 0,1 2-10 0,0-1-19 15,0 3-3-15,0-4 21 0,1 2 1 16,-3 0-6-16,3 0 14 0,-1 0-11 0,0-1-13 0,-1 2-13 16,1 0 29-16,1-2-20 0,-1 2 13 15,0 0 4-15,1-3-5 0,-1 4-7 0,0-4 28 16,1 5-13-16,-1-5-3 0,0 3-9 16,1-2 2-16,-3 2 7 0,3 1-15 0,-1-2 20 15,0 2 4-15,1-3-13 0,4 6 4 0,-2-2-13 16,0 1 12-16,-2-3 8 0,-1 1-13 15,1-2 17-15,0 1-9 0,-2-2 3 0,1 1-9 16,2 0 2-16,-3 1 4 0,1-1-11 16,-2 1 19-16,3-2-18 0,-3 1-6 0,4 0 6 15,-3 1 5-15,1-2-1 0,-1 2 0 16,-1-2 18-16,1 0-20 0,1 0 7 0,-2 0-24 16,3 1 19-16,-1-2-21 0,-2 1 26 0,3 0-6 15,-3 0 0-15,0-1-10 0,2 0 15 0,-2 0 13 16,0 0-19-16,3-1 1 0,-3 1 17 15,0-1-20-15,1 1-1 0,-1-1-8 0,1 0-2 16,0 1 9-16,0 1-6 0,0-2 20 0,-1 0-23 16,0 1-2-16,2 0 17 0,-1-1-2 15,-1 3 0-15,0-3 11 0,3 1-5 0,-2-1-2 16,0 1 18-16,0 0-29 0,1 1 12 0,-2-1-5 16,2 0-4-16,-1 0-3 0,2 0-14 15,-2 0 23-15,2 1 7 0,-2-2 2 0,0 2-21 16,0-1 24-16,-1 1-5 0,0 0-10 0,3-1 5 15,0 0 13-15,-2 0-13 0,1 1-20 16,-1 0 10-16,0 1 2 0,-1-1 17 0,3 0-28 16,-1-1 25-16,-1 3 10 0,2-2-19 0,-2-1 12 15,1 4-24-15,0-4 8 0,-2 3-10 16,0-3 3-16,3-1 20 0,-3 5-5 0,1-4-24 16,2 3 33-16,-3-3-5 0,0 3 12 15,2-3-17-15,-2-1 7 0,0 0 1 0,0 0-4 16,0 0 8-16,0 5-20 0,0-5 10 0,0 5-28 15,0-5 26-15,0 6 16 0,0-6-18 16,0 6 9-16,8 1-4 0,-8-3-4 0,2 0-19 16,-1 0 9-16,-1-1 9 0,0 0 0 0,3-1-17 15,-3 1 19-15,0 2 3 0,1-2-4 16,0 0 9-16,0-1-5 0,0 1-5 0,-1 0 3 16,2-1-9-16,-1 2 11 0,0 0-3 0,0-1-3 15,1 0 8-15,-2 0-19 0,1 2 22 0,2-1-17 16,-3-1 18-16,1 0 0 0,1-2-12 15,1 4 0-15,-3-5-1 0,3 3-12 0,-3 1-8 16,1-1 27-16,1-1-3 0,0 1-15 0,1-1 36 16,-3 0-17-16,2 1-6 0,0 0-3 15,0 0 5-15,-1 0-3 0,2 0 0 0,-2-2 19 16,2 2-27-16,6 4 0 0,-5-1 13 16,1-3-14-16,-2 0 3 0,3 1 23 0,-3-1-21 15,1 0 7-15,0-1 5 0,5 6 2 0,-4-7-16 16,1 4-2-16,-1-4 0 0,-3 2 3 15,2-1 2-15,-1-1 1 0,-2-1-5 0,2 3 4 16,-3-2-1-16,3-1 9 0,-2 1 4 0,2 1-16 16,-1-2 11-16,-1 3-27 0,1-2 6 15,0 2 22-15,2-1-11 0,-2-1 26 0,1 1-6 16,1 1-11-16,-3 0 5 0,2-1-16 16,0 2 14-16,1-2-1 0,3 5-5 0,0 0 10 15,-1-2-11-15,-3 0-6 0,1-1 19 0,0-1 1 16,-1 0-6-16,-2 1-10 0,2-2 22 15,0 1-22-15,-2-1 1 0,1 0-14 0,-1 1 21 16,0-2 12-16,2 2-18 0,-1 0 12 0,-1 1-22 16,-1-1-10-16,3 0 25 0,-3 0-2 0,3 0 0 15,-2 1-4-15,-1 1 6 0,3-2 1 16,-2 1-16-16,-1-2 20 0,3 1-2 16,-2 1-22-16,-1-1 11 0,2 2 4 0,-1 0 15 15,0-1-29-15,1-1 16 0,0 0-15 0,-2 1 5 16,1-1 20-16,0 2-4 0,-1-1-9 15,1-1 8-15,1 2-19 0,-1 0 20 0,-1-2-18 16,3 0 28-16,-2 2-12 0,-1 0-18 16,0 0 24-16,5 7-10 0,-1-4-11 0,-3-2 18 15,1 0 8-15,-1 0-23 0,-1-1 26 0,0-1-18 16,3 0 11-16,-3 1-13 0,3-2 0 16,-2 0-8-16,0 2 16 0,0-2 3 0,0 2-20 15,0 0 22-15,-1-2-12 0,2 1 4 0,-1 0-2 16,-1 1-18-16,0 0 17 0,2-5-4 15,0 6 3-15,0-4 13 0,-1 2-7 0,-1-2-14 16,2 2 7-16,-1-1 5 0,-1-2-8 0,0 3 6 16,3-2-6-16,-3 1 23 0,1-1-24 15,-1-1 0-15,1 3 1 0,1-3-4 0,-2 1 10 16,1 1-4-16,2-2 5 0,-3 1-1 0,2 2 0 16,1-1 7-16,0-1 2 0,0 0-8 15,0 1-1-15,0 0-3 0,1-1 9 0,-1 1-10 16,1-2 13-16,-1 2-8 0,0 0-15 0,1-2 10 15,0 1-11-15,-1 0 2 0,0 0 16 16,-2-1-6-16,2 0 3 0,-1 2-10 0,0-2 9 16,0 0-1-16,-1-1 8 0,1 2-5 15,-1 0 7-15,1-2-13 0,-2 0 21 0,0 0-26 16,0 0 3-16,0 0-12 0,0 0 24 0,0 0-1 16,0 0-21-16,0 0 5 0,5 0 10 0,-5 0 7 15,0 0-8-15,0 0 1 0,0 0 21 16,4 0-12-16,3 7 3 0,-5-7-12 0,-2 1-4 15,1 0 8-15,-1 1-2 0,2-1-13 0,-1 1 31 16,0-1-3-16,2 0-16 0,-3 2-4 16,3-2 12-16,-3 0-9 0,0 0-3 0,3 1-14 15,-1 0 21-15,1 0-18 0,0 0 29 0,-1 1-7 16,1-1-2-16,1 1 12 0,-3-1-15 16,9 4 3-16,-6 0-1 0,3-2-11 0,-1 0 1 15,-1 0 4-15,-2-2 8 0,3 1-3 0,-2-1 15 16,-1 0-9-16,-2 1-5 0,3 0-6 15,-1-2 14-15,-2 3-18 0,2-3 3 16,-1 0 1-16,1 2 16 0,-2-2-7 0,2 0-2 16,0 1-4-16,-2 1-7 0,1-2-5 0,0 1 11 15,1 1 6-15,0-2-19 0,-2 2 12 16,3-1-15-16,5 4 13 0,-1 3-6 0,-2-5 3 16,5 0 4-16,-5 0 6 0,4 1 6 0,1 1-5 15,-1 0-1-15,-4-3 0 0,1 0-13 0,2 4-2 16,-6-5 11-16,4 2-10 0,0-1 16 15,-3-3-1-15,-2 3 6 0,3-1-12 0,-2-2-17 16,-1 3 23-16,-1-1-12 0,2-1 4 0,1 1 13 16,-4-2 2-16,0 0-25 0,0 0 8 15,0 0 7-15,0 0 5 0,5 0-17 0,-5 0 10 16,9 6-13-16,-6-6-2 0,-3 2-3 0,3-1 25 16,0 0 4-16,-1-1-11 0,1 0-2 15,1 1-24-15,-1 0 19 0,0-1 11 0,0 0-5 16,1 1 5-16,0 1-9 0,1-1-8 0,-1-1 16 15,0 1 6-15,-1 0-7 0,0 0-5 0,-3-1-19 16,0 0 13-16,5 0 16 0,-5 0-18 16,7 0 5-16,-7 0 11 0,6 0-5 0,-6 0 5 15,6 0-18-15,-6 0 31 0,7 0-36 16,-7 0 23-16,6 0 3 0,-6 0 0 0,5 0-14 16,-5 0 5-16,7 0-22 0,-7 0 30 0,6 0-33 15,-1 0 27-15,-5 0 7 0,6 0-3 16,0 0-6-16,-2 0 0 0,-4 0-11 0,8 0-2 15,-2 0 5-15,-2 0 12 0,0 0 13 16,-4 0-25-16,8 0 3 0,-3 0 8 0,0 0 16 16,-5 0-17-16,7 0-4 0,-2 0-9 15,-5-6 9-15,5 6-13 0,-5 0 30 0,7 0-24 16,-7 0-1-16,5 0 15 0,-5 0-2 0,6 0-6 16,-6 0 6-16,5 0 16 0,-5 0-12 15,0 0-9-15,5-5 7 0,-5 5 7 0,0 0-16 16,0 0-5-16,12-8 11 0,-10 8-9 0,-2-2-12 15,2 2 23-15,-1-1-2 0,1-1-7 16,0-1-3-16,1 3 16 0,-3-4-4 0,3 3 5 16,-1 1 5-16,-2-2-23 0,2 1 11 0,-1-2 6 15,2 2-15-15,-1 1 22 0,-1-1-19 16,1-2 15-16,1 3-8 0,1-1-7 0,-2-1-8 16,3 2 26-16,-4-1-37 0,5-1 32 0,-2 2-16 15,1 0 5-15,-2-2 4 0,2 2 5 16,0 0-8-16,6-1 0 0,-3-1 7 0,-3 1-17 15,2 1 20-15,0-1-3 0,-3 0 4 0,0 1-10 16,0 0 9-16,1 0-10 0,-3-2-11 0,3 2 0 16,-3 0 24-16,4-1-21 0,-4 1 17 15,2 0 15-15,-2 0-27 0,3 0 3 0,-4 0-6 16,3 0 17-16,-4 0-16 0,0 0 17 16,0 0-12-16,0 0 11 0,8 0-6 0,-8 0 1 15,4 0-1-15,-4 0-2 0,5 0-21 0,-5 0 8 16,8 0 13-16,-8 0-4 0,4 0 1 0,-4 0 5 15,7 0-5-15,-7 0 2 0,5 0 12 16,-5 0 4-16,7 0-26 0,-2 0-2 0,-5 0 18 16,8 0-17-16,-4 0 9 0,-4 0 8 15,7 0-5-15,-2 0-11 0,0 0 13 0,-5 0 18 16,7 0-14-16,-7 0-4 0,5 0-10 0,1 0 10 16,2-10 5-16,-6 10-12 0,1-1 0 0,-1 1 14 15,0 0-10-15,-1-1 4 0,2 1 1 16,-1-3-20-16,0 2 6 0,-1 0 28 0,3 1-22 15,-1 0 8-15,-2 0 3 0,1 0 1 16,0-1-7-16,-1 1 16 0,3 0-13 0,-2-1-10 16,0 1 1-16,-1-1-5 0,0 0 4 0,0 1 11 15,-1 0-12-15,0 0 5 0,0 0-15 16,5 0-2-16,-5 0 19 0,7 0-15 16,-2 0-5-16,2 0 16 0,-3 0 21 0,3 0-16 15,-2 0-11-15,1 0 21 0,3 0 2 0,4 0-9 16,-3 0-11-16,1 0-2 0,-2 0 20 0,-2 0-8 15,1 0 8-15,4 5 7 0,-7-5-24 16,-2 3 8-16,0-3-6 0,1 0 6 0,-2 0-6 16,1 1 7-16,-3-1 13 0,0 0 7 0,0 0-33 15,0 0 6-15,5 0 6 0,-5 0 7 16,5 0-13-16,-5 0 12 0,0 0-19 0,5 0 26 16,-5 0 1-16,0 0-16 0,5 0 7 0,-5 0 7 15,13 7-2-15,-11-2-38 0,2-5 11 0,-3 3 15 16,2 0 9-16,-1 0-11 0,2-1-5 15,-2 1-12-15,1-1 4 0,-2-1 18 0,3 2-8 16,0-1-2-16,-3 2 16 0,1-2 6 16,2 2-22-16,-3-2 5 0,1 3 19 0,3 3 5 15,-1 1-37-15,-1-5 10 0,0 0 21 16,0-2-26-16,0 2 8 0,-2-2 14 0,1 1-18 16,-1 0 0-16,2-1 11 0,-1 1 8 15,-1-2-14-15,1 4 12 0,-2-4-34 0,2 1 35 16,-1 2-4-16,1-1-20 0,0 1 5 15,-1-2 18-15,1 3-31 0,4 4 10 0,1-1 2 16,-2-2-14-16,-1 0 8 0,-2-3 17 16,1 1-9-16,0 0 22 0,-2-2-19 0,1 1 5 15,1-2-3-15,-1 1-9 0,-1-1 24 0,0 1-1 16,2-2-14-16,-1 3 15 0,0-1-11 0,-1-1-9 16,2 0-5-16,-2 2 6 0,1-2-7 0,0 0 14 15,0 0-12-15,1 3-9 0,-2-3 8 16,1 1 16-16,1-2 7 0,0 3-4 15,0 1-18-15,4 3-17 0,-1 2 21 0,0-5 6 16,1 4-15-16,0-5 17 0,-3 3-21 0,3-3 15 16,-4 0-3-16,1 1 4 0,-3-1-2 0,4-1 4 15,3 4-5-15,-4-2 14 0,4 1-2 16,-2-4-7-16,-4 4 9 0,1-4 4 0,-1 2-32 16,2-1 9-16,-2 0-5 0,2 2 8 15,-3-4 22-15,2 3-12 0,-1 0-12 0,-1-2 29 16,3 0-23-16,-1 0-3 0,-2 1 29 0,1-1-35 15,1 1 10-15,-3-1-6 0,2 1 11 16,-2 0-11-16,2-1 13 0,2 0-9 16,-4 0-4-16,1 1 14 0,1 1-11 0,-1-2-14 15,0 2 37-15,1 0-38 0,-1 2 12 0,1-3 11 16,-1 2 4-16,1 0 0 0,-1-1-7 16,2 2 18-16,-2-2-26 0,3 8 3 0,-1-5 1 15,-2-2-11-15,0-1 29 0,3 1-25 0,-4-2 5 16,1 1 15-16,0-1-1 0,0 0-28 15,-1-1 18-15,0 1 35 0,2 0-43 0,-1 1 2 16,-1-2 0-16,0 0 26 0,2 2-7 16,1-2-25-16,-3 1 6 0,0 0-9 0,3-1 17 15,-3 4-7-15,1-4 6 0,1 2 17 16,-2-1-21-16,4-1 13 0,-3 0-10 0,1 2-7 16,-1-1 30-16,0 0-43 0,0-1 23 15,0 0-20-15,2 0 10 0,-2 2 1 0,0-3 17 16,1 1-1-16,1 0-23 0,-3 0 30 0,3 1-22 15,-2-1 32-15,0-1-34 0,1 1 30 16,-1 0-27-16,1 0-14 0,-2 0 11 0,4 0 16 16,-3 1-9-16,1-1-14 0,-1 0 25 0,2 1-26 15,-1 0 22-15,3-2 21 0,-2 2-43 16,0 1 14-16,1-2-3 0,0 1 3 16,-3 0-7-16,4-1 11 0,-3 2-11 0,3 0 11 15,-2-1-9-15,1-1 14 0,-1 0 17 16,-1 1-8-16,0-1-23 0,2 1 5 0,-3 0 11 15,1-2-22-15,-1 2-5 0,2 0 14 16,-1-2 14-16,-1 1 10 0,1 2-7 0,-1-2-34 16,0 1 37-16,2-2-24 0,-3 2-4 0,1-1-1 15,1 0 33-15,1 0-6 0,-2-1-25 16,1 1 13-16,-2 0-9 0,1 1 18 0,1-2 2 16,0 1-23-16,-2 0-6 0,0 0 14 0,1 0-9 15,1 0 1-15,-2 2 4 0,1-3 23 0,-1 1-11 16,3 0-10-16,-2 0 10 0,0 1 20 15,0-2-39-15,-1 2 6 0,2-1 2 0,-2 1-6 16,1-1 1-16,1 0 6 0,0-1 20 16,-1 3-14-16,-1-2-12 0,2 2 18 0,-1 0-10 15,1-2-9-15,-1 1 30 0,0-1-23 16,0 1-8-16,1-1 33 0,-2 1-32 0,1 0 0 16,1-2 15-16,-2 0-16 0,2 1 33 0,-1 3-25 15,0-3 6-15,0-1 18 0,-1 1-23 16,3 0 5-16,-3 1-16 0,1-2 33 0,1 1-18 15,-2 0-13-15,1-1 5 0,-1 2-1 16,0-2-1-16,1 1 4 0,-1 0 8 0,0-1 3 16,2 1-16-16,-2-1 16 0,0 0-9 0,2 0 10 15,-1 1 10-15,0-1-21 0,-1 1-2 16,2-1 27-16,-2 0-24 0,0 0 7 0,0 0-10 16,0 0 7-16,0 0-5 0,0 0 19 15,0 0-19-15,0 0-10 0,0 0 6 0,0 0 14 16,0 0-10-16,3 5-16 0,-2-3 40 0,-1-2 10 15,1 1-36-15,-1-1 6 0,0 1 5 0,2-1-17 16,-2 2 6-16,1-1 12 0,-1-1-12 16,0 0-8-16,0 0 13 0,0 0 16 15,2 3-12-15,-2-3-8 0,1 0 17 0,-1 0-6 16,0 0-12-16,0 0-2 0,0 1 12 0,0-2 0 16,0 1 8-16,1 2-18 0,0-2 5 15,-1 2-14-15,1-2 23 0,-1 1-18 0,2-1 25 16,-2 0-11-16,2 1-21 0,-2 2 18 15,0-2-12-15,0-1 14 0,1 1 10 0,-1 1-4 16,2-2 10-16,-1 2-6 0,1-1-26 0,-2 1 8 16,1-2 1-16,-1 1-3 0,3-1-3 15,-3 2-3-15,1-1-3 0,-1 0 33 16,2 1-33-16,-2-2 27 0,0 0-12 0,1 0-1 16,2 2 5-16,-3 1 1 0,0-2-10 15,2 1 0-15,1 0 7 0,-1 1-8 0,-1-2 17 16,1 2 8-16,-1-1-39 0,1-2 24 0,0 1 3 15,0 2-21-15,-2-3 27 0,1 1-15 16,1 0 15-16,-1 0 11 0,-1 1-20 16,0 0 0-16,2-2-2 0,-2 1-13 0,2-1 10 15,-1 1-3-15,0-1-11 0,-1 0 24 0,1 2-25 16,0-1 12-16,-1-1 0 0,0 0 16 0,0 0-24 16,0 0 14-16,0 0-14 0,0 0 3 15,0 0 0-15,0 0 27 0,0 0-23 0,0 0 3 16,0 0 20-16,0 0-25 0,5 0 23 15,-5 0-17-15,0 0 6 0,0 0-8 0,0 0-6 16,0 0 29-16,0 0-8 0,5 0-17 0,-5 0-4 16,0 0 8-16,0 0 10 0,0 0-33 15,6 0 7-15,-6 0 44 0,0 0-19 0,0 0-18 16,4 0 0-16,-4 0 2 0,0 0 16 0,0 0-4 16,6 0-17-16,-6 0 30 0,0 0-22 15,5 4 3-15,1 2-12 0,-3-4 17 0,-3-2 2 16,3 4-19-16,-1-4 30 0,0 2-16 0,1-2 10 15,-2 4-9-15,2-2-11 0,0 0 12 0,1-1-5 16,-3 3 28-16,1-1-12 0,0-2-20 16,0 2 1-16,2 0-10 0,-2-1 15 0,0 0-3 15,0 0-7-15,1 2 19 0,-1-1-24 0,0-1 33 16,1 2-28-16,-1-1 33 0,1-1-24 16,-1 0-7-16,-1 1-3 0,1 0 38 0,0 0-10 15,1 0-4-15,-2 1-20 0,1-2-8 0,1 1 31 16,-3 1-21-16,4-3-6 0,-3 3 5 15,2-1 7-15,-3 0 10 0,2 0-7 0,0 0-4 16,-1 0-6-16,1-1 3 0,0 2 13 16,-1-2-9-16,0 1 8 0,1-1 5 0,1 1-18 15,0 0-7-15,-1 1 17 0,1-1 10 0,-1 1-40 16,0-2 11-16,1 2 35 0,3 4-13 16,-1-2-18-16,0-1 9 0,-1 0 3 0,0-2 9 15,-1 2-30-15,1-2 20 0,-2-1 2 16,0 1-20-16,1 1 15 0,0-2 1 0,0 0 2 15,1 1 17-15,-1-1-25 0,-1 1 6 16,1-2 15-16,-1 0-19 0,2 2 0 0,-2-2-14 16,1 0 26-16,-1 0-15 0,1 0-7 15,0 2 0-15,-1-1-2 0,1-2 11 0,0 1 9 16,0 1 6-16,-1 1 5 0,1-3-5 16,0 2-10-16,0-2-17 0,-1 1 14 0,1 0-1 15,1 1 12-15,-3-2-2 0,2 0 5 0,1 2-11 16,-1-1-2-16,0 1 15 0,-3-2-28 0,0 0 35 15,0 0 4-15,5 0-20 0,-5 0 6 16,6 0 5-16,-6 0-18 0,5 0 2 16,-5 0-6-16,5 0-8 0,-5 0 17 0,0 0-6 0,5 0 14 15,-5 0-1-15,6 0 12 0,-6 0-25 16,3 0-21-16,-3 0 17 0,7 0 8 16,-7 0 9-16,3 0 1 0,-3 0-9 0,7 0-7 15,-7 0 4-15,4 0 9 0,-4 0 1 0,7 0-17 16,-7 0 8-16,8 0-1 0,-4 0 7 15,-4 0-22-15,8 0 8 0,-3 0 9 0,-1 0 11 16,2 0-3-16,-2 0-8 0,6 6-14 0,1-6 15 16,5 8 6-16,-10-6-9 0,1-2 19 0,-1 3-36 15,-1-1 44-15,0-1-10 0,-1-1-13 16,2 0-10-16,-3 1 9 0,1-1 20 0,0 0-24 16,-1 2-1-16,1 0 5 0,0-2-14 0,-1 0 3 15,-3 0 17-15,0 0 4 0,0 0 9 16,7 0-22-16,-7 0 15 0,4 0-15 0,-4 0-6 15,6 0 6-15,-6 0 13 0,4 0 8 0,-4 0-28 16,7 0 11-16,-7 0-15 0,10-10 24 16,-8 9-15-16,-1 1-1 0,2 0-2 0,-2-2 14 15,2 1-20-15,0 1 23 0,-1-1-21 16,0-1 29-16,0 1-6 0,1-1-14 0,0 1 0 16,0-2 20-16,0 2-9 0,0-1-7 0,1 0 0 15,0 1 9-15,2 0-18 0,-2 1 10 16,2 0-3-16,-1-1-10 0,0 0 5 0,9 0 14 15,-7 1-6-15,1 0-11 0,2 0 9 0,-3 0-11 16,0 0 2-16,0 0 18 0,-1 0 7 16,-1 0-34-16,1 0 21 0,-2 0 8 0,2 0 8 15,-6 0-22-15,6 0 19 0,-1 0-7 0,-5 0-12 16,7 0 21-16,-3 0-22 0,-4 0 2 16,14-2 16-16,-11 0-14 0,0 0 3 0,1 0-7 15,-2 1 11-15,1 0-24 0,-1 1 38 16,2-3-20-16,-1 2 13 0,-1 0-18 0,0 0 8 15,0 1-1-15,1-1-2 0,-2 0 18 0,2 0-13 16,-1 0-19-16,0-1-6 0,1 2 24 0,0 0 9 16,-2 0-13-16,1 0 2 0,-1-1 6 15,3 1-10-15,-4-1 7 0,2-2-9 16,-1 3 8-16,1 0-12 0,2-1 8 0,-3 0-7 16,2 1 24-16,0-3-42 0,-2 2 31 0,3-1-22 15,-2 2 1-15,0-1 11 0,0-1-2 0,-1 0-2 16,2 1 5-16,-2 1-10 0,1-2 36 15,1 2-17-15,-2-2 6 0,1 0-3 0,-1 1-12 16,0 1 6-16,1-1-6 0,-1 0 10 0,1-1 1 16,-2 1 4-16,4-1-19 0,-3 2-14 15,1-1 11-15,-1 0 3 0,-1-2 7 0,3 2-5 16,-3 1 10-16,1-1-1 0,3-2-11 16,-4 2 8-16,2 0-1 0,-1 0-3 0,1-1 19 0,-1 1-18 15,1 0-2-15,-1 0 14 0,1-2-6 16,0 2-4-16,-1 0 19 0,0 0-23 0,0 0-13 15,2 0 12-15,-2-1-5 0,-1 1 18 0,2 1-26 16,0-1 15-16,-2 0 19 0,2-1-36 16,-1 2 28-16,2 0-21 0,-2-2 0 0,0 0 11 15,1 2 1-15,1-1 1 0,-1 0 10 16,0 0-4-16,-2 1-13 0,0 0 8 0,0 0 3 16,0 0 4-16,6 0 16 0,-6 0-29 15,6 0-16-15,-6 0 17 0,5 0 1 0,1 0-5 16,-6 0 11-16,5 0-1 0,-5 0 8 0,6 0-14 15,-2 0 2-15,-4 0 13 0,7 0-18 16,-3 0 17-16,-4 0-7 0,6 0 2 0,0 0-15 16,-2 0-3-16,2 0 20 0,-6 0-4 15,6 0-9-15,0 0 7 0,0 0 0 0,-6 0 8 16,7 0-11-16,-3 0-11 0,2 0 17 0,-6 0 7 16,7 0-3-16,-2 0-2 0,-5 0-3 15,6 0-6-15,1 0-6 0,-3 0 5 0,-4 0 6 16,7 0-19-16,-1 0-6 0,3 0 22 15,-2 0-3-15,0-5 16 0,-2 5-19 0,0 0 6 16,-5 0 10-16,14-5-2 0,-11 5-15 0,0 0 11 16,1-2-3-16,-1 1 14 0,-1 1-15 0,3-2-7 15,-2 2 14-15,1-1-19 0,-1 1 11 16,-1 0 11-16,1 0-7 0,0-1 10 0,0 1-20 16,1-2 2-16,-2 2 5 0,0-2 5 0,1 2-13 15,0 0-11-15,0-1 24 0,0 0-13 16,-1 1-1-16,3-1 10 0,-4-1 1 0,3 1 8 15,-1 0-6-15,0-1-14 0,0 1 3 16,1 0 18-16,-3-2-8 0,2 2-9 0,1 0 25 16,-1 0-14-16,-1-2 6 0,-1 3-7 0,5-2-14 15,-4 0 10-15,0-1 20 0,3 3-13 0,-2-2 0 16,0 0-5-16,6-3-4 0,-3 1 5 16,-3 0-10-16,0 2 9 0,1-1 7 0,-2 0 1 15,0 1-19-15,1-1 19 0,-1 2-17 16,-2-2 18-16,3 1 5 0,-1 0-28 0,1 0 11 15,-1-1 2-15,0-1 2 0,0 1-6 0,-1 2 0 16,2-2-1-16,-2 1 14 0,2 1 2 16,-1-1-11-16,-2 0 19 0,1 0-23 0,2 0 16 15,-1-1-21-15,0 2 8 0,1-3 7 0,0 3-1 16,-2-1-22-16,2-1 23 0,0 2-3 16,-2-2 4-16,1 1-13 0,-1-1-10 0,3 2 16 15,-4 0-14-15,3-1 15 0,0 0 0 0,-2 1-5 16,1 0 19-16,-2-1-14 0,2 0-4 15,1 1 5-15,-1 1-4 0,-1-1 3 0,1-2-7 16,2 2 0-16,-3 1 20 0,2-1-2 16,0 1-2-16,1-4-29 0,-1 3 4 0,0 0 24 15,0 1-11-15,2-1-13 0,-2 0 32 0,2-2-34 16,-2 3 13-16,0-2-3 0,2 2 14 0,-2 0-12 16,3 0 2-16,-2-2-11 0,1 1 14 0,-1 1 17 15,0-3-13-15,2 3-11 0,-2 0 23 16,1-1-11-16,-1 1-3 0,-4 0-18 0,0 0 29 15,5 0-6-15,2 0-29 0,-3 0 9 16,2 0 39-16,-1 0-25 0,-5 0-8 0,6 0 6 16,1 0 5-16,-3 0-22 0,-4 0 30 0,7 0-22 15,-2 0 25-15,-5 0-21 0,5 0 1 16,1 0 11-16,-6 0-11 0,7 0 15 0,-3 0-19 16,-4 0 19-16,7 0-14 0,-7 0 3 0,7 0 14 15,-7 0-12-15,6 0-13 0,-6 0 1 16,5 0 12-16,-5 0 2 0,6 0-11 0,-6 0 14 15,5 0 5-15,-5 0 0 0,5 0-23 0,-5 0 30 16,0 0-11-16,5 0-24 0,-5 0 14 16,5 0-9-16,-5 0 18 0,4 0 6 0,-4 0-16 15,0 0-5-15,7 0 5 0,-7 0 17 16,6 0-12-16,-6 0-2 0,5 0-3 0,-5 0 2 16,6 0 0-16,-1 0-3 0,-5 0-1 0,6 0 19 15,-6 0 2-15,6 0-15 0,-6 0 15 16,7 0-19-16,-3 0-3 0,-4 0 9 0,6 0 17 15,-6 0-32-15,5 0 13 0,-5-7-14 0,6 7 16 16,-6 0 7-16,5 0-18 0,-5 0-8 16,7 0 23-16,-7 0-8 0,6 0 11 0,-6 0-12 15,0 0-1-15,4 0 26 0,-4 0-12 16,5 0-27-16,-5 0 14 0,0-5 3 0,5 5 5 16,-5 0-11-16,5 0 4 0,-5 0 18 0,0 0-5 15,6 0-11-15,-6 0-5 0,5 0 15 0,-5 0-17 16,0 0-4-16,5 0 1 0,-5-4 11 15,5 4 9-15,-5 0 2 0,5 0-13 0,-5 0-6 16,13-8 13-16,-12 8-12 0,1-1-8 0,1 1 7 16,0-1-10-16,-1-1 26 0,0 2-3 15,1-1-11-15,0 1 17 0,-1-1-17 0,-1 1 0 16,2-1 8-16,1 1-18 0,-2-1-1 0,0 1 27 16,3 0-16-16,-3 0-1 0,1 0 11 0,-3 0 1 15,0 0-6-15,0 0-3 0,4 0-17 16,-4 0 31-16,8 0-12 0,-3 0-7 0,-5 0-6 15,5 0 17-15,1 0-5 0,-6 0 1 0,5 0 17 16,-5 0-29-16,6 0 23 0,-6 0-11 16,7 0 3-16,-7 0 10 0,6 0-9 0,-1 0-3 15,-5 0 4-15,6 0-21 0,-2 0 16 16,-4 0-1-16,6 0 1 0,-6 0 4 0,6 0-5 16,-6 0-2-16,5 0-8 0,-5 0 22 0,7 0 14 15,-7 0-26-15,6 0 4 0,-6 0-1 16,5 0 8-16,-5 0-21 0,0 0-9 0,5 0 32 15,-5 0-3-15,6 0-18 0,-6 0 24 0,0 0-6 16,5 0-13-16,-5 0 14 0,0 0-9 16,5 0-21-16,-5 0 37 0,0 0-8 0,6 0 5 15,-6 0-18-15,0 0 14 0,6 0 0 0,-6-4-24 16,0 4 19-16,6 0-18 0,-6 0 26 16,6 0-17-16,-6 0 11 0,4 0-2 0,-4 0-16 15,6 0-1-15,3-10 17 0,-8 9-10 16,0 1 0-16,2-2-4 0,-1 1-4 0,0 0 21 15,0 1-6-15,1-1-2 0,-1 1 11 0,0 0-31 16,4 0 25-16,-5-1 7 0,2 0-26 0,1-1 22 16,-1 2-10-16,-2-1 0 0,3 0-5 0,-1 0 19 15,2 1-3-15,-3-1 3 0,1-1-4 16,0 1 5-16,0 1-18 0,0 0 9 16,1 0-10-16,-3-3-4 0,3 3 16 0,-1-1-5 15,0-1 2-15,-1 1 6 0,1 1-8 0,1 0 2 16,-2-3-8-16,0 3 2 0,1 0 14 0,0-1-10 15,-1 0-2-15,1-1-17 0,-1 1 19 0,1 0 13 16,-1 0-9-16,0 1-3 0,-1-2 7 16,0 1-15-16,1 1 9 0,1-1-8 15,-1 0-6-15,-2 1 10 0,3-3 8 0,-1 3-23 16,-1-1 21-16,1 0-9 0,0 0 11 0,-1 1-4 16,1-1 7-16,0 1-6 0,-1-1-12 0,0 0 8 15,2 0-6-15,-1 0 21 0,0 0-17 16,1 0 1-16,-3 1-15 0,0 0 1 15,0 0 13-15,0 0 10 0,0 0 2 0,5 0 0 16,-5 0-7-16,5 0-1 0,-5 0-18 0,5 0 18 16,-5 0-2-16,11-8-3 0,-9 6 0 15,-1 1-7-15,2 1 25 0,-1-2-18 0,1 2 8 16,-1 0 2-16,-1-2-5 0,1 2-15 0,2 0 22 16,-2 0-20-16,0-2-4 0,0 2 19 15,-1-1-17-15,2 1 10 0,-1-1 12 0,0 1-11 16,0-1 3-16,0 1-12 0,0 0 27 15,0 0-15-15,-1-1 6 0,1 1-4 0,-1 0-2 16,0-1-4-16,-1 1-11 0,0 0 28 0,0 0-13 16,0 0-20-16,0 0 2 0,0 0 37 15,6 0-10-15,-6 0-11 0,0 0-10 0,5 0 11 16,-5 0-12-16,0 0 16 0,6 0-6 0,-6 0 9 16,0 0-10-16,5 0-6 0,-5 0 0 15,6 0 8-15,-6 0 3 0,0 0-4 0,5 0 11 16,-5 0-10-16,0 0 7 0,5 0 5 15,-5 0-14-15,6 0 5 0,-6 0 13 0,5 0-26 16,-5 0 6-16,5 0 4 0,-5 0 18 0,7 0-43 16,1 7 23-16,-4-5-8 0,-2-2 18 0,2 2-12 15,-1-2 5-15,1 1 12 0,-2 0-10 16,3 1-3-16,-1 1-24 0,-1-3 16 0,-1 0 5 16,2 2 10-16,-1 0-5 0,1-1-1 15,-1 0 0-15,0-1 1 0,1 1 0 0,0 0 6 16,0-1-4-16,-1 1 4 0,0 0-6 0,0 0-19 15,1 1 2-15,-1-2 18 0,0 1 0 16,2 2-9-16,-4-3 7 0,2 1-10 0,1 0 3 16,-1 2 27-16,0-3-14 0,-1 1-19 15,2 0 5-15,0-1 18 0,-1 1-5 0,-2-1-3 16,3 2 3-16,-1-1-3 0,-1-1-2 0,0 0-9 16,1 0 13-16,0 0-5 0,0 1-20 15,-2-1 24-15,3 0 1 0,-1 3 2 16,-1-3-3-16,2 1-5 0,0-1 3 0,-1 0-8 15,1 0 24-15,0 1-2 0,-2 0-12 0,1-1 3 16,1 3-14-16,-1-2 17 0,1-1-9 0,-1 0-4 16,1 0 8-16,-1 1-8 0,0 0-4 15,1 0 8-15,-1-1 13 0,1 1-5 0,-1-1-12 16,-1 0-6-16,0 0 29 0,1 1-19 0,0-1-27 16,-3 0 20-16,0 0 27 0,0 0-19 15,6 0 0-15,-6 0 4 0,6 0 15 0,-6 0-30 16,5 0-7-16,-5 0-2 0,5 0 18 0,-5 0-4 15,5 0 12-15,-5 0-5 0,6 0-2 0,-6 0 5 16,0 0-2-16,5 0-9 0,0 0 7 16,-5 0-9-16,11-8 21 0,-8 8 1 0,-1-2-11 15,1 1-2-15,1 1-1 0,-3 0-22 16,4-1 26-16,-2 1 1 0,0-3 13 0,-2 3-23 16,2 0 6-16,-2 0 6 0,2-1-24 15,0 0 17-15,0-1 3 0,1 2-5 0,-3-1 8 0,1 0-12 16,1 1-1-16,0-1 19 0,-1 1-17 15,1-2 8-15,0 1-27 0,-2 1 46 0,1-1-17 16,2 0-4-16,-4 1-8 0,3-2 13 16,-1 1-16-16,0 0 21 0,-1 1-27 0,2 0 30 15,0-1 0-15,-2 1-13 0,1-1-5 16,1 0 6-16,-1 0-7 0,0 1 9 0,0-1 6 16,0 0-9-16,1 1 8 0,-2 0 5 0,1 0-15 15,0 0 14-15,0-1-12 0,0 1-10 0,-1 0 14 16,3-1-6-16,-3 0 0 0,1-1-14 0,1 1 10 15,-1 0-18-15,0 1 33 0,0-2 8 16,1 2-16-16,-1-1 1 0,1 1 8 0,-1-2-30 16,0 1 31-16,-1 0 0 0,1 1-13 15,1-2-7-15,-1 1 3 0,1 0 21 0,-2 1-2 16,2 0-9-16,-1 0-16 0,0-2 14 0,1 1 13 16,0 1-23-16,-1-2 14 0,3 1-6 15,-2 0 5-15,-2 0-3 0,2 0-28 0,0 0 17 16,1 0 9-16,-3-1 8 0,2 2-9 15,1-1 3-15,-2 0-3 0,-1 1 8 0,1 0-8 16,2-2-7-16,-1 1 10 0,0 0 6 0,-2 0-27 16,2 1 19-16,-3 0-3 0,0 0 11 0,0 0-37 15,0 0 44-15,5 0-13 0,-5 0-14 16,5 0-4-16,-5 0 16 0,0 0 18 0,5 0-15 16,-5 0-20-16,0 0 22 0,5 0-20 15,-5 0 16-15,0 0 8 0,7 0-11 0,-7 0 1 16,0 0-7-16,0 0 17 0,0 0-33 0,5 0 17 15,-5 0 7-15,0 0 12 0,0 0-16 0,4 0 16 16,-4 0-27-16,0 0 13 0,0 0-16 16,6 0 22-16,-6 0 5 0,10 3-1 0,-10-3-14 15,3 2-13-15,-3-1 10 0,4 0 8 16,-3 2 4-16,3-1-24 0,-1 0 7 0,6 6-6 16,-1-4 3-16,-2 1 4 0,4-1-14 0,-2-1 34 15,-2-1-22-15,1 0 6 0,-3-1 11 16,2 1-1-16,-1 1-1 0,4 2 10 0,-1-3-12 15,1 1-35-15,-2-2 30 0,-3 0-21 0,1-1 20 16,1 3 31-16,-3-3-21 0,2 1 0 0,-1-1-6 16,0 0-20-16,0 0 28 0,0 1-18 15,1-1 6-15,-1 1 15 0,0 0-28 0,0-1 23 16,-1 0-17-16,1 0 35 0,-1 0-13 16,1 0 3-16,0 0-2 0,-1 0 5 0,0 0-39 15,1 2 38-15,-4-2 2 0,0 0-26 0,0 0 27 16,6 0-15-16,-6 0 11 0,6 0-10 15,-6 0-32-15,6 0 13 0,-6 0 28 0,7 0-6 16,-7 0 2-16,6 0-9 0,-6 0-5 0,4 0 12 16,-4 0-7-16,6 0-14 0,-6 0 4 15,9-9-3-15,-6 8 23 0,0 1-14 16,-1-1 12-16,0 1-4 0,1 0 1 0,-3 0 23 0,0 0-51 16,0 0 29-16,0 0-13 0,7 0-7 15,-7 0 23-15,3 0-7 0,-3 0 8 0,7 0 3 16,-7 0-16-16,0 0 9 0,4 0 3 15,-4 0 21-15,6 0-11 0,-6 0-8 0,6 0-8 16,-6 0 19-16,5 0-37 0,-5 0 15 0,6 0-6 16,-1 0 12-16,-5 0-9 0,6 0 5 15,-1 0-21-15,-5 0 27 0,5 0-13 0,-5 0 5 0,7 0-27 16,-3 0 36-16,-4 0-4 0,7 0-2 16,-7 0-28-16,6 0 40 0,-6 0-4 0,5 0-10 15,-5 0-5-15,6 0 18 0,-6 0-4 16,5 0 5-16,-5 0-19 0,6 0 18 0,-6 0-8 15,5 0-25-15,-5 0 38 0,0 0-9 0,6 0 7 16,-6 0-4-16,6 0-14 0,-6 0 5 16,7 0-5-16,3 5 22 0,-6-4-6 0,-1 0-21 15,2 1-13-15,6 2 28 0,-1-1-10 16,0 1-4-16,-2-1 5 0,-2 2 11 0,2-4-7 16,3 3 0-16,-3-2 5 0,-1 0 7 0,0-1-47 15,-4 1 30-15,2-1 19 0,-3 0 6 16,2 0-24-16,2 0-3 0,-5-1 12 0,2 1-19 15,1 0 13-15,-1-1 12 0,-2 1-6 16,1-1 7-16,2 0 6 0,-4 3-5 0,3-3-11 16,0 0 5-16,-2 0-18 0,3 0 6 0,-2 0-26 15,0 1 22-15,-2-1 14 0,0 0-10 0,0 0 12 16,0 0-9-16,5 0 9 16,-5 0 1-16,0 0-26 0,12-8 18 0,-10 7 8 15,0 0-31-15,0 0 32 0,0-1-38 0,-1 1 44 16,3-2-9-16,-3 2-15 0,1-2 3 0,1 2 13 15,-2 1-21-15,2-3 22 0,-2 1 2 16,2 1-11-16,-3 0 4 0,3-2-7 0,0 1 19 16,-2 2-11-16,-1-2-16 0,3 0 16 0,-3 1 3 15,3 1-10-15,0-1-10 0,-1-2 3 16,1 2 30-16,-1 0-38 0,0 1 26 0,1-1-5 16,-1-2 0-16,0 3 10 0,0 0-11 0,-1 0-4 15,2-1 20-15,-1 0-11 0,0 1-16 0,0-2 0 16,-1 2 13-16,3-1-25 0,-3 1 20 15,1-1-13-15,-1 1-8 0,1-1 29 0,-1 1-22 16,2 0 24-16,-1-2-12 0,0 2 2 16,-2 0-4-16,3-1 16 0,0 1 2 0,-1-1-9 15,0 1-14-15,1-1 18 0,-1 1 10 16,1 0-17-16,-1-2 9 0,2 2-4 0,-1-1-7 16,-2 1 3-16,1 0-24 0,1 0 18 15,0 0-19-15,-1 0 31 0,1-1-14 0,-3 1 15 16,0 0-6-16,0 0 3 0,0 0-9 0,0 0-22 15,5 0 13-15,-5 0-9 0,5 0 21 0,-5 0 1 16,5 0-8-16,-5 0 26 0,5 0-46 0,-5 0 21 16,5 0 14-16,-5 0-24 0,6 0 22 15,-6 0 9-15,5 0-11 0,-5 0 6 16,6 0-3-16,-6 0-6 0,5 0 7 0,-5 0 12 16,0 0-9-16,5 0-7 0,-5 0-20 0,0 0 31 15,6 0-3-15,-6 0-17 0,0 0-1 16,5 0 0-16,-5 0 15 0,0 0-28 0,0 0 6 15,5 0-10-15,-5 0 36 0,5 0-4 0,-5 0-5 16,0 0-20-16,0 0 16 0,6 0-19 0,-6 0 6 16,0 0 12-16,4 0 5 0,-4 0-6 15,0 0 4-15,0 0 19 0,0 0-28 0,0 0 9 16,6 0-16-16,-6 0 36 0,0 0-21 16,0 0-30-16,0 0 35 0,0 0-7 0,5 0 2 15,-5 0-4-15,0 0 6 0,0 0-10 0,0 0 12 16,0 0 7-16,0 0-14 0,5 0 0 15,-5 0 3-15,0 0-2 0,0 0 7 0,0 0-11 16,5 0 0-16,-5 0-2 0,0 0-21 0,0 0 25 16,6 0-6-16,-6 0-7 0,9 9 30 15,-7-7-7-15,0 1 10 0,0-1-8 0,0-2-32 16,-1 3 27-16,2-1-28 0,-2 2 43 16,2-3-21-16,0 2 23 0,-2-1-55 0,2 0 43 15,-2 0-4-15,2 0 7 0,-1-2 10 16,-1 1-24-16,2 0-9 0,-2 2-8 0,2-2-1 15,-2 0 32-15,1 0-24 0,0 1 23 16,0-2-22-16,-1 1-8 0,0 0 39 0,0 1-29 16,-1-1 8-16,3 0-9 0,-3 0 7 0,1-1 13 15,0 1-4-15,1 0-25 0,-2 0 35 16,2-1-36-16,0 1 41 0,0-1-21 0,-1 1 8 16,-1-1 0-16,2 1-17 0,-1-1 13 0,1 1 5 15,0 1-23-15,1-1 34 0,-3-1-21 16,3 0 10-16,-2 1-12 0,1-1-19 0,2 0 13 15,0 0 10-15,-2 0 13 0,2 1-1 16,0 0-22-16,-1-1 28 0,2 0-25 0,-2 1 19 16,0-1-3-16,1 3 8 0,-1-3-11 15,-3 0-16-15,0 0-7 0,0 0 42 0,4 0-24 16,-4 0-19-16,6 0 27 0,-6 0-16 0,4 0 13 16,-4 0 2-16,0 0 4 0,7 0-11 0,-7 0-11 15,0 0-9-15,3 0 30 0,-3 0-10 0,7 0 3 16,-7 0-18-16,0 0 25 0,4 0-12 15,-4 0 6-15,0 0-19 0,7 0 26 16,-7 0 11-16,0 0-28 0,6 0 23 0,-6 0-29 16,5 0-5-16,-5 0 21 0,0 0 8 0,5 0-15 15,-5 0 4-15,0 0-11 0,5 0 15 0,-5 0-4 16,0 0-15-16,0 0 17 0,0 0-1 16,0 0-9-16,6 0 1 0,-6 0 7 0,0 0 1 15,0 0 18-15,4 0-19 0,-4 0-12 16,0 0 10-16,0 0-16 0,6 0 12 0,-6 0-4 15,0 0 10-15,0 0 5 0,5 0-5 0,-5 0 3 16,0 0-9-16,5 0 0 0,-5 0 10 0,0 0-5 16,5 0-4-16,-5 0-14 0,0 0 24 15,5 0-7-15,-5 0 14 0,0 0-10 0,6 0-11 16,-6 0 20-16,0 0-28 0,6 0 17 16,-6 0-18-16,5 0 35 0,-5 0-20 0,5 0 6 15,-5 0-3-15,0 0-22 0,5 0 16 16,-5 0 7-16,0 0-10 0,5 0 23 0,-5 0-31 15,0 0 26-15,0 0-31 0,0 0 0 0,6 0 31 16,-6 0-9-16,0 0-16 0,0 0 12 0,4 0 6 16,-4 0-3-16,0 0 5 0,0 0-4 0,0 0-10 15,0 0 3-15,6 0-1 0,-6 0 9 16,0 0-16-16,0 0 6 0,0 4 20 0,0-4-22 16,0 0 6-16,0 0 6 0,4 0 10 15,-4 0-26-15,7 6 18 0,-7-6-18 0,0 1 19 16,0-1-17-16,2 0 7 0,-1 2 14 15,-1 0 0-15,2-1-7 0,-2 1-1 0,2-1-4 0,1 1 0 16,-1-1-18-16,-1 2 27 0,0 0-1 16,1 0-7-16,-1-1-4 0,3 0 1 0,-1 1 5 15,0 1 4-15,0-2 12 0,2-1-12 16,-3 2-11-16,9 2 5 0,-4-2 22 0,-4-2-12 16,3 5-10-16,-2-5 10 0,-1 0-19 15,1 0 27-15,-2 1-25 0,0-2 12 0,2 1 12 16,-2 0-11-16,-1 0 6 0,2 0-6 0,-1 1-13 15,0 0 22-15,1-2-26 0,-1 0 16 16,-2 0-8-16,0 0 15 0,0 0 15 0,0 0-10 16,0 0-16-16,6 0 20 0,-6 0-19 0,5 0 6 15,-5 0-2-15,5 0 3 0,-5 0-3 16,5 0-5-16,-5 0-2 0,5 0 33 0,-5 0-14 16,6 0-4-16,-6 0-11 0,5 0 10 0,-5 0-15 15,6 0 5-15,-6 0 24 0,4 0-32 0,-4 0-3 16,6 0 12-16,-6 0 3 0,0 0-9 15,5 0-3-15,-5 0 7 0,0 0-2 0,6 0-1 16,-6 0 1-16,6 0 4 0,-6 0-3 16,0 0 25-16,5 0-32 0,-5 0 10 0,6 0 2 15,-6 0-11-15,4 0 7 0,4-10 1 0,-5 10-9 16,-1 0 20-16,1 0-2 0,-1-1-10 16,1 0 2-16,-1 1-14 0,-1-1 17 0,3 1-12 15,-1 0-7-15,-2-1 7 0,2 0 12 0,-1 0-8 16,0 0 0-16,0-1-12 0,-1 2 19 15,2 0 2-15,0-1-8 0,0 1-14 0,-1-1 47 16,0 1-37-16,1-1 4 0,0 0-3 0,-1-1 13 16,1 1-14-16,0 1 21 0,-2-1-25 15,1 0 22-15,-1-1-19 0,1 1-6 0,0 0 3 16,-2 1 5-16,0 0 4 0,0 0-3 16,0 0 8-16,0 0 16 0,0 0-32 0,5 0 30 15,-5 0-19-15,0 0-12 0,0 0-1 0,0 0 14 16,5 0-18-16,-5 0 27 0,0 0-1 15,0 0 7-15,0 0-21 0,0 0-8 0,0 0 9 16,6 0 24-16,-6 0-39 0,0 0 4 0,0 0 14 16,0 0-7-16,0-4 21 0,0 4-20 15,0 0 4-15,0 0-15 0,0 0 12 0,0 0-15 16,0 0 22-16,4 0 4 0,-4 0-15 16,0 0 16-16,4-5 0 0,-4 4 12 0,0 2-30 15,2-1 9-15,-2-1-3 0,1 1 2 0,-1 1 18 16,0-1-41-16,0 0-3 0,0 0-32 15,0 0-29-15,0 0-26 0,0 0 11 0,0 0-141 16,0 0-129-16,0 0 40 0,-1 3 18 0,1-3-15 16,0-3 53-16,1 2 25 0,-1 0 5 15</inkml:trace>
</inkml:ink>
</file>

<file path=ppt/ink/ink2.xml><?xml version="1.0" encoding="utf-8"?>
<inkml:ink xmlns:inkml="http://www.w3.org/2003/InkML">
  <inkml:definitions>
    <inkml:context xml:id="ctx0">
      <inkml:inkSource xml:id="inkSrc0">
        <inkml:traceFormat>
          <inkml:channel name="X" type="integer" max="32767" units="cm"/>
          <inkml:channel name="Y" type="integer" max="32767" units="cm"/>
          <inkml:channel name="F" type="integer" max="8191" units="dev"/>
          <inkml:channel name="T" type="integer" max="2.14748E9" units="dev"/>
        </inkml:traceFormat>
        <inkml:channelProperties>
          <inkml:channelProperty channel="X" name="resolution" value="1290.54749" units="1/cm"/>
          <inkml:channelProperty channel="Y" name="resolution" value="2151.47729" units="1/cm"/>
          <inkml:channelProperty channel="F" name="resolution" value="0" units="1/dev"/>
          <inkml:channelProperty channel="T" name="resolution" value="1" units="1/dev"/>
        </inkml:channelProperties>
      </inkml:inkSource>
      <inkml:timestamp xml:id="ts0" timeString="2022-10-31T18:27:37.062"/>
    </inkml:context>
    <inkml:brush xml:id="br0">
      <inkml:brushProperty name="width" value="0.06667" units="cm"/>
      <inkml:brushProperty name="height" value="0.06667" units="cm"/>
      <inkml:brushProperty name="color" value="#ED1C24"/>
      <inkml:brushProperty name="fitToCurve" value="1"/>
    </inkml:brush>
    <inkml:brush xml:id="br1">
      <inkml:brushProperty name="width" value="0.06667" units="cm"/>
      <inkml:brushProperty name="height" value="0.06667" units="cm"/>
      <inkml:brushProperty name="fitToCurve" value="1"/>
    </inkml:brush>
  </inkml:definitions>
  <inkml:trace contextRef="#ctx0" brushRef="#br0">0-11 354 0,'0'0'70'0,"0"0"23"0,0 0-50 16,0 0 29-16,0 0 4 0,0 0-32 0,0 0 8 15,0 0-5-15,0 0-7 0,0 0-2 16,0 0-5-16,0 0-4 0,0 0-3 0,0 0-2 16,0 0 19-16,0 0 27 0,0 0-13 0,0 0-6 15,0 0 18-15,0 0-30 0,0 0 4 16,0 0-4-16,0 0-65 0,0 0 3 0,0 0 60 15,0 0-13-15,0 0 0 0,0 0-5 16,0 0 9-16,14 0-22 0,-2 16 57 0,-9-16-46 16,-3 2 17-16,0 2-29 0,0-2-3 0,2 3-1 15,-2-4-1-15,1 1 34 0,1 1 16 0,-2-1-42 16,0 0 19-16,1 1-54 0,-1 0 13 16,0-1 18-16,0 2 42 0,4-3-36 15,-4 2 11-15,2 0-5 0,-2-1-7 0,1 0-33 16,1 2 49-16,-2-2-8 0,1-1-17 0,-1 3-11 15,3-1 37-15,-3-2 10 0,0 3-45 16,2-3 27-16,-2 2 7 0,2 0-15 16,-2-2-20-16,0 0 37 0,2 4-44 0,-1-3 21 15,1-1 9-15,-2 3-26 0,1-2 32 16,0 0 12-16,2 2-68 0,-3-3 41 0,1 0-4 16,-1 4 3-16,3-5 29 0,-3 2-33 0,0 0 7 15,2-1-8-15,-1 1-2 0,1 0-29 16,-2-2 58-16,0 1-1 0,2 1-10 0,1 1 6 15,-2-2-8-15,0-1-11 0,1 2-9 0,-2-1-20 16,2 1 46-16,0 0-21 0,0-1-6 0,-1 1 34 16,0-1-43-16,1 1-34 0,-2 0 33 0,2-2 30 15,-2 2 8-15,2-2-10 0,-1 2-28 16,0-1-16-16,-1 1 33 0,3-1 39 16,-3 0-67-16,1 0-3 0,2 1 52 0,-1-1-19 15,0 0-26-15,-1 0 36 0,-1-1-42 0,1 0 52 16,1 1 16-16,0 0-53 0,2 1 14 15,-2-2 11-15,-2 2-7 0,3-2 33 0,-2 2-42 16,2-2 24-16,-2 1-13 0,1 0 6 16,0-1-39-16,0 1 30 0,2 0 10 0,-3 0-2 15,2 0-39-15,-3-1 40 0,2 1-29 16,1 0 18-16,-2 1-26 0,2-2 11 0,-1 0 20 16,1 1 24-16,-3 0-19 0,4 0-41 0,-2 0 15 15,-1 0 32-15,2 0 3 0,-1 0 3 16,1 1-25-16,1-1-4 0,-4-1 21 0,0 0-14 15,0 0-25-15,0 0 56 0,0 0-71 16,0 0 48-16,6 0-3 0,3 8 8 0,-6-7-24 16,-3 1 20-16,2-2 27 0,1 3-24 15,-3-2 7-15,1 1-18 0,3 0 6 16,-3-1 28-16,0 2-65 0,3-2 42 0,-3 4-44 16,2-3 51-16,-3-2-44 0,4 3 62 0,-2-1-51 15,1 0 24-15,-2-2 8 0,2 2-34 16,-1-1 15-16,-2 2 8 0,2-3-22 0,-2 2 53 15,1 2-40-15,0-3 11 0,3 2-12 0,-2-2-10 16,0 4 6-16,0-4 9 0,0 3-18 16,0-2 34-16,-1 0-7 0,1-2 16 0,0 4-20 15,1-2-14-15,-2 2 17 0,3-1-35 0,-4-1-12 16,4 0 35-16,-3 1 20 0,0-1-21 16,1 0-2-16,-1 1 27 0,-1-1-8 15,2 1-29-15,1 0 14 0,-3-2 20 0,1 3 6 16,2-1-4-16,-3-1 15 0,2 3-33 0,-2-4 9 15,4 4 3-15,-4-3-24 0,4 2 43 16,-4-1-71-16,2-1 34 0,-2 2 36 0,3-1-61 16,-1 0 50-16,-1 0-8 0,1-1-26 0,2 3-33 15,-4-3 52-15,0 3-29 0,3-3 64 0,0 3-75 16,-2-3 57-16,1 1-47 0,-2 0 44 16,0 1-44-16,3-1 49 0,-1-1 1 0,-1 1-23 15,-1 0 18-15,3-1-10 0,-3 2 26 16,0-2-45-16,0 1 23 0,3 0-38 0,-3-1 27 15,2 3-1-15,-2-3 35 0,1 0-27 0,-1 3 10 16,3-3 3-16,-3 1-30 0,0-1 3 0,3 1-4 16,-2 0 22-16,1-2-18 0,-2-1 2 15,0 0-27-15,0 0 55 0,0 0 4 0,0 7-25 16,0-7-12-16,0 0-5 0,0 6 19 16,0-6-9-16,0 0-10 0,0 5 18 0,0-5 1 15,0 0-8-15,0 6-18 0,0-6 6 0,0 0 24 16,0 0-13-16,0 6 16 0,0-6-3 15,0 0-17-15,0 0 14 0,0 0-48 0,0 6 48 16,0-6 4-16,0 0-2 0,0 0-24 0,0 5 43 16,0-5-27-16,0 0 5 0,0 0-31 0,0 5 19 15,6-5 1-15,-6 0 16 0,0 0-16 16,0 7 9-16,0-7 5 0,0 0 21 16,0 0-72-16,7 0 54 0,-7 5-6 0,7 2-7 15,-4-6 15-15,-3-1 5 0,1 1-17 0,0-1-13 16,1 1-4-16,-1 1-10 0,-1-2 31 15,2 2-6-15,-2 0-8 0,0-1 30 0,2 0-16 16,-2 1-18-16,1 0-1 0,0-2 3 0,2 1 8 16,-3 0 4-16,0 1-14 0,1-1 39 15,-1 0-10-15,1 1-9 0,1-1-20 0,-2 0 3 16,0 1 14-16,0-1 0 0,0 0-23 0,1 1-15 16,-1-1 34-16,1 1-3 0,-1-2-29 15,0 0 61-15,0 0-36 0,0 0 2 16,0 0-4-16,0 0 18 0,0 0 19 0,0 6-30 0,0-6-10 15,0 0 21-15,0 6-14 0,0-6 6 16,0 0-36-16,0 5 52 0,0-5-21 0,0 0 17 16,0 6 10-16,0-6-6 0,0 0-10 15,0 5-3-15,0-5-9 0,0 6-1 0,8-6 3 16,-8 6 19-16,0-6 1 0,0 5-12 16,0-5 29-16,0 0-15 0,0 7-14 0,0-7-7 15,0 6 14-15,0-6 5 0,0 6-16 0,6-6 14 16,-6 6-9-16,0-6 6 0,0 6-9 0,0-6-9 15,0 5 13-15,8-5 11 0,-8 0-16 16,0 7 14-16,10 3-5 0,-9-7-11 0,2-3 5 16,-3 3-38-16,2 0 46 0,-2-3-15 0,0 0 1 15,0 0 19-15,0 0-13 0,0 0 4 16,0 5 0-16,0-5 5 0,0 0-11 0,0 6-26 16,0-6 17-16,0 0 10 0,0 6 7 0,9 0-31 15,-9-4 37-15,0 0-14 0,3-2-1 16,-3 1-6-16,3 0 8 0,-2 1-23 0,1-2 0 15,-2 0 34-15,3 1-8 0,-3 0-14 16,0-1 14-16,1 0-9 0,1 1-17 0,1 2 25 16,-3-5-12-16,0 0 7 0,3 2 3 0,-1-1-21 15,-1 0-14-15,-1-2 23 0,2 0-6 16,-1 1 25-16,-1 0-28 0,4-2 10 0,-2 4-1 0,-2-5-2 16,1 3 31-16,-1 0-31 0,2-3-6 15,-1 3 22-15,-1-1 0 0,0-1 0 0,4 2-36 16,-4-2 15-16,0 1 24 0,0-3-22 15,1 4-1-15,-1-1-5 0,2 0 11 16,-2-1 6-16,1 0 8 0,0 1 7 0,0-2-24 16,2 3-6-16,-3-1 22 0,1 1-13 0,-1-3 14 15,4 3-10-15,-4-1 27 0,0 3-10 0,0 0-35 16,0 0 23-16,0 0-19 0,0-7 13 16,0 7-3-16,0-5 1 0,0 5-25 0,0 0 53 15,0-7-27-15,0 7 32 0,0 0-41 0,0-6 16 16,0 6 3-16,10-10-1 0,-9 7-4 15,1 2 0-15,-2-1 7 0,1 0 6 0,0 0-35 16,-1 1 29-16,2 0-6 0,-1 0 17 0,-1 0 6 16,1 1-16-16,-1-2-12 0,1 2 1 15,-1 0-27-15,0 0 40 0,0 0-3 0,0 0-6 16,0 0-16-16,0 0 16 0,0 0 0 0,0 0-12 16,0 0 18-16,0 0-11 0,0 0 8 15,0 0 2-15,0 0-19 0,11-9 27 0,-10 7-7 16,-1 2 6-16,0 0-26 0,-1 0 16 15,2 0-26-15,-1 0 26 0,0 0-6 0,2 0 16 16,0 0-50-16,-1 2 37 0,0-1 10 0,2 1-5 16,-2-1-13-16,2-1 15 0,0 1 7 15,-1 2-6-15,1-3-4 0,-3 2-18 0,3 0 1 16,1-1 2-16,-2 1 14 0,1 0 11 0,-3 1-38 16,4-1 11-16,-1 0 17 0,0-1-9 15,-1 1-7-15,1 1 14 0,0 1-8 0,-3-2 9 16,3 1-4-16,0-1 3 0,-3 3-2 15,3-3 3-15,-1-1 19 0,2 3-11 0,-3-2-8 16,-1 0-6-16,3 2 6 0,-1-1-4 0,1 0-6 16,-2 0-6-16,2 0 6 0,-1-1 22 0,1 1-14 15,-1 0-23-15,2 0 23 0,-3-1 1 16,3 2-17-16,-1-1-3 0,-2 0 21 0,2 0 18 16,-2-1-20-16,1 1 0 0,1 0-1 0,0 0-1 15,0-1 2-15,0 1 4 0,-2 1-19 16,3-1 27-16,-3 0-12 0,1 0 6 0,-1 1-11 15,1-1-5-15,1 1-32 0,-2-2 12 0,2 1 24 16,-1 0-11-16,2 0 26 0,-3 0-7 16,2 0 21-16,-1 0-21 0,1 1 8 0,1-1-9 15,-1-1-21-15,-1 2 31 0,2-2-17 16,-3 0 4-16,1 2-24 0,0-1 35 0,0-1-7 16,2 1-10-16,-4 1-18 0,3-2 27 0,1 1 10 15,-2-1-28-15,2 1-3 0,-1 0 43 0,0-1-12 16,0 0-7-16,0 0 10 0,-1 2-30 15,2 0 5-15,-2-4 13 0,2 3 2 0,-3-2-9 16,3 1 11-16,-1-1-7 0,-2 3-12 0,-1-2 15 16,5-1-24-16,-4 0 25 0,2 3-11 15,-1-3 3-15,2 2-15 0,-3-2 7 0,2 0 15 16,-2 0-7-16,2-1-28 0,-1 2 1 0,1-1 28 16,-2 1 24-16,1-1-17 0,0-1-11 15,2 1-17-15,-2 0 30 0,1 0 2 0,-1-1-4 16,0 0-5-16,-1 1 0 0,2-1 20 0,-1 0-16 15,1 1-2-15,-2-1-22 0,0 0 2 16,2 0 24-16,0 0-37 0,0 0 2 0,-3 0 9 16,4 0 35-16,-3 0-7 0,-1 0-26 0,2 1 34 15,-2-1-13-15,1 0 2 0,-1 0 6 16,0 0 15-16,0 0-59 0,0 0 42 0,0 0 4 16,0 0-25-16,0 0 4 0,0 0 27 0,0 0 9 15,0 0-8-15,6 0-21 0,-6 0 1 16,0 0-8-16,0 0-6 0,8 0-22 0,-8 0 7 15,0 0 39-15,6 0 10 0,2 10-49 16,-5-10 32-16,0 0 12 0,1 2 11 0,-2 0-17 16,-1-1-8-16,1-1 0 0,-1 2-13 0,2-1-2 15,0 1 14-15,-1 0-3 0,-1-1-6 16,3 1 3-16,-1-1 11 0,-2 1-21 16,3-1 17-16,-1 1-11 0,0 1-9 0,0-1 49 15,0-1-14-15,0 1-27 0,1 1 33 0,-1 0-22 16,1-2-2-16,-1 3-8 0,1-2 28 0,-3 2 5 15,3-2-16-15,-1 0-31 0,0 0 31 16,1 1-1-16,-1 0-12 0,0 0-25 0,1-2 33 16,-1 1 22-16,2 2-15 0,-2-1-43 0,1-2 46 15,0 1-16-15,-1 0 16 0,3 1 0 16,-3-3-17-16,-2 2-1 0,2 1 15 0,3-1-5 16,-4 0 5-16,1 0-11 0,1 2-4 0,-1-2 4 15,-1 1 3-15,3 0-11 0,-1-2 22 0,3 10-11 16,1-5 0-16,1-2 3 0,-3 1 6 15,-3-2 13-15,2-1-41 0,-1 1 10 16,1-1 20-16,0 1-8 0,-1 0 4 0,0-1-17 16,0 0 13-16,1 0 13 0,0 0-1 0,-1 1 2 15,-1-1-58-15,0 0 42 0,3 1 2 16,-3-1-24-16,1 2 39 0,-1-2-19 0,0 1 8 16,2-2 7-16,-1 2-10 0,-2-1-9 0,1 0-31 15,2 0 17-15,-3 1 29 0,1-2-10 16,0 0-10-16,-1 1 9 0,1 2 3 0,-2-3 4 15,2 1-32-15,0-2 23 0,1 1 16 0,-1 0-14 16,-2 2 4-16,1-3 5 0,1 2-14 16,-2-2-29-16,2 2 57 0,0 0-27 0,-1 0 12 15,-1-2-22-15,3 2 34 0,-3-2-37 16,3 0 1-16,-3 0 1 0,2 1 21 0,-2-1-32 16,-1 0 32-16,0 0-13 0,0 0-4 0,0 0 31 15,0 0-8-15,0 0-32 0,0 0 18 16,8 0 10-16,-8 0-4 0,0 0 10 0,0 0-30 15,13-9 8-15,-12 7 14 0,2 2-6 0,-2-2-14 16,0 0-4-16,0 0 26 0,1 1-4 16,-1-1-14-16,0-2 28 0,-1 2-14 0,2-2-5 15,-1 2-8-15,-1-1 9 0,3 0-14 16,-3 1-28-16,0-3 63 0,3 3 1 0,-3-2-17 16,1 0-5-16,1 0-5 0,1 0 15 0,-3 2-3 15,0-2-4-15,0 1-4 0,3 0 2 16,-3 0-8-16,0-1 1 0,0 4-14 0,1-3 12 15,-1 3-27-15,0 0 7 0,0 0 59 0,0 0-31 16,0-7 8-16,0 7 24 0,0-5-38 16,0 5-29-16,0-7 30 0,0 7 0 0,0 0 36 15,12-11-31-15,-12 9 11 0,0 0-11 0,0 0 13 16,2-1-16-16,-2 1 13 0,3 0-5 16,-2 0-11-16,1-1-20 0,-1 1 34 15,1-1 20-15,-2 3-4 0,0 0-64 0,0 0 4 16,0 0 19-16,0 0 21 0,0-5-1 0,9-4 14 15,-5 8-21-15,-2 0 31 0,-1-2-33 0,2 2 3 16,0 0-16-16,-1-1 31 0,2 1 10 16,-1-1-22-16,1 2 12 0,2 0-20 0,-2-2-2 15,-3 1 18-15,4 0-11 0,-1 0-2 16,-2-1-27-16,1 1 39 0,2 1 16 0,-4-2-27 16,3 0 15-16,-1 0-16 0,-2 2 17 15,2-2-6-15,-1 2-11 0,1-2 14 0,-2 2-17 16,4-1-2-16,-4-1 8 0,2 1 13 0,-2-1 9 15,2 2-13-15,0-3-5 0,-3 1-2 0,3 0-4 16,-3-1 9-16,3 2-13 0,-2-1-7 16,0 1 17-16,2-2-12 0,-1 1 13 0,-2-1 12 15,3 3-28-15,-1-4 5 0,1 2-24 16,-3 1 27-16,0 1 31 0,0 0-21 0,0 0 14 16,0 0-44-16,0 0 19 0,0-5-34 0,0 5 51 15,0 0-21-15,10-12 22 0,-8 10 3 16,2 0-14-16,-4 1-9 0,3-1 1 0,-3 0 37 15,2 0-14-15,-1 0-23 0,1 0-2 16,-1 0 14-16,2 0-11 0,-1 2-11 0,-2-3 26 16,1 1-13-16,-1 0-7 0,3 0 8 0,-3 0 12 15,3 0-1-15,-3 0-16 0,3 0 8 16,1 2 10-16,-4-4 15 0,4 4-33 0,-1-2 3 16,-2 1 4-16,1 0 23 0,-1-3-32 15,4 4 2-15,-2-2 2 0,-1 1-35 0,0-1 50 16,1 1 6-16,-1 0-22 0,2-1 17 0,-3 0-4 15,1 0 16-15,-1 0-34 0,3 1 17 0,-2 0-38 16,1-1 25-16,-2 2-22 0,2-2 43 16,-1 0 8-16,1 2-17 0,-2-2 4 0,2 2-14 15,0-1-3-15,0 0 27 0,-3 0-40 16,5 0 13-16,-2-1 15 0,-1 1-47 0,1 1 64 16,-1-2-12-16,2 1-14 0,-1 1 4 15,-1-1-2-15,1 0 7 0,1 0-10 0,-1-1-1 16,0 2 2-16,-2-2 17 0,4 0-21 15,-2 2 1-15,-1-1-25 0,1 0 35 0,-1 1 7 16,1 0-28-16,-1 0 31 0,2-2-10 0,-4 1-23 16,2 1 50-16,1-1-18 0,0 1-10 0,-3 0-20 15,3-2 30-15,-1 2-13 0,2 0 3 16,-3 0-1-16,-1-2 13 0,4 2-2 16,-3-1-4-16,-1 1 0 0,3-2-18 0,-1 1-11 15,0-1 31-15,-1 2-13 0,0 0-29 0,2-2 45 16,-2 1-3-16,-1-1-38 0,1 2 29 15,2 0 23-15,-1-1-22 0,-2 0-27 0,0-1 41 16,1 2-18-16,1 0 8 0,-1 0-9 0,2-3 20 16,-2 3-17-16,0-2 11 0,0 2 4 0,2-1-32 15,-3 0 22-15,1 1-4 0,3-1 10 16,-4 1-6-16,4-2-4 0,-3 2-5 0,0-1 34 16,1 0-22-16,-1-1-31 0,2 2 9 15,-1 0-1-15,-2-1 24 0,3 0 5 16,-2 1-22-16,2 0 27 0,-1-1-11 0,-2 0-9 15,1 0-3-15,1 1 2 0,1-1 7 0,-3-1-11 16,3 1 8-16,-3 1 12 0,0 0-8 16,0 0-11-16,0 0 0 0,0 0-13 0,0 0 25 15,0 0 0-15,10-8-20 0,-7 8-19 0,-3-1 44 16,2-1-17-16,1 2 11 0,-3 0-30 16,3 0 36-16,-2-2-12 0,-1 2 20 0,3-1-24 15,-3-1 12-15,0 2-2 0,3 0-9 16,-3 0-1-16,2-1 12 0,-1 0-7 0,1-1 1 15,-2 1 6-15,3 1-9 0,-2 0-29 0,3 0 48 16,-3-1-12-16,3 0-3 0,-2 0-28 0,-1 0 18 16,2 1 9-16,0-1-2 0,-1 1-14 15,1-2-16-15,-1 2 38 0,1 0 6 0,-2 0-16 16,3 0 4-16,-4 0 7 0,0 0 5 16,0 0-28-16,0 0 4 0,6 0 15 0,-6 0-5 15,0 0-15-15,8 0 17 0,-8 0 5 0,5 0-19 16,-5 0-4-16,0 0 9 0,18 8 16 0,-16-5 6 15,2-2-4-15,1 2-29 0,-4-1 25 16,2 0-8-16,2-1-13 0,-2 1 34 0,-1 1-16 16,4 0-8-16,-5-2-1 0,5 3-12 15,-5-1 20-15,4-2 1 0,-2 3 5 0,-1-1 11 16,1-1-46-16,0 1-9 0,0-1 18 0,1 2 22 16,-1-1 0-16,-1-1 23 0,-1 3-47 15,2-2 41-15,0-1-49 0,-1 2 37 0,1-2-27 16,-2 2 24-16,2-1-29 0,3-1 24 0,-5 1-15 15,0 2 34-15,3-3 9 0,-2 2-24 0,0 1-16 16,1-3 9-16,-1 3 14 0,0-3-13 16,1 2-7-16,-2-1 0 0,3 1 12 0,-2 0-33 15,-1 0 32-15,0-2 0 0,0 1 3 16,3 0-1-16,-2 1-44 0,-2-1 57 0,2-1-13 16,-1 2-34-16,1-2 31 0,-1 0-16 0,1 1 22 15,0 0 1-15,0-1-9 0,-2-1 15 16,3 2-15-16,-1-1 5 0,0 1-23 0,0-1 9 15,-2 2 37-15,2-4-23 0,0 4-1 0,-2-2 7 16,4 0-3-16,-3 0-5 0,3 1-10 0,-2 0 12 16,1-1 13-16,-2 1-40 0,1-1-16 15,1-1 57-15,-1 2-32 0,1-1 7 0,-3 1 0 16,3 0-25-16,1-2 40 0,-3 0-11 0,2 2-33 16,-1-1 39-16,1-1 4 0,-2 0-10 15,3 2-6-15,-3 0 22 0,2-2-8 0,-1 0 0 16,1 1-17-16,-1 0 16 0,1 0 8 15,-1-2-8-15,1 2-17 0,-1 1-5 0,0-2-19 16,0 0 39-16,-2 0-7 0,3 1-8 0,-1-1-20 16,-2-1 50-16,3 1-30 0,-1 1 2 15,-2-2-15-15,0 2 35 0,2-2-7 0,-1 1-22 16,-1 0-9-16,2 0 9 0,-1 1 15 0,-1-1 28 16,2 0-47-16,-1 0 39 0,1 1 14 15,-1 1-5-15,0-3-14 0,0 0-5 0,2 2-22 16,-2 2 16-16,1-3 0 0,-1 0 11 0,0 1-38 15,1 0 51-15,0 0-15 0,0 0-3 16,0 0-1-16,0 0-23 0,-2-1 26 0,3 2 16 16,-3 2-32-16,2-4-15 0,-2 2 28 0,2 0-21 15,-1-2 16-15,0 2 15 0,-1 0-11 16,3-1 9-16,-3 2-4 0,1 0-6 16,-1-2-45-16,1 2 40 0,2 0 18 0,-3-4 0 15,0 0-24-15,0 0 11 0,0 7-4 0,0-1-1 16,0-6 15-16,0 5-22 0,0-5-3 0,0 7-26 15,0-7 7-15,0 7 35 0,0-7-22 0,0 8 15 16,0-3-22-16,0-5 36 0,0 7-22 16,0-7-1-16,0 5 25 0,0 1-14 0,0-6-9 15,0 6 18-15,0-6 3 0,0 6 0 16,0-6-45-16,0 6 55 0,0-6-12 0,0 5 12 16,0-5-3-16,0 6-26 0,0-6 26 0,0 6-54 15,0-6 43-15,0 6-34 0,0-6 41 0,0 0 7 16,0 5-17-16,0-5 2 0,0 6-38 15,0-6 12-15,0 6 24 0,0-6-2 0,0 0-29 16,0 8 42-16,0-8-7 0,0 6-4 16,0-6 23-16,0 5-17 0,0-5-3 0,0 6-15 15,0-6 35-15,0 6-2 0,7-6-22 0,-7 5-11 16,0-5-3-16,0 0 35 0,0 8-30 16,0-8 11-16,0 7 3 0,6-7-7 0,-6 7-32 15,0-7 1-15,0 6 16 0,0-6 40 0,0 5-29 16,0-5-3-16,0 7 17 0,0-7-11 0,0 6-5 15,7-6-12-15,-7 6 30 0,0-6-7 16,0 8-40-16,0-8 46 0,0 7-1 0,8-7-15 16,1 14-24-16,-8-11-2 0,-1 1 36 15,3-1-27-15,-3 0 30 0,2 1-18 0,-2-1 22 16,3 0-2-16,-3-1 6 0,3 2-23 0,-3-2 19 16,3 0-7-16,-3 2-3 0,1-2-35 0,-1 3 32 15,3-3 9-15,-1 0-11 0,-2 1 9 16,3 0 9-16,-2 0-33 0,2 0 26 0,-1-1-6 15,-2 2-9-15,2-3-18 0,-2 2 9 0,1 0-7 16,2-1 17-16,0-1 24 0,-2 2-26 16,2-1-1-16,-1 0 16 0,1 0 3 15,-2 0-38-15,1 0 20 0,-1 0 17 0,0 1-10 16,3-1 1-16,-3-2 29 0,2 4-47 16,-1-2-12-16,1 0 31 0,-1 0-6 0,1 0-3 15,0 0-12-15,-1 0 26 0,-1 0-21 0,3 1 25 16,-2-1-17-16,1-1 2 0,0 2 19 15,-3-1-7-15,4-1 4 0,-2 1-7 0,2 1 14 16,-3-3-13-16,3 2-6 0,-2-2 0 16,2 2-4-16,-2 1 13 0,0-2-18 0,1 0 0 15,0 2-6-15,0-1 10 0,0-1 0 16,-2 0 5-16,5 1-5 0,-3-2 27 0,-2 2-21 16,3 1-19-16,-3-3-8 0,4 2 28 0,-1-2 0 15,-4 1-2-15,5 1-4 0,-1 1 11 0,-3-3 0 16,4 2-13-16,-2-2-19 0,0 1 35 15,0 2-5-15,0-2-7 0,1 0 3 0,-1-1 2 16,-1 2-20-16,0 0 2 0,3-1-2 0,-3 1 24 16,0-1 0-16,1 0 6 0,-1 0-17 15,3 2 8-15,-2-3-10 0,-1 2 7 0,2-2-7 16,-2 2 9-16,0 0 1 0,3 1-21 16,-2-2-3-16,1 3 26 0,-1-3-6 0,0 1-4 15,1 1 4-15,-2-1-3 0,2 0-27 0,-1-1 25 16,1 3-18-16,-1-4 32 0,0 1-33 0,-2 1 34 15,4 1 11-15,-2-2-13 0,-3 0-2 16,2 0-26-16,2 3 31 0,0-2-13 16,-2-2 2-16,1 3 23 0,-2 1-18 0,4-4 14 15,-5 2-25-15,3 2 6 0,-1-2-4 0,2 0-11 16,-4 1 20-16,4-1-21 0,-1 0 18 0,0 2-14 16,-1-2 2-16,-1-1 6 0,2 4 9 15,0-3-3-15,-1 0-11 0,-1 1 27 0,0-1-19 16,3 2-19-16,-2-1 21 0,0-2-34 15,0 1 29-15,-2 3 18 0,4-3-2 0,-1 1-9 16,-1-1 18-16,0 2-10 0,0-1-22 16,1 0-16-16,0 0 49 0,-1-1-30 0,0 2-3 15,0-1-25-15,1-1 23 0,-1 1 12 16,2-1 13-16,-1 2-10 0,-1-2-2 0,0 0 12 16,1 2-13-16,-1-2-9 0,1 0 6 15,-1 1 18-15,-2-1-25 0,4 0 9 0,-2 1-3 16,-1 0 7-16,1-1-15 0,1 0 27 0,-2 1-17 15,3-1-18-15,-2 1 21 0,1 1 9 0,-3-4-28 16,2 3 1-16,1-1-10 0,-2 1 40 16,4-2-13-16,-5 1 20 0,3 2-51 0,0-2 22 15,-3 1 5-15,4-1 19 0,-1 0 6 16,0 2-13-16,0-3 5 0,-1 2-41 0,-1-1 44 16,-1 0-14-16,3-2-35 0,0 4 14 0,-1 0 29 15,1-2 9-15,-1-1-12 0,0 1-5 0,-1 0 6 16,2-1-26-16,-2 2 39 0,1-1-50 15,-1-2 42-15,2 2 1 0,-1 0-18 0,-1 2 19 16,-1-4 4-16,4 1-16 0,-4 1-17 16,0 1 24-16,4-2-37 0,-2 0 33 0,0 2-17 15,-1-2 17-15,0 2-18 0,1-3 18 16,-1 1-6-16,1 0-30 0,-2 1 23 0,0-2 18 16,2 2-45-16,-1-1 49 0,0-1-7 0,-1 0 9 15,2 0-44-15,-2 2 18 0,1-2 17 0,-1 0 4 16,1 0-8-16,0 1 8 0,-1-1-6 15,0 2-33-15,3-2 51 0,-1 0-25 0,-2 2 10 16,3-2-17-16,-3 1 20 0,0-1-21 0,0 0 27 16,0 0-19-16,0 0-10 0,0 0-3 15,0 0 25-15,0 0-6 0,0 0-33 0,6 0 7 16,-6 0 29-16,0 0-37 0,0 0 37 16,9 0 4-16,-9 0 4 0,0 0-27 0,0 0-2 15,8 0 22-15,-8 0-8 0,0 0-10 16,7 0-7-16,-7-6 26 0,9-2-34 0,-8 8 3 15,2 0 20-15,-3 0 9 0,0 0-28 16,0 0 48-16,0 0-7 0,0 0-22 0,0 0 6 16,0 0-24-16,0 0 20 0,0 0 3 0,0 0 0 15,0 0-13-15,0 0 20 0,0 0-13 16,0 0 3-16,0 0-21 0,0 0 33 0,6 0 6 16,-6 0-48-16,9-11 20 0,-9 10 26 15,0 1-8-15,0-1-11 0,0 1 0 0,2 0-3 16,-1 0 6-16,-1-2-1 0,0 4-16 0,0-4 11 15,0 4-7-15,0-4 18 0,3 2 12 16,-3 0-22-16,0-1 13 0,0 1-14 0,0 0 25 16,0 0 3-16,0 0-24 0,0 1-34 0,0-1 37 15,0-1-3-15,0 1 11 0,4 0-38 16,-4 0 44-16,0 0-18 0,0 0-1 0,0 0-4 16,0 0-3-16,0 0-17 0,2 0 27 15,-4 0-1-15,4 0-3 0,-2 0 16 0,0 0-30 0,0 0 18 16,0 1-2-16,1-1-13 0,-1 0 22 15,0 0-14-15,0 2-9 0,0-2 17 0,0 1 27 16,0-2-37-16,0 2 4 0,0 2 8 16,3-2 14-16,-3-1-22 0,0 3-1 0,1-2-3 15,-1 1 15-15,0-2-35 0,0 2 13 0,0-1 30 16,0 1-5-16,1 0-14 0,1-1 3 16,-2 1 6-16,0 1 1 0,0-1-14 0,1-2-18 15,-1 1 41-15,1 3-40 0,0-4 31 0,-1 2-31 16,0 0 42-16,3-1-11 0,-3 1-2 0,0 0 1 15,1 0 1-15,1-1-31 0,-2 1 29 16,0 0 3-16,1-1-8 0,-1 1 8 16,0-2-19-16,2 3 30 0,-2-1-14 0,0-1 5 15,0 0 1-15,0 2-13 0,0-1 10 0,4 0-5 16,-4-1 21-16,3 1-32 0,-3 0 9 0,1 1-8 16,-1 0 15-16,0-3-14 0,0 3 15 15,2 0-9-15,-2-3-2 0,0 0-4 0,0 0 22 16,0 0-7-16,0 0 15 0,0 0-29 0,0 0 3 15,0 6 2-15,0-6 16 0,0 0-26 16,0 0 27-16,0 7-55 0,0-7 29 0,0 0 5 16,0 6-9-16,9 2 39 0,-9-8-29 0,2 3 11 15,-1-1-4-15,0 0-19 0,-1-1 22 0,0 3-7 16,0-3 4-16,4 0 5 0,-4 1-14 16,3-4-14-16,-3 2-12 0,1 3 40 0,-1-1 0 15,0-2-22-15,1 2-1 0,0 0 27 16,-1-1-9-16,3-2-9 0,-2 2-10 0,1 1 29 15,-2 0-33-15,0-2 16 0,1 1-11 0,1-1 32 16,-2 2-11-16,0-2-5 0,3 2 3 16,-2 0-3-16,1-1-14 0,-2 0 27 0,2-1 14 15,0 1-33-15,-2-1-22 0,0 2 17 0,3 1 24 16,-2-3-2-16,-1 1-10 0,3 0 0 16,-1 0 16-16,0 0-1 0,0 0-16 0,-2 1-4 15,4-2 10-15,-1 2-5 0,-2-2 0 16,2 2 7-16,0 0-12 0,0-1 1 0,-2 0-12 15,1 0 18-15,1 1 0 0,0-1 21 16,-3 0-13-16,3 1-19 0,0-2-28 0,-3 2 30 16,4-2 23-16,-2 2 3 0,1-2-14 0,-2 2-6 15,-1 1-11-15,3-2-1 0,1 1 1 16,-3 0 8-16,1-2-3 0,1 2-13 0,1 0 28 16,-3 0 12-16,1 0-29 0,1 0 7 15,0 0 5-15,-2 0 5 0,1 0-23 0,-2 1 4 16,3-3 14-16,-2 4-8 0,2-3-14 0,0 1 15 15,0 0 12-15,-2 1-32 0,2-1 22 0,0 0-5 16,-2 0 14-16,1 0-36 0,-2 1 17 0,4-1-3 16,-1-2 26-16,-1 3 0 0,-2-2 13 15,4 3-9-15,-1-2-5 0,-2 0 14 0,1-1-13 16,0 2-39-16,-1-2 23 0,0 1-4 16,1-1-1-16,-1 1 12 0,2 0-9 0,-3 1 13 15,0-3-9-15,0 0-4 0,0 0 1 0,0 0 1 16,0 0 3-16,0 0-4 0,0 0 11 0,0 0-7 15,14 8-21-15,-14-8 30 0,0 0-6 16,3 0-10-16,-3 0-4 0,0 0-7 0,0 0 22 16,0 0-47-16,0 0 36 0,0 0-14 15,6 0 25-15,-6 0-5 0,0 0-10 0,0 0-1 16,6 0 18-16,6-7 0 0,-11 4-29 0,2 3 4 16,0-2 28-16,-3-1-8 0,2 0-12 15,-1 2 38-15,1-2 1 0,-1 1-28 0,1-1-21 16,1 1 20-16,0-1 3 0,-3 0 4 0,1 1-5 15,1 1 13-15,-1-4-57 0,1 2 59 16,-1 1-34-16,2-2 17 0,-3 1 6 0,0-1-7 16,0 3-1-16,2-4 9 0,-2 1-45 15,0 2 40-15,3-1-20 0,-2 0 30 0,1 3-14 16,-2-4 14-16,2 2-41 0,-1 0 33 0,-1 2-1 16,0 0 3-16,0 0 8 0,0 0-3 0,0 0-11 15,0 0 13-15,0 0 2 0,0 0-38 16,0-6 61-16,0 6-34 0,0 0-16 0,0 0 35 15,0 0-7-15,0 0-25 0,0 0 9 16,0 0 0-16,0 0 16 0,0 0-13 16,0 0-10-16,0 0 18 0,0 0-16 0,0 0 12 15,0-6 7-15,0 6 16 0,0 0-34 0,0 0 6 16,11-5 10-16,-11 5-38 0,0 1 19 16,0-2 20-16,0 1-1 0,0 0-12 0,0 1 6 15,0-1 4-15,1 0-3 0,1 0-21 16,-2 1 7-16,3 0 16 0,-3 1-9 0,0-2-3 15,3 2-15-15,-3 0 32 0,3-1 16 0,-3-1-48 16,1 3-5-16,1-1 7 0,-1 0 24 16,0 0-12-16,1 0-1 0,-1 2 19 0,1-2-8 15,-2 0-6-15,4 1-13 0,-2 0 27 16,-1 1 7-16,2-1-27 0,-2-1 9 0,0 1 9 16,0 0-12-16,4 1-7 0,-2-2-1 0,-1 1 22 15,-2-1-8-15,3 1 13 0,1-1-25 16,-4 1 5-16,3-2 10 0,-2 2-11 0,1 1 6 15,2-3 6-15,-4 1-6 0,1 1-20 0,1-2 21 16,-1 2-17-16,1-1 29 0,1 0-19 16,-3 1 0-16,3 0-1 0,-1-1 9 0,-1 1-1 15,2-1 0-15,-1 1-16 0,2-1 13 0,-3 0 5 16,-1 2-7-16,0-2 22 0,3 0-16 16,-1 0-13-16,-1 0 18 0,1 1-19 0,0-1 12 15,-2 1-22-15,0-2 14 0,3 2 14 0,0 0 3 16,-3-1-18-16,0 1 6 0,0 0 5 15,1 0 2-15,-1-2-43 0,3 2 54 0,-3-1-6 16,0-1-5-16,3 2-15 0,0-1-4 16,-2 2 18-16,-1-2-3 0,4 0-3 0,-4 1 21 15,0-3-27-15,0 0-10 0,0 0-3 0,0 0 13 16,0 7 13-16,0-7-1 0,0 5 18 0,9 4-5 16,-8-7-46-16,0 1-4 0,2-1 29 0,1 0-6 15,-2 1-3-15,-2 1 38 0,1-2-56 16,-1-1 56-16,3 2-22 0,0 0 24 0,-2-2-34 15,2 1 11-15,-3 1-20 0,2-1 19 16,1 0 11-16,-3 0-27 0,1-1 39 0,3 2-28 16,-4-3-9-16,0 2 29 0,2 0-55 0,-1 0 43 15,1 0-3-15,-1-2 9 0,0 0-18 16,1 1 4-16,0-1-3 0,-2 2-4 0,1-2 16 16,1 2 1-16,-1-1-6 0,-1-1 4 15,3 1-40-15,-2-1 31 0,1 1-40 0,-2-1 63 16,5 0-15-16,-2 0-17 0,-3 0 13 0,3 0 1 15,-3 0 0-15,0 0-2 0,0 0-23 16,0 0 28-16,0 0-12 0,0 0-2 0,0 0 14 16,0 0-26-16,0 0 26 0,0 0-44 0,6 0 29 15,-6 0 17-15,0 0-34 0,0 0 43 0,0 0-10 16,0 0-13-16,0 0 12 0,0 0-22 16,0 0 15-16,6 0-29 0,-6 0 52 15,0 0-14-15,0 0 2 0,0 0-8 0,0 0 9 16,10-6 1-16,-8 7-32 0,-1-1 20 0,-1 0 8 15,0 0-2-15,0 0 0 0,3 2-14 16,-3-2 9-16,0 1 9 0,0-1 1 0,2 1-9 16,-2-1 9-16,0 2 0 0,0 0-40 0,1 0 22 15,1 0-19-15,0 0 16 0,-4 1 33 0,4-2-16 16,1 1-36-16,-3 0 41 0,1 0-12 16,3 0-2-16,-4 2 5 0,0-2 2 0,3 0 14 15,-1 0-44-15,-2 1 39 0,1 0-21 16,-1 1-2-16,3-1 32 0,-3-1-19 0,3 2 7 15,-1-2-28-15,-2 3 15 0,1-3-3 0,2 1 12 16,-2 0 8-16,0 1-7 0,1-2-7 0,0 2-33 16,0-1 3-16,-2 0 35 0,2 1 14 15,-1-2-8-15,0 0-3 0,1 3-6 16,-2-5 0-16,0 0 10 0,0 0-32 0,0 0 16 16,0 7 6-16,0-7 14 0,9 9-24 0,-7-6 9 15,-1 0-9-15,2-1 11 0,-2 0 1 16,0 1-3-16,1-3-3 0,-1 2-5 0,0 1 24 15,0-1-22-15,1-1-24 0,-1 1 34 16,2 2-35-16,-2-3 38 0,0 0-27 0,0 1 10 16,2 1 15-16,0-2-10 0,-1 0 2 0,-1 0-13 15,1-1 23-15,0 2-10 0,2 1 0 0,-4-3 7 16,1 1 0-16,1 0-16 0,1 0 10 16,0-1-7-16,-2 3 14 0,1-2 6 0,1-1-20 15,0 1 6-15,1-1 7 0,-2 1-15 16,-1 0-22-16,2-1 51 0,2 1-47 0,-2 0 30 15,1 1-14-15,-1-2 18 0,0 0 11 16,2 0 0-16,-4 0-25 0,2 0-12 0,-3 0-12 0,0 0 41 16,0 0-18-16,0 0 8 0,6 0-6 15,-6 0 21-15,0 0-12 0,9 0 10 0,-9 0-9 16,0 0 5-16,6 0-24 0,-6 0 24 16,0 0-6-16,0 0-3 0,0 0-20 0,6 0 34 15,-6 0 9-15,0 0-29 0,0 0-11 16,0 0 20-16,15-8-43 0,-14 7 3 0,0-1 58 15,0 1-59-15,1 0 54 0,0 1-11 0,0-1-29 16,-2 1 14-16,2-3-18 0,-1 1 34 16,-1 2-17-16,0 0-13 0,4 0 42 0,-1-1-14 15,-2 0-1-15,0 1 33 0,1-1-40 0,-1-1 21 16,-1 2-21-16,0 0 11 0,0 0-7 16,0 0 21-16,0 0 0 0,0 0-15 0,0 0-21 15,0 0 15-15,0 0 2 0,0 0 3 16,0 0-12-16,0 0 7 0,0 0-9 0,0 0 14 15,6 0 6-15,-6 0-35 0,0 0 21 0,0 0-7 16,0 0-22-16,0 0 27 0,0 0-16 0,0 0 26 16,0 0-33-16,0 0 27 0,8 0-5 15,-8 0 16-15,0 0-8 0,9 7-5 0,-9-4-5 16,1-1 15-16,2 1-1 0,-3-1-11 16,0 0-27-16,0 1 45 0,1-1-46 0,0 0 43 15,2 2-27-15,-3-3 33 0,0 2-12 0,1-1-8 16,2 0 35-16,-3 0-19 0,0-1 3 0,2 1-16 15,-2 1 16-15,0-1-10 0,4-2-7 16,-4 2 11-16,0 1 9 0,1-1-13 0,-1-2-46 16,3 2 10-16,-3-1 19 0,2 1 10 15,-2-1 3-15,3 0 2 0,-3-1 23 0,1 1-21 16,3 1-10-16,-4 0-21 0,4-1-3 0,-4 0 35 16,3-1 9-16,0 1-23 0,-2-1-20 15,-1 0 32-15,0 0-3 0,0 0-27 0,0 0-1 16,0 0 33-16,6 0-12 0,-6 0-9 0,0 0 10 15,0 0 13-15,8 0-17 0,-8 0-19 0,0 0 26 16,9 0-5-16,-9 0-34 0,12-8 32 16,-12 6 13-16,2 0 8 0,-1-1 2 0,1 1-19 15,-1-1 3-15,-1 1-1 0,1 0 4 16,1-1-15-16,-2 0 45 0,0 2-35 0,3-4 3 16,-1 3-27-16,-2-1 14 0,1 0 25 15,-1 1-50-15,0-2 26 0,0 2 25 0,1 0 5 16,0-2-6-16,-1 2 1 0,0-2-12 0,2 2 10 15,-2 0-6-15,0-1-1 0,0 1 23 0,0 1-34 16,0-3 10-16,1 2-14 0,-1 1 11 16,0 0 1-16,0-1 0 0,0-1-4 0,0 2 24 15,1 1-62-15,-1 0 53 0,0 0 0 0,0 0-32 16,0 0 36-16,0 0-41 0,0 0 18 0,0 0 44 16,0 0-31-16,0 0 11 0,0 0-24 15,0 0 14-15,0 0-2 0,0 0-2 0,0 0-12 16,0 0 35-16,0 0 3 0,0 0-64 0,3-6 13 15,-2 6-3-15,-1 3 39 0,1-1-7 16,1-2-12-16,-2 1 27 0,1 1-10 0,-1 0-3 16,1-1-22-16,1 1 13 0,-1-1 9 15,-1 0-8-15,3 3-14 0,-1-3 25 0,-1 0-16 16,0 1 13-16,1 1-42 0,-2-1 44 0,2-1 1 16,1-1-10-16,-2 1-4 0,2 3 29 0,-3-4-20 15,1 1-9-15,2-1 26 0,-2 1-36 16,1 0-34-16,3 1 0 0,-5-1 42 0,3 0-2 15,1-1 25-15,-2 1-19 0,1-1 24 16,-3 0-23-16,4 0-2 0,-2 0 1 0,-2 0-14 16,0 0 15-16,0 0 5 0,0 0-32 0,9 0 20 15,-9 0-40-15,0 0 45 0,4 0-37 16,-4 0 49-16,0 0-15 0,8 0 11 0,-8 0-6 16,0 0 10-16,7 0-12 0,-7 0-43 15,0 0 48-15,8 0 11 0,-8 0-3 0,0 0-26 16,0 0-6-16,6 0 59 0,-6 0-37 0,0 0-28 15,8 0 27-15,2-8 7 0,-6 8-41 16,-4-3 38-16,0 2-21 0,2 0 42 0,-2 1-32 16,2-1 9-16,-2 0-22 0,3 0 8 15,-1-3 42-15,-2 2-31 0,0 1-37 0,1-3 53 16,-1 2-58-16,1 0 56 0,-1-2-32 0,0 2-20 16,0-3 57-16,0 3-47 0,0 2 21 15,0 0 14-15,0-7 6 0,0 7-7 0,0-8 33 16,0 3-19-16,0 5-10 0,0-8-31 0,0 1 6 15,0 7 30-15,0-8 13 0,0 2-28 16,0 0-43-16,0 6 61 0,0-8-59 0,0 1 45 16,0 7 25-16,0-7-12 0,0 0-11 0,0 2 20 15,0 5-10-15,0-8-10 0,0 2-41 16,0 6 18-16,0-8 19 0,0 2 9 0,0 0 1 16,0 6 10-16,0-7-27 0,0 1-4 15,0 6 11-15,0-7 1 0,0 7-28 0,0-8 25 16,0 8 4-16,0-6-22 0,0 6 17 0,0-7 12 15,0 7 13-15,0-7-26 0,0 7 10 16,0 0-49-16,0-6 54 0,0 6-29 0,0 0 18 16,0 0-15-16,0-6 21 0,0 6-22 0,0 0 32 15,0 0-22-15,0-5 9 0,0 5-27 16,0 0 34-16,0 0-2 0,0 0 14 0,0-6-45 16,0 6 2-16,0 0 28 0,0 0 7 0,0 0-13 15,0 0 1-15,0 0-43 0,0 0 41 16,0 0 14-16,0 0-3 0,0 0 12 0,8-9-18 15,-8 8 14-15,0 2-52 0,1 1-14 16,-1-2 47-16,0 0 6 0,0 0 2 0,3 0-54 16,-3 0 52-16,0 0-8 0,0 2 14 0,0-1-4 15,0 0-41-15,0 1 62 0,0 1-31 16,0-3 3-16,0 4-3 0,0-2-20 0,0 0-27 16,0 2 52-16,2-1-11 0,-2 1 37 15,0 1-28-15,2-3 9 0,-1 1-11 0,-1-3-3 16,0 0 13-16,0 8-6 0,0-2 8 15,0-2-12-15,0-4 1 0,0 8 1 0,0-3 5 16,0-5 0-16,0 8-42 0,0-2 35 0,0 1 6 16,0-2-8-16,0-5 32 0,0 7-16 15,0-2 13-15,0 1-65 0,0-6 41 0,0 7 13 16,0-1-59-16,0-6 6 0,0 7-1 0,0-2 4 16,0-5 44-16,5 8 9 0,-5-8-12 15,0 6-8-15,11 6 14 0,-9-9-1 0,-2 1-42 16,1-2 34-16,-1 2-11 0,1-2 25 15,1 1-13-15,-1-1-5 0,-1 0 11 0,2 1 5 16,-2-2-15-16,0 2-4 0,3-1 39 16,-3-1-25-16,0 1-10 0,0 0 28 0,1-1-34 15,-1 1 0-15,0-2-20 0,3 2 32 0,-3-1 4 16,0 1 14-16,0-2-17 0,3 1 10 0,-3-1-13 16,3 1-12-16,-3-1 24 0,1 1-50 15,3-1 6-15,-3 0-1 0,2 3 12 0,-3-3 48 16,0 0-23-16,5 0-12 0,-5-1-7 0,3 1-15 15,-2 0 25-15,2-3-23 0,-3 3 13 16,0 0-6-16,0 0 33 0,0 0-52 0,0 0 14 16,0 0 44-16,0 0-3 0,0 0 1 15,12-5-20-15,-10 5 31 0,-1-2-17 0,1 2-7 16,-2 0 3-16,1 0-2 0,1 0-2 0,-1 0 20 16,-1 0-30-16,0 0-22 0,0 0 34 0,0 0 2 15,0 0-10-15,0 0-12 0,0 0 20 16,0 0-5-16,0 0-25 0,0 0 11 0,0 0 18 15,0 0-1-15,0 0-18 0,0 0-16 16,0 0 39-16,0 0-10 0,0 0-8 0,9 0-1 16,-9 0 18-16,0 0 8 0,0 0-40 0,0 0 28 15,0 0-40-15,0 0-3 0,0 0 35 0,6 0 9 16,2 11-4-16,-7-10 37 0,3 0-41 0,-4 0-16 16,0 1 22-16,0 1-1 0,0-2-6 15,2 1 18-15,0-1-1 0,0 3-3 16,-2-3 10-16,3 0-22 0,-2 1 12 0,0 1-39 15,1-2 19-15,-1 0 45 0,3 2-44 16,-4-2 11-16,1 1 23 0,3-1-61 0,-3 1 29 16,0 1 13-16,1-3-5 0,-1 2 10 0,0 0-15 15,2-1 2-15,-3 1 22 0,1 1-14 0,2-3 0 16,-2 2 0-16,1 0-6 0,2-1 10 16,-1 0-45-16,-3-1 31 0,2 2 1 0,0-1 7 15,1 2 0-15,-3-1-10 0,3-2 6 0,-3 0-14 16,1 1 12-16,2 0-3 0,-3-1 15 15,2 3-19-15,0-3 9 0,-2 0 13 0,0 2-36 16,3-2 31-16,-3 0-5 0,0 0-9 16,3 0 7-16,-3 0 5 0,0 0-38 0,0 0 28 15,0 0-9-15,0 0 11 0,0 0 13 0,0 0-31 16,0 0 27-16,0 0-30 0,10 3 33 0,-10-3-34 16,3-1 31-16,-2 1-41 0,1 0 55 15,0-2 1-15,-1 2-30 0,2 0-1 0,0-2 25 16,0 2-16-16,1-3-7 0,-2 3 24 15,1-1-55-15,-3 0 53 0,5 1-16 0,-4-2 5 16,2 0-23-16,2 0 12 0,-3 1 6 0,1 0-6 16,1 1 0-16,-2-2 22 0,2 0-15 0,-1 0-8 15,-1 2 10-15,2-2-4 0,-2 1 20 16,0 0-18-16,3-1-16 0,-4 0 24 0,2 2-52 16,-1-2 46-16,1 2-37 0,-1-4 37 15,1 3-38-15,-1 0 37 0,0-1-9 0,0-1 31 16,1 2-61-16,-1-1 36 0,1 2-30 0,-2-4 26 15,-1 3 14-15,3 0-2 0,-1 0 3 16,0 0-2-16,3-1 18 0,-3 0-61 0,-1 0 8 16,1 1 27-16,1-1 9 0,0 0 16 15,-3 1-6-15,1 0-28 0,1 0 14 0,1 0-16 16,-2 0 3-16,1-1-5 0,2 0 14 0,-4 1 3 16,2 1 12-16,-1 0-30 0,1-2 24 15,-1 1-32-15,-1-1 32 0,3 2 9 0,-1-2-10 16,-1 2-16-16,1-3 29 0,-1 2-46 0,2-1 33 15,-3 2-5-15,2 0-6 0,2-1 16 16,-4 0-27-16,2 0 40 0,1-1-25 0,-2 1 1 16,2 1-1-16,-3-2-7 0,2 1 3 15,-2 1-14-15,3 0 25 0,-3 0-1 0,0 0 10 16,0 0-13-16,0 0-24 0,0 0 29 16,0 0-9-16,8 0 21 0,-8 0 0 0,0 0-12 15,7 0-5-15,-7 0-37 0,0 0 9 0,8 0 22 16,-8 0 0-16,14-9-1 0,-12 9 25 15,0-1-12-15,0 0-26 0,1 0-7 0,-3 1 39 16,0 0-19-16,0 0 0 0,0 0-9 0,0 0 6 16,6 0 4-16,-6 0 1 0,0 0 4 15,0 0-4-15,8 0-7 0,-8 0 4 0,0 0 1 16,6 0 7-16,-6 0 4 0,0 0-30 0,0 0 24 16,7 0-8-16,-7 0-5 0,0 0 8 15,0 0 5-15,5 0-6 0,-5 0 5 0,0 0 7 16,0 0-29-16,10 0 13 0,-10 0 4 15,0 0 15-15,5 0-26 0,-5 0 17 0,0 0 7 16,7 0-31-16,3 5 37 0,-7-2-31 0,1-1 5 16,0 0 6-16,-1 1 5 0,0-2-20 15,0 2 10-15,1-2 14 0,2 0 13 0,-2 1-23 16,0 1 23-16,-2-2-34 0,1 0 8 16,2 0 21-16,-3-1 0 0,1 3-5 0,2-1-19 15,-4-2-12-15,2 2 20 0,1 1-11 16,-3-2 10-16,4 0 1 0,-4 0-6 0,2 0 5 15,1 0 8-15,-2 1 1 0,1 0-12 16,1-1 7-16,-2 1-9 0,2-1 14 0,-1 2-13 16,0-1-1-16,0-1-7 0,0-1 2 0,0 2 14 15,0 1-14-15,0-2 18 0,-1 1-4 0,3 1 1 16,-2-1-21-16,-1-1 20 0,2 0 18 16,-2 1-19-16,1 0-4 0,-3 0 16 0,5-2 7 15,-3 4-34-15,1-3 33 0,-3 0-18 16,3 1-28-16,2-2 20 0,-4 0 14 0,3 2-6 15,-2 1 14-15,1-3-13 0,-2 1 4 0,3-1-28 16,-2 1 23-16,2-1-11 0,-1 0 11 16,2 1 13-16,-4-1-25 0,2 1 12 0,2 0-10 15,-1-1 12-15,-2 0-15 0,2 0 17 0,0 0 8 16,-4 0-8-16,0 0 10 0,0 0-34 16,8 0 16-16,-8 0 10 0,7 0-24 0,-7 0 20 15,8 0 6-15,-8 0-8 0,9 0-3 16,-9 0 7-16,0 0 6 0,7 0-8 0,-7 0-32 15,6 0 31-15,-6 0 15 0,0 0-16 16,8 0-17-16,-8 0-1 0,0 0 9 0,0 0 12 16,9 0-1-16,-9 0 9 0,0 0-24 15,6 0 17-15,-6 0-5 0,0 0 11 0,7 0-5 0,-7 0-8 16,0 0 5-16,6 0 5 0,-6 0-32 16,0 0 21-16,8 0 6 0,-8 0-5 15,6 0-18-15,-6 0 18 0,0 0 7 0,8 0-12 16,-8 0-11-16,7 0 5 0,-7 0 15 0,7 0 1 15,5 4-5-15,-9-3 6 0,2 0 18 0,-2 2-20 16,1-3-9-16,1 2 8 0,-1-2 3 0,3 2-11 16,-4 0 7-16,0 0 0 0,0-1 3 15,2-1 0-15,-4 3-3 0,4-3-6 16,-1 3 27-16,-3-2-13 0,4 1 2 0,-2-1-26 16,0 1 6-16,0 0 5 0,0 0-11 0,1 0 24 15,-1 2-20-15,0-4 27 0,0 2-31 0,0 1 25 16,0 0-10-16,-2-3-1 0,2 2-6 15,-2 1 21-15,-1-1-10 0,3 0-10 0,0-1 18 16,0 2-12-16,0-2-1 0,-1 2-11 16,1 0 30-16,-2 0-20 0,2-1 11 0,-2 1-35 15,1-1 29-15,1 2-12 0,-1-2-7 0,0 0 29 16,0 2-10-16,-1-1 0 0,3-1-4 16,-1 3-7-16,-1-1 14 0,2-1-10 0,-1 0-14 15,1 2 14-15,-1-3 15 0,0 2-43 0,0-1 42 16,-1 2 0-16,2-3-4 0,-1 2 11 15,-2-1 3-15,4 2-30 0,-2-2 20 0,0 1-10 16,1-1-10-16,-2 1 13 0,1-1 7 16,-3 1-8-16,5-2 8 0,0 1-23 0,-5 1 31 15,3-2-31-15,-1 0 15 0,2 0 14 0,-4-1-17 16,3 1-4-16,-3-2 1 0,3 3 7 16,1 1 0-16,-3-4-7 0,1 1 11 0,0 2 7 15,1-1-34-15,-3-1 24 0,3 1-19 0,-1 1 5 16,-1-2 12-16,2 0-21 0,-1-1 20 15,1 3-11-15,-3-1 14 0,3-2 3 0,-1 2-20 16,2-1-1-16,-2-1 21 0,1 2-18 0,-1 0 22 16,1 0-16-16,1-2 15 0,-3 1-28 15,3 1 25-15,0 1-11 0,-2-2 11 0,1 0-4 16,-1 0-10-16,1 0 25 0,1 1-15 0,-2-1-6 16,2 1-26-16,0 0 39 0,1 1-5 15,0-2-5-15,-1 1 11 0,1 0-11 0,-2-2 3 16,4 4-18-16,-4-2 3 0,0 1-4 15,0-1 26-15,2-1-6 0,0 0-26 0,0 0 22 16,0 1 3-16,-1 1-6 0,-1-1 7 0,2-2 14 16,1 4-14-16,-5-3 3 0,2 0 5 15,1 1-9-15,0 0-22 0,0 0 14 0,-2-1 20 16,3 0-18-16,-1 0-22 0,-3 0 31 16,3 2-2-16,-1-1-23 0,-1-1 5 0,-2-1 9 0,0 0 13 15,0 0-11-15,0 0 9 0,0 0-16 16,9 0-3-16,0 8 22 0,-8-5-6 0,2-1-9 15,-2-2 17-15,2 1-1 0,0 2-39 16,1 0 51-16,-4-2-26 0,4 3 5 0,-1-3-12 16,-1 2 20-16,3-1 10 0,-4 3-20 0,2-5-25 15,0 4 21-15,0-1 5 0,0 1 3 16,0-1-8-16,0-1 11 0,0 1-6 0,2 1-12 16,-2-1 20-16,0 0-14 0,1 2-12 15,0-3 22-15,-4 2 20 0,5 0-19 0,-4-2-8 16,2 2 6-16,0-2-6 0,-1 3 16 15,2-2 2-15,-3 1-28 0,2-2 20 0,-1 0-2 0,1 3-15 16,-1-4 1-16,1 1 2 0,-2 1 9 16,2 1 24-16,-2-1-20 0,2-1-7 0,0 0-6 15,-2 1 10-15,2 0-2 0,-3-1 14 16,3 0-13-16,-3 1-10 0,1-3-10 0,0 3 19 16,3-1-1-16,-3 0 1 0,2-1 20 0,-2 2-25 15,3-1 12-15,-1 0-25 0,-2-1 24 16,1 1 2-16,1 0-16 0,-2-1 9 15,1 0-1-15,1-1-27 0,-3 4 37 0,3-4 3 16,0 2-24-16,-2-1 21 0,1-1-12 0,1 2 5 16,0-1-12-16,0-1 3 0,0 2 18 15,1 0-24-15,-2-1 16 0,1 0-19 0,4 1 30 16,-2-1-1-16,-2 0-12 0,-2 0-16 0,4 0 18 16,0 0-5-16,-1-1-9 0,0 2-11 15,-4-2 28-15,0 0-8 0,6 0-13 0,-6 0-3 16,9 0 27-16,-3 0-31 0,-6 0 16 0,8 0-12 15,-1 0 26-15,-7 0-2 0,10 0-7 16,-4 0 13-16,4 0-2 0,-6 0-3 0,4 0-9 16,-2 0-14-16,1 0 20 0,-7 0-9 15,10 0 2-15,-3 0-12 0,-7 0 18 0,9 0 6 16,1 0-5-16,-3 0 16 0,-7 0-18 16,7 0-5-16,2 0 7 0,-9 0-8 0,8 0 17 15,-2 0-11-15,-6 0 6 0,9 0-23 0,-1 0-11 16,-8 0 7-16,6 0 20 0,-6 0 9 15,10 0-39-15,-5 0 37 0,-5 5 2 0,8-5-3 16,-8 0-12-16,6 0-15 0,-6 0-10 0,0 0 34 16,8 0-4-16,-8 0 0 0,6 0-5 15,-6 0 18-15,0 0-15 0,0 0-5 0,8 0-24 16,-8 0 42-16,0 0-9 0,7 0-13 0,-7 0 15 16,0 0-14-16,8 0 12 0,-8 0 2 15,0 0 6-15,5 0-5 0,-5 0-24 0,0 0-10 16,0 0 38-16,7 0 7 0,-7 0-27 0,0 0 7 15,9 0 18-15,-9 0-11 0,0 0 11 16,6 0-5-16,-6 0-20 0,5 0-19 0,-5 0 9 16,9 0 20-16,-9 0-12 0,6 0 21 15,-6 0-7-15,0 0-29 0,8 0 15 0,-8 0 17 16,7 0-9-16,-7 0 15 0,0 0-4 0,8 0-7 16,-8 0 3-16,7 0-10 0,-7 0 14 0,0 0-23 15,6 0-7-15,-6 0 18 0,10 0 14 16,-10 0 2-16,4 0-22 0,-4 0 23 0,0 0-30 15,8 0 18-15,-8 0-14 0,13-8 11 16,-10 7-23-16,0-1 37 0,-1-1-22 0,1 2 24 16,2 1-22-16,-4-1 11 0,3-1 1 0,-1 1-13 15,0-1 18-15,0 0-32 0,0-1 23 0,0 1 8 16,1 0 0-16,0 1-7 0,0-2-12 0,-2 1 22 16,1 0 12-16,-1 0-1 0,0 0-30 15,2-1 24-15,-2 1-4 0,3-1-20 16,-2 1 6-16,-2-1 20 0,4-1-37 0,-2 1 9 15,-1 0-9-15,-1 0 22 0,3-1-26 0,1 2 5 16,-2-3 10-16,-1 2 11 0,0-1-5 16,0 1 6-16,1 1 6 0,0-2-5 0,0 0-15 15,0 0 21-15,-2 2-14 0,3 0 11 0,-2-1-29 16,1 1 25-16,-1-1 11 0,-1-1-6 16,1 3-38-16,-1-3-3 0,4 4 39 0,-2-3-26 15,-2 2 25-15,3-2-31 0,-2 0-2 16,1 1 23-16,2-1 12 0,-4 1 11 0,2 0 8 15,-1-2-13-15,2 1-12 0,-2 1-1 16,0-1-27-16,3 1 50 0,-2-1-1 0,-1 1-3 16,-1 1-22-16,3-1 0 0,-1-2-10 15,-2 2 26-15,5-1-36 0,-3 1 26 0,1 0 4 16,-2 0 3-16,2-2 5 0,-2 4-8 0,1-3-27 16,2 1 32-16,-3 1-2 0,0-1 16 15,1 0-8-15,1 0-36 0,0 1 6 0,-1-1 22 16,1 1-6-16,0 0-19 0,-3 0 11 15,4-2 7-15,-5 2 18 0,3 1-20 0,0-2 5 16,0 2 3-16,-1-1 4 0,1 0 3 0,1-2-29 16,-4 3 12-16,3 0-14 0,0-2 31 15,0 2-12-15,-2 0-12 0,4-2 7 0,-3 1-9 16,-1 1 11-16,1-2 9 0,3 1-1 16,-3 0-17-16,-1 0 4 0,5 1 28 0,-4-2-47 15,2 0 23-15,-1 0 4 0,2 1 2 16,-2-1-9-16,-1 0 6 0,0 2 10 0,2 0 1 15,-2-2-27-15,3 1 20 0,-2 0 2 0,-2 0 7 16,5-2-21-16,-3 3 7 0,0 0 2 0,0-2-21 16,0 2 12-16,-2 0 1 0,4-2-13 15,-2-1-11-15,2 3 13 0,-4-1 22 0,4 0-15 16,-5 0 3-16,4 0 2 0,-1-2 11 16,-1 2 3-16,0 0 0 0,1 0-9 0,1-1-19 15,-1 0 19-15,0 0 12 0,0 1-9 0,-2-1 6 16,1 2-10-16,1 0 18 0,-2 0-45 0,2-2 23 15,-1 0-5-15,1 1 2 0,-2 1-14 16,1 0-1-16,-2 0 28 0,1 0 13 0,-1 0-41 16,3-1 29-16,-1 1-13 0,-2 0 7 15,0 0 16-15,0 0-37 0,0 0 24 0,0 0-16 16,0 0 7-16,0 0 2 0,0 0 1 0,0 0-26 16,0 0 29-16,0 0 1 0,0 0-23 0,0 0 16 15,4 0 10-15,-4 0-8 0,0 0-17 0,11 8 15 16,-11-7 7-16,0 3-27 0,2-2-4 15,-1 1 31-15,-1 2 2 0,1 0-16 0,-1-3 31 16,0 0-26-16,0 4 14 0,0-6-19 16,0 0 33-16,0 8-25 0,0-2 6 0,0-6 14 15,6 14-31-15,-4-8-1 0,-1-2 17 16,-1 2-35-16,3-3 30 0,-2 2-14 0,0 1 35 16,2-2-37-16,-2 0 24 0,-1 0-3 0,1 0-12 15,-1-1 16-15,3 1-12 0,-3-1 18 16,1-1-16-16,-1 1 8 0,1 1 14 0,-1-1-21 15,0-2-28-15,0 2 55 0,2-1-25 16,-1 0 13-16,0-1 3 0,-1 1-29 0,2-1-5 16,-1 0 24-16,1 0-20 0,-2-1 5 15,0 2 20-15,2-2-5 0,-1 2-32 0,0-1 13 16,-1 1-5-16,4-2 27 0,-2 2-14 0,-2 0-5 16,2 0 25-16,0-1-14 0,0 0-2 0,1 0-28 15,-3 0 33-15,4 1 6 0,-1-2-44 16,-3 2 11-16,1-2 44 0,2 2-2 0,0-2-25 15,-1 0-14-15,-1 2 12 0,3-1 36 16,-3 0-1-16,0 0-20 0,1 0 7 0,-1-1-52 16,2 2 13-16,0-2 9 0,0 0 18 0,0 0 20 15,0 0-21-15,-3 0-3 0,0 0 28 0,0 0-25 16,0 0 3-16,8 0-16 0,-8 0 14 16,6 0-11-16,-6 0 21 0,0 0-32 0,4 0 18 15,-4 0 10-15,0 0-8 0,11 0-8 0,-11 0 22 16,4 0-12-16,5-10 21 0,-5 10-34 15,0-2-7-15,-2 0 11 0,1 1 4 0,-1-1 20 16,1-1-17-16,0-1-34 0,0 3 27 0,-3-3-2 16,5 2 1-16,-5-1 19 0,3 0-9 15,-1 1-9-15,1-3-4 0,0 1 2 0,-2 0 11 16,1 2-25-16,1-1 36 0,0-2 3 16,-2 2-15-16,1-2 1 0,2 1 7 0,-1-1-36 15,-2 1 19-15,3 1 9 0,-2 0 9 16,1-2-24-16,-2 2 32 0,1-1-14 0,0 0 0 15,2 2 27-15,-3-3-23 0,1 3-2 16,1-2-43-16,0 4 27 0,-3-2 29 0,0-3-13 16,3 3-37-16,-2-1 24 0,-1 1 16 0,2 0-44 15,-2-3 65-15,3 5-44 0,-1-2 37 0,-1 0-41 16,-1 1 31-16,3-2-35 0,-2 1 29 16,-1 0-13-16,3 2 18 0,-3-3 3 0,3 1-13 15,-3 1-26-15,2-3 50 0,-1 3-7 16,-1 0-24-16,2 0 14 0,-1-1-8 0,-1 2-6 15,0 0 12-15,0 0 2 0,0 0-15 0,0 0 1 16,0 0-1-16,0 0 27 0,0 0-25 16,0 0-1-16,0 0 10 0,0-5-36 15,12-3 21-15,-10 8-5 0,-1-1 27 0,-1 1 6 16,2-3-45-16,-2 3 22 0,1-1 18 16,1 0-37-16,-1 1 19 0,1 0 7 0,-1-1 8 0,1 0-14 15,-2 0 24-15,3 1-20 0,-2-4 10 16,-1 4-25-16,2 0 22 0,0 0-9 0,-2 0 11 15,2-2-10-15,-2 1-15 0,3 1 0 16,-2 0 47-16,2-1-22 0,-2 0 13 0,0-1-44 16,2 2 7-16,-2 0 25 0,1-2 7 0,0 2-8 15,0-1 3-15,2 1 3 0,-4-4 2 0,3 3-30 16,-2-1-1-16,2-1 20 0,-1 3 6 16,0 0-6-16,0-2-19 0,1 1 25 0,-1 1-21 15,0-1-2-15,0 1-6 0,-2-1 22 16,4 1 2-16,-2-4-28 0,0 4 6 0,-1 0 20 15,1 0 7-15,-2-2 2 0,3 2-6 0,0 0-4 16,-3-1 8-16,4-1 9 0,-2 0-21 16,2 2-1-16,-4 0-11 0,3-1 24 0,-1-1-1 15,-1 2-18-15,-1 0 0 0,0-2 21 16,3 2-1-16,-1-2-7 0,-2 2-4 0,3-1 9 16,-3 0 0-16,1 0-15 0,1 0 23 0,1-2-8 15,1 2 4-15,-2 0 1 0,2 0 8 16,-1 0-16-16,-1 0-1 0,1-2-10 0,0 1 17 15,0 2 5-15,1-3-14 0,-1 1 8 0,0 1 1 16,-1 1-34-16,2-1 24 0,-2-2-19 16,2 1 20-16,-3 0-19 0,6 1 36 0,-6 0-36 15,3-2 26-15,0 3-12 0,-3-3 18 0,1 2-8 16,1 1-23-16,-2-4-10 0,4 4 16 0,-2-2 13 16,-2 2-10-16,2-2-13 0,-1 2 24 15,2-3 8-15,-3 3-21 0,3-2 12 16,-1 0-12-16,-3 2 16 0,3-1-11 0,-3 1 6 15,0 0 0-15,4-3-20 0,-4 2 27 0,3 1-25 16,-3-1 14-16,3 1 2 0,-1-1 4 16,-1 1-22-16,1 0 23 0,-1-1 6 0,1 0-8 15,-2-2-7-15,3 3 4 0,-3 0 4 16,1-1-31-16,1 1 31 0,-1-1-8 0,2 1 7 16,-2 0-8-16,1 0 3 0,-2 0 15 0,1 0-20 15,-1 0-1-15,0 0-6 0,2 0 19 0,-1 0-21 16,-1 0 13-16,0 0 4 0,-1 0-13 15,4 0 18-15,-1 0-7 0,-2 0-25 16,0 1 48-16,0-1-23 0,1 1 1 0,-1-1-14 16,0 0 14-16,2 0-4 0,-2 0 18 0,0 0-16 15,0 2-12-15,1-4 16 0,1 2 1 0,1 0 8 16,-3 2-25-16,1-1 14 0,-1-1-29 0,3 1 14 16,0-1 10-16,-2 1-10 0,1 0 2 15,1 0 17-15,0 0-18 0,1 2 29 16,-1-3-11-16,-1 1-6 0,2 1-20 0,1-1 8 15,-3-1 16-15,2 1 4 0,-1-1 18 0,-1 3-38 16,1-3 16-16,1 2-31 0,-1-2 34 16,0 0-3-16,1 0 5 0,0 2 2 0,-2-2-19 15,0 0 10-15,2 0 2 0,-1 0 5 0,-1 0 2 16,1 2-10-16,-3-2-25 0,3 0 16 0,-1 0 8 16,2 1-4-16,-4-1 18 0,0 0-10 15,0 0-14-15,0 0 6 0,0 0 8 0,8 0-6 16,-8 0-11-16,0 0 13 0,8 0-1 15,-8 0 9-15,0 0-17 0,0 0 13 0,6 0-5 16,-6 0 1-16,0 0-17 0,0 0-1 0,7 0 16 16,-7 0 9-16,0 0 7 0,0 0-27 0,8 0 22 15,-8 0 6-15,0 0-22 0,0 0 1 16,8 0 6-16,-8 0 3 0,0 0-9 0,6 0 3 16,-6 0 14-16,0 0-11 0,6 0 4 15,-6 0 8-15,0 0-12 0,7 0-10 0,-7 0 16 16,0 0 7-16,6 0-11 0,-6 0-30 0,0 0 25 15,9 0 14-15,-9 0-7 0,0 0-2 0,8 0-9 16,-8 0 13-16,0 0 4 0,6 0-18 0,-6 0-21 16,0 0 36-16,7 0-12 0,-7 0-10 15,0 0 22-15,0 0-3 0,7 0-7 0,-7 0-2 16,0 0 1-16,0 0-10 0,6 0 26 16,-6 0-24-16,0 0 28 0,0 0-12 0,0 0-22 15,7 0 34-15,-7 0-10 0,0 0-25 0,0 0 7 16,0 0 19-16,8 0-3 0,-8 0-3 15,0 0 2-15,6 0 11 0,-6 0-22 0,0 0 2 16,0 0 14-16,8 0-15 0,-8 0 15 16,0 0-9-16,5 0 0 0,5 8-25 0,-5-6 23 15,-4 0 4-15,2 0-1 0,2 1 6 0,-4-3-2 16,2 2 7-16,0 1-29 0,0-1 28 16,2 0-11-16,-4 0 6 0,4 1 16 0,-2-2-13 15,-2 1-16-15,2 0-14 0,0 0 24 0,3-1 2 16,-4 0-5-16,1 0 18 0,-3-1-12 15,0 0 1-15,0 0-9 0,0 0 17 0,0 0-27 16,0 0 10-16,6 0-15 0,-6 0 28 16,0 0 0-16,0 0-2 0,8 0-31 0,-8 0 33 15,0 0-1-15,0 0-19 0,9 0 15 0,-9 0 14 16,0 0-18-16,5 0 24 0,-5 0-13 0,0 0 4 16,8 0-14-16,-8 0 21 0,0 0-19 15,7 0 12-15,-7 0-9 0,0 0 0 0,6 0-2 16,-6 0-10-16,0 0 19 0,8 0-28 15,-8 0 19-15,11-1-16 0,-6 0 19 0,-2 1 4 16,0-1-3-16,-3 1 5 0,3-1-15 0,0-2 4 16,1 2 1-16,-2 1-7 0,-2-1 9 15,4 1-1-15,-1-1-4 0,-1 0 4 0,1 0-20 16,0 0 17-16,0-1-6 0,0 2-13 0,1 0 34 16,-2-2-5-16,1 2-3 0,-1 0-12 15,1-2 10-15,-1 1-4 0,0 0 4 0,0 0-8 16,1-1-23-16,2-1 26 0,-4 1-17 0,1 0 24 15,4 2-24-15,-4-1 9 0,2 1 28 16,-1-2-23-16,2 2 6 0,-3 0-19 0,2-2 14 16,0 0 10-16,-4 2-16 0,0 0 16 15,0 0-19-15,0 0 10 0,8 0-15 0,-8 0 21 16,7 0-5-16,-7 0 13 0,0 0-24 0,8 0 15 16,4-8 8-16,-9 8-17 0,0-2 12 0,-2 2-12 15,-1 0-4-15,0 0 2 0,0 0 9 16,0 0-15-16,8 0 21 0,-8 0 3 0,6 0-15 15,-6 0 7-15,0 0-4 0,0 0-6 16,9 0-11-16,-9 0 21 0,0 0 3 0,0 0-7 16,6 0-18-16,-6 0 28 0,0 0-12 0,7 0-2 15,-7 0 0-15,0 0 10 0,0 0 0 16,7 0-11-16,-7 0 9 0,0 0-21 0,0 0 19 16,9 0-1-16,-9 0-1 0,0 0 4 15,0 0-6-15,0 0 0 0,6 0-6 0,-6 0 20 16,0 0-3-16,0 0-10 0,0 0-9 0,6 0-5 15,-6 0 9-15,0 0 1 0,0 0 0 0,0 0-12 16,0 0 29-16,0 0-16 0,10 0 2 16,-10 0-5-16,0 0-7 0,0 0 18 0,5 0-11 15,-5 0 1-15,0 0 6 0,0 0-2 16,9 0-18-16,-9 0 28 0,0 0-13 0,7 0 1 16,-7 0-15-16,12-3 24 0,-8 3-14 0,1 3 7 15,-3-3-7-15,1 0 12 0,-2 0-4 16,-1 0 13-16,0 0-8 0,0 0-5 0,0 0-9 15,0 0 0-15,9 0 5 0,-9 0 18 16,0 0-18-16,0 0 5 0,6 0 4 0,-6 0-26 16,0 0 21-16,0 0-3 0,0 0-9 0,7 0 26 15,1 8-10-15,-8-8-1 0,0 0-4 0,0 0-10 16,0 0 9-16,0 0 3 0,0 0-20 16,0 0 15-16,0 0 7 0,6 0-7 0,-6 0 23 15,0 0-20-15,0 0-7 0,7 0 8 16,-7 0-2-16,0 0 2 0,0 0 8 0,8 0 5 15,-8 0-20-15,0 0 5 0,0 0-8 0,0 0 21 16,6 0-10-16,-6 0-4 0,0 0-16 16,0 0 11-16,0 0 15 0,7 0 3 0,-7 0-20 15,0 0 18-15,8 0-9 0,-8 0 1 0,0 0 4 16,6 0-4-16,-6 0 3 0,0 0 2 16,0 0-2-16,7 0 4 0,-7 0-16 15,0 0-7-15,7 0 30 0,-7 0-15 0,0 0-18 0,0 0 27 16,7 0-10-16,-7 0 6 0,0 0-9 15,0 0 16-15,13-8-7 0,-11 8-3 0,2 0-20 16,-1 0 24-16,-3-3-3 0,0 3-17 0,0 0 12 16,0 0-11-16,0 0 20 0,0 0-7 15,0 0-13-15,0 0 21 0,0 0-3 0,0 0 0 16,0 0-5-16,0 0 8 0,0 0-2 0,8 0-5 16,-8 0 6-16,0 0-11 0,0 0 10 15,0 0-20-15,0 0 5 0,0 0 24 0,0 0-9 16,5 0-4-16,-5 0-19 0,0 0 22 0,0 0-5 15,0 0-10-15,0 0 13 0,0 0-5 16,0 0 13-16,0 0-10 0,12-2-14 0,-10 3 31 16,-2-2-9-16,-2 1 4 0,4 0-13 0,-5 0 2 15,3 0-2-15,0 0 4 0,0 0 4 16,0 0 23-16,0 0-23 0,0 0 6 0,0 1-7 16,1-1 9-16,1 0 5 0,-2 0 15 15,-2 0-30-15,2 0 10 0,2 0-16 0,-2 0 9 16,0 0 14-16,0-1 8 0,0 1-20 15,0 1 6-15,0-1-4 0,0-1 38 0,0 2-10 16,0 0 27-16,0-1-27 0,0 0-33 0,0 0 17 16,0-1 2-16,-2 1 12 0,1 0-10 0,2 0 11 15,-2-1 21-15,1 1-31 0,0 0-28 16,0 0 3-16,0 0-16 0,0 0 27 0,0 0-6 16,0 0-3-16,0 0-11 0,0 0 66 15,0 0-54-15,3 0 17 0,-3 0 20 0,0 0-9 16,0 0-10-16,0 0-16 0,0 1 21 0,1-1 16 15,-1 0-9-15,0 0-9 0,0 0-1 16,2-1 17-16,-2 2 25 0,1-1-9 0,-1 0-50 16,0 0-1-16,-1 0 46 0,2 0-42 15,-1 0 21-15,0-1-20 0,0 2-3 0,0 0 16 16,0-1 10-16,2-1-13 0,-2 1-5 0,-2 0-10 16,2-1 5-16,0 2-10 0,0-1 22 15,2 0-14-15,-2-1-11 0,0 1-2 0,0 0 30 16,1 0-42-16,-1 0 6 0,0 0 14 15,2 0 8-15,-2 0-33 0,0 0 18 0,2-2-7 16,1 1-10-16,-2 1 2 0,3-2-3 0,1 1-26 16,-1 1-33-16,1-1 60 0,0 0-70 0,0 1 17 15,-2-2 15-15,4 1-13 0,-1-2-6 16,0 2-1-16,9-4 3 0,-5 3 23 0,1-3-20 16,-4 3 29-16,-1 0 9 0,1-3-13 15,-2 3 1-15,1 2 21 0,-2-1 1 0,2-2-22 16,-1 0 4-16,-1 3-11 0,-1-3 6 0,2 0 1 15,1 1 5-15,-5 2 32 0,2-3-12 16,2 1-13-16,-1 1 25 0,-2 0-7 0,-1 0-2 16,5-1-3-16,-5 0 13 0,3 1-28 15,-4 0 22-15,2 0-9 0,1 0-8 0,-1 0 20 16,0-1 2-16,-2 2 2 0,2-2-7 16,1 2-15-16,-3-1 19 0,0 1 0 0,0 0 10 15,0 0-21-15,0 0 5 0,0 0 11 0,0 0-9 16,0 0-9-16,0 0 6 0,0 0-13 15,0 0 26-15,5-5-1 0,-5 5-11 0,0 0 11 16,1-2-3-16,-1 2-8 0,0 2 4 0,3-2-3 16,-3 0 1-16,0 0 15 0,1 0-11 15,0 0 10-15,-1 0-3 0,0 0-5 0,0-2-2 16,0 2-14-16,1 2 23 0,1-2-7 16,-2 0 1-16,0 0-13 0,0 1 21 0,0-1-12 15,1 0-1-15,0 0 6 0,-1 1-1 0,2-1 2 16,-2 1-2-16,2-1 1 0,1 1-2 0,-3-1-2 15,0 1 3-15,4-1-16 0,-4 0 20 16,2 0-3-16,2 0 9 0,-3 0-29 0,2 0 11 16,-3 0 9-16,5 0 1 0,-5 0-7 0,1 0 11 15,-1 0 3-15,3 0-26 0,0 0 27 16,0 0-2-16,-3 0 4 0,3 0-23 0,-1 0 22 16,1 0-8-16,-3 0-10 0,0 0 4 0,0 0 13 15,0 0 9-15,0 0-36 0,0 0 23 0,7 0-6 16,-7 0 7-16,7 0-12 0,-7 0 10 15,0 0 9-15,0 0-20 0,7 0 4 0,-7 0 6 16,13-9-21-16,-12 9 16 0,2-3 9 16,-3 3-2-16,3-1-14 0,-3 0-2 0,3 1 19 15,1 0-1-15,-2-2 2 0,0 0 4 16,-1 0-15-16,0 1 8 0,2 1-8 0,-2-1 0 16,2 1-5-16,-3-1 13 0,2 0 16 0,-2 1-23 15,3-2 8-15,-2 2-6 0,-1 0-3 0,0 0-15 16,0 0 24-16,0 0-4 0,0 0 11 0,0 0-25 15,0 0 13-15,0 0-13 0,0 0 9 16,9 0 0-16,-9 0 13 0,0 0-18 0,0 0 7 16,0 0-2-16,5 0 5 0,-5 0-6 15,0 0 22-15,0-6 1 0,8 6-13 0,-1-6-9 16,-4 6 2-16,-3-2-1 0,1 2-2 0,0-2 11 16,1 1 0-16,-2 1-5 0,0-1-2 0,2 0-20 15,0 0 8-15,-1 0 13 0,0 1 4 16,2-2-10-16,-2 1-3 0,-1 1 16 0,3-1 3 15,0 0-10-15,-3 1-4 0,0 0 18 16,3 0-14-16,-2-3-13 0,1 3 27 0,-1-1-10 16,1 0 0-16,1 1-18 0,-3 0 22 0,1 0-6 15,2 0 10-15,-3-1-8 0,2 1 1 0,1 0-10 16,0 0 10-16,-3-1-10 0,3 1-2 16,-2 0 1-16,2 0-10 0,-1-1-11 15,1 1 23-15,-2 0-2 0,3-2-12 0,-3 0 21 16,2 2-25-16,1 0 23 0,-1 0-11 0,-3 0 21 15,0 0-29-15,0 0 32 0,6 0 1 16,-6 0-8-16,7 0-12 0,-7 0 13 0,0 0-20 16,9 0 23-16,-9 0 4 0,0 0-19 0,6 0 17 15,-6 0-41-15,0 0 29 0,7 0 0 16,-7 0 12-16,0 0-20 0,0 0 22 0,0 0-16 16,6 0 2-16,-6 0-33 0,0 0 30 15,8 0-12-15,-8 0 23 0,0 0-6 0,0 0-3 16,0 0-15-16,6 0 4 0,-6 0 13 15,10 7 10-15,-8-7-26 0,-2 2 2 0,1 1 20 16,1-2-9-16,1 0-10 0,-3 2 3 0,1-1 17 16,2-1 7-16,-3 1-25 0,0 0 16 0,0 0-3 15,1 0 9-15,1 0 4 0,-1 1-22 0,1 0 15 16,-2-3-32-16,3 2 11 0,-3 1 10 16,0-2-9-16,1 1 26 0,1 0-26 0,-1 2 22 15,-1-4-5-15,0 2-10 0,0 1-10 16,1-3 6-16,0 2 8 0,-1-2-1 0,0 0 2 15,0 0-13-15,0 0 14 0,0 0 8 0,0 0-3 16,0 0-15-16,0 6 11 0,0-6 0 16,0 0 6-16,0 0-5 0,13 11-4 0,-13-9-2 15,2 0-16-15,1-1 9 0,0-1 4 16,-2 1-11-16,5-1 4 0,-6 1 0 0,3 0 12 16,0-1-7-16,-1 1 8 0,-1 0 0 0,1-1 0 15,-1 0 5-15,2 0 15 0,0 2-32 0,-1-2 14 16,1 0-6-16,-1 0 17 0,-2 0-24 15,0 0 17-15,0 0-18 0,0 0 14 0,0 0 0 16,7 0 0-16,-7 0 13 0,0 0-27 0,7 0 7 16,-7 0-5-16,8 0 15 0,-8 0-7 15,6 0-6-15,-6 0 10 0,0 0 0 0,7 0-4 16,-7 0 15-16,0 0-12 0,8 0-4 16,-8 0 7-16,6 0-12 0,-6 0-15 0,0 0 16 15,8 0 0-15,-8 0 2 0,0 0 1 16,7 0-14-16,-7 0 32 0,0 0-3 0,0 0-4 15,8 0 4-15,-8 0 2 0,0 0 9 16,6 0-6-16,-6-6-5 0,0 6 15 0,0 0-6 16,0 0-13-16,7 0-2 0,-7 0 8 15,0 0 26-15,0 0-12 0,0 0-20 0,0 0 34 16,6 0-28-16,-6 0 3 0,0 0 11 16,0 0 21-16,0 0-2 0,0 0-34 0,0 0 2 15,0 0 29-15,0 0-14 0,0 0-20 16,8 0 35-16,-8 0-12 0,0 0-32 0,0 0 4 15,0 0 13-15,0 0 3 0,0 0-23 16,0 0 10-16,0 0 27 0,0 0-26 0,7 0 41 16,-7 0-40-16,0 0 9 0,0 0 13 0,0 0-27 15,0 0 0-15,7-8 5 0,-5 8 30 16,-1 0-5-16,-1 0-38 0,2 0 43 0,-2 0-30 16,2 0-3-16,-2 0-15 0,0 0-4 0,0-1-4 15,2 1 48-15,-1 0-24 0,-1-1 5 0,2-2 3 16,-1 3 6-16,2-2-41 0,-2 2 41 15,2-1-52-15,-3 1 55 0,1-1-24 0,2-1-10 16,-1 0 25-16,1 0-32 0,-1 2-3 0,5-2 19 16,-5-1-5-16,1 2-7 0,1 0 0 15,-1-1 18-15,2 0-21 0,-1-1 5 16,0 2 21-16,0-1-30 0,0-2-6 0,-2 2 16 16,2 0 11-16,1 0-21 0,-2 0 32 0,2 0-8 15,-1-1 7-15,0 1-26 0,-2 0 3 0,3 0-19 16,-2-1 34-16,1 2 10 0,2 0 17 15,-4-2-29-15,1 1-27 0,-1 2 3 0,3-1 32 16,-2-1-15-16,0-1-28 0,-3 3 23 16,5-1-13-16,-4 0 2 0,3 0-6 0,-4 0 23 15,4-1-5-15,-1 0-10 0,0 1 18 0,1 0 16 16,-4 0-32-16,3 0-3 0,-1 0 10 0,3 1-3 16,-1-3-4-16,-3 2 8 0,3 1 31 15,-2-1-20-15,1 1-3 0,-2 0 12 16,2-3-24-16,-1 1-3 0,-2 1 36 0,3 0-35 15,0 1 16-15,-2-1 6 0,1-2-21 0,2 2 34 16,-3-1-16-16,2 2-28 0,-3-1 5 16,2 0 44-16,1-1-23 0,-2 1 15 15,3-1-36-15,-2 1-6 0,0 1 27 0,1-2-4 16,-1 0 11-16,1 1-32 0,-2-1 13 0,-1 2-3 16,2-2-2-16,-2 1 11 0,2 0-1 0,1-1-3 15,-2 1 18-15,1 1-19 0,-1-2 38 16,1 0-6-16,-1 2-15 0,1-2-16 0,1 2-10 15,-3-1 14-15,2 1 4 0,1-1-16 16,-3 1 20-16,0 0 4 0,4-1-5 0,-3 0-13 16,1 1-6-16,-1 0 13 0,1-2-10 0,-2 0 25 15,0 2-19-15,3-2-13 0,-3 0 14 16,4 2 1-16,-2-2 24 0,2 0-10 0,-2 2-20 16,1-2-1-16,-2 0 6 0,-1 0 2 15,3 1-3-15,-3 0 6 0,2 0-10 0,1-2 39 16,-3 1-23-16,1 1-13 0,2 1-6 0,-3-2 2 15,2 0 24-15,-2 0-1 0,0 0-20 0,4 1 19 16,-1-1-27-16,-3 0 10 0,1-1 2 16,-1 1-6-16,4 0-1 0,-2 0 9 0,1 1 23 15,-3-1 2-15,2-1-13 0,-2 1-26 16,2 1 35-16,-1-1-35 0,0 0 8 0,3 2 2 16,-4-2-7-16,0 1 5 0,0 1 0 0,0 0 4 15,0 0 7-15,0 0-19 0,0 0 25 16,0 0 17-16,0 0-34 0,0 0 4 0,0-7-12 15,12 0 32-15,-11 7-12 0,0-1 5 16,-1-1-1-16,1 2 10 0,1-2-15 0,-1 2 1 16,2-1-1-16,-2 1-31 0,-1-2 7 0,2 2 42 15,-1-1-36-15,2 0 9 0,-3 1 8 16,0 0-15-16,0 0 4 0,0 0-7 0,0 0 3 16,0 0 5-16,0 0-3 0,0 0 3 15,0 0 18-15,0 0-15 0,0 0-6 0,14-10 11 16,-14 9-6-16,1 1 2 0,2-1-2 0,0 1 16 15,0-2-14-15,-3 1-3 0,3 1 7 16,-3 0-14-16,1 0 10 0,1-2-11 0,0 2 2 16,-1-1 25-16,1 1-17 0,1-1 6 15,0 0-13-15,-2 0 19 0,3-1-16 0,1 0 28 16,-5 2-27-16,1-1-2 0,3 0 7 0,-4 1 19 16,1-1-4-16,2 0 13 0,-3-1-31 15,2 2 20-15,1-2-11 0,-3 2 0 0,0 0-23 16,4 0 33-16,-3 0 0 0,-1 0-19 15,0 0-20-15,2-2 25 0,-1 2 13 0,1 0-19 16,-1-1-19-16,-1 1 33 0,0 0-27 16,0 0 16-16,0 0 6 0,3 0-20 0,-3 1 1 15,0-1 8-15,1 0-7 0,-2 0 15 0,1-1-16 16,0 1 8-16,2 0 18 0,0 0-28 16,-1 1 6-16,-1-1 5 0,1 2 19 0,-1-2-12 15,2 2 9-15,-1-2-20 0,-1 2 15 0,1 0-23 16,0-1 12-16,1 0-15 0,0 1 14 15,-2 1-2-15,0-2 7 0,0 1-13 0,3 0 30 16,-3 1-11-16,0 0-2 0,2 0 7 0,-1-1-15 16,2 0-5-16,-3 1-3 0,0 0 5 15,0-1 18-15,3 2-20 0,-2-2-4 0,-1 1 2 16,1-1 20-16,1 2 7 0,-1 0-30 0,0-4 34 16,-1 2-14-16,1 3 16 0,1-4-37 15,-1 3 26-15,-1-2-15 0,2 0 2 0,-2 1 16 16,2-1-17-16,-1 3-5 0,-1-3 9 15,1 1 7-15,0-1 7 0,1 1-14 0,-1-1 11 16,-1 1-8-16,1 0 3 0,1-2-25 0,-2 2 9 16,1-2 11-16,-1 2 7 0,2-3-10 0,-2 5 16 15,3-4-17-15,-3 1 3 0,0 0 11 0,1 1-5 16,1-1-12-16,-1-1 7 0,-1 1-13 16,1 1 6-16,1-2-4 0,1 0 12 0,-1 1-22 15,-1 0 13-15,1 0 8 0,-2-2-7 16,3 3 11-16,-2-1 3 0,0 0-10 0,3 1-16 15,-1 0 21-15,-2-1 0 0,4-1 4 0,-2 1 8 16,-2 2-18-16,1-2 1 0,1 1 2 16,1-1 7-16,-4 0-8 0,5 2-7 0,-5-2 11 15,3-1-6-15,0 2 5 0,0 0-6 16,-2-3 5-16,1 1 0 0,1 1-14 0,-2-1 15 16,2 2 11-16,-3-2-25 0,2 0 13 0,1-1 4 15,-2 0 11-15,1 2-24 0,-1 1 27 0,-1-3-19 16,3 0 10-16,0 1-15 0,-3-1 10 15,0 1 8-15,3-1-9 0,-1 1-7 0,1-1 5 16,-2 2-3-16,-1-2 11 0,0 0 4 0,0 0-9 16,0 0-3-16,0 0 4 0,0 0-14 15,7 0 11-15,-7 0 0 0,0 0-18 0,7 0 27 16,-7 0-3-16,0 0-3 0,0 0 4 16,6 0-13-16,-6 0 5 0,0 0-23 0,0 0 26 15,7 0-13-15,-7 0 20 0,0 0-2 16,9 0-6-16,-9 0 13 0,0 0-14 0,0 0 2 15,6 0-6-15,-6 0 11 0,0 0-12 0,0 0 9 16,0 0 11-16,7 0-14 0,-7 0 1 0,0 0 0 16,0 0-10-16,0 0 3 0,6 0-2 15,-6 0 11-15,0 0-12 0,0 0 8 0,0 0 10 16,7 0-6-16,-7 0-7 0,0 0 3 16,0 0-5-16,0 0 11 0,7 0 0 0,-7 0-3 15,0 0-3-15,0 0 18 0,8 0-10 0,-8 0-10 16,0 0 8-16,0 0-14 0,0 0 20 15,7 0-13-15,-7-5 12 0,0 5-8 0,0 0-1 16,8 0-9-16,-8 0 18 0,10-8 0 0,-10 8 8 16,3 0-4-16,0-2-6 0,-2 2-1 15,-1-1-21-15,0 1 20 0,0 0-3 0,0 0 8 16,0 0 1-16,0 0-34 0,0 0 24 16,0 0-12-16,0 0 4 0,0 0 8 0,0 0-4 15,0 0 3-15,0 0-2 0,0 0 3 0,0 0 2 16,8 0-9-16,-8 0 9 0,0 0-2 0,0 0-14 15,0 0 2-15,0 0 4 0,0 0 4 16,0 0-8-16,5 0 12 0,-5 0-1 0,0 0-13 16,0 0 13-16,0 0-5 0,0 0 5 0,7 0 6 15,-7 0 0-15,0 0-12 0,0 0-5 16,8 0 17-16,-8 0-4 0,7 0-14 16,-7 0 22-16,15 8-5 0,-14-8-21 0,2 3 6 15,2-3 11-15,-4 0 12 0,2 1-23 0,1-1 8 16,-2 0-9-16,3 0 28 0,-5 0-12 15,0 0 0-15,0 0-15 0,8 0 0 0,-8 0 9 16,7 0 0-16,-7 0-9 0,6 0 20 0,-6 0-5 16,9 0-5-16,-9 0 15 0,6 0-14 15,-6 0-4-15,8 0 0 0,2-8-11 0,-7 8 4 16,0-1 11-16,0-1-11 0,-3 1-3 0,3 0 24 16,-3 1-10-16,0 0-3 0,0 0-11 15,0 0 18-15,7 0-7 0,-7 0 0 0,0 0-13 16,15-9-3-16,-14 9 17 0,2-1 3 15,-2 0 11-15,3 0-6 0,-3-2-7 0,1 2-18 16,0 0 13-16,1 1 11 0,-2 0-6 16,0-3 2-16,3 1-7 0,-3 1-2 0,1 0-8 0,-1 1 20 15,-1-1-27-15,3-1 25 0,-3 0 10 16,2 1 0-16,-1 0-15 0,-1 1-8 0,1-1 2 16,2 0 1-16,-3-1-3 0,0 1 13 15,3-1-8-15,-3 1 6 0,1 1-5 0,0 0-3 16,-1 0 0-16,0-2 7 0,0 0-13 0,1 2 20 15,1 0-9-15,-1-1-26 0,-1-1 10 16,0 2 22-16,0 0-23 0,0 0 12 0,0 0-5 16,1 0-4-16,-1-2-2 0,2 1 14 15,-1 1 8-15,-1 0-5 0,0 0-6 0,0 0-2 16,0 0 16-16,0 0-13 0,0 0-6 16,0 0-8-16,0 0 3 0,0 0-7 0,0 0 22 15,0 0 4-15,0 0 10 0,0 0-24 16,0 0 7-16,0 0 3 0,7 0 0 0,-7 0 13 15,0 0-28-15,0 0-6 0,0 0-5 0,8 0 19 16,-8 0 4-16,0 0 15 0,4 0-14 16,-4 0-2-16,0 0 1 0,0 0-14 15,0 0-7-15,0 0 17 0,0 0 15 0,8 0-11 16,-8 0-25-16,0 0 23 0,0 0 7 0,0 0 4 16,7 0-28-16,-7 0 7 0,0 0 21 0,0 0-1 15,0 0 0-15,0 0-6 0,8 0 5 16,-8 0 2-16,6 3 15 0,-6-3-31 0,3 0 1 15,-3 0 8-15,3 0 10 0,1 0-10 16,-4 0-32-16,3 2 23 0,-3-4 8 0,0 2-15 16,2 0 7-16,-2 0 10 0,1 0-16 0,-1 0 25 15,2 0-2-15,-1 0-1 0,-1 0-22 16,0 0 26-16,3 0-9 0,-3 0 2 0,0 0-22 16,0 0 12-16,2 0 13 0,-2 0 3 15,1 0-7-15,-1 0 5 0,0-2-3 0,3 4-30 16,-3-4 36-16,0 2-15 0,0 0 14 0,0-1 10 15,2 1-11-15,-2-1 2 0,2 0-26 0,-1 1 16 16,-1-1 9-16,0 1-8 0,1 0-15 16,-1-1 37-16,2 0-20 0,-2 1 4 0,1 0-7 15,0-1 11-15,-1-1-13 0,2 1 3 16,-2 0 11-16,2 0-9 0,-2 1-2 0,1-1 12 16,1 1-6-16,-2-1-18 0,1 0 3 0,-1-1 18 15,0 0-5-15,3 2-14 0,-3-2 11 16,2 2 0-16,-2-1 0 0,1 0 6 0,-1-1-17 15,0 0 29-15,4 2-15 0,-4 0-4 0,0 0-7 16,1-3 23-16,-1 2-15 0,2-1-15 16,-2 1 1-16,2 1 11 0,-3-1 6 0,2 0-1 15,-1-1 6-15,0 1-7 0,0-1-6 0,0 2-22 16,0-1 40-16,0 0-15 0,0 1 1 16,0 0-4-16,0 0-18 0,0 0 29 0,0 0-16 15,0 0 9-15,0-7-4 0,0 7 11 0,0 0 11 16,0-7-29-16,0 7-3 0,0 0 21 15,0 0-4-15,0-5-14 0,0 5 20 0,0 0-5 16,0 0 16-16,0 0-31 0,0 0 9 0,0-5-1 16,0 5-5-16,0 0 24 0,0 0-32 0,0 0 8 15,0 0 3-15,0 0-19 0,0 0-4 16,0 0 22-16,1-6-1 0,-1 7-6 0,-1 0 18 16,1 1-38-16,-1 0 14 0,0 1-3 0,2-1 0 15,-1 2-2-15,-1-3 21 0,-1 3-19 16,1-2-3-16,1-1 15 0,0 3 2 0,-2-1 2 15,2-1 19-15,-2 0-25 0,1 1-8 16,1-1 10-16,-2-1-28 0,0 1 36 0,2 0 10 16,-1 0-60-16,0 0 52 0,-1 0 8 0,1-2-24 15,0 2-4-15,-2-2 22 0,3 2-18 16,-2-2 2-16,0 2-9 0,1-2 31 0,1 0-46 16,-3 0 14-16,1 2 30 0,1-2 6 15,-2 0-1-15,1 0-29 0,2-2 48 0,0 4-23 16,-3-2-12-16,3-2 8 0,0 2 6 0,-1 0 1 15,1-2-16-15,-2 2 23 0,2 0 4 0,-1 0-12 16,1 0-21-16,-2 0-21 0,2-2 25 16,2 2 21-16,-2-1-38 0,-2 1 5 0,4-1 46 15,-2 1-59-15,0 0 3 0,0 0 36 0,0 0 2 16,0-1 24-16,1 0-20 0,-1 1-21 16,0 0 31-16,2 0-36 0,-1 0-22 0,-1-2 28 15,0 2 13-15,0 0-36 0,0 0 35 0,0 0 9 16,3 0-25-16,-3 0 21 0,0 0-5 15,2 0-31-15,-1 0 56 0,-1 0-27 16,2 0-18-16,-1 0 43 0,-1 0-20 0,0 0 13 16,0 0-16-16,0 0-11 0,2 0 16 0,-2 0-12 15,0 0-3-15,0 0 8 0,0 0 0 16,0 0 5-16,0 0-18 0,2 0 15 0,-2 0-9 16,0 0 0-16,1 0 24 0,-1 0-53 15,-1 0 56-15,1 0-59 0,1 0 25 0,-1 0-28 16,0 0 60-16,0 0 0 0,0 0-2 0,0 0-30 15,0 0 25-15,0 0-28 0,0 0 8 16,0 0-4-16,0 0 12 0,-1 0-6 0,2 0 16 16,-1 0-6-16,0 0-6 0,0 0-5 0,0 0-24 15,0 0-5-15,-1 0 33 0,2 0-32 16,-2-2 50-16,1 2-14 0,-2 0 12 16,2-1-3-16,0 2-12 0,-2-1 7 0,2 2-11 15,0-2 15-15,0 0-39 0,0 0 35 0,0 0 9 16,0 0-18-16,0 0-9 0,0 0 13 15,-1 0-2-15,2 0-35 0,-1 0 38 0,0 0-16 16,0 0 21-16,0 0-36 0,0 0-3 0,0 0 32 16,0 2 11-16,0-2-35 0,0 0 48 0,0 0-32 15,0 0 5-15,0 0 6 0,0 0 5 16,0 0 1-16,0 2-17 0,0-2 40 0,0 0-66 16,0 0 30-16,0 0 21 0,0 1 6 15,0-1-30-15,0 0-59 0,2 0 6 0,-2 1-21 16,2 1-49-16,-2-2-42 0,-2 2-4 0,2 1-99 15,0 0 26-15,-2 1 18 0</inkml:trace>
  <inkml:trace contextRef="#ctx0" brushRef="#br1" timeOffset="1">48-29 251 0,'0'0'40'0,"0"0"-21"0,0 0 51 0,0 0-88 15,0 0 27-15,0 0 53 0,0 0-56 16,0 0-15-16,14 0-8 0,-14 0 106 0,0 0-85 16,0 0 71-16,0 0-13 0,0 0-36 15,0 0-49-15,0 0 11 0,0 0 27 0,0 0 20 16,0 0-43-16,0 0 13 0,0 0 10 0,0 0-12 15,0 0-4-15,0 0 11 0,0 0 26 16,0 0-10-16,0 0 8 0,0 0-32 0,0 0 0 16,0 0 0-16,0 0 7 0,0 0-12 15,0 0 10-15,0 0-7 0,0 0 29 0,0 0-5 16,0 0 0-16,0 0-26 0,0 0 47 0,0 0-7 16,0 0-4-16,0 0-4 0,0 0-14 15,0 0-3-15,0 0 43 0,0 0-1 0,0 0-6 16,0 0-5-16,0 0-27 0,0 0-2 0,0 0 0 15,0 0 5-15,0 0 18 0,0 0-4 16,0 0-4-16,0 0-18 0,0 0-2 0,0 0-44 16,0-11 4-16,0 11 50 0,0 0-3 0,0 0-28 15,0 0-1-15,0 0 19 0,0 0 0 0,0 0 23 16,0 0-4-16,0 0-43 0,0 0-29 16,0 0 42-16,0 0 1 0,0 0 1 0,0 0-1 15,0 0 45-15,0 0-20 0,0 0-2 16,0 0-4-16,0 0 11 0,0 0-4 0,0 0-65 15,0 0 5-15,0 0 35 0,0 0 11 0,0 0-1 16,0 0 0-16,0 0 26 0,0 0-18 16,0 0 0-16,0 0-18 0,0 0-1 15,13 0 2-15,-13 0-7 0,0 0 31 0,0 0-9 16,0 0-11-16,0 0-8 0,20 8 8 0,-16-7 0 16,-4 1 1-16,2 1-2 0,0-3 1 0,0 2-5 15,0 0 18-15,-1-2-1 0,0 2-4 0,3 0-13 16,-4-1 7-16,4 0-1 0,-2 1-1 15,-2 0-12-15,1-1 16 0,1-1-1 0,0 2 0 16,0-1 8-16,-1 0-35 0,-1-1 6 16,1 4 20-16,0-4-2 0,1 1-29 0,-1 1-20 15,0 0 4-15,3-1 35 0,-4 1 8 0,3-2 1 16,-2 2 1-16,-1-2-1 0,0 3 13 16,2-2-12-16,-2 0 1 0,3 1 0 0,-3 1-1 15,1-1-8-15,1-1 3 0,1 0 9 16,-3 0 1-16,3 1 14 0,-3 0-35 0,2 0 1 15,-2 0 0-15,4 0 3 0,-4 0 42 16,1-2-32-16,-1 2 4 0,3 2-2 0,-3-2 0 16,2 0 5-16,1 2-8 0,-3-3 4 0,0 2-2 15,1 0 1-15,-1-1 0 0,0-1-2 16,3 2-24-16,-3-1 6 0,0 0-13 0,0 2 3 16,2-2 60-16,-2 0-2 0,2 2-69 15,-1-3 21-15,-1 0 1 0,0 2 1 0,0 1 2 16,0-4 1-16,1 3 22 0,-1 0 1 0,0-2 12 15,4 1-3-15,-4 1-2 0,1-2-2 16,-1 1-62-16,1-1 6 0,-1 3 65 0,0-4-29 16,2 2 23-16,-2-2 1 0,0 2-52 0,0-1 2 15,0 0 50-15,1 0-1 0,-1 1-2 0,0-2-2 16,0 0-12-16,0 0 1 0,0 0-25 16,0 0 2-16,0 0 37 0,0 0 11 0,0 0-21 15,0 0 0-15,0 0-29 0,0 6 3 16,0-6 18-16,0 0 6 0,0 0-11 0,0 0 31 15,0 5-3-15,0-5-2 0,0 0-38 0,0 0 13 16,0 6 3-16,0-6-1 0,0 0 0 16,0 0-1-16,0 5-4 0,0-5 3 0,0 0 23 15,0 0 3-15,0 7-6 0,0-7-14 0,0 0-4 16,0 7 6-16,0-7 19 0,0 0-4 16,0 5-49-16,0-5 2 0,0 0 27 0,0 0-4 15,0 0 28-15,0 6-34 0,6-6 0 16,-6 0 3-16,0 0-7 0,0 5-1 0,0-5 26 15,0 0-3-15,0 7-1 0,0-7-46 0,0 6 5 16,0-6 39-16,0 0 1 0,8 4 33 16,-8-4-30-16,0 0 4 0,0 0-14 0,0 5 8 15,13 5 0-15,-11-8 0 0,-2 0-3 16,0-1 10-16,3 1-18 0,-2 1 2 0,2-1-38 0,-3 0 4 16,0 1 44-16,2-1 30 0,0 1 9 15,-1-2-25-15,0 2-22 0,3 0 4 0,-4-1 32 16,1-1 4-16,0 1-14 0,1 0-22 0,-2 0 1 15,2 1-21-15,2-3 34 0,-4 2-15 16,0-1 11-16,3 3 18 0,-3-4-27 0,2 2 14 16,0 0-3-16,-1 0-67 0,0 0 4 15,3 2 73-15,-4-2-20 0,2-1-23 0,0 0 27 16,-1 1 19-16,0-1-9 0,1 2 7 16,-1-2-50-16,-1 1 20 0,2 2 28 15,-2-4-20-15,3 2-8 0,-2 0 16 0,-1-1 6 16,2 1-29-16,-1 0-19 0,-1-1-3 0,0 3 36 15,2-2-1-15,2-1-33 0,-4 1 2 0,0 2 3 16,3-3 21-16,-2 1 17 0,-1-1 0 0,0 3-17 16,2-4-8-16,-2 2 36 0,3 0-39 15,-3-2 51-15,0 0-22 0,0 0-3 0,0 0 2 16,0 5 19-16,0-5-49 0,0 0 25 16,0 7-33-16,0-7 16 0,0 0 29 0,0 0-30 15,0 6-7-15,0-6 14 0,0 5 25 0,9 3-8 16,-3-7 0-16,-5 0-3 0,-1 1-44 15,0 1 44-15,0-2-9 0,0 1 7 0,0-1 15 16,0 2-35-16,2-2 11 0,-2 0 1 0,0 1 0 16,0 1 0-16,0-3 0 0,0 0-15 0,0 0 28 15,0 0 12-15,0 5-8 0,0-5-3 16,0 0-2-16,0 6-37 0,0-6-6 16,0 7 50-16,0-7-15 0,0 0 12 0,0 6-43 15,0-6 43-15,0 0 6 0,0 6-17 0,0-6 2 16,0 5-34-16,0-5 50 0,0 7-19 0,0-7-16 15,0 0 13-15,0 7 21 0,0-7-45 16,0 5 25-16,0-5-2 0,0 0 21 0,0 7 0 16,0-7-6-16,0 0-9 0,0 7 11 15,0-7-14-15,0 0-19 0,0 6 24 0,0-6 12 16,0 0-30-16,0 5 32 0,0-5-22 16,0 5 16-16,0-5-4 0,0 0-28 0,0 6 4 15,0-6 30-15,0 0 1 0,0 7-43 0,0-7 41 16,0 0-13-16,14 10-2 0,-14-10-13 0,0 0 0 15,0 0 13-15,0 0 17 0,0 6-8 0,0-6-35 16,0 0 33-16,0 7-1 0,0-7 4 16,0 0 23-16,0 6-27 0,0-6 3 0,0 0-11 15,10 12-4-15,-9-10 24 0,0 0 2 16,2 0-31-16,-3 0-6 0,1 1 17 0,0-1-25 16,-1-1 31-16,2 2 19 0,-2 0-49 0,2-1 44 15,0 1-16-15,-1-1-9 0,-1 1 10 0,1 0 15 16,2-1-31-16,-1 1 4 0,1 0 45 15,-2-3-35-15,-1 0 13 0,0 0-30 16,0 0 30-16,0 0-10 0,0 7 15 0,10 4-9 16,-10-9-15-16,2 1-2 0,0 0-8 0,-1-1 25 15,1 1-21-15,-2-2-7 0,0 1 20 16,5 1-5-16,-4-2-19 0,-1 1 23 0,4 1-1 16,-4-1 11-16,1 1-8 0,0-1 22 15,1 1-19-15,-1-1-20 0,0 0 14 0,-1 1-4 16,2-3 11-16,-1 3-1 0,-1 0-18 0,1-2 15 15,0 3 1-15,2-2 16 0,-3 0-28 16,1 1 0-16,-1 0 1 0,2-3 24 0,-2 2-43 16,2-1-9-16,-2 1 39 0,0-1-1 15,0 1-15-15,2-2-23 0,1 0 45 0,-3 0-13 16,1 2-7-16,-1-1 8 0,0-1 10 16,0 0 20-16,0 0-52 0,0 0 32 0,0 0-23 15,0 0 8-15,0 0 1 0,0 0-2 16,0 0-25-16,0 0 28 0,0 0-5 0,0 0 14 15,0 0 1-15,13 11 5 0,-13-10-9 0,1-1 11 16,-1 2-7-16,3-2-40 0,0 0 45 16,-3 0 10-16,0 0-21 0,3 0 8 0,-3 2-9 15,0-2-8-15,3-2 13 0,-3 2 24 0,0 0-22 16,3-2-21-16,-3 2 13 0,3-2 12 16,-3 1-20-16,0-2 27 0,3 3-47 0,-3-2 45 15,0-1-34-15,3 1 27 0,-1 0-14 16,-2-1 10-16,0 0-22 0,1 2 25 0,-1-3-7 15,4 1-5-15,-2 1 3 0,-1 0 5 0,1-2-16 16,-2 2 6-16,1 0-17 0,3-1 30 0,-4 0-14 16,1-1 12-16,1 3-8 0,-1-2 19 15,-1 0-23-15,2 1-2 0,0-2 8 0,-1 1 5 16,-1 2-30-16,0-1 22 0,1 0-23 16,3 1 37-16,-4-1-36 0,0-1 16 0,2 3 14 15,0-2 6-15,-1 1 8 0,-1 0-12 0,0-1-3 16,0 1-1-16,1 0 15 0,-1-1-26 15,2 2 25-15,-1 0-49 0,-1-1 38 0,2 0-20 16,-2 0 17-16,2 0-13 0,-2 0 21 16,1 0-26-16,0 1 9 0,2-2 15 0,-3 1-13 15,1 1-6-15,0 0 8 0,-1-2 3 0,3 2 5 16,-1-2-1-16,-2 2 2 0,3-3-17 16,-3 3 7-16,1 0 7 0,-1 0-1 0,2 0 1 15,0-1-1-15,1 0-11 0,-2 1-2 16,2 0 2-16,-2-1 7 0,0 1-12 0,-1 0 8 15,0 0 14-15,0 0-16 0,0 0 2 0,0 0-14 16,9 0 30-16,-9 0-44 0,0 0 27 0,6 0 5 16,-6 0 12-16,0 0-10 0,8 0-23 15,-8 0 46-15,0 0-18 0,7 0 7 0,-7 0-16 16,0 0-22-16,0 0 24 0,6 0-12 16,-6 0-5-16,0 0 26 0,0 0 2 0,5 0-2 15,-5 0-4-15,0 0 3 0,9 0 7 16,-9 0-14-16,7 0 19 0,2 10-16 0,-6-9-7 15,1 2-13-15,-1-2-10 0,2 2 34 16,-2 0-2-16,-1-1-12 0,1 1 1 0,-2 0 14 16,2-1-15-16,-1-1 0 0,0 2-24 0,4-1 43 15,-5 0 0-15,0 0-31 0,1 0 20 16,2 1 7-16,-3-1-8 0,2-1-11 0,-2 2 6 16,1-2 16-16,1 2-4 0,-2-1-30 15,1 1 49-15,-1-1-56 0,2 1 4 0,-1 0 10 16,-1-2-8-16,0 2 28 0,2-2-32 0,-2 2 34 15,0 0 3-15,2-1-13 0,-2 0 3 0,1-1 7 16,-1 1 1-16,-1 0-36 0,3-1 42 16,-3 1-30-16,2 0 47 0,-2 0-58 0,4 0 45 15,-3-1-9-15,-1 1-4 0,2 1 11 16,-1-1-34-16,-1-1 15 0,2 1 8 0,1 0 20 16,-1-1 7-16,-2 2-23 0,3-3 7 15,-3 2-8-15,0-1 21 0,3 2-19 0,-3-1 18 16,3-1-52-16,-3 1 24 0,4 0 9 0,-1-1 11 15,0 0-47-15,0 2 31 0,-3-1-2 16,5-1 23-16,-4 1-6 0,2 0-15 0,0 0-10 16,0 1 12-16,1-2-5 0,-3 1 19 0,2 0-18 15,-1 2 20-15,1-4-20 0,-1 3 7 0,0-2-1 16,-1 2 2-16,2-3-5 0,1 4 1 16,-1-3-3-16,0 0-33 0,-1 1 15 0,2 0 24 15,-1 0-3-15,-1 1-8 0,2 0-13 16,1-1 44-16,0 1-29 0,-4 0 11 0,3 0-4 15,0-1-21-15,0 1 9 0,0 0 8 0,1-1 11 16,-1 0-7-16,-3 0 3 0,4 0-4 16,-1 1-16-16,-4-2 27 0,5 2-10 0,-3-2 5 15,1 1-6-15,-3-1-32 0,4 0 25 0,-2 0-10 16,1 1 11-16,-1 1 0 0,-1-2-15 16,1 0 8-16,-1 0 22 0,3 1-16 0,-2-2 6 15,1 4-19-15,-2-3 23 0,2 1-13 16,0 0 3-16,1-1-18 0,-1 2 29 15,-3-1-24-15,4-1 25 0,0 1 20 0,-2-1-20 16,-1 1 22-16,2 0-12 0,0 0-26 0,-2-1 33 16,1 0-16-16,-2 0 10 0,3 2-27 15,-3-3 6-15,1 1 14 0,2 1 2 0,-3-2-27 16,3 1 25-16,0-1 6 0,-3 0-11 16,0 0-10-16,0 0 13 0,0 0 7 0,0 0-31 15,0 0 9-15,6 0 11 0,-6 0-19 0,0 0 23 16,7 0 1-16,-7 0-11 0,0 0-14 0,6 0-14 15,-6 0 27-15,0 0 0 0,0 0-9 0,8 0 11 16,-8 0 10-16,8 0-1 0,-8 0-21 16,0 0-6-16,6 0 12 0,-6 0 7 0,0 0 6 15,9 0-21-15,-9 0 20 0,0 0-3 16,6 0 10-16,-6 0-13 0,8 0-4 0,-8 0 10 16,0 0-10-16,7 0-12 0,-7 0 4 0,8 0 1 15,-8 0 8-15,7 0 2 0,-7 0-23 16,7 0 25-16,-7 0-2 0,0 0-9 0,8 0 22 15,-8 0-16-15,6 0-4 0,-6 0-10 0,0 0 14 16,9 0 11-16,2 7-12 0,-8-6-15 0,1-1 23 16,0 1-8-16,-2 1 3 0,3-1 17 15,-1 0-4-15,-4 1-15 0,5-2-16 0,-2 2 1 16,-2-2 11-16,2 3 4 0,0-2 4 0,1 1 0 16,0 0-11-16,-1 2 20 0,-1-3-21 15,2 1 17-15,-1 0-39 0,0 1 27 0,0-2 9 16,1 2-9-16,-1 0-22 0,0-1 25 15,-2-1 4-15,3 2-1 0,0-1-1 0,-4 0 3 16,3 2 11-16,-1-3-11 0,2 1-16 0,-3-1 9 16,4 1 2-16,-2 1 2 0,-1-2-8 15,1 1 11-15,-2 1-2 0,2-2 3 0,-1 1-10 16,-1 2-15-16,3-3 30 0,-4 1-1 0,4 2 1 16,-2-2-25-16,0 1 15 0,-1-2-3 15,0 0 9-15,2 2-16 0,-3-1 11 0,3 0-10 16,-1-2 20-16,-1 1 9 0,2 0-19 15,-2 1-4-15,3 0-12 0,-3 1 10 0,0-3 11 16,-1 2-8-16,3-1-24 0,-2 1 35 0,3 1-12 16,-3-3 11-16,-1 2-8 0,2 0 7 0,-1-1-17 15,-1-1 11-15,0 1 0 0,0-1 7 16,4 0-16-16,-4 1 14 0,2 0-3 0,-1 1 3 16,2-2 4-16,-3 2-20 0,0-2 16 15,3 0-10-15,-3 2-8 0,0-2 10 0,0 0 4 16,0 0 9-16,0 0-10 0,0 0-18 0,0 0 21 15,0 0-2-15,0 0 3 0,6-2-25 0,-6 2 38 16,0 0-17-16,3 0-1 0,-2 0-17 0,-1 0 22 16,1-2-10-16,1 2 3 0,-1 0 0 15,2-2 3-15,-3 2-16 0,0-2 12 0,3 2-9 16,-3-1 10-16,0-1-19 0,1-1 15 16,1 3-4-16,-1-2 7 0,1 1-3 0,-2-2 10 15,3 1 4-15,-3 2 2 0,0-3 1 16,1 1-11-16,1 1-25 0,-1-2 33 0,-1 1-16 15,2-2 1-15,-2 2 0 0,3-2-29 0,-3 2 35 16,0 2-3-16,0-3-9 0,0 0 24 16,0-1-12-16,3 0-5 0,-3 1-14 0,1 1 9 15,-1-1 14-15,0 1 12 0,0 2-43 0,0 0 34 16,0 0-10-16,0-5 4 0,0 5-8 16,0-7 14-16,0 7-26 0,0 0 13 0,0-5-23 15,0 5 29-15,0 0-18 0,0-7 25 0,0 7-10 16,0 0 16-16,0 0-3 0,0-5-33 0,0 5 4 15,0 0 20-15,0 0-19 0,0 0 26 16,0 0 3-16,0-7-9 0,0 7-17 0,0 0 3 16,0 0 14-16,0 0 15 0,0 0-19 15,0 0 12-15,0-5 10 0,0 5-32 0,0 0 10 16,0 0 7-16,0 0 1 0,0 0 0 0,0 0 0 16,0-7-3-16,0 7 7 0,0 0-42 15,0 0 44-15,0 0-12 0,0 0-3 0,0 0-3 16,0 0 13-16,6-5-4 0,-6 5-6 0,0 0-2 15,0 0 11-15,0 0-7 0,11-9 4 16,-8 8-11-16,-3 0-17 0,0-1 23 0,6 1 8 16,-5-1-20-16,-1 0 22 0,0 1-14 15,3-1 20-15,-3 2-22 0,0-3 26 0,0 1-18 16,3 1 9-16,0-1 7 0,-3 0 7 0,0 1-15 16,3 0 4-16,-2-1-5 0,2 0-13 15,0 1 3-15,0-1 3 0,0 1 19 16,-1-1 5-16,1 0-16 0,-1 0-5 0,1 0-24 15,1 1 9-15,-2 0 25 0,1-1-12 0,2-1-1 16,-4 2 5-16,3-1 2 0,-3 0-3 0,2 1 18 16,2-1-32-16,-4 1 4 0,2-1-3 15,2 1 16-15,-3 0-11 0,1 0 12 0,0-1-9 16,-2 0 7-16,1 0-14 0,1 2 7 0,0-2 6 16,-1 2-20-16,2-2 18 0,-3 0 3 15,0 0 2-15,3 0 1 0,-1 1-3 0,-2-2-9 16,1 2 4-16,1-1 0 0,0 0 0 0,-2 2-13 15,-1-2 21-15,3 0-8 0,0 0-22 16,0 2 31-16,0-2-5 0,0 0 3 0,0 0-27 16,-1 2 8-16,-1-2 17 0,2-2-14 0,0 4 9 15,2-2 15-15,-2 0-12 0,0 0-13 16,0 1 26-16,-2-1-14 0,2-1 6 0,2 0-26 16,-2 2 16-16,1-2 12 0,-1 1-11 15,1 2 10-15,-2-4-9 0,-1 4 6 0,2-2-12 16,1 0 12-16,-2-1-1 0,1 3-30 0,-1-3 35 15,1 2-11-15,-2 0 9 0,0 0 6 16,2-1-24-16,0-1 17 0,0 2-15 0,-2 0 20 16,1-2-24-16,2 2 29 0,-2 0-28 15,0-1 31-15,0 2-39 0,-1-2 29 0,2 2-9 16,-3-1-12-16,4-1 9 0,-1 1-5 0,0-1 21 16,0 2 14-16,-1-2-18 0,0-1 2 0,1 2-1 15,0 0 7-15,-3-1-17 0,1 2 9 16,4-3 2-16,-5 3-1 0,0 0-10 0,0 0-10 15,0 0 5-15,0 0-17 0,6 0 25 16,-6 0-4-16,13-9 2 0,-12 7 7 0,2 2-3 16,-2-1-16-16,1 0 27 0,-1-1-14 0,2 1 0 15,-3-2 19-15,2 2-13 0,0 0 1 16,1-1-8-16,-3-1 7 0,3 3 1 0,-1 0-4 16,-2-2-7-16,3 1-11 0,-2-1 6 0,0 0-1 15,1-1 1-15,0 3 18 0,-1-2-17 16,2 0 4-16,2 1-9 0,-4 0-1 0,2 0 22 15,-1-1 0-15,0 1-1 0,0-1-6 16,1 2 4-16,-2-1-11 0,2 0 1 0,-1-1 1 16,2 2 19-16,-3-3-28 0,2 1 5 15,-1 2 14-15,1 0-13 0,-2-3 6 0,2 3 10 16,-2 0-19-16,2 0 10 0,-2-2-13 0,0 1 20 16,-1 0 0-16,3-1-29 0,0 2 16 15,-3-1 12-15,3-2-9 0,-3 3-3 0,1-1-4 16,2 0 13-16,-1 1-14 0,1-2 15 0,-2 1-6 15,1 1-14-15,-1-1 28 0,-1-1-1 16,2 2-34-16,-2-1 29 0,0 1 0 0,3 0-3 16,0-2-19-16,-3 2-7 0,1-2 31 0,-1 1-12 15,3 1 0-15,-3-2-18 0,0 2 26 16,3 0-17-16,-3 0 23 0,2-1-11 0,-2 0-24 16,0 1 28-16,1 0-5 0,1-1 2 15,-2-1-6-15,0 2 15 0,3-1-16 0,-2 1 20 16,-1-1-19-16,0 1 8 0,4-1-8 0,-4 1-17 15,1-1 21-15,-1 1-9 0,0 0 7 16,0 0 11-16,0 0-15 0,0 0 8 0,0 0-3 16,0 0-9-16,0 0 13 0,0 0 2 0,0 0-12 15,0 0-7-15,0 0-5 0,0 0 10 16,0 0-3-16,6 0 8 0,-6 0-17 0,0 0 15 16,0 0 3-16,0 0 3 0,0 0 15 0,0 0-20 15,0 0 6-15,0 0-11 0,7 0-3 0,-7 0 17 16,0 0 7-16,0 0-4 0,7 0-15 15,-7 0 6-15,0 0 6 0,0 0-10 0,0 0 2 16,9 0 6-16,-9 0-19 0,0 6 11 16,0-6 8-16,6 0 16 0,-6 0-22 0,0 0-8 15,8 0 0-15,4 10-6 0,-10-9 10 0,1-1 7 16,-1 0 2-16,0 3-5 0,0-2 6 16,1 1-12-16,-1-2 19 0,0 1-16 15,1 0 6-15,0-1-7 0,-1 2 14 0,2-1-2 16,-2 0 1-16,1 1-18 0,-3-2 17 0,4 1-18 15,-2 0 16-15,1 1 10 0,-3-2-11 0,5 2 1 16,-3-1-1-16,1-1 1 0,0 2 1 16,-1-1 5-16,1 1-10 0,-3-2 5 0,3 2-20 15,-2-1 9-15,3 0 3 0,-2 2-6 0,1-2 7 16,-1 1 12-16,2-1-3 0,1 0-9 16,-2 2 8-16,-2-2 1 0,2 2 8 0,0-1-19 15,-2 0 8-15,2-1-4 0,-2 1 8 0,2-2-14 16,-2 2 11-16,2 0-23 0,-1 0 22 0,1-1-19 15,0 1 5-15,-2 0 6 0,4 0 12 16,-3-1 8-16,0 2-25 0,0-1-14 16,1 1 22-16,-1-1-9 0,2 0 15 0,-3 1-6 15,4-1 0-15,-2 1-8 0,-2-1 12 16,2 0-1-16,1 1 0 0,-2 0-19 0,1-1 29 16,-2 2-22-16,3-1 16 0,-3-1-14 0,3 1 22 15,-2 1-27-15,1-1 16 0,-2-1 18 16,2 3-18-16,-1-4-3 0,1 3-11 0,0 1 26 15,-1-3-34-15,2 3 22 0,-3-2-15 0,2-1 22 16,-1 2-12-16,-2 1 1 0,3-2 6 16,-3-1-9-16,1 0-4 0,3 2 11 0,-3 0-3 15,-1-2-1-15,3 1 1 0,-1-1 17 16,-1 3-17-16,1-3-4 0,0 1 8 0,-2 0-10 16,3 0 5-16,-1 0 7 0,-2 0-9 0,3 1 5 15,-2-1-2-15,0 1-3 0,1-1-3 16,0-1 13-16,-2 1-20 0,2 1 22 0,-1-2-10 15,1 1 6-15,-2 0-15 0,3-1 27 0,-1 0-15 16,-2 3-2-16,0-2-11 0,3-1 22 16,-3 0-6-16,0 1-6 0,2 0 10 0,-1-1-20 15,-1-2 20-15,0 0-1 0,0 0-8 0,0 0 5 16,0 8-3-16,0-8-2 0,0 6 6 16,0-6-4-16,0 7-9 0,0-7-5 0,0 7 22 15,0-7-5-15,0 7-20 0,0-7-1 0,11 13 12 16,-10-11 9-16,-1 2 1 0,0-1-21 15,0 0 17-15,2 0 13 0,-1 1-15 0,0-2 15 16,-1 1-17-16,2-2-5 0,-2 1 16 0,2 2 5 16,-2-3-19-16,1 1 11 0,0 0-23 0,-1 0 13 15,2 0 6-15,-2 1-6 0,0-1-3 16,1-1 22-16,-1 1-30 0,0 0 13 0,1 1 17 16,-1-1-18-16,0 1-9 0,0 0 20 15,0-1-12-15,0 2 1 0,3-2 3 0,-3 2 1 16,1-2 11-16,0 0-30 0,-1 4 19 15,2-4 3-15,-1 1 10 0,-1 0-25 0,1 1 13 16,-1-1 4-16,2-1 12 0,-1 2-30 0,-1-2 17 16,1 0 0-16,-1 2-11 0,1-2-3 0,2 0 12 15,-3 1 2-15,2-3 6 0,-2 3-25 16,0-1 18-16,2-1-2 0,-2 1-13 0,0 0 19 16,1 0-8-16,-1-2 4 0,0 3-1 15,2-1-20-15,-2 1 21 0,3-1-12 0,-3-1-2 16,1 1 15-16,-1 0-5 0,2 0-12 0,-2 0 5 15,1 2-8-15,0-3 19 0,-1 2-15 0,3-3 31 16,-3 4-18-16,2-2 2 0,-2-2 10 0,2 2-14 16,1 0 4-16,-3 1-19 0,3-2 1 15,-3 0 18-15,0 0 7 0,0 1-21 0,0 1 30 16,1-1-11-16,1 1-6 0,-1-2-18 16,-1 1 4-16,2 0 9 0,-2 0 13 0,0 0-17 15,0-1 0-15,0 1 16 0,3 3-16 0,-3-4-3 16,1 1 4-16,-1 0 3 0,2 0 4 15,1 1-16-15,-3-2 25 0,0-1 3 0,0 0-8 16,0 0 6-16,0 0 1 0,0 0-8 0,0 6-17 16,0-6 13-16,0 0-2 0,0 0 9 0,0 6-10 15,0-6 0-15,0 0 3 0,0 6-2 16,0-6-1-16,0 0 4 0,0 7 4 0,0-7-23 16,0 0 40-16,0 3-25 0,0-3 14 15,0 0-6-15,0 0-32 0,0 7 25 0,0-7-12 16,0 0 18-16,0 6 5 0,0-6-21 0,0 0 27 15,0 7-14-15,0-7-19 0,7 6 20 16,1 0-19-16,-7-5 28 0,-1 1-10 0,2 0 1 16,-2-1 10-16,0 1-24 0,1 0-5 15,-1-1 26-15,0 1-5 0,0 0 1 0,3 1-1 16,-1-3 0-16,-2 2 3 0,0 1-6 0,0-2-7 16,3 2-3-16,-2-2 14 0,1 2 10 15,-2-2-15-15,2 1 0 0,0-2-14 0,-2 3 13 16,0-1 15-16,2-2-21 0,-1 3 13 0,-1 0-1 15,0-1 10-15,2 0-34 0,-1-2 26 16,1 4-7-16,-1-3 1 0,-1 1-14 0,3 2 21 16,-3-2-13-16,4 0 15 0,-2 2-13 15,-2-2 22-15,3 1-18 0,-2 0 12 0,-1-1-5 16,1 1 3-16,-1 0-8 0,3-3-14 16,-3 2-3-16,2 3 11 0,-2-3-14 0,2-1 34 15,0 2-16-15,0-3-12 0,0 2 5 0,-1 1 5 16,1-1 4-16,0 1 6 0,-2-3 6 15,0 2-19-15,4 0 17 0,-3 0-12 0,0-1 15 16,3 1-31-16,-4 0 31 0,3 0-2 16,-2-2-19-16,-1 3 4 0,0-2 17 0,4 1-22 15,-3-2 7-15,-1 2-1 0,4-2-14 0,-2 0 15 16,2 0 3-16,-2 2-14 0,0-2 24 16,1 1-37-16,0 1 25 0,0-2 1 0,0 1-17 15,-2 0 25-15,5 0-14 0,-3 1 5 0,-2-2 10 16,3 3-15-16,0-2 1 0,-2 0-5 15,2 0 2-15,1 1 20 0,0-1-22 0,-3 2 4 16,1-3 7-16,0 1 1 0,3 0-11 0,-3 0 6 16,1 1-19-16,-1 0 9 0,0-2 14 15,2 2-1-15,-2-2 6 0,-1 2-15 0,1-1 3 16,1 0-5-16,-1 0 2 0,0-1-1 16,-2 3 6-16,0-3-4 0,2 4 7 0,-2-3-2 15,3 1 3-15,1 0-10 0,-2 1-7 0,-1-2 22 16,3 1-3-16,-2 2-9 0,0-2 15 0,0-2-17 15,0 4 4-15,1-2-12 0,0-1 13 0,-1 3-17 16,-3-2 19-16,4-1 6 0,-1 1-6 16,-1 1-2-16,1-1 0 0,-1-2 0 0,1 3-10 15,-2 0 2-15,3-3 10 0,1 2 4 16,-4 1 9-16,1 0-18 0,1 0-2 0,0 0 11 16,-3-1-8-16,2 1 13 0,-1-1-21 0,2 1 15 15,1-2-16-15,-1 2-2 0,0-1 16 16,0 3-1-16,-3-4 9 0,6 5-25 0,-3-5 17 15,0 1-8-15,1 3 6 0,-1-2-2 16,0 0-3-16,0-1 1 0,1 0-7 0,-1 2 5 16,0-2 13-16,1 0 13 0,-1 0-16 0,1 2 11 15,-2-4-13-15,0 4 9 0,0-2-5 16,1 2 3-16,-1-2-10 0,2-1 11 0,-1 0-10 16,1 0-20-16,-3 0 16 0,1 0 5 15,1 1 2-15,-3 0-13 0,1-1 14 0,1 0-21 16,-1 0 23-16,1 0 0 0,1 1-13 0,-3 0 27 15,0-2-30-15,1 0 14 0,1 0-18 0,0 2 29 16,0-1-13-16,-2-1 14 0,3 1-31 16,-3 0 17-16,2 0-7 0,-2 0-17 0,1-1 10 15,1 1 20-15,-2 1-16 0,1-1 10 16,-1-1 0-16,2 0-16 0,1 1 7 0,-3 0-3 16,0 0 11-16,3 0 1 0,-3-1-3 0,0 1 6 15,3 0-6-15,-3 1-4 0,4 1 4 16,-4-3-20-16,3 3 21 0,-3-1-18 0,3 0 7 15,0 0 6-15,-1 0 2 0,-1 0-6 0,-1 0 3 16,3 1 15-16,0-2-22 0,-1 2 33 16,0-1-23-16,-1 2 13 0,2-1-11 15,-2-1 9-15,0 3-11 0,1-3 6 0,0 2-5 0,0-1-2 16,-1 1 13-16,2-2-5 0,-1 2-10 16,-1-1-10-16,1-1 5 0,0 3 2 0,1-2 11 15,0 0-8-15,-3 0 17 0,2 1-2 16,0 0-9-16,1 0-19 0,-3-3 8 0,2 3-1 15,0-1 9-15,0 0-8 0,0-1 5 0,-1 1 21 16,1-1-17-16,-2 1 19 0,3-1-32 16,-3 0 25-16,2 0-25 0,-2 0 25 0,0-1-4 0,3 2 8 15,-2 0-24-15,1-2-7 0,-1 2 13 16,-1-2-1-16,2 2-13 0,1-2 17 0,-3 0 11 16,3 1-8-16,-2 1 6 0,-1-3-12 15,2 0-10-15,-2 2-5 0,4-2 11 0,-4 3 6 16,0-3-3-16,1 2 12 0,-1-2-8 15,2 0 7-15,-1 1-10 0,-1 3 1 0,2-4-8 16,-2 0-3-16,2 0 2 0,-2 0 20 0,0 0-9 16,0 0-6-16,0 0 12 0,0 0 5 0,0 0-24 15,0 0 15-15,0 0-11 0,0 0-16 16,0 0 16-16,0 0 13 0,7 4 4 0,-5-4-24 16,1 0 26-16,-3 0-10 0,1 0 4 0,2 0-12 15,-3 0 2-15,3 0 4 0,-3-2 6 16,3 2-17-16,-3 0 14 0,3 0 7 0,-3-2-6 15,3 2-12-15,-3 0 15 0,2 0-5 0,-1 0-17 16,-1 0 10-16,3-3 6 0,-3 6 13 0,0-3-25 16,0 0 6-16,0 0 10 0,3 0-11 15,0 1 15-15,-2-1-7 0,1 1 5 0,-1-1-23 16,-1 2 21-16,4-2 3 0,-1 1-5 16,-3-1-4-16,2 0 8 0,-1 3 0 0,1-2-31 15,-1 2 27-15,2-3-3 0,-2 2-1 0,-1-2 19 16,2 2-18-16,0-1 12 0,0 1-25 0,-1-2 30 15,1 0-17-15,-2 2-9 0,1 0 13 16,0 0-7-16,0-1-13 0,-1 2 11 0,2 0 14 16,-1-1-8-16,2 0 2 0,-1 2-10 15,-1-3 28-15,1 2-21 0,0-1 4 0,-2 0 0 16,4 1 4-16,-4 0-3 0,3-1-1 0,-3 2-18 16,0-1 16-16,1-1 3 0,-1 0-3 15,1 0-12-15,0 1 13 0,-1 2 2 0,3-3-3 16,0 1-17-16,-3 0 12 0,2 2 11 15,-1-2-3-15,-1-2-10 0,2 3 7 0,2-1 6 16,-2 0-10-16,-2 1-1 0,2-2 5 0,-2 1-4 16,3 1 10-16,-2-2-12 0,2 1 19 15,-1 0 3-15,0 1-15 0,-2-2 9 0,2 1-30 16,-2-1 37-16,4 0-13 0,-1 0 6 0,-3 2-4 16,1-2 2-16,3 0-10 0,-2 0-2 15,1 0 10-15,-3-1-4 0,0 2 2 0,3-1 2 16,-2 0-9-16,1-1 9 0,1 0 0 15,-3 1 4-15,2-1-9 0,-1 0 1 0,-1 1-19 16,2-2 12-16,-1 2-1 0,-1-2 7 0,4 0-1 16,-2 1 5-16,1 0-3 0,-2-1-2 15,-1 0 12-15,3 0-7 0,1 1-13 0,-4 1 8 16,2-2-9-16,-1 0 9 0,6 0 7 16,-6 0-25-16,1 2 29 0,1 0-4 0,0-1-11 15,-3-1-13-15,0 0 15 0,0 0 8 0,0 0-30 16,6 0 15-16,-6 0 7 0,7 0 6 0,-7 0-4 15,7 0-2-15,-7 0 25 0,6 0-10 0,-6 0 4 16,0 0-5-16,9 0-5 0,1 9-5 16,-7-9 8-16,0 1-12 0,1-1-10 0,-3 1 23 15,1-1-16-15,-2 0 4 0,0 0 14 16,0 0-5-16,0 0-18 0,0 0 11 0,0 0-8 16,9 0 3-16,-9 0 3 0,0 0 2 0,0 0 2 15,14 9 5-15,-11-7 4 0,-2-1-24 16,2-1 27-16,0 0-16 0,0 3-5 0,0-3-7 15,-1 2 21-15,-1 1 5 0,2-3-3 0,0 2-3 16,-1 1-11-16,-2-2-15 0,1 2 20 16,4 0-12-16,-2-1 11 0,-2 1 1 0,1-1-3 15,2 1 7-15,-1-1-2 0,-1 1 13 16,2 1-29-16,0-2 18 0,-1 2-24 0,-1 0 0 16,2 0 12-16,-1-2 8 0,0 1-14 0,-1 0 16 15,2-1 8-15,-1 0-32 0,1 1 13 16,-1 0 11-16,0-1 0 0,0 0-1 0,0 0 10 15,-2 1-14-15,2 0 15 0,-3-1-31 0,3 0 10 16,-3 1 16-16,4-1-6 0,-1 1 2 0,-2 0 0 16,1 0 10-16,2 0-14 0,-1-1-9 15,-3-2 22-15,3 3-2 0,0-1-9 0,1 1-5 16,-1-1 13-16,-2 0 3 0,1 0-11 16,1-1 2-16,-3 0 8 0,2 1-11 0,-1-1-8 15,2-1 5-15,-3 3 0 0,5-2 9 0,-4 0-9 16,2 1 9-16,-2-1-1 0,2 1-11 15,0-2 8-15,-1 2 9 0,1 0-11 0,0-2 4 16,-1 2-29-16,2-2 33 0,-1 1-1 0,0 2-10 16,1-1-14-16,-2 0 14 0,1-1 13 0,1 1 3 15,-3 0 5-15,3 0-17 0,1-1 7 16,-5 0-16-16,2 1 2 0,1-1 3 0,1 2 11 16,-2-3 10-16,0 0-7 0,3 4-22 15,-4-3 14-15,3 0-3 0,-2 1-5 0,-1-2 2 16,2 1-13-16,0 1 29 0,-1 0-26 0,2-1 11 15,-1 1-13-15,-2 0 18 0,1-1-8 0,3 1-8 16,-1 0 4-16,-2-1 22 0,1 3 12 16,0-3-28-16,0-1 22 0,-2 2-27 0,1 0 18 15,2 1-25-15,-1-2 1 0,-1 1 24 0,-1 2 8 16,5-2-32-16,-4-1 24 0,-1 3-18 16,3-3 6-16,-1 2 11 0,-2-2 0 0,3 2 0 15,-2-1 2-15,1 0-8 0,1 1 5 0,-2 0-9 16,1 1-22-16,-1-2 19 0,1-1-4 15,0 3 13-15,0-2-17 0,0 2 19 0,-1-2-1 16,0 0-26-16,1 2 17 0,0-2-9 16,0 0 18-16,-2 2-2 0,0-2-7 0,3 0-1 15,0 1-2-15,-4 1 16 0,3-3-10 0,0 3-8 16,0-3 17-16,-2 2-13 0,0 0 3 16,2-2 3-16,-1 1-9 0,0 2 15 0,1-3-6 15,-1 1-2-15,0 1-15 0,2-1 10 0,-4-1 2 16,0 3 7-16,3-2-10 0,-3-1-7 15,3 0 12-15,0 1-1 0,-3 1-6 0,1-2 16 16,1 1-4-16,-2-1-5 0,3 2 11 0,0-1-15 16,-2-2 12-16,-1 0-14 0,3 1-3 15,-3 1 1-15,0-2 11 0,2 3-15 0,-2-3 1 16,1 1 24-16,2 0-9 0,-3 0-10 16,3 2 21-16,-1-2-7 0,-2 0-8 0,3-1 9 15,-3 2 5-15,1-1-7 0,3 0-21 0,-4 1 24 16,2-2-14-16,1 2-13 0,-3-2 14 15,0 2-5-15,2-1 2 0,-1 0 14 16,1 0-19-16,-2-1 20 0,1 3-7 0,-1-3 2 16,0 0-14-16,0 0 17 0,0 0 2 15,0 0-8-15,0 0 6 0,0 0-23 0,0 0 18 16,0 0-5-16,0 5-11 0,0-5 11 16,9 7 3-16,-5-5-8 0,-4-2 2 0,1 1 1 15,0 0 9-15,-1-1 4 0,1 3-10 0,1-1 2 16,0-2-5-16,0 2 4 0,-2-1 2 15,1 1 11-15,0-1-15 0,1 0 14 0,-1 0 1 16,-1-1-5-16,2 2-5 0,-1 0-15 0,1-1 5 16,-2 0 15-16,0 0-8 0,4-1-7 15,-4 2 12-15,0-2 3 0,2 1-14 0,-1 0 21 16,1 1-9-16,-2-1-11 0,0 1 11 16,1-2 10-16,-1 1-26 0,0 0 12 0,1 0 7 15,1-1 0-15,-2 2-22 0,0-2 19 16,0 2-1-16,1-2 7 0,0 0-3 0,-1 2-21 0,1-1 3 15,1-1-1-15,-2 0 22 0,1 3-12 16,0-3 7-16,1 0-19 0,-2 0 12 0,0 0-3 16,0 0 3-16,0 0 8 0,0 0-7 0,1 0 4 15,-1 0-4-15,1 0 13 0,-1 0-21 16,0 0 21-16,0 0 0 0,0 0 13 0,0 0-7 16,0 0-11-16,0 0 9 0,0 0-23 15,0 0-6-15,0 0 9 0,0 0 14 0,8 0 0 16,-8 0-16-16,0 0 4 0,6 0 4 15,-6 0 13-15,13-11-23 0,-9 10-2 0,-2-1 33 16,1 1-36-16,-2 0 16 0,2-2-11 16,-2 2-6-16,3-1 27 0,0 1-19 15,-2 0 16-15,2 0-9 0,-3-1-3 0,2-1-11 16,-1 2 17-16,1-1 0 0,0 0 19 0,-1 0-23 16,-1 0-9-16,2 2 19 0,-1-3-14 15,2 2 9-15,-3 0 8 0,2 1-22 0,-3-2 6 16,3 2-2-16,-1-2 11 0,0 2-20 0,-1-3 23 15,1 2-5-15,-1 1-9 0,1-2 1 16,-1 2 7-16,-1-2 27 0,3 2-33 16,-3-2 14-16,3 2-11 0,0 0 12 0,-3-2 13 15,0 2-24-15,0 0-2 0,0 0-1 0,0 0-10 16,0 0 6-16,0 0-3 0,0 0 8 0,0 0 2 16,0 0 26-16,0 0-37 0,0 0 6 15,0 0 20-15,7 0-21 0,-7 0 31 0,0 0-36 16,0 0 1-16,0 0 16 0,0 0 6 0,0 0-5 15,0 0-16-15,0 0 8 0,7 0 15 16,-7 0-26-16,0 0-2 0,0 0 8 0,0 0 4 16,0 0 21-16,0 0-15 0,7 0-12 15,-7 0 28-15,0 0-35 0,0 0 16 0,0 0-6 16,0 0 8-16,0 0 3 0,0 0-23 0,7 0 16 16,-7 0-18-16,0 0 2 0,0 0 38 0,0 0-23 15,6 0 21-15,-6-6-7 0,0 6 10 16,7 0-43-16,-7 0 16 0,0 0 12 0,7 0-29 15,-7 0 7-15,0 0 33 0,8 0-39 16,-8 0 12-16,0 0 3 0,6 0 7 0,-6 0 7 16,0 0-3-16,10 0-9 0,-10 0 20 0,0-5-3 15,7 5-32-15,-7 0 24 0,5 0-5 0,-5 0 11 16,0 0-24-16,10 0 4 0,-10 0-5 16,0 0 5-16,0 0 10 0,6 0-9 0,-6-5-3 15,0 5 23-15,0 0-11 0,8 0-13 16,0-11 27-16,-6 11-16 0,-2 0-9 0,2 0 10 15,-1 0-6-15,1 0-19 0,-2-1 20 0,1 1-4 16,-1 0-3-16,0 0 34 0,0 0-31 16,0 0-3-16,0 0 10 0,0 0-6 0,0 0 0 15,0 0 3-15,6 0 33 0,-6 0-23 16,0 0-26-16,0 0 46 0,7 0-9 0,-7 0-31 16,0 0-1-16,0 0 20 0,8 0 14 0,-1-9-15 15,-5 9 4-15,0-2 6 0,0 1-32 0,-1 1 3 16,1 0 9-16,0-1 27 0,-1 1-24 15,3-1-21-15,-2 1 41 0,1 0-33 0,-2 0 9 16,2 0 6-16,-1 0 5 0,0 0 10 16,0 0-33-16,1 0 10 0,-3 0 14 0,0 0-20 15,0 0 25-15,8 0-21 0,-8 0 10 0,8 0 11 16,-8 0-4-16,18 10 3 0,-13-8-15 16,-1-1 16-16,1 1-8 0,-2-1-21 15,4 3-4-15,-4-3 12 0,3 0 2 0,-3 2 6 16,2-1 12-16,0-1-8 0,0 0-16 0,-3 1 8 15,1 1 3-15,-1-3 11 0,2 2-20 16,-2-2 19-16,1 0 7 0,1 2-31 0,0-1 26 16,0 0-9-16,-3-1-12 0,2 1 22 0,-1-1-4 15,1 1-9-15,-2-1 2 0,-1 2-8 16,4-2 6-16,-3 0 26 0,2 0-12 16,0 2-12-16,-1-2-10 0,2 0 22 0,-2 0-30 15,1 0 15-15,-1 0 18 0,1 0-18 0,2 0 23 16,-3 0-23-16,1 0 6 0,-3 0 5 0,0 0 3 15,0 0-20-15,8 0-9 0,-8 0 21 16,8 0 5-16,-8 0-12 0,8 0-9 0,-2 0 27 16,-6 0 3-16,19-8-25 0,-13 6-13 15,-1 2 23-15,1-2-6 0,-2 0-2 0,0 0 0 16,2 2 26-16,-3-1-9 0,3 0-27 16,-2 1 37-16,1-1-34 0,-1 0 22 0,-2-2-25 0,2 2 14 15,0 0-9-15,0 1 7 16,1-1 1-16,-3 1 0 0,1-3 28 0,0 1-21 15,-1 2-17-15,1 0 6 0,-1 0-2 0,3-1 6 16,-5 1 27-16,3-1-12 0,1 0-23 16,-2-2 22-16,-2 3-1 0,3 0-28 15,-3-2 11-15,3 1 28 0,0 1-2 0,1 0-30 16,-2-1 1-16,1-1 31 0,-2 2-4 16,2-2-21-16,-1 2-8 0,-1-1 35 0,1 1-38 15,-1 0-1-15,2-1 8 0,-1 1 5 0,-2-1 23 16,4 0-24-16,-2 1 13 0,0-1 14 15,-2 1-34-15,0 0 3 0,0 0 0 0,0 0 13 16,0 0 2-16,0 0-9 0,5 0-1 16,-5 0-10-16,0 0 25 0,0 0-12 0,13-10-6 15,-11 9-2-15,1 0 31 0,-2 0-14 0,0 1 9 16,0-3-33-16,1 2-3 0,-1 0 6 16,3 1 12-16,-4-1 13 0,2 0-29 0,0 1 24 15,0-1-14-15,1-2 22 0,-2 3 10 0,3-3-42 16,-2 3 21-16,0-2-3 0,0 0 17 15,1 2-19-15,-1-3 13 0,1 3-32 0,-2-2 11 16,2 1 4-16,-1-1 1 0,1 1 10 0,-2 0 13 16,3 1-27-16,0-1 34 0,-4 1-27 15,3-1-4-15,0-1 0 0,0 2 24 16,-2 0-42-16,5-3 1 0,-6 3 39 0,3 0-30 16,-2-1-4-16,3 1 12 0,0-1-2 15,-2 1-4-15,-2 0 7 0,3 0 7 0,1-1 16 16,-4 1 2-16,6 0-30 0,-6 0 4 0,0 0 14 15,0 0-19-15,0 0-7 0,5 0 8 16,-5 0 5-16,0 0-4 0,7 0 5 0,-7 0-1 16,6 0 16-16,-6 0-6 0,9 0-7 15,-9 0-3-15,0 0 8 0,10 10 9 0,-6-9-27 16,-3-1 32-16,3 1-28 0,-3 0 2 16,2 0 11-16,-2 0-14 0,1 1 1 0,1 1 8 15,1-1-9-15,-2 0 22 0,1-1 17 16,2 1-35-16,-4-1 31 0,2 2-24 0,2-1-8 15,-1 1 2-15,2 0-8 0,-2-1 5 0,2 1 11 16,6 4-4-16,-5-3-13 0,1 1 38 16,-2-2-41-16,-1 1 17 0,3-2 6 0,-8-1-14 15,8 1 1-15,-6 1 7 0,1-2 2 16,-1 1-8-16,1 1 20 0,2-2 9 0,-3 0-31 16,1 1 9-16,0-1 4 0,-2 0-14 15,1 1-3-15,1-2 14 0,-2 0-2 0,2 0-2 16,-3 2-4-16,5-2 2 0,-5 0 6 15,2 2-12-15,1-1 24 0,-2 0-16 0,0 0 0 16,1 0 12-16,0 1-22 0,1-2 17 0,-2 2-2 16,2 0 6-16,-1-1 2 0,3 0-4 15,-2-1 16-15,-2 2-7 0,4 0-26 0,-2 0 19 16,-3 0-14-16,4-2 6 0,-2 2-8 16,1-2-4-16,1 3 3 0,-2-1 27 0,2-2-28 15,-1 2 8-15,-1-1 6 0,1 1 15 16,0 0-26-16,0-1-1 0,-3 1-3 0,6-2 4 15,-5 2 2-15,2 0 22 0,-3-2-25 0,2 1 22 16,1 1-19-16,-2 0 1 0,2 2-6 16,-3-2 11-16,3 2-7 0,-1-2-2 15,3 4 1-15,-2-4 32 0,-2 2-8 0,1 0-5 16,1 1-22-16,1 0 22 0,-3-2-27 0,3 1 24 16,1-1-22-16,-5 2-5 0,4-3 36 15,-3 3-24-15,0-2 14 0,2-1-10 0,-3 1 7 16,1-1-8-16,1 2 15 0,-1-3-14 15,-1 0-12-15,1 1 31 0,-1 0-27 0,1 0 34 16,2-1-42-16,-3 1 14 0,1-2 7 0,1 0-14 16,-1 2-4-16,1 0 8 0,2-2 11 15,-3 2-15-15,-1-2 15 0,0 0 25 0,0 0-37 16,0 0 7-16,0 0 11 0,0 0 9 16,0 0-29-16,8 0 3 0,-8 0 14 0,0 0-23 15,5 0 23-15,-5 0-5 0,0 0 11 0,0 0-25 16,0 0 5-16,0 0 3 0,10 0-4 15,-10 0-8-15,6 0 26 0,-6 0-5 0,0 0 4 16,6 0-18-16,-6 0-9 0,0 0 4 0,8 0 12 16,-8 0 2-16,7 0-2 0,-7 5 3 15,0-5 6-15,15 9 6 0,-11-8-6 0,1 0 9 16,-1 0-30-16,-1 3 2 0,1-3 8 0,0 1 7 16,2 0-4-16,-3 1-12 0,2 0 2 15,-1 1 28-15,0-3-19 0,1 1 17 0,-1 1-18 16,-1-1 12-16,1 0-20 0,-1 0 0 15,-1 1 18-15,1-1-6 0,1 0-10 16,0 1 6-16,-1 0 18 0,0-1-36 0,-2 1 18 16,2-1 13-16,-3-1-19 0,2 4 34 0,2-4-32 15,-1 4 4-15,9 2 16 0,-6-1-8 0,-4-3-10 16,3 3 6-16,0-3-5 0,-2 1 16 16,0 0-18-16,0 0-2 0,0 0 1 0,-3 0 1 15,5-1 0-15,-3 2 4 0,1-4 22 16,-1 5-31-16,3-4 10 0,-2 3-5 0,1 0 21 15,-2-1-12-15,2-1 2 0,2 2-6 0,3 2 3 16,-2 0-9-16,-2-1 2 0,0-1-5 16,0-1 6-16,-2-1-8 0,-2 1 13 0,3-2-13 15,-2 1 22-15,1-1 2 0,2-1-12 16,-3 2-2-16,1 0-1 0,-1-1 1 0,1-2 2 16,0 5 2-16,-2-3 8 0,4 0 7 0,-2 1-21 15,-1-2-1-15,3 1-1 0,-2 1-1 0,2-1 12 16,-4 0-5-16,2 0 21 0,0 1-5 15,1-1-10-15,-4-1-15 0,4 1-2 16,-1 0 7-16,-2 0 26 0,4-2-12 0,-5 0-21 16,4 0 7-16,-4 3 1 0,5-2-2 0,-5 0 24 15,5 0-21-15,-3-1-15 0,1 2 29 0,-2-2 11 16,2 0-27-16,-1 0-6 0,1 2-9 16,-2-2 33-16,1 0-13 0,0 0 26 15,2 1-29-15,-3 0-2 0,2-1 6 0,-2 1-1 16,2 0 8-16,-3-1-19 0,0 0 3 0,0 0-5 15,0 0 18-15,0 0-6 0,6 0 8 16,-6 0-19-16,0 0 0 0,6 0 15 0,-6 0-15 16,0 0 26-16,0 0-6 0,8 0-7 15,-8 0-4-15,0 0-4 0,8 0-1 0,-8 0 10 16,0 0 20-16,0 0-13 0,6 0-3 0,-6 0-5 16,0 0 16-16,9 0-36 0,-9 0-4 0,6 0 38 15,-6 0-21-15,0 0 14 0,8 0-2 16,-8 0-14-16,4 0 25 0,-4 0-31 0,0 0 1 15,10 0 4-15,-10 6 14 0,7-6 6 0,4 9-17 16,-6-9-2-16,-2 2 25 0,0-1-37 16,1 1 11-16,1-1 11 0,-1 0 0 0,0 1 3 15,-2 1 18-15,2-1-35 0,1 0 25 16,-1-1-15-16,0 2-17 0,1-1 2 0,-1 0 6 0,0 1 32 16,1-1-18-16,1 1-12 0,0 0-8 15,6 4 37-15,-6-3-29 0,3 1 7 0,-5-1-9 16,1-1 2-16,4 1-9 0,-3-1 18 15,-2-2 4-15,1 2-10 0,-1-1 7 0,2-1-1 16,-2 2 12-16,2-1 10 0,0 0-29 16,1 1-12-16,-2-1 21 0,-1 1 11 0,1-1-20 15,2 0-6-15,0-1 35 0,-3 1 1 16,1-1-31-16,0 0 9 0,-1 1 19 0,2-1-27 16,0 1 6-16,-1-2-7 0,-1 2 0 15,-1-2 16-15,4 3-7 0,-2-3 17 0,1 0-37 16,-1 0 10-16,-5 0 33 0,0 0-5 15,10 0-25-15,-3 0 16 0,-7 0 11 0,7 0-13 16,2 0-20-16,-2 0-1 0,-1 0 11 16,-6 0-4-16,10 0 2 0,-4 0 19 15,2 0-17-15,-8 0 9 0,10 0-14 0,-3 0-5 16,-1 0 37-16,1 0-12 0,-7 0-26 0,9 0 19 16,-1 0-26-16,-8 0 10 0,10 0 17 15,-3 0-10-15,0 0-17 0,0 0 13 0,-7 0 10 16,9 0-16-16,-2 0 22 0,0 0 2 0,0 0 9 15,0 0-29-15,-7 0 2 0,7-5 11 16,1 5 20-16,-8 0-39 0,9 0 21 0,4-7 14 16,-13 7-44-16,0 0 8 0,7 0 4 0,-7 0 3 15,9 0 15-15,-3 0-5 0,-6 0-7 16,9 0 1-16,-2 0 14 0,-7 0 1 16,6 0-19-16,-6 0 24 0,9 0-14 0,-9 0-10 15,9 0 2-15,-9 0 19 0,8 0 1 0,0 0-4 16,-8 0-21-16,5 0-7 0,-5 0 5 15,8 0 0-15,-8 0 7 0,5 0-5 0,-5 0 24 16,0 0-14-16,8 0 9 0,-8 0-6 16,0-6-10-16,6 6 8 0,-6 0 17 0,0 0 0 15,8 0-37-15,-8 0 14 0,0 0 2 0,15-11 10 16,-12 9-18-16,1-1-2 0,-2 2 21 0,1 0 14 16,-2 0-29-16,5-1 6 0,-3 0-12 15,0 0 6-15,0 1 14 0,0-2-15 16,2 3 25-16,-1-1-33 0,0-1 9 0,-2 1 12 15,3-1-7-15,-4 0-5 0,2-1 9 0,-3 1 5 16,6 0-15-16,-2 1 21 0,0 0-15 16,-2-1-6-16,1-1 13 0,-2 3-16 0,4-2 20 15,-3 1 20-15,0-3-11 0,4 3 2 16,-3 1-10-16,0-2-2 0,-1 0-20 0,1 1 24 16,-1-1-27-16,2 2 29 0,-3-3-2 0,4 1 1 15,-2 1-5-15,-2 0 1 0,3-1-25 0,-1 0 26 16,-1 0 4-16,1 0-22 0,-1 0-4 15,2 0 2-15,0-1 2 0,-3 3 6 16,4-2-4-16,-2 1 37 0,-2-2-37 0,4 1 20 16,-5 0-11-16,3-1-20 0,-1 2 7 0,2-1 2 15,-1 1-6-15,0-3 22 0,-3 1-4 16,3 2-20-16,-2-1 20 0,1 0-16 0,1 0 11 16,-1 0 15-16,-1 0-22 0,-1 1-7 15,3-2 35-15,1 1-20 0,-1 0-5 0,-3 0 2 16,3 0 12-16,-3-1-3 0,2 1 16 0,1 0-30 15,-2 0 32-15,0 0-6 0,-1 0-29 0,4 0 13 16,-3-1-2-16,1 2 7 0,1 0 16 16,-3-1-35-16,0 1 25 0,0-1-19 0,3 1-12 15,-2 0 3-15,0 0 14 0,-1 0 8 0,2 0-24 16,-2 0 3-16,0-2 33 0,2 3-28 16,0 0-2-16,-2-3 7 0,1 3 0 0,0 0 28 15,-1-1-18-15,0 1-25 0,4 0 34 16,-4 0-21-16,0 0-3 0,0 0 14 0,0 0 0 15,0 0-1-15,0 0-22 0,0 0 19 0,0 0 4 16,0 0-2-16,0 0-21 0,0 0 15 16,0 0-9-16,0 0 22 0,0 0-18 0,0 0 8 15,0 0 12-15,0 0-21 0,13 2-2 16,-12-2 13-16,0 2-11 0,-1-2 8 16,3 0 18-16,-1 2-30 0,0-1 10 0,0 1-7 0,1-1 14 15,-1 0 9-15,2 0-22 0,0 3-3 16,0-1 0-16,1-2 17 0,-4 2-8 15,4 1-1-15,0-3 1 0,-1 0 18 16,-1 1-16-16,1 0 30 0,-2 0-31 0,1 1-1 16,1-2-11-16,-1 0 25 0,0-1 9 0,0 4-16 15,0-4-3-15,-3 2 22 0,3-1-25 0,0 0-4 16,-1 0-1-16,-1-1 3 0,-1 1 28 16,0 1-23-16,4-2-9 0,-1 0 24 0,-1 0-25 15,-2 0 32-15,0 0-26 0,0 0-3 0,0 0 5 16,0 0-10-16,0 0 13 0,0 0-6 15,0 0 26-15,6 0-18 0,-6 0 1 0,0 0 13 16,6 0-27-16,-6 0 13 0,0 0-15 16,16-8-7-16,-14 4 13 0,0 4 9 0,0 0-9 15,-2-2 28-15,3 1-25 0,-1-1-3 16,2 0-9-16,-4 1 5 0,6-2 2 0,-3 1 31 16,-2 0-17-16,3 0-16 0,-1-1-1 0,2 2 16 15,-5-2 22-15,4 2-45 0,-1-3 18 16,0 2-14-16,0 0 11 0,-1-1 29 0,-1 1-22 15,4 0 11-15,-4 0-32 0,2 1 23 16,0-2-12-16,1 3 30 0,-2-3-16 0,1 2-4 16,0-1-11-16,0 0-9 0,0 1 5 0,0-2 12 15,0 0 18-15,1 0-6 0,-1 2-3 16,1-2-18-16,0-1-2 0,-1 3 0 0,0-1 1 16,4-1 32-16,-3 1-1 0,1 0 2 15,9-4-48-15,-5 0 6 0,2-2 7 0,-1 6-9 16,-3-2 18-16,-1 2 9 0,0 1-23 0,2-3 34 15,-2 4-9-15,-3-2 11 0,3 1-11 16,-2 0-13-16,2 0 27 0,-3-2-25 0,2 3-19 16,1-2 37-16,1 0-24 0,-1 2-4 0,-1 0 23 15,-1 0-19-15,2 0 13 0,-2-3 8 16,-1 3-24-16,1-1 1 0,-2 0-3 0,4 1 0 16,-6 0 0-16,0 0-5 0,0 0 35 15,8 0-28-15,-1 0 15 0,-7 0-6 16,7 0 10-16,-7 0-10 0,8 0-4 0,-8 0 30 15,8 0-14-15,-8 0-27 0,8 0 10 0,-8 0 11 16,7 0 7-16,4-9 1 0,-11 9-13 16,0 0 18-16,0 0-11 0,9 0-23 0,0 0 28 15,-9 0-20-15,7 0 16 0,1 0-26 16,-8 0 10-16,8 0 26 0,-8 0-10 0,6 0-19 16,-6 0 22-16,9 0-4 0,-9 0-19 15,8 0 14-15,-8 0 8 0,6 0-23 0,-6 0 14 16,0 0-2-16,7 0-15 0,-7 0-1 15,0 0 27-15,7 0-13 0,-7 0 9 0,0 0-22 16,0 0 15-16,8 0-3 0,-8 0-5 0,0 0 13 16,0 0-19-16,6 0 8 0,-6 0 1 15,0 0 2-15,0 0 9 0,7 0 18 16,-7 0-3-16,0 0-23 0,0 0-9 0,7 0 0 16,-7 0 29-16,0 0-19 0,7 0-3 0,-7 0 9 15,0 0 20-15,0 0-36 0,7 0 8 16,-7 0-1-16,7 0 19 0,-7 0-16 0,7-6 1 15,-7 6-11-15,10 0 22 0,-10 0-15 0,10 0-5 16,-3 0 19-16,-1 0-27 0,1 0 20 16,2 0 5-16,-9 0-14 0,7 0 3 0,0 0 7 15,-7 0-8-15,8 0-8 0,-8 0 26 16,8 0-6-16,-8 0 13 0,7 0-30 0,-7 0 3 16,9 0 2-16,-9 0 8 0,6 0-12 0,-6 0 8 15,0 0-10-15,6 0 25 0,-6 0-6 16,8 0-9-16,-8 0 4 0,0-7-17 0,0 7 8 15,8 0 7-15,-8 0 23 0,0 0-10 16,6 0-26-16,-6 0 20 0,0 0 9 0,0 0-15 16,0 0-14-16,7 0 9 0,-7 0 21 15,0 0-30-15,0 0 11 0,0 0-3 0,0 0 19 16,0 0-1-16,8 0-20 0,-8 0-5 16,0 0 4-16,9-2-9 0,-6 2 11 0,-3 0-10 15,0 0 14-15,0-1-2 0,3-1-3 16,-3 2 10-16,0 0 4 0,3-1-5 0,-2 1-10 15,0-1 22-15,2 1 2 0,-2 0-19 0,-1 0 12 16,3-1-13-16,-3 1-2 0,3-1 6 16,-1 0 15-16,-1 0-16 0,-1 2-1 0,0-1-3 15,3-1 10-15,-1-1-14 0,0 5 6 16,-1-3 1-16,0 0 23 0,3 0-26 0,-2-3 1 16,0 2 19-16,-1 1 1 0,2 0-2 0,-1 0-19 15,-1-2-16-15,-1 1 28 0,3-1 9 16,-2 2-15-16,2-2 16 0,-2 2-27 0,0 0 14 15,-1-2-20-15,4 1 14 0,-3-1-2 0,1 2 15 16,-1-1-19-16,1 0 24 0,1 1-23 16,0-1 4-16,-1 1-5 0,-1 0 21 0,3 0-28 15,-2 0 8-15,0-1-1 0,2 0-4 0,-2 0 17 16,1 1-1-16,-3 0-17 0,0 0 32 16,0 0-25-16,0 0 0 0,0 0 1 0,6 0 13 15,-6 0-4-15,0 0-14 0,9 0 10 16,-9 0 10-16,0 0-5 0,9 0-9 0,-9 0 13 15,0 0-31-15,8 0 25 0,-8 0-10 0,4 0 11 16,-4 0 13-16,0 0-33 0,0 0 11 16,9 0-17-16,-9 0 15 0,0 0-4 0,8 0 7 15,-8 0 19-15,0 0-27 0,7 0 4 16,-7 0 20-16,9 0-28 0,-9 0-2 0,7 0 10 16,5 4-10-16,-7-3 27 0,-1 2-2 15,-1-3-20-15,3 0-12 0,-2 1 12 0,2-1 19 16,-2 2-10-16,-2-2-9 0,2 0 21 0,1 0 4 15,-2 2-28-15,2-1 5 0,-3-1 7 16,2 1 4-16,-1-1-14 0,-1 1 35 0,-2-1-15 16,0 0-15-16,0 0 3 0,0 0 19 0,0 0-24 15,8 0 6-15,-8 0 9 0,0 0-14 0,7 0 26 16,-7 0-25-16,0 0 21 0,6 0-12 16,-6 0-8-16,0 0-8 0,8 0 18 0,-8 0 13 15,4 0-30-15,-4 0 12 0,0 0 8 16,10 0-8-16,-10 0 20 0,7 0-12 0,-7 0-3 15,6 0 6-15,-6 0 1 0,9 0-23 16,-9 0 23-16,8 0-9 0,-8 0-9 0,7 0-1 16,-7 0 10-16,9 0 4 0,-2 0-17 0,-7 0 20 15,9 0-20-15,-3 0 25 0,-6 0-19 16,9 0 6-16,0 0 12 0,-3 0-20 0,-6-5 5 16,9 5 4-16,-3 0-9 0,-6 0 19 0,8 0 10 15,-1 0-24-15,-7 0-4 0,7 0 8 16,1 0-17-16,-8 0 5 0,10 0 23 0,-4 0-6 15,1 0-16-15,-7 0 4 0,8 0-11 16,-8 0 22-16,8-6-15 0,-8 6 12 0,8 0-6 16,-8 0-4-16,7 0 2 0,-7 0 1 0,0 0 12 15,7 0 18-15,-7 0-22 0,6 0-2 16,-6 0 9-16,0 0 2 0,8 0-12 0,-8 0 13 16,0 0-20-16,9 0 18 0,-9 0-17 15,0 0-6-15,7 0 22 0,-7 0 6 0,0 0-22 16,8 0-5-16,-8 0 15 0,0 0 10 0,0 0-21 15,7-5 15-15,-7 5-14 0,0 0-2 16,0 0 9-16,8 0 1 0,-8 0 1 0,0 0 0 16,7 0-7-16,-7 0-10 0,0 0 10 15,7 0-11-15,-7 0 14 0,0 0-10 0,0 0 23 16,8 0-10-16,-8 0-5 0,6 0-5 0,-6 0 11 16,13 3-8-16,-9-2 20 0,-2-1-9 15,1 1-10-15,-3-1 5 0,0 0-16 0,0 0 21 16,7 0-6-16,-7 0 10 0,8 0-19 15,-8 0 15-15,6 0-14 0,5 10 16 0,-8-10-10 16,0 1-7-16,-2 1 7 0,2-2-6 16,-1 0 5-16,2 1 17 0,-1 1-10 0,1-2-19 15,-3 0-1-15,-1 0 35 0,0 0-17 0,0 0-5 16,0 0 15-16,0 0-20 0,0 0 11 16,7 0-12-16,-7 0 24 0,0 0-6 0,6 0-23 15,-6 0 34-15,0 0-13 0,10 0-12 0,-10 0-4 16,0 0 0-16,0 0 21 0,5 0-20 15,-5 0 21-15,0 0-18 0,0 0 11 0,8 0-16 16,-8 0 13-16,0 0-4 0,0 0 17 0,7 0-19 16,-7 0 3-16,0 0 1 0,5 0 5 15,-5 0 2-15,0 0-7 0,9 0-9 0,-9 0 0 16,8 0 21-16,-8 0-12 0,6 0 15 0,-6 0-9 16,8 0-8-16,-8 0 4 0,5 0-15 0,-5 0 9 15,9 0 6-15,-9 0-8 0,5 0 7 16,-5 0-16-16,7 0 16 0,-7 0 11 0,7 0-12 15,-7 0 23-15,9 0-18 0,3-3 2 16,-9 3 4-16,2 0 1 0,-2-2-17 0,3 1 11 16,-2-1-5-16,1 0 18 0,-4 2-23 0,4-2 18 15,-2 2-5-15,3-1 14 0,-5 1-34 16,2-2 26-16,0 1-14 0,-3 1-9 0,0 0 1 16,0 0-1-16,0 0 18 0,0 0-19 15,8 0 7-15,-8 0 14 0,7 0-15 0,-7 0 1 16,0 0-1-16,7 0-7 0,-7 0 20 0,0 0-3 15,14-10-14-15,-11 10 19 0,-2 0-11 0,2-1-9 16,-1 1 1-16,1 0 12 0,-1 0-17 0,0 0 21 16,0-1-17-16,1-2 27 0,-2 3-25 15,2 0 0-15,-3 0 6 0,0 0 6 0,0 0-15 16,0 0 9-16,6 0 2 0,-6 0 9 16,0 0-14-16,8 0-7 0,-8 0 7 0,6 0-11 15,-6 0 28-15,8 0 6 0,-8 0-31 0,7 0 23 16,-7 0 3-16,0 0-21 0,8 0-13 15,-8 0 30-15,0 0-6 0,6 0-6 16,-6 0-3-16,0 0 15 0,8 0-30 0,-8 0 6 16,7 0 1-16,-7-3-2 0,0 3 5 0,7 0 5 15,-7 0 2-15,6 0 10 0,-6 0-1 0,9 0-11 16,-1 0-1-16,-8 0 21 0,7 0-32 16,1 0 19-16,-8 0-13 0,8 0 26 0,2 0-12 15,-10 0-8-15,7 0-11 0,0 0 2 0,-7 0 17 16,11 0 9-16,-5 0-24 0,-6 0-3 15,7 0 2-15,-7 0 7 0,8 0 14 0,-8 0-7 16,7 0-12-16,-7 0-3 0,8 0 22 0,-8 0-15 16,0 0-2-16,9 0 20 0,-9 0-16 15,6-6 14-15,-6 6-29 0,0 0 12 0,6 0 15 16,-6 0-11-16,0 0 5 0,8-7 2 0,2 0 3 16,-7 6 0-16,-2 0-13 0,2 0-2 15,-3-3-1-15,2 2 3 0,1 0 14 0,-2 0-14 16,2 0 22-16,-2 0-14 0,2 0-17 15,-1 0 20-15,-1 0 5 0,0 0 2 0,2-1 2 16,-2 1-11-16,2 1-17 0,-3 0 20 0,0-1 0 16,4 0-9-16,-4 0 7 0,1 2-23 0,0-2 22 15,1 2-4-15,-1-3-6 0,-1 2 18 16,1 0-8-16,-1-1 4 0,1 1-19 0,1 1 14 16,-2-2-2-16,1 1 8 0,1 0-7 15,0 0-5-15,-1 1 3 0,-1-2 2 0,0 2 7 16,1-1-13-16,2 1 1 0,-3-1 13 0,0-1-1 15,0 2-23-15,3-1-8 0,-3 1 25 16,0 0 10-16,0 0-24 0,0 0 16 0,0 0 0 16,0 0-7-16,0 0-2 0,0 0 17 15,0 0-28-15,0 0 18 0,0 0-2 0,0 0-10 16,7-1-3-16,-7 1 9 0,0 0-7 0,2 0 16 16,-2 0 8-16,1 0-7 0,-1 1-4 15,0-1 4-15,2 1-5 0,-2-1-2 0,4 2-1 16,-4-1-4-16,2-1 6 0,1 1 8 0,-3 0-12 15,3-1 6-15,-2 1-6 0,4 0 3 16,-5 0 4-16,4-1-3 0,0 3-11 0,-2-3 11 16,3 1-6-16,-1 1-3 0,-2-2 2 0,2 2 8 15,-1-2-1-15,2 3 0 0,-4-3-7 16,3 2-6-16,-3-2 31 0,2 0-11 0,-2 0-3 16,2 2-9-16,-1-2 21 0,1 0-17 15,-1 0 13-15,2 0-24 0,-3 2 12 0,2-2 3 16,-2 1 11-16,2-1-25 0,-1 1-2 0,1-1 12 15,-2 0 13-15,-1 0-23 0,0 0 14 0,0 0-9 16,0 0 10-16,0 0-6 0,0 0 8 16,0 0-6-16,0 0 9 0,7 0-3 15,-7 0-23-15,0 0 8 0,0 0 9 0,6 0-13 16,-6 0 18-16,0 0-8 0,0 0-7 0,0 0 8 16,0 0-11-16,9 0 32 0,-9 0-26 15,0 0 7-15,0 0 8 0,6 0-6 0,-6 0-10 16,12-11 0-16,-11 11 26 0,0-1-29 15,2 0 28-15,-3 1-26 0,0 0 16 0,4 0 7 16,-3-2-3-16,-1 2-22 0,2-1 7 0,1 1 3 16,-3 0 17-16,0 0-3 0,1 0-26 0,3-2 8 15,-2 1 29-15,-1 0-34 0,1 1 6 16,-2-1-5-16,3 1 29 0,-1 0-14 0,-1 0 4 16,2-1-12-16,-3 0 16 0,2 0 16 15,1 0-30-15,0-1-6 0,-1 2 12 0,1-1 1 16,-1 0-2-16,-1 1-14 0,2-1 4 15,1 0 16-15,-4 0-9 0,1 0 1 0,2-1 9 16,0 2-1-16,1-2-13 0,-1 2 17 0,-1 0-19 16,2-3 3-16,-1 2 6 0,-1 0-12 15,1 1 14-15,-2-1-9 0,2 1 4 0,-2-1 18 16,4 0-20-16,-1-2-5 0,-2 2-6 0,2 0 3 16,0 0 14-16,0 0-8 0,2 0-7 15,-2-2 5-15,1 1-2 0,0 2 0 0,1 0 1 16,1-3 1-16,-2 2 16 0,1-1-6 15,-1 2 5-15,3-2-6 0,-5 2-9 0,3-3 1 16,2 2 19-16,-2 0-6 0,-2-1-18 0,1 2 6 16,-5 0-11-16,0 0 17 0,8 0-1 15,-8 0-4-15,8 0 15 0,-8 0-26 0,9 0 18 16,-2 0-9-16,4-8 2 0,-7 6-2 16,0 2-9-16,0-2 10 0,-2 0 1 0,3 1-11 15,-2 0 17-15,2 0-8 0,-2 0 9 0,-1 0 6 16,2 0-10-16,1-1-9 0,-3 2 27 0,3-2-14 15,-2-1-7-15,0 2 19 0,2 0-26 16,-1-1 13-16,-2 0-14 0,4 0 8 0,-3 0 9 16,1 1 8-16,-1-2-22 0,0 1 3 15,0 2-3-15,2 0-2 0,-4-3 3 0,3 2 18 16,0-1-21-16,-3 0 11 0,3 0-4 0,0 2-10 16,0-3 28-16,-1 1-22 0,1 1 9 15,0-1-11-15,-1-2-1 0,0 3 7 0,1-3 2 16,-1 2-3-16,3 1 15 0,-2-1-15 15,-2-2-3-15,1 2 2 0,2-1-3 0,-4 1-5 16,2 0 6-16,3 1 22 0,-3-1-37 16,0-2 25-16,-1 3 10 0,-1-1-4 0,2-1-6 15,-1 2-1-15,1 0-6 0,1-2-11 0,-1 1 9 16,0 1 6-16,-3 0 14 0,5 0-34 16,-4 1 28-16,-1-3-13 0,5 2-10 0,-2 1 8 15,-2-2 7-15,3 1 9 0,-4 1-14 0,3 0-6 16,-1 0 14-16,-1-4-18 0,2 4 9 15,-3-1-2-15,2-1 4 0,1 2 17 0,-2 0-28 16,-1-2 15-16,3 1 0 0,-3-1 17 0,2 2-13 16,2 0-17-16,-4 0 11 0,0-1 10 15,3 1-26-15,-3 0 8 0,0 0-13 0,0 0 29 16,0 0-10-16,0 0-7 0,0 0-18 0,0 0 9 16,0 0 13-16,0 0-2 0,0 0-11 15,0 0-2-15,0 0 19 0,0 0-5 0,10 11-7 16,-10-9 2-16,1 1 14 0,1 1-9 0,0-2 14 15,-2 3-8-15,1-2-6 0,1 2-1 16,-1-2 9-16,1 2 2 0,0-2-2 0,1 1-24 16,-3 2 21-16,3-3-3 0,-3 2 4 0,1 0 10 15,2-2 5-15,-2 1-15 0,2 0 16 16,-2-1-16-16,0 0 3 0,1 1-15 0,-1-1 2 16,0 0 3-16,3 1 2 0,-3-1 9 15,2-2 0-15,-1 4-14 0,-2-3 10 0,3 1-7 16,-2-1 8-16,0 1 10 0,2 1-19 0,-3-3 16 15,3 1-21-15,-1 0 27 0,-1 1-5 16,3-1-9-16,-1-1 8 0,-2 1 6 0,1 0-4 16,1 0-4-16,0-2-14 0,-2 3-9 15,2-3 24-15,-1 1-2 0,0 1-4 0,2-2-2 16,-1 0-14-16,-2 2 18 0,2-2 6 16,0 0 12-16,-1 1-25 0,-1 1 13 0,4-2-20 15,-2 1 20-15,-2-1-19 0,4 1 12 0,-4-1-14 16,2 1 11-16,-1-1-6 0,2 1 13 15,-1-1 9-15,-2 1-24 0,4-1 7 0,-5 0-4 16,0 0 17-16,0 0 6 0,0 0-12 16,0 0-1-16,8 0-17 0,-8 0 13 0,6 0-8 15,-6 0 7-15,8 0 7 0,-8 0 3 0,7 0 9 16,-7 0-20-16,9 0 18 0,-9 0-13 16,5 0 6-16,-5 0-16 0,9 0 5 0,-9 0 2 15,7 0 13-15,-7 0-32 0,0 0 32 0,6 0-11 16,-6 0 0-16,0 0-9 0,10 0 13 0,-10 0-13 15,0 0 11-15,6 6-9 0,-6-6 12 16,0 0-17-16,0 0-10 0,0 0 2 0,8 0 15 16,-8 0 9-16,0 0-4 0,0 0 7 15,0 0-7-15,0 0-20 0,10 9 7 0,-9-7 4 16,-2-3 5-16,2 2-21 0,-1 0 37 0,2 0-14 16,-2-1 3-16,0 0-11 0,0 2 6 0,0 0-1 15,0-1 6-15,0 1-21 0,0-2 30 16,0 2-18-16,0-1-3 0,2 2-2 0,-1-3 14 15,-1 1-11-15,0 1-4 0,0 0 30 0,0 1-9 16,0-3-2-16,-1 2-14 0,2 0 2 16,-1 1 5-16,0-2 2 0,0 1 13 0,-3 2-19 15,3-2 13-15,2-1-1 0,-2-1-3 0,0 0-8 16,0 0-5-16,0 0 3 0,0 8 19 0,0-8-8 16,0 0-6-16,0 6-8 0,0-6 18 15,0 0-10-15,0 5-4 0,0-5 2 0,0 0 8 16,0 0 1-16,0 5-14 0,0-5 7 15,0 0 11-15,0 0-4 0,0 6-21 0,0-6 13 16,0 0 0-16,12 10-15 0,-11-8 17 0,2-1 8 16,-3-1 6-16,6 0-7 0,-5 2-5 15,2-2 4-15,-2 1-11 0,2 2 5 0,-1-2-13 16,-1-1 20-16,3 1-8 0,-2-1 4 16,-1 0 12-16,4 0-12 0,-3 0 14 0,0 0-11 15,0 0 10-15,-2 0-7 0,0 0 1 0,0 0 25 16,0 0-29-16,0 0-14 0,8 0 9 0,-8 0-2 15,0 0 4-15,6 0 7 0,-6 0-13 16,0 0 23-16,9 0-7 0,-9 0 20 0,5 0-32 16,-5 0 8-16,8 0-5 0,-8 0 18 15,0 0-34-15,7 0 12 0,-7 0-3 0,0 0-4 16,7 0 1-16,-7 0 10 0,0 0 6 0,7 0-8 16,-7 0 16-16,0 0 18 0,0 0-42 15,7 0-4-15,-7 0 10 0,0 0 5 16,6 0 31-16,-6 0-29 0,0 0-9 0,0 0 34 15,9 0-30-15,-9 0-4 0,5 0-2 16,-5 0 38-16,0 0-41 0,8 0 18 0,-8-6-4 16,10 0-14-16,-7 6 31 0,-1-1-26 15,2 0 7-15,-3 1-11 0,-1-2 40 0,4 0-31 16,-3 0-5-16,1 2 3 0,0-1 29 0,-2 0-12 16,3 1-18-16,-2-1-10 0,0 0 35 0,1-2-25 15,0 1-5-15,-1 2 4 0,2-1 15 16,-3-1 0-16,1 1-23 0,4-1 2 0,-4 2 50 15,1-2-47-15,-1 0 1 0,0 0-2 16,1 1-1-16,-2 1 2 0,0 0 33 0,0 0-26 16,0 0-18-16,0 0 10 0,0 0 29 0,9-9-34 15,-7 8 23-15,0 0-21 0,0-2 17 16,-2 3-31-16,2-3 8 0,0 3 28 0,-1-1 15 16,-1 1-44-16,3-2 3 0,-3 0 5 0,2 2 17 15,-2-2-26-15,1 2 24 0,2 0-8 16,-3-2-7-16,3 2 19 0,-3-3-17 15,2 3 38-15,-2-1-40 0,1 1-6 0,-1 0 5 16,3-1 16-16,-3 1-1 0,0 0-27 0,3-2 16 16,-1 2 35-16,-2 0-45 0,0 0 5 15,0 0 29-15,0 0 4 0,0 0-37 0,0 0 1 16,0 0 19-16,0 0 25 0,9-4-10 0,-9 3-34 16,1 1 39-16,-1 0-3 0,0 0-34 15,0 0-7-15,2-1 40 0,-2 1-4 0,0 0-1 16,1 0-41-16,1 0 3 0,-2-1 20 0,3 2-16 15,-3-2 3-15,0 0 33 0,3 1-9 16,0-2-39-16,-2 2 0 0,-1-2 16 0,3 2 4 16,-3-1-8-16,0 0 28 0,3 0-22 0,0-2 20 15,-3 3-17-15,0 0 1 0,3-2-9 16,-3 2 1-16,3 0 5 0,-1 0 0 0,-1 0 11 16,1 0 1-16,1-2-9 0,-2 2 3 15,1 0-6-15,-1 0-5 0,-1-1-5 0,3 1 18 16,-2-2-7-16,0 1 49 0,0 1-41 0,1-1-5 15,-2 1-5-15,1-1 33 0,-1 1-43 16,0-1 46-16,3 0-11 0,-1-2-30 0,-1 3-8 16,3-2 51-16,-4 1-48 0,3 0 14 15,-1 0 2-15,-1-2 1 0,2 3-5 0,-2-2-4 16,2 2 7-16,-2-3 32 0,1 0-17 16,-1 3-22-16,0-2 5 0,0 2 12 0,-1-2-16 15,4 1 4-15,-4 0 20 0,5 1-4 0,-5-1-15 16,1 0-11-16,-1 0 11 0,0 1-19 0,2 0 3 15,-2 0 27-15,0 0-26 0,1-1 25 16,0-1-4-16,-1 2-16 0,2 0-9 0,-2 0 44 16,0-1-33-16,0 1-5 0,0 0 28 15,0 0-18-15,0 0-24 0,0 1 7 0,-2-1 22 16,4 2 2-16,-2-2-27 0,-3 1 34 16,3-1-23-16,0 1 2 0,-1 0-3 15,1 0 27-15,-2 1-18 0,2 0 6 0,-1-2 12 16,0 2-2-16,0-2-23 0,-2 2-9 0,2-1 14 15,0 0-13-15,-1 1 9 0,1-2-11 16,1 0-2-16,-2 0 21 0,2 2-14 16,-2-2-8-16,2 0 8 0,-2 0-1 0,-1 0 13 15,3 0-23-15,-1 0-2 0,-2 0 27 0,3 0 2 16,-2 0-15-16,0 0 6 0,1 0-3 0,1 0 15 16,0 0-12-16,-4-2-8 0,3 2 25 15,1 0-7-15,-1-2 23 0,0 2-17 0,-1 0-8 16,1 0-10-16,1-1 0 0,-1 0 23 0,1-1-28 15,0 2 15-15,-2 0 18 0,2 0-15 0,0 0-7 16,2 0 17-16,-4 0 0 0,2 0 8 16,2-2-19-16,-2 2 15 0,0 0-6 0,-2 0-6 15,2 0 16-15,2 0-13 0,-2 0 2 16,-2 0-23-16,2 0 19 0,2-2 2 0,-2 4 9 16,0-2-9-16,1 0-1 0,-1 0-20 15,0-2 25-15,0 2-11 0,0 0 15 0,0 2-30 16,0-4 26-16,0 2 5 0,1 2-14 0,-2-2-8 15,1 0 16-15,0 0-12 0,0 0-4 0,0 0 20 16,0 0-33-16,0 0 29 0,0 0-15 16,0 0 4-16,0 0 13 0,3 2-11 0,-5-4-14 15,4 2 22-15,-4 0-23 0,2 0 35 16,2 2-33-16,-2-2 29 0,1 0-12 0,-2 0 1 16,2 0 0-16,-2 0 8 0,1 0 2 0,0 0-8 15,-2 0-4-15,4 0 4 0,-2 0-9 16,0 0 10-16,0-2-5 0,0 4-1 0,-2-2-23 15,4 0 24-15,-4 0-2 0,2-2-9 0,2 4 27 16,0-2-14-16,-3-2-15 0,0 4 15 16,2-2-2-16,-1 0-4 0,0 0 15 15,-1 2-20-15,2-2 12 0,-1-2-4 0,0 2 12 16,0 0-33-16,0 0-26 0,-1 0-3 0,3 0-28 16,-2 0 24-16,0 2 6 0,0-1-166 15,-1 2-23-15,0-3-134 0,2 2 82 0,-1-2-36 16,1 0 26-16,0 1 40 0</inkml:trace>
</inkml:ink>
</file>

<file path=ppt/ink/ink3.xml><?xml version="1.0" encoding="utf-8"?>
<inkml:ink xmlns:inkml="http://www.w3.org/2003/InkML">
  <inkml:definitions>
    <inkml:context xml:id="ctx0">
      <inkml:inkSource xml:id="inkSrc0">
        <inkml:traceFormat>
          <inkml:channel name="X" type="integer" max="32767" units="cm"/>
          <inkml:channel name="Y" type="integer" max="32767" units="cm"/>
          <inkml:channel name="F" type="integer" max="8191" units="dev"/>
          <inkml:channel name="T" type="integer" max="2.14748E9" units="dev"/>
        </inkml:traceFormat>
        <inkml:channelProperties>
          <inkml:channelProperty channel="X" name="resolution" value="1290.54749" units="1/cm"/>
          <inkml:channelProperty channel="Y" name="resolution" value="2151.47729" units="1/cm"/>
          <inkml:channelProperty channel="F" name="resolution" value="0" units="1/dev"/>
          <inkml:channelProperty channel="T" name="resolution" value="1" units="1/dev"/>
        </inkml:channelProperties>
      </inkml:inkSource>
      <inkml:timestamp xml:id="ts0" timeString="2024-06-24T10:16:24.990"/>
    </inkml:context>
    <inkml:brush xml:id="br0">
      <inkml:brushProperty name="width" value="0.06667" units="cm"/>
      <inkml:brushProperty name="height" value="0.06667" units="cm"/>
      <inkml:brushProperty name="color" value="#ED1C24"/>
      <inkml:brushProperty name="fitToCurve" value="1"/>
    </inkml:brush>
    <inkml:brush xml:id="br1">
      <inkml:brushProperty name="width" value="0.06667" units="cm"/>
      <inkml:brushProperty name="height" value="0.06667" units="cm"/>
      <inkml:brushProperty name="fitToCurve" value="1"/>
    </inkml:brush>
  </inkml:definitions>
  <inkml:trace contextRef="#ctx0" brushRef="#br0">-1 13 331 0,'0'0'90'0,"0"0"-12"16,0 0-10-16,0 0-8 0,0 0-7 0,0 0-15 15,0 0 10-15,0 0-5 0,0 0 31 16,0 0-8-16,0 0-2 0,0 0 33 0,0 0-20 16,0 0-8-16,0 0-9 0,0 0 7 0,0-14-19 15,0 14-27-15,0 0-18 0,0 0-1 0,0 0 25 16,0 0 23-16,0 0-4 0,0 0-8 15,0 0 0-15,0 0-19 0,0 0 22 0,0 0-47 16,15 0 17-16,-15 0-27 0,0 0 21 16,0 0 49-16,0 0-27 0,0 0-52 0,0 0 2 15,0 0 24-15,0 0 22 0,0 0-45 0,0 0 9 16,0 0-4-16,0 0 3 0,0 0 54 0,0 0-30 16,0 0 8-16,0 0-39 0,26 13 39 15,-24-10-17-15,1 1 46 0,-2-1-20 0,1-2-14 16,-2 5-44-16,2-3 16 0,1 2 19 15,-2-3 12-15,-1 2-5 0,1 0 29 0,3-1-33 16,-4 0 3-16,1-1-35 0,2 2 14 0,-3-1-19 16,0 0 48-16,1-1-13 0,1 3 16 15,1-3 18-15,-2 2-20 0,-1-2-17 0,1 2-47 16,1-1 57-16,-2 0-39 0,0 0 58 0,2-2-13 16,-2 0 3-16,1 4-14 0,1-3-1 0,-2 0-38 15,1-1-13-15,1 1 54 0,0-1 21 16,0 3-5-16,-2-4 0 0,4 3-43 0,-4-2 24 15,1 4 16-15,0-4-32 0,2 0 15 0,-3 3 12 16,2-3-22-16,1 2 4 16,-3-3 3-16,2 1 0 0,1 0-28 0,-2 1 15 0,-1 0 19 15,2-1-57-15,-2 2 54 0,2-3-51 16,2 0 67-16,-3 0-11 0,3 2-15 0,-3-2 20 16,0 0-21-16,3 2 16 0,-3 0 1 0,0 2-18 15,1-4 5-15,1 1 8 0,0 0 10 0,-2 1 17 16,1 2-55-16,1-4 34 0,-1 1-22 15,0 0-17-15,2 0 39 0,-2 0-1 0,0 1-49 16,1 3 72-16,1-5-29 0,0 0 10 0,-3 1-20 16,2 0 2-16,-1-1-30 0,1 1 43 15,-1 1-7-15,2-2 23 0,-2 5-11 0,1-5 1 16,-1 0-6-16,1 2 31 0,2-1-25 16,-4-1 4-16,2 2 11 0,-1 0-48 0,1 0 30 15,0-2-3-15,-1 1-5 0,-1-1 28 0,2 2 0 16,-1 1-28-16,0-1-28 0,1 0 39 15,-1-2-9-15,1 0 9 0,-2 1 1 0,0 1-52 16,1-1 42-16,0 3 2 0,1-2-23 0,-1-2-13 16,1 1 40-16,-3-1-17 0,2 2-2 15,1 2 32-15,0-3-31 0,0 0 14 0,-1 0-44 16,1 2 36-16,1-3-26 0,-2 4 14 0,1-3-3 16,-1 1 4-16,1 1 26 0,-1 1-10 15,1-4-13-15,-1 2-13 0,2-1 39 0,0 4-4 16,-2-4-28-16,1 1 19 0,-1 0-4 15,2 1 16-15,0-1-16 0,-4 0 31 0,5 0-22 16,-4 0 5-16,3 2-13 0,-4-3-13 0,6-1 31 16,-5 3-10-16,1-3-34 0,0 6 39 15,1-5 0-15,-1 2-43 0,1-3 28 0,-1 6 33 16,2-5-19-16,1 2 1 0,-4 1-11 0,2-1 7 16,0-2 2-16,-1 3 12 0,-1 0-10 15,3-2 8-15,-2 1-45 0,1 0 28 16,-1 0 15-16,1 1 5 0,3-3-13 0,-5 1 5 15,2 2-6-15,0-1-4 0,0 0 11 0,1-1-21 16,-3 1 14-16,3 2 19 0,-2-3-14 0,3-2-21 16,-2 3-1-16,-1 0 27 0,2 0-12 15,-3-1 0-15,1 0-11 0,4 1-18 0,-5 0 14 16,4 0 10-16,-1-3-1 0,-2 1-14 0,1 1 4 16,3 1 18-16,-3-2-34 0,-1 2 23 0,1-2 9 15,2 2-13-15,-4-1-13 0,4-1 22 16,0 1 0-16,-4 0-21 0,3 0 6 0,-2-1 21 15,1 4-10-15,1-5-1 0,1 4 15 16,-1-3-21-16,-1 4 18 0,0-5-6 0,2 2 0 16,-4 0 5-16,2-1 4 0,0 4-11 15,1-5-6-15,-2 0 6 0,2 2-8 0,0-1 4 16,1 3-18-16,-5-2 14 0,4-1 6 0,-2 2-1 16,0-3 9-16,3 5-1 0,0-4-17 15,-2 0 3-15,0 1 0 0,-1 2-10 0,3-2-5 16,-2-1 19-16,1 0-9 0,-2 5 7 15,1-5-2-15,2 4-3 0,-1-2 5 0,-2 0-6 16,2-1 19-16,-1 2-24 0,1-2 18 0,-1 0-1 16,-1 2 11-16,3-1-13 0,-2-2-3 0,-1 3-17 15,2-2 25-15,-1 2 5 0,-1-4-5 0,3 2-25 16,0 0 27-16,0 2-21 0,-1-2 12 16,1 0-16-16,-3-2 23 0,3 3 2 0,-2 0-19 15,0-3 11-15,-1 2 0 0,3-1 4 16,-4 3-4-16,3-2 10 0,1 1-11 0,-3-2 4 15,0 3-2-15,5-2 1 0,-5-1-5 0,0-1 1 16,-1 2-12-16,2-1 16 0,1 1 6 16,-3 0-17-16,2-2 8 0,-3 1 2 0,3 0 1 15,-1-1 10-15,1 1-6 0,-3 0-22 0,2 1 29 16,2 0-11-16,-3 1-29 0,2-3 15 16,-3 1 13-16,4 0-6 0,-3 1-15 0,3 3 13 15,-4-4 6-15,3 0 4 0,-1 0-6 16,1 1 11-16,0 1-9 0,1-1 1 0,-1 0-31 15,0-1 29-15,0 2-2 0,-2 1 2 16,4-4 2-16,-3 3 11 0,1 0-27 0,-1 0 3 16,2-2 7-16,0 1 0 0,-2 1-4 0,1 0-1 15,-2-1 19-15,-1-1-8 0,5 3 14 16,-1 0-31-16,-2-1 23 0,1 3 2 0,2-5-6 16,-1 4-4-16,-1-2 20 0,0 0-30 0,1 2 15 15,2-2 3-15,-4 1-14 0,3 0 18 16,2-2-8-16,-4 4-13 0,0-4 19 0,1 3 6 15,2-3-14-15,-1 1-8 0,-1 0-9 0,1 1 18 16,5 6 0-16,-3-6-11 0,0 2 15 16,-3-3 8-16,0 0-11 0,-1 1 8 0,1-4-7 15,2 3-6-15,-3-2 3 0,0 2-5 0,2 0 7 16,-1-3 2-16,-1 1-4 0,0 0-5 16,0 1-1-16,3 1 8 0,-1-3-3 0,-1 1-21 15,-1 1 26-15,1-2-10 0,1 0 7 0,0 0-13 16,-2 0 18-16,3 1-20 0,-6-1 19 15,0 0-15-15,0 0 19 0,7 0-4 0,-7 0-11 16,8 0 24-16,-8 0-28 0,0 0-1 16,6 0 17-16,-6 0-24 0,0 0 17 0,8 0 14 15,-8 0-11-15,9 0 1 0,-9 0-16 0,7 0 12 16,-7 0-2-16,0 0 7 0,6 0 1 0,-6 0 8 16,8 0-15-16,-8 0 1 0,7 0 6 15,-7 0 0-15,8 0-21 0,-8 0 19 16,0 0-12-16,8 0 8 0,-8 0 15 0,9 0-27 15,-9 0 18-15,7 0-29 0,-7 0 48 0,6 0-22 16,-6 0 5-16,8 0-29 0,-8 0 26 16,7 0-1-16,-7 0-5 0,9 0-8 0,-9 0 19 15,7 0-11-15,-7 0 11 0,8 0-4 0,-8 0-3 16,9 0 1-16,-9 0 3 0,7 0-12 16,-7 0 8-16,9 0-9 0,-9 0 15 0,7 0 10 15,-7 0-7-15,8 0-3 0,-8 0 5 0,7 0-5 16,-7 0 1-16,8 0 2 0,-8 0 4 0,0 0-9 15,6 0 0-15,-6 0-20 0,0 0 20 16,9 0-2-16,-9 0 2 0,7 0 1 0,-7 0-20 16,0 0 17-16,7 0-9 0,-7 0 9 0,0 0 4 15,9 0-2-15,-9 0-11 0,0-7 3 16,9 7 19-16,-9 0-24 0,0 0 10 0,7 0-8 16,-7 0 0-16,0 0 9 0,9-6-3 0,3-2 6 15,-10 7-3-15,1 0 0 0,-2-1-1 0,2 0 4 16,1 1 1-16,-2-1-6 0,-2 1-23 15,4-1 5-15,0 0 17 0,-2 0-4 0,3 1 18 16,-4-1-14-16,2-1-18 0,0 2 30 16,0-2-3-16,-2 0-27 0,1 2 3 0,0-1 1 15,2 0 11-15,-1-1 7 0,-1 1-4 0,2 1-2 16,-2-4 4-16,-1 5 2 0,3-2-4 16,-4 0-10-16,3 0 2 0,-1-2-2 0,1 4-8 15,1-2 31-15,-1 1-24 0,1-4 6 0,-3 3-13 16,3 0 20-16,-4-1-1 0,4 2-15 0,-2-2-2 15,2 1 25-15,-1 1 7 0,-1-1-30 16,1-2 15-16,-2 3 0 0,3 1 5 0,-2-3-18 16,3 1 12-16,-2 0-14 0,-1-1 17 15,3 3-12-15,-2-1 16 0,1-2-1 0,0 2-3 16,-1-2-1-16,1 1 15 0,-1 1-32 16,4-2 16-16,-4 1-7 0,0-1 27 0,2 2-11 15,-3-3-11-15,3 1-15 0,-3 1 6 0,2 2 1 16,-1-4 17-16,1 3-9 0,-1-2 12 15,-1 1 2-15,1 2-17 0,-1-4 1 0,3 3 7 16,-1-1-21-16,1 1 5 0,-5 0 2 0,5-4 20 16,-3 4-13-16,1-1 3 0,0 1 0 15,-1 0 8-15,0-2-6 0,2-1-9 0,0 4 5 16,-1-2-2-16,0 1 11 0,0-2-6 16,0 1-7-16,0-1 5 0,0 3-2 0,-1-2-5 15,0-2 8-15,3 3 7 0,-3 0-3 0,0-2-4 16,3 2-9-16,-4-3 6 0,2 3-5 0,-1-2-5 15,1 3 6-15,-2-3-6 0,3 0 19 16,-4 3 6-16,5-2-19 0,-5 1 1 0,5 0 3 16,-4-1-5-16,2 0 3 0,-1 0 17 0,0 0-6 15,1 2 10-15,-3-1-28 0,0-2 7 16,3 3 8-16,-2-2-4 0,2 0-8 0,-2 2-11 16,0-2-4-16,0 1 19 0,3-2-11 0,-1 3 23 15,-2-2-7-15,0 2-4 0,1-2-9 16,0 2 2-16,-1 0 27 0,3-3-22 0,-4 2-7 15,2 1 11-15,-2 0-4 0,1-2-8 0,-1 2 21 16,3-2 1-16,-3 2-21 0,0 0 2 16,1 0 11-16,1-1 8 0,-2 1-8 0,0 0 6 15,0 0-4-15,0 0 6 0,0 0-4 16,0 0-9-16,0 0-2 0,0 0-9 0,0 0 6 16,0 0-3-16,0 0 3 0,0 0 11 0,0 0 15 15,0 0-12-15,0 0 1 0,12-7-1 0,-12 7 0 16,0-2-8-16,3 2 13 0,-2-1-32 15,0 1 17-15,-1 0-12 0,1-2 6 16,2 2 25-16,-3 0-3 0,0 0-20 0,4 0 14 16,-3-1-19-16,-1 1 0 0,1 0 10 15,-1 0 13-15,0-3-16 0,3 3-12 0,-2 0 25 16,-1-1-1-16,2 1-12 0,0 0 9 0,0 0-5 16,-2-2 10-16,1 2-11 0,1-1-13 0,0 1 17 15,-2-1-6-15,0-1-3 0,0 2 18 16,3-3-18-16,-2 2 5 0,0-1-5 0,1 1 16 15,1 1-9-15,-3 0 13 0,0 0 2 0,1 0-3 16,1 1-19-16,-1-2 0 0,0 1-3 16,-1 1 4-16,3-1 6 0,-2-1 0 0,-1 1-1 15,1 1-17-15,-1-1 30 0,3 0-17 0,-3-1-3 16,1 1 12-16,-1 0-12 0,0 1 8 16,1-1 6-16,-1 0-15 0,3 0 5 15,-3 0-3-15,0 0 0 0,0 0 8 0,0 0 1 16,0 0-17-16,0 0 25 0,0 0-29 0,0 0 26 15,0 0-7-15,0 0 11 0,0 0-1 16,0 0-6-16,0 0-8 0,10 10 13 0,-9-10-27 16,0 3 12-16,0 1 4 0,-1-4 4 0,3 2-18 15,-3-1 24-15,1 1-5 0,1 0 3 16,-1-1-1-16,0 0-5 0,-1 2-1 0,4-2 8 16,-3 3-17-16,0-2 7 0,2 0 3 15,-2-2 7-15,-1 4-5 0,1 0-3 0,1-2 2 0,1 0 5 16,-3 3-9-16,0-4 1 0,0 1-1 15,3 0-7-15,-2 0 16 0,-1 1-8 0,3-2 11 16,0 1-23-16,-3 1-7 0,0 0 22 16,2-3 3-16,-2 3-1 0,1 1-10 0,-1-2-1 15,2 0 9-15,0-1-2 0,0 1 15 0,-2 2-7 16,3-2-9-16,-3 1-10 0,0 1 16 16,2-2 0-16,-1 0-3 0,2 2 12 0,-1 0-5 15,-2-1-10-15,3 2-1 0,-2-3-1 0,-1-1 8 16,4 2 1-16,-3 1-7 0,0-4-6 0,0 3-1 15,1 0 8-15,-2 1 1 0,2-2-2 16,1 1 6-16,-3 0-4 0,4-1 0 0,-2 1 12 16,-2 2-5-16,1-3-4 0,1 2-13 15,0-3 0-15,2 3 17 0,-2-1-20 0,1-1 19 16,-2 0 3-16,-1 1-12 0,2 0 9 0,1 0-3 16,-1-2-6-16,0 2 12 0,-2 0-27 15,4 1 22-15,-3-2 10 0,0-2-18 16,1 4-5-16,1-1 23 0,-3-2 4 0,3 1-34 15,-2 1 19-15,2-2-14 0,0 3 13 0,-3-4 7 16,0 2-2-16,2 2-8 0,0-2-18 0,-1 0 19 16,1-1-8-16,0 3-1 0,3-2 8 0,-5 1 17 15,4 1-6-15,-2-2-25 0,1 2 26 16,-1-3-15-16,-2 1 1 0,4 2-10 0,-4-3 21 16,4 1 0-16,-4 1-14 0,4 0-2 15,-2-2 24-15,1 0-15 0,-1 2-2 0,0 0-8 16,0-2 12-16,-1 2 5 0,2-2-1 0,-3 4-11 15,1-4 13-15,1 1-3 0,1 1-1 16,-2 0-8-16,1-1 11 0,0 1-4 0,-1 0-16 16,2 0 8-16,-2-2-1 0,1 3 2 15,2-2 10-15,-4 1-9 0,3-2 9 0,-1 1-7 16,-1 1-2-16,2 0 15 0,-3-1-11 0,0-1-28 16,0 2 36-16,4 1 1 0,-3-2-7 0,0 0-4 15,-1 2-13-15,1-2 0 0,1 0 22 16,-1 1-1-16,0 0-11 0,1 2 6 0,0-3-2 15,-2 2-10-15,3-3 14 0,-1 5-17 16,-2-2 20-16,1 0-11 0,2 0-1 0,-2-1 0 16,0 0-7-16,3 1 18 0,-3 0-9 15,2-1 2-15,-2 0-13 0,-1 1 15 0,2-1 3 16,-1 0-9-16,-1 1 4 0,2-1 5 0,-2 1-5 16,0 2-2-16,5-2-9 0,-5-2 30 15,3 2-21-15,-1-3 0 0,-2 4 1 0,2-2-8 16,1 1 8-16,0-1-2 0,0 0-4 0,-3 1 1 15,2 1 13-15,0-1 5 0,0-2 2 16,-1 1-14-16,1 2-6 0,1-1 9 0,-1 2 2 16,-1-3-6-16,3 1 7 0,-1-1-14 0,-2-1 27 15,0 4-22-15,3-2 14 0,-4 0-23 0,4 2 20 16,-2-6-1-16,0 5-31 0,0 0 11 16,0-2 6-16,2 0 13 0,-1 0 3 0,-1-1-11 15,1 0-10-15,-1 1 12 0,0 0-8 16,1 0 10-16,-2-1-10 0,2 2 14 0,-1-1-6 15,1 0 2-15,-3-1-12 0,0 0 12 0,4 1-12 16,-2-1 11-16,1 1-15 0,-1-1-1 16,1 1 10-16,2 0-2 0,-3 1-5 0,2-1-6 15,-1-1 11-15,-1 1-2 0,3 0 7 0,-1 2 13 16,-2-4-14-16,3 0 4 0,-2 2-12 16,-1-1 11-16,5 0-4 0,-6 0 3 0,3 1-8 15,-2 0 12-15,1 0-7 0,-1-2-6 0,-1 0 9 16,4 2 1-16,-3 0-11 0,0-3 5 0,2 3-4 15,-2-2 20-15,-2-1-13 0,0 0 5 16,0 0 3-16,0 0-12 0,0 0-11 0,0 0 18 16,0 0 2-16,0 0-19 0,12 13 9 15,-10-11 18-15,-2-1-15 0,2 1 11 0,-1-1 5 16,1 2-7-16,1-2-10 0,-3 1 12 0,3-1-15 16,-1 2 16-16,0-2-12 0,-1 2 10 0,2 0-6 15,-2-1 1-15,1 0-1 0,-2 3 11 16,1-2-2-16,0-3-7 0,3 7-14 0,-3-4 2 15,0 2 14-15,1-3-7 0,-1 1 7 0,1 2 2 16,-2-1-3-16,3 0-6 0,-2 0 8 16,-1-1-10-16,4 4 11 0,-2-2-4 0,-2-1-8 15,3 0 14-15,-2 3-2 0,0-2 5 16,1 0 3-16,0 0-13 0,1 0 7 0,-3 0-31 16,2 0 23-16,-1 0-1 0,2 0 11 0,-1 0-26 15,-2-1 17-15,2 2 6 0,-2-1-3 16,3-1-15-16,-3-1 12 0,0 2 1 0,0-5-2 15,0 0-12-15,0 0 21 0,0 7-11 0,0-7 0 16,0 0 4-16,0 9 5 0,0-9-12 16,0 7 12-16,0-7-11 0,12 13-14 0,-12-9 27 15,2-1 0-15,-2 0-23 0,0-1 16 0,0 0 7 16,1 1-16-16,1-1 8 0,0-2 13 0,-2 5-14 16,0-4 12-16,2 3-20 0,-2-2 16 15,0-1 7-15,2 0-10 0,-1 3-8 0,-1-2 11 16,3-2 2-16,-3 3-7 0,3-1 2 15,-1-1 6-15,-2 2-7 0,1-2 10 0,-1 2-4 16,1-1-25-16,-1-1 8 0,0 1 10 0,1 1-2 16,1-3-13-16,0 2-2 0,-2-2 34 15,0 0-20-15,0 0-6 0,0 0 11 0,0 0-4 16,0 0-9-16,0 7 21 0,10 2-19 0,-10-7 9 16,3 0 2-16,-2-2 9 0,0 2-12 15,-1 2 5-15,2-4-10 0,0 1-3 0,-2 0 4 16,5 4 6-16,-4-3 6 0,-1-2-10 15,0 2-20-15,3-1 26 0,-2 1-5 0,0-1 5 16,3 3 0-16,-4-4 13 0,3 2-21 16,-2 1 6-16,1-2-7 0,2 2-1 0,-3-2 3 15,1 1-7-15,0-1 14 0,-1 5-6 0,2-6-2 16,0 3 6-16,-3 1 4 0,3-1-7 16,-3-3 3-16,3 3-1 0,0 2-7 0,-1-3 6 15,0 1 14-15,-2 2-16 0,5-3 0 16,-2 1-15-16,0 0 22 0,1 0-13 0,-4-1 10 15,4 3-19-15,-3-2 21 0,2-3 6 16,-3 2-13-16,2 2 8 0,1-3-17 0,-1 2 19 16,-2-1-5-16,3 3-3 0,-2-5-15 0,0 2 18 15,1-1-2-15,0 5-3 0,0-5 5 0,-2 1-1 16,2-1 2-16,0 3-6 0,-1-2-7 16,-1-1 8-16,3 2-3 0,-3-3 4 0,4 4 19 15,-4-2-18-15,2-1-5 0,-2 0-1 16,2 1-9-16,-2-2 22 0,0 0-17 0,0 0-5 15,0 0 19-15,0 0-1 0,0 0 4 16,0 0 9-16,0 8-13 0,0-8-22 0,12 11 29 16,-11-8-8-16,1-1 1 0,-1 0 1 0,2-1 3 15,-1 0-10-15,-1 3-13 0,-1-4-2 16,3 2 19-16,-1 0 11 0,-1 0-18 0,-1 1 6 16,0-2-8-16,3 1 10 0,-1 1-16 0,-2-1 17 15,3 0-7-15,-1-1 4 0,1 2 1 0,-3-2 5 16,2 2 13-16,0-1-16 0,0-2-7 15,-2 4 3-15,4-3 0 0,-3 0-9 16,2 3-2-16,-1-3-3 0,2 2 17 0,-3-1 6 16,0 0 8-16,4 0-12 0,-3-1-6 15,-1 2-12-15,1 0 11 0,2-2 5 0,-3 2 1 16,1-2-11-16,-1 5 15 0,0-4-2 0,2-1-25 16,-1 1 18-16,1 1 7 0,-2-3-5 0,0 2 1 15,3-1 15-15,-2 3-15 0,0-4 13 16,-1 3-33-16,0-3 23 0,2 1-19 0,0 1 26 15,-3 2-14-15,4-3-13 0,-2 1 17 16,0 0-2-16,-1 1-1 0,2-1-9 0,-1-1 11 16,-2 1 15-16,4 0-13 0,-4-1-4 0,2 5-3 15,3-6 5-15,-2 3 9 0,-2-2-22 0,2 1 11 16,-1 1 2-16,0-2-1 0,0 2-8 16,-2-3 16-16,4 3-13 0,-2 0 5 0,0-2 8 15,1 0-18-15,1 4 0 0,-2-4 13 0,0 1 0 16,0 0 1-16,1 3-8 0,-1-2 5 15,-2-3 13-15,4 2-25 0,-1 2-3 0,-1-3 20 16,2 1 10-16,0 1-32 0,-3 2 9 16,3-4 11-16,0 1-17 0,-1 4-3 0,-2-4 19 15,3 0 5-15,1 2-5 0,-1-1 10 0,-3-1-9 16,3 3 0-16,0-3-11 0,-2-2 13 0,1 3-2 16,2 2 4-16,-3-3-17 0,3 2 6 15,-2 1 12-15,-1-2-8 0,4-2-7 0,-3 5 10 16,-2-5-2-16,5 1 10 0,-2 3-28 15,-1-3 11-15,-1 0 12 0,2 4-3 0,-3-5-19 16,4 1 11-16,-2-1 15 0,0 3-10 16,0-1-16-16,-2-3 23 0,6 2-21 0,-4 3 16 15,-1-4 11-15,0 0-7 0,1 1-8 0,2 0 3 16,-3 2-8-16,2-3 3 0,-2 2 12 16,0 1-3-16,2-1-3 0,-1-3 0 0,0 1-6 15,-1 1 8-15,2 2-2 0,-2-2-11 0,3-2 12 16,-2 2 5-16,0 1-21 0,0-1 19 0,-1 1 7 15,1-2-15-15,2 2-12 0,-1-1 18 16,-3 0-8-16,4 0 4 0,-2-2-15 0,-1 2 8 16,0 1 1-16,1 0 6 0,0-1-5 0,-1-2 2 15,1 0 12-15,2 4 2 0,-3 0-8 16,2-2-6-16,0 0-2 0,-2 1 0 0,1 0 11 16,2-1-4-16,-3 1-3 0,1-2 1 0,1 1 6 15,-1 0-23-15,2 0 19 0,-3 2 0 16,2-3-17-16,-2 2 15 0,3-1-2 0,-4-2-14 15,5 3 17-15,-3 0-12 0,2 2 24 0,-1-3-23 16,0 0 12-16,-1 1 1 0,2 0-15 0,-1 1 2 16,0-3 0-16,-1 1 21 0,0 2-12 15,-2 0 0-15,5-2 6 0,-5 1-12 0,1-1 16 16,2 0-5-16,-2-1-1 0,2 2 3 0,-1-1 5 16,-1 0-8-16,2 0 1 0,-2-1-20 15,1 1 21-15,-1 1-3 0,0-3-16 16,0 2 6-16,-2-2 12 0,4 1-3 0,-1 1-8 15,-1-1 9-15,0 4-14 0,1-4 23 0,-1 2-6 16,1 0 5-16,0-3-22 0,0 2 15 0,-2 0 10 16,1-1-1-16,0 1-10 0,1 1 3 15,-1-1 1-15,0 0-26 0,3 1 16 0,-4 0 4 16,2-1 8-16,-1 0-7 0,3 2-4 16,-4-2 5-16,3 0-10 0,-4 2 11 0,2 0-3 15,2-3 2-15,0 2-13 0,-3 1-1 0,2-2 12 16,1-1 6-16,0 2-20 0,0 1 17 0,-1-2-3 15,0 2-4-15,0 2-12 0,1-3 21 16,-1-1-9-16,1 3 5 0,-3-2 9 0,2 1-26 16,0-3 14-16,0 4 8 0,1-3-10 15,-1 1 6-15,1 0 3 0,-1 1-23 0,1-1 11 16,-2 0 12-16,-1-1-16 0,6 0-6 0,-6 1 11 16,1 0 12-16,1 0-16 0,0 2 19 15,0-1-6-15,1-1-15 0,-2 0 18 0,4 1 1 16,-5-1-3-16,2 3-10 0,1-3 10 0,0 1-19 15,-3 0 15-15,6 0 2 0,-5 0-20 0,-1-2 14 16,4 3 13-16,-2-2 1 0,0 1-16 16,1 0-15-16,0-2 27 0,0 4-5 0,-2-2-1 15,3 0-4-15,-2 0 13 0,-1-2 0 16,5 4-11-16,-4-3 10 0,1 1-7 0,0-1-6 16,-2 0 13-16,1 1-21 0,1-1 14 0,1-2-3 15,-3 5-6-15,1-3 8 0,2-1-3 0,-3 3 5 16,1-2-7-16,-1 0 13 0,2 1-4 15,-2-2 3-15,1 0-19 0,-2 2 11 0,2-1 6 16,2-1-4-16,-3 1-2 0,2 2 6 16,-1-3 6-16,-1 2-13 0,-1 0 16 0,4 0-15 15,-1 0-9-15,1-1 12 0,-1 0-14 0,1 3 12 16,-2-4 10-16,3 2-5 0,-3 1-9 0,1 1-1 16,0-4 15-16,8 7-4 0,-8 0-4 15,2-5-3-15,1 0-4 0,-1-1-9 0,-5 1 15 16,2-1-4-16,0 1 0 0,-2-3-4 15,0 2-5-15,1 1 16 0,0-3-5 0,3 1 14 16,-5 1-18-16,4 0 3 0,-4-1-16 0,4 0 36 16,-4 1-24-16,4 1-1 0,-2-3-2 15,1 3 7-15,0-2 5 0,2 2 4 0,-4-2-24 16,1 1 0-16,5 1 19 0,-6-1-2 16,1 3-16-16,3-4 25 0,0-1-7 0,-3 6-3 15,1-5 12-15,0 1 3 0,-1 1-15 0,2-1-5 16,0 0-9-16,-1 0 17 0,1-1 0 15,0 2-3-15,0 0 0 0,-2-2-9 0,5 2 2 0,-5 0 10 16,3 0-13-16,0 2-8 0,-1-4 6 16,6 12 15-16,-2-6 4 0,-1-4-4 15,-1 3-4-15,-1-4 2 0,-1-1 8 0,-1 0-6 16,3 2-4-16,-4-2-10 0,0 0 23 0,1 1-6 16,-3-3-7-16,5 3-2 0,-4-3 20 15,1 2-17-15,0 0-7 0,1-2-12 0,-1 0 22 16,1 1-16-16,-3 1 16 0,3-2-18 15,0 2 25-15,0-2 6 0,-3 1-13 0,1 1 2 16,-1-2-6-16,0 0 8 0,0 0-21 0,0 0 14 16,0 0 12-16,0 0-7 0,0 0-2 0,0 0 2 15,0 0 1-15,0 0-4 0,8 0 9 0,-8 0-16 16,0 0 10-16,6 0-3 0,-6 0 8 16,0 0-24-16,0 0 10 0,10 0 1 15,-10 0-6-15,0 0 10 0,0 0 2 0,6 0-8 16,-6 0-4-16,0 0 9 0,7 0-12 0,-7 0 17 15,0 0-7-15,0 0 4 0,8 0 6 0,-8 0-20 16,0 0-3-16,9 0 16 0,-9 0-3 16,0 0 7-16,7 0-15 0,-7 0 11 0,0 0 1 15,7 0 12-15,-7 0 4 0,0 0-19 16,0 0 14-16,7 0-14 0,-7 0 0 0,0 0-17 16,0 0 34-16,7 0-33 0,-7 0 8 15,0 0 11-15,9 0-1 0,-9 0 10 0,0 0-19 16,0 0 9-16,0 0-4 0,7 0-6 0,-7 0 11 15,0 0-1-15,7 0-10 0,-7 0 32 0,0 0-18 16,0 0 5-16,8 0-11 0,-8 0-10 16,0 0 12-16,0 0-6 0,6 0 6 0,-6 0-23 15,0 0 31-15,0 0-8 0,0 0-8 0,9 0 15 16,-9 0-3-16,0 0 5 0,0 0-24 16,7 0 10-16,-7 0 14 0,0 0-9 0,0 0-3 15,0 0 4-15,0 0 4 0,8 0 0 0,-8 0-11 16,0 0-3-16,0 0 19 0,0 0-6 15,7 0-7-15,-7 0 8 0,0 0-2 0,8 0 3 16,-8 0-12-16,0 0-12 0,0 0 26 16,7 0-3-16,-7 0-8 0,7 0-7 0,-7 0 9 15,14 2 2-15,-12-1-9 0,-1 1 13 0,2 1-4 16,-1-3-2-16,1 3-4 0,-1-3 12 0,-2 0-2 16,0 0-5-16,0 0 11 0,0 0-7 15,0 0-7-15,0 0 4 0,6 0 6 0,-6 0-22 16,0 0 31-16,0 0-16 0,17 12 6 15,-16-12-19-15,0 2 10 0,2-2-3 0,-3 0 10 16,2 2 4-16,1-2-3 0,-2 3-6 0,0-3 6 16,3 1-7-16,-2-1-2 0,1 1 12 0,-3-1-3 15,0 0 9-15,0 0-13 0,0 0 1 16,0 0-17-16,5 0 22 0,-5 0-11 0,9 0 2 16,-9 0-22-16,7 0 18 0,-7 0 8 15,0 0 6-15,9 0-22 0,-9 0 13 0,8 0-6 16,-8 0-21-16,7 0 37 0,-7 0-8 0,7 0-20 15,-7 0 0-15,9 0 13 0,-9 0 11 16,7 0-4-16,-7 0-15 0,7 0 20 0,-7 0-15 16,8 0 14-16,-8 0 7 0,8 0-9 0,-8 0-20 15,7 0 20-15,-7 0-2 0,9 0 4 16,-9 0 1-16,7 0-8 0,-7 0-6 0,20-9 13 16,-15 7 17-16,-2 2-12 0,1-4 5 0,0 4-7 15,0-4 3-15,-1 2-12 0,-1 2 6 16,2-3 5-16,1 3-10 0,-1-1 9 0,-2-3-3 15,2 4 4-15,-3-1-18 0,3 1 10 16,-3-2-10-16,-1 2 23 0,0 0 1 0,0 0-12 16,0 0 11-16,0 0-17 0,8 0 13 0,-8 0-11 15,0 0 3-15,0 0 7 0,7 0-26 16,-7 0 20-16,8 0 7 0,-8 0-12 0,0 0-19 16,0 0 21-16,7 0-15 0,-7 0 25 0,0 0 7 15,8 0-18-15,-8 0 12 0,7 0-17 16,-7-8 9-16,8 8-10 0,3-10-8 0,-8 10 16 15,3 0 2-15,-2-2-7 0,2 0 6 16,-1 2-10-16,-1 0 6 0,2 0-4 0,-2 0 16 16,2 0-7-16,-6 0-10 0,0 0-3 15,6 0 12-15,-6 0-10 0,10 0 10 0,-2 0-9 16,-8 0 17-16,10 0-8 0,-3 0-8 16,1 0-7-16,-8 0 9 0,7 0 20 0,2 0-28 15,-9 0 20-15,8 0-23 0,-2 0 8 0,-6 0 5 16,10 0 12-16,-10 0 1 0,7 0-6 15,-7 0-20-15,7 0 36 0,-7 0-26 0,8 0 8 16,-8 0-2-16,9 0 12 0,-9 0-18 0,8 0 7 16,-8 0-9-16,7 0-12 0,-7 0 15 15,0 0 5-15,9 0 0 0,-9 0-14 0,9 0-4 16,-9 0 13-16,5 0 0 0,-5 0 15 0,0 0-6 16,10 0-6-16,-10 0-16 0,0 0 13 15,7 0-17-15,-7 0 19 0,8 0 1 0,-8 0-1 16,0 0 2-16,8 0-8 0,-8 0 10 0,7 0-17 15,-7 0 20-15,7 0-17 0,-7 0-10 16,0 0 29-16,8 0-11 0,-8 0 4 0,0 0-20 16,7 0 6-16,-7 0 4 0,0 0 1 0,7 0-7 15,-7 0-3-15,0 0 34 0,8 0-23 16,-8 0-16-16,17 14 30 0,-15-13 1 0,1 1-14 16,4 0 10-16,-3 3-26 0,2-4 21 0,-2 3 4 15,0-1 8-15,1 0-21 0,-3-1 1 16,3 3 5-16,-1-2 7 0,3 1-9 0,-3 0 0 15,1-3-4-15,-2 4 21 0,2-1-16 0,-1-1-28 16,2 0 33-16,-1 0-12 0,-1-1 11 16,-2 3 8-16,2-2-14 0,0-1-13 0,-1 1 21 15,1 2 5-15,-1-3-2 0,-1 2-11 16,3 0-6-16,-4-2 6 0,3 2 10 0,1 0-9 16,-2-1-11-16,0 3 4 0,1-2 9 0,-1 2-8 15,2-2 15-15,-3 2-12 0,8 5-1 16,-4-3 7-16,-2 1-2 0,1-6 2 0,-2 4 8 15,-1-6-8-15,1 1-21 0,-2 3 13 0,3-3 8 16,-4-1 16-16,2 2-17 0,1 1-6 16,1-4 15-16,-3 2-21 0,0-1 13 0,1 2-2 15,0 1-10-15,-2-4 13 0,2 2-3 16,-2-2 22-16,2 3-35 0,-1-2 8 0,1 2 13 16,-1-2 0-16,1 1 8 0,-2-1-32 0,0 1 22 15,1 0-12-15,3 0 13 0,-3 0-8 16,0-2 11-16,1 4 8 0,-1-2-9 0,1 0-3 15,1-2-3-15,-2 2-3 0,2 0-11 16,-1 2 24-16,-1-1-10 0,2-2 4 0,-1 3-18 16,1-2 11-16,-2 2 21 0,4-2-15 15,-1 3-11-15,0-2 11 0,-1 1-21 0,0 0 20 16,1-2 0-16,-1 2 8 0,0 0 2 0,1 1-9 16,-2-3-10-16,2 2 14 0,0 1-18 15,-4-2 19-15,6 1-18 0,-5-1 23 0,2 0 3 16,2 2-13-16,-1-5 16 0,-3 4-18 0,4-1 0 15,-3 0 2-15,3-1-7 0,-5 2 4 16,4-1 12-16,-2-2-9 0,2 1 9 0,-3 2-7 16,2-3-20-16,-3 2 17 0,4 1 7 0,-3-2-3 15,4 1-17-15,-4-2 9 0,2 4-4 16,0-3 14-16,0-2-18 0,0 5 13 0,-1-1 1 16,0-1 0-16,1 1-23 0,1-2 12 15,-4 0 18-15,6 1-5 0,-5 0-8 0,2-1 6 16,-1 2 5-16,-1-1 3 0,3-2-13 0,-1 0-9 15,-2 0 5-15,1 3 12 0,1-1-11 16,-3-1 7-16,1-1-5 0,2 1 7 0,-1 1-5 16,-2 0 1-16,3-2-23 0,-1 2 28 0,2-1 3 15,-4 0-3-15,4 1-15 0,-1-2 13 16,0 5-15-16,2-4-4 0,-4 2 9 0,2 2 7 16,2-5 5-16,-4 5-1 0,2-3-15 0,0-1 11 15,1 3 11-15,0-3-7 0,-2 4 5 16,2-4-6-16,-2-1-8 0,0 3 25 0,2 0-4 15,-3-2-12-15,4-1-20 0,-5 1 20 0,4 3-1 16,-2-4 12-16,2 0-13 0,-3 0-15 16,3 3 10-16,-2-3-10 0,-1 1 19 0,2 0-7 15,0 0 4-15,-2 2 15 0,4-3-17 0,-4 3-1 16,2 0-22-16,3-3 4 0,-3 0 18 16,0 2 25-16,0-2-45 0,3 3 32 15,-6-3-20-15,4 0 4 0,1 2 13 0,-2 0-3 16,4-1 6-16,-5 0-13 0,1 0 13 0,1 4-13 15,1-5 6-15,-1 1 11 0,0 3-14 0,-1-3-19 16,2-1 23-16,-2 0-5 0,3 2 2 16,0 0-7-16,-1-1 9 0,0-1 11 15,0 3-3-15,9 4-14 0,-5-5 27 0,-2 1-15 0,-4-2 0 16,2 2 6-16,-2-3-22 0,0 1 24 16,3 1-11-16,-5-2-12 0,2-1 17 15,0 3 4-15,0-1-13 0,-1-2-1 0,0 1 7 16,-1 0 5-16,3-1-11 0,-2 3-1 0,2-3 1 15,-1 2-4-15,-1-2 2 0,-1 1 4 16,3-1-4-16,-3 2-2 0,2-1-3 0,-3-1 5 16,0 1 1-16,2 1-19 0,0-2 13 0,-1 2 18 15,1-2-9-15,1 0-13 0,-3 1-11 16,0-1 33-16,2 0-19 0,0 1 0 0,0 1-9 16,-1-1 21-16,2 2 3 0,-3-3-13 15,3 3 1-15,-1-3 9 0,0 1-13 0,1-1-1 16,-1 2 10-16,-1-1-5 0,1 1-16 0,-1 0 8 15,3 0 9-15,0-2 5 0,-4 1 4 0,3 1-32 16,1 2 8-16,-4-2 14 0,4 2-2 0,-4 0 18 16,2-3-6-16,1 2-24 0,-1 0 35 15,0-1-24-15,0 0 5 0,1 1 10 0,-1 0-24 16,2-1-1-16,-3 0 12 0,2-1-1 16,-1 2 6-16,1 1 3 0,-2-2-14 0,0-1 5 15,1 1 0-15,0 3 0 0,1-5 1 0,-2 3 14 16,1 3-8-16,1-3-16 0,1 0 1 15,-2 0 14-15,-1-1-5 0,2 1-1 0,2 2 5 16,-3-3 7-16,2 3-7 0,-3-1-16 16,2-3 11-16,1 4-13 0,-3-2 17 0,4 1-21 15,-4-1 28-15,0 0-1 0,3-3-5 16,-1 5-7-16,-2-2 5 0,3-2 0 0,-2 2 0 16,-1 1 6-16,2-2-7 0,-2 0-12 0,1-2 12 15,-1 5-2-15,2-4-2 0,0-1 9 0,-2 2-3 16,2-2-1-16,0 1-4 0,1 0 4 0,-2 2 6 15,-2-3-9-15,0 0-21 0,0 0 27 16,0 0-3-16,8 0-1 0,-8 0-16 0,8 0 24 16,-8 0-3-16,5 0 2 0,-5 0-11 15,10 0 9-15,-10 0-16 0,5 0 23 0,-5 0-12 16,10 0 3-16,-10 0 12 0,10 0-7 16,1-13 6-16,-7 11-26 0,2 2 16 0,-2-2-11 15,1 0 1-15,0 0 1 0,0 2 8 0,0-2 9 16,-2 1-6-16,1 1-2 0,-1-1-1 0,3 0 2 15,-2-1 4-15,1-1-8 0,0 1-1 16,-1 2 4-16,-1-2-15 0,1 1-2 0,0-2 9 16,1 1 11-16,-3 2-7 0,1-2 4 15,1 2-2-15,0-2-6 0,-2-3 19 0,2 5-19 16,1-2-2-16,-3 2 25 0,0-1-20 0,-1-2 5 16,3 2-11-16,-2-1 12 0,1-1-9 0,2 3 8 15,-3-3-22-15,2 0 23 0,-4 0-10 16,3 3 10-16,0-1 10 0,1 0-11 0,-2-1 10 15,1 1-24-15,-1-1 21 0,1-2-5 0,-3 4 11 16,4-1-9-16,-2-1-7 0,1-1 0 16,-1 3 0-16,1 0-3 0,-2-1 3 0,2-1-15 15,-3 2 15-15,2-2 5 0,2 2-11 16,-3-3 25-16,0 3-17 0,2-2-7 0,-2 1-6 16,3-1 0-16,-2 2 15 0,0 0-2 0,1 0-18 15,0-4 28-15,-1 2 6 0,2 1-24 16,-1 1 12-16,-1 0-10 0,-1 0-3 0,2-1 29 15,-3 1-5-15,4 0-1 0,-1-2-15 0,0 2 16 16,1 0-15-16,2 0 19 0,-2-4-19 16,-4 4 9-16,0 0-16 0,0 0 23 0,7 0-12 15,-7 0-6-15,10 0 8 0,-10 0-11 0,10 0 24 16,-10 0-29-16,8 0 15 0,-1 0-7 16,-7 0 24-16,10 0-25 0,-1 0 3 15,-9 0 6-15,9 0-7 0,0 0-2 0,-2 0 12 16,-7 0-13-16,10 0-13 0,-5 0 13 0,3 0 13 15,-8 0-5-15,10 0-19 0,-3 0 17 16,1 0-14-16,-8 0 23 0,10 0-18 0,-3 0 5 16,0 0-1-16,-7 0 8 0,10 0 3 0,-3 0-11 15,-7 0 6-15,10 0 14 0,-5 0-5 16,-5 0-25-16,10 0 7 0,-3 0-11 0,-7 0 7 16,8 0 2-16,-8-6 23 0,10 6-2 15,-10 0-18-15,8 0 4 0,-8 0-5 0,9 0 5 16,-9 0-1-16,8 0-3 0,-8 0 26 15,9 0-27-15,-9 0 17 0,5 0-16 0,-5 0 6 16,0 0-7-16,10 0-8 0,-10 0 13 16,0 0-14-16,6-8 9 0,-6 8-6 0,0 0 2 15,8 0 16-15,-8 0-6 0,0 0-8 0,14-15-4 16,-12 15 9-16,0 0-3 0,-2-2 24 16,3 1-25-16,-3 1 10 0,3-3-4 0,0 2-10 15,-3-2 26-15,4 1-32 0,-1 1 17 16,-1 1 13-16,-1-2-13 0,2 1-11 0,-2-1 0 15,-1 1 12-15,2 0 12 0,-1 1 2 0,0-2-21 16,3 1 15-16,-2 1-10 0,-2-1-5 0,1-3-6 16,2 3 1-16,-3 0 22 0,7 1-28 15,-3 0 20-15,-4-2 15 0,3 2-18 0,-1-1-11 16,2-1 14-16,1-2-1 0,-5 4-18 0,5-1 21 16,-3-2-9-16,1 1 14 0,2 1-3 15,-3-2-20-15,2 1 4 0,0 1 31 16,1 0-17-16,1-4-20 0,-2 3 33 0,1 0-32 15,0-1 4-15,-2 3 12 0,3-3 0 0,-1 3 10 16,-1-2-6-16,2 0-19 0,0-1 32 16,-3 3-27-16,3-2 0 0,0 1 15 0,-2-1 14 15,2 1-32-15,-3-3 21 0,2 3-11 16,0 0-7-16,0 1 16 0,-3-1 9 0,2 1-20 16,0-2-12-16,-1 2 24 0,1-2-15 15,-1 0 13-15,-2 1-1 0,2 1 8 0,0 0-25 16,1 0 11-16,-3-1-20 0,4 1 13 15,-3 0 0-15,0-1-10 0,2 1 10 0,1 0 9 16,-4 0-6-16,0-1-5 0,2-1-1 0,-2 2 18 16,5 0-13-16,-6-2-6 0,0 2-2 15,0 0 8-15,0 0 17 0,0 0-17 0,9 0-5 16,-9 0 12-16,5 0 17 0,-5 0-31 0,0 0 33 16,10 0-26-16,-10 0 23 0,9 0-3 15,-9 0-16-15,16-11 12 0,-11 10 7 0,-1-2-27 16,4 3 5-16,-4-1-6 0,3-3 8 15,-6 3 7-15,7 0 23 0,-1-1-36 0,-2 2 14 16,2-1-7-16,-2 0-4 0,4-3 1 0,-4 2 20 16,4 2-8-16,-4-2-16 0,4 1 11 15,7-4-16-15,-2 3 24 0,-5-1-17 0,-2-2 8 16,1 3-15-16,-1 2 11 0,-1-1-1 0,3-1 8 16,-6 2-10-16,2-3 1 0,0 2 5 15,2-1 14-15,-4 2 11 0,3 0-16 0,-2-2-17 16,0 2-2-16,0 0-3 0,2-1 18 15,1 1-8-15,-3-4-4 0,1 4 1 0,-3-2 1 16,2 2 16-16,0-1-19 0,1 1 28 16,-1-1-25-16,1 1-1 0,-1-1 20 0,0 1-24 15,-2-1-2-15,3 1 32 0,-5 0-27 16,0 0 2-16,0 0 16 0,7 0 21 0,-7 0-31 16,0 0 7-16,10 0-18 0,-10 0 9 0,6 0-12 15,-6 0 0-15,8 0 4 0,-8 0 42 16,0 0-21-16,8 0-26 0,-8 0 23 0,0 0-18 15,7 0 37-15,-7 0-21 0,0 0-17 0,7 0-1 16,-7 0-15-16,0 0 54 0,9 0-37 16,-9 0 10-16,7 0 8 0,-7 0 6 0,0 0-13 15,7 0 3-15,-7 0 3 0,8 0-23 16,-8 0 18-16,6 0-22 0,-6 0-1 0,0 0 8 16,9 0 12-16,-9 0 7 0,7 0-33 0,-7 0 10 15,8 0 34-15,-8 0-3 0,7 0-30 16,-7 0 17-16,9 0-18 0,-9 0 6 0,6 0-13 15,-6 0 9-15,8 0-1 0,-8 0-4 0,7 0 3 16,-7 0 6-16,9 0 12 0,-9 0-17 16,9 0-8-16,-3 0 10 0,-6 0 23 0,9 0-24 15,-9 0 20-15,9 0-5 0,-2 0-8 0,0 0-5 16,0 0-11-16,-7 0 22 0,9 0 13 16,-2 0 6-16,-7 0-35 0,10 0 13 0,-2 0 19 15,-1 0-10-15,-7 0-21 0,9 0 9 0,-1 0 2 16,-1 0 8-16,-7 0 5 0,9 0-17 15,-1 0-8-15,-8 0 40 0,9 0-44 0,-9 0 42 16,10 0-20-16,-3 0-4 0,-7 0-19 16,7 0 32-16,-7 0 0 0,11 0-29 0,-5 0 17 15,-6 0-3-15,8 0 1 0,-8 0 9 0,9 0 14 16,-9 0-37-16,9 0 3 0,-9 0 33 0,7 0 4 16,0 0-7-16,-7 0-2 0,8 0-10 15,-8 0-21-15,9 0 12 0,-1 0-7 16,-8 0-10-16,8 0 20 0,-8 0-4 0,7 0-15 15,-7 0 4-15,9 0 33 0,-1 0 6 16,-8 0-43-16,7 0 23 0,-7 0-13 0,8 0 17 16,-8 0 2-16,9 0-25 0,-9 0 5 0,9 0 31 15,-9 0-34-15,10 0 4 0,-1 0 14 16,-9 0 4-16,7 0-14 0,-7 0-5 0,8 0 13 16,-8 0 17-16,8 0-11 0,-8 0-22 0,10 0-11 15,-10 0 13-15,8 0 22 0,-8 0-7 16,9 0-11-16,-9 0-7 0,7 0 4 0,-7 0 1 15,9 0-1-15,-9 0 1 0,8 0-1 16,-8 0 20-16,8 0-7 0,-8 0-18 0,8 0 25 16,-8 0-21-16,9 0 30 0,-9 0-33 0,7 0 12 15,2 0 5-15,-9 0-3 0,7 0 15 0,-7 0-14 16,8 0-8-16,-1 0-1 0,-7 0-9 16,8 0 33-16,-8 0-23 0,9 0 4 15,-3 0-2-15,-6 0-12 0,11 0 40 0,-2 0-30 16,-3 0 29-16,-6 0-25 0,9 0 16 0,-9 0-23 15,9 0-1-15,-9 0 5 0,9 0 11 0,-9 0 6 16,10 0 2-16,-4 0-2 0,-6 0 7 16,7 0-9-16,-7 0-7 0,10 0 15 15,-10 0-2-15,8 0-31 0,-8 0 0 0,6 0 29 0,-6 0-11 16,11 0-10-16,-11 0 9 0,6 0 20 16,-6 0 0-16,7 0-7 0,-7 0-23 15,18-8-3-15,-14 7 9 0,-1 1 22 0,0 0-17 16,-1-2-15-16,-1 0 6 0,2 2 5 0,-1-2 4 15,0 2 9-15,1-2 27 0,0 2-14 16,-2 0-32-16,2-1 38 0,1 1-42 16,-3 0 16-16,2 0 18 0,1-3-29 0,0 1 0 15,-2 2 12-15,1-1 41 0,1 0-3 0,-1 1-7 16,1-2-45-16,-4 2-7 0,0 0 30 0,0 0 11 16,0 0-31-16,6 0 12 0,-6 0-2 15,7 0-5-15,-7 0-5 0,0 0 15 0,8 0-23 16,-8 0 6-16,9 0 3 0,-9 0 1 15,7 0-4-15,-7 0 40 0,0 0-20 0,7 0-11 16,-7 0 4-16,14-10 16 0,-14 10-13 0,0 0 11 16,0 0-32-16,0 0 12 0,6 0-8 0,-6 0-19 15,0 0 42-15,7 0-30 0,-7 0 10 16,0 0-21-16,7 0 15 0,-7 0 37 16,0 0-29-16,8 0 4 0,-8 0-12 0,0 0 31 15,8 0-26-15,-8 0-4 0,0 0 24 16,0 0-16-16,8 0 2 0,-8 0 27 0,0 0-32 15,0 0-4-15,6 0 9 0,-6 0-15 0,0 0-2 16,0 0 16-16,9 0 22 0,-9 0-36 16,0 0 9-16,0 0 6 0,7 0 34 0,-7 0-42 15,0 0 24-15,6 0-13 0,-6 0-17 16,0 0 11-16,9 0 0 0,-9 0 13 0,0 0-22 16,0 0 26-16,8 0-16 0,-8 0-7 15,0 0 18-15,7 0-12 0,-7 0 0 0,0 0 25 16,8 0-32-16,-8 0-5 0,0 0 42 15,9 0-38-15,-9 0 4 0,0 0 23 0,7 0-15 16,-7 0-9-16,7 0 2 0,-7 0 0 0,0 0 4 16,7 0 17-16,-7 0-29 0,0 0 10 15,16 6 1-15,-14-4 2 0,1 0-2 0,0-2 17 16,0 0-11-16,0 0-10 0,0 0 3 16,3 2 20-16,-5-2 21 0,3 0-26 0,-2 0-17 15,1 0-12-15,-2 1 13 0,-1-1 23 0,0 0 7 16,0 0-28-16,0 0 33 0,0 0-26 15,8 0-19-15,-8 0 36 0,0 0-39 0,7 0-13 16,-7 0 21-16,0 0-8 0,7 0-5 0,-7 0 35 16,0 0-15-16,7 0-16 0,-7 0 40 15,0 0-23-15,0 0-9 0,10 0 19 0,-10 0-27 16,0 0 23-16,0 0 12 0,6 0-43 0,-6 0 57 16,0 0-44-16,0 0 25 0,8 0 4 15,-8 0 7-15,0 0-18 0,7 0-2 16,-7 0-30-16,0 0 8 0,6 0 6 0,-6 0-5 15,0 0 35-15,12 0-44 0,-12 0 18 0,0 0 28 16,7 0-27-16,-7 0-10 0,6 0 38 0,-6 0-30 16,0 0-3-16,8 0 26 0,-8 0-21 15,0 0 3-15,9 0 24 0,-9 0-29 0,7 0-15 16,-7 0 43-16,0 0 1 0,7 0-32 16,-7 7 21-16,0-7-18 0,8 0 33 0,-8 0-31 15,0 0 0-15,8 0 1 0,-8 0-3 16,0 0 9-16,7 0-14 0,-7 0 8 0,0 0 24 15,7 0-18-15,-7 0-10 0,0 0 44 0,7 0-23 16,-7 0-5-16,0 0-23 0,8 0 3 16,-8 9 29-16,0-9-8 0,8 0-22 0,-8 0 6 15,0 0 20-15,8 0 1 0,-8 0 13 0,0 0-9 16,7 0-29-16,-7 0 12 0,9 0 26 0,-9 8-32 16,0-8 13-16,10 0-7 0,-10 0 14 15,8 0-26-15,-8 0 0 0,6 0 30 0,-6 0-16 16,9 0 15-16,1 11-6 0,-6-9-19 15,-2-2-1-15,1 1 37 0,2-1-30 0,-3 0 9 16,2 1 18-16,1-1-37 0,-3 1 4 0,1-1 6 16,2 0-8-16,-3 3 24 0,5-1-22 15,-5-2 5-15,2 0 8 0,1 1-12 0,-5-1 8 16,0 0 31-16,0 0-52 0,0 0 14 16,6 0 28-16,-6 0-15 0,8 0 6 0,-8 0 15 15,8 0-38-15,-8 0 2 0,8 0-4 0,-8 0 0 16,6 0 8-16,-6 0 13 0,0 0 11 0,9 0-3 15,-9 0-11-15,9 0 24 0,-9 0-38 16,7 0-2-16,-7 0 8 0,7 0 2 0,-7 0 21 16,7 0-8-16,-7 0-18 0,0 0 37 15,9 0-9-15,-9 0-6 0,8 0-2 0,-8 0-12 16,0 0-16-16,7 0 13 0,-7 0 18 0,7 0 9 16,-7 0-33-16,0 0 8 0,9 0 28 0,-9 0-38 15,0 0 36-15,8 0-53 0,-8 0 19 16,0 0 7-16,0 0-16 0,6 0 13 0,-6 0 0 15,0 0 8-15,0 0-12 0,9 0-6 16,-9 0 12-16,0 0 32 0,0 0-33 0,7 0 0 16,-7 0 25-16,0 0-4 0,0 0-31 0,8 0-5 15,-8 0 13-15,0 0 16 0,7 0-11 16,-7 0-12-16,0 0 44 0,0 0-1 16,8 0-39-16,-8 0-1 0,0 0 33 0,0 0-32 15,7 0 1-15,-7 0 29 0,0 0-20 0,0 0 11 16,0 0-23-16,7 0 6 0,-7 0 37 0,0 0-24 15,8 0 25-15,-8 0-43 0,0 0-10 16,0 0 13-16,8 0 0 0,-8 0-9 0,0 0 43 16,0 0 3-16,7 0-9 0,-7 0-18 15,0 0-25-15,0 0 8 0,0 0 1 0,0 0 13 16,7 0 12-16,-7 0 3 0,0 0-30 0,7 0 38 16,-7 0-43-16,0 0 23 0,8 0-29 0,-8 0 21 15,0 0 29-15,0 0-13 0,0 0-17 16,7 0-2-16,-7 0-5 0,0 0 1 0,0 0 8 15,7 0 2-15,-7 0 16 0,0 0-5 16,0 0-14-16,0 0 20 0,5 0-4 16,-5 0-8-16,0 0-13 0,0 0-6 0,9 0 3 0,-9 0 8 15,0 0 18-15,0 0-21 0,0 0 29 16,8 0 5-16,-8 0-20 0,7 0 8 0,-7 0 0 16,0 0-25-16,0 0 2 0,7 0 20 15,-7 0-21-15,0 0-1 0,6 0 20 0,-6 0-1 16,0 0-3-16,9 0-17 0,-9 0-4 0,0 0 36 15,0 0-33-15,7 0 20 0,-7 0 16 16,0 0-5-16,0 0-29 0,7 0 20 0,-7 0-20 16,0 0 12-16,0 0 6 0,7 0 0 15,-7-8 15-15,0 8-46 0,0 0 7 0,9 0-3 16,-9 0 6-16,10-8 9 0,-10 8 2 0,4 0 12 16,-4 0 6-16,5 0 16 0,0 0-40 15,-3 0 16-15,-2 0-28 0,3 1 15 0,-1-1-1 16,2 0-3-16,-3-3 46 0,2 3-20 15,-2 2-28-15,0-4 33 0,2 2-21 0,-2 2-18 16,3-2 10-16,1-2 10 0,-3 2-18 0,1 0 25 16,3-1-16-16,-6 1 15 0,0 0-27 0,0 0 8 15,6 0 0-15,-6 0 26 0,8 0 13 0,-8 0-26 16,10 0 2-16,-10 0-19 0,7 0-3 16,-7 0 4-16,8 0-7 0,-8 0 9 0,11 0 4 15,-4 0 26-15,-7 0-29 0,8 0 37 16,-8 0-34-16,8 0 1 0,-8 0 4 0,11 0 34 15,-11 0-37-15,7 0 0 0,-7 0 1 16,8 0 6-16,-8 0 12 0,9 0-16 0,-9 0 21 16,7 0-2-16,-7 0-30 0,9 0-2 15,-9 0 39-15,0 0-6 0,0 0 1 0,6 0-29 16,-6 0 5-16,0 0 16 0,8 0-15 0,-8 0 29 16,0 0-33-16,7 0 22 0,-7 0-24 15,0 0 20-15,8 0-15 0,-8 0-8 0,0 0 31 16,0 0-15-16,7 0 22 0,-7 0 0 15,0 0-11-15,8 0-20 0,-8 0 14 0,0 0 29 16,0 0-45-16,7 0 4 0,-7 0-10 16,0 0 17-16,8 0-7 0,-8 0 25 0,0 0 6 15,0 0-1-15,6 0 7 0,-6 0-19 16,0 0-41-16,0 0 30 0,0 0 29 0,8 0-25 16,-8 0-7-16,0 0-12 0,0 0 37 15,0 0-7-15,7 0-35 0,-7 0 1 0,0 0-6 16,0 0 0-16,0 0 31 0,9 0-20 0,-3-12 7 15,-2 10 3-15,-4 0-1 0,4 2-6 0,-4-2 26 16,2 2-36-16,-2 0 8 0,4 0 23 16,-3 0-25-16,-1-2 29 0,4 2-9 0,-4 0 1 15,1-1-19-15,0 1-6 0,-1 0 5 16,0 0 12-16,0 0 34 0,0 0-15 0,0 0-26 16,0 0-4-16,0 0 5 0,0 0-11 0,0 0 26 15,0 0-14-15,0 0 19 0,0 0 1 0,7 0-28 16,-7 0 7-16,0 0-4 0,0 0-4 15,6 0 51-15,-6 0-45 0,0 0 8 0,0 0 16 16,0 0-25-16,9 0 5 0,2-16 7 0,-11 16 31 16,1-1-40-16,1 1-21 0,0 0 55 15,-2 0-10-15,3 0-11 0,-3 0-35 0,2-2 21 16,-1 2-7-16,1 0 53 0,-2 0-27 16,0 0 9-16,1-3-34 0,3 2 10 0,-4 1-6 15,0 0-1-15,0 0 6 0,0 0 20 0,0 0-38 16,0 0 46-16,0 0-39 0,0 0 7 15,0 0 42-15,0 0-23 0,6 0-27 0,-6 0 6 16,0 0 33-16,0 0-48 0,0 0 11 16,0 0 6-16,0 0 8 0,7 0-6 0,-7 0 44 15,0 0-31-15,0 0 13 0,0 0 12 0,0 0-17 16,0 0 8-16,8 0-14 0,-8 0 7 0,0 0-11 16,0 0-7-16,0 0 11 0,0 0-5 15,0 0 5-15,0 0-15 0,0 0-10 0,0 0 16 16,0 0 1-16,6 0-22 0,-6 0 21 15,0 0-25-15,0 0-3 0,0 0 16 0,0 0 21 16,9 0-8-16,-9 0 3 0,6-6-14 16,-4 6 13-16,-1 0-10 0,-1 0 25 0,1 0-30 15,1 0-2-15,-2 0 18 0,2 2-20 0,-2-2 32 16,1 0-34-16,3 0 4 0,-4-2-3 16,0 4 19-16,2-2-3 0,1 0 13 0,-3 0-1 15,0-2 2-15,0 2 8 0,2 0-33 16,-2 0 35-16,0 0-15 0,2 0-27 0,0 0 28 15,-1 0-19-15,-1-4 40 0,4 6-40 0,-4-4 14 16,0 2 0-16,0-2 14 0,1 2-13 16,-1-1 14-16,0 1-18 0,0 0-17 0,4 1-4 15,-4-1 27-15,0 0-3 0,0 0 17 0,0 0-18 16,0-1 15-16,0 1-17 0,3 0-17 0,-2 1 29 16,0-1-11-16,-1 0-3 0,2 0 21 15,-2-1-19-15,2 1-5 0,-1 0-23 0,-1 0 17 16,0 1 11-16,1-1-12 0,2 0 0 15,-3 2 19-15,0-2-24 0,2 0 27 0,-2 0-24 16,0 2 26-16,0 0 3 0,3-2-38 0,-3 0 11 16,2 0 6-16,-3 0-10 0,2 0 51 0,1 0-48 15,0 0-3-15,-2 0 33 0,0 0-37 16,0-4 10-16,1 4-6 0,-1 2 11 0,0-2-1 16,2 0-7-16,-2 0 13 0,0 2 4 15,0-2-6-15,2 0-1 0,-1 0 9 0,1-4 8 16,-1 4-19-16,-1 2-16 0,1 0 42 0,-1-2-35 15,4 0 14-15,-4 0 2 0,1 0 30 0,0 0-53 16,-1 0 13-16,3 0 35 0,-3 0-17 16,2 0-3-16,0 0 2 0,-1 0-19 0,0 2-5 15,0-2 2-15,-1 0 12 0,4 0 2 0,-4 1 18 16,0-1-43-16,1 0 30 0,0 1-9 16,1-1 17-16,-2 0 15 0,2 0-42 0,-2 0 34 15,2 0 17-15,-2 0-58 0,2 0 25 0,1 2-9 16,-2-1 14-16,0-1-22 0,-1 3 2 15,4-3 11-15,-4 0-1 0,0 0 10 16,2 0-16-16,-2 0 14 0,0 0-30 0,0 0 3 16,3 0 26-16,-3 0-25 0,0 2 48 0,2-2-7 15,-2-2-27-15,3 4 2 0,-3-2-9 16,1 0 1-16,0 0-1 0,2 1 15 16,-3 0-13-16,0-1 13 0,0 2-19 0,4-2 21 15,-4 2-14-15,1 0 11 0,4-2 8 0,-5 0-11 16,1 0-14-16,3 2 18 0,-4-2-5 0,2 0 7 15,0 0-18-15,-2 0 12 0,3 1-1 0,-1-1 3 16,0 1 10-16,0 1-35 0,-2 1 2 16,2-3 30-16,1 0-19 0,-1 1 1 0,2-1 20 15,-3 2-14-15,3-2-8 0,-4 2 35 16,2-2-45-16,0 4 0 0,0-4 24 0,0 1-21 16,1 0 0-16,-3 0 1 0,4 1 47 0,-3-2-29 15,0 0-16-15,1 4 5 0,4-3 16 16,-5 0 21-16,3 0-28 0,0 0-7 15,1 2 3-15,-3 1-8 0,2-4 4 0,0 0 37 16,-2 2-22-16,2-1-11 0,1 0 13 0,-3 3-17 16,1-2-8-16,-1-1 30 0,1 0-21 15,1-1-2-15,-2 2-3 0,2 2 23 16,-3-2-17-16,2-1-4 0,-1 0 19 0,3 0 20 16,-3 0-14-16,0 3-2 0,0-3-30 0,1-1 7 15,0 2 13-15,-2-2 19 0,0 2-19 16,3 2 25-16,-2-2-42 0,3 0 22 0,-2-1-22 15,-1 0 28-15,3 1-16 0,-1 0 8 0,-2-1-34 16,0 0 18-16,2 1 2 0,-1-1-5 16,2 4 20-16,0-5 1 0,-2 2-1 0,-1-1-30 15,5 2 16-15,-6 1 1 0,4-3-1 16,-4-1 23-16,2 1-18 0,2 0 0 0,-2 0-8 16,0 3 22-16,1-1-19 0,-1-2 9 0,0 4-10 15,2-4 8-15,-1 1-12 0,0 1 30 16,-1 0-30-16,5-1 12 0,-5 0-2 15,0 1-7-15,3 0 27 0,1-1-19 0,-4 0-11 16,4 1 32-16,-1 0-29 0,-1 0 23 0,0-2-6 16,-3 4-5-16,5-2-7 0,-4-1 36 15,2 1-17-15,-2 0-5 0,-1 0-16 0,2-2-7 16,0 4 19-16,-1-4-4 0,-1 1-8 16,0-1 6-16,1 2-5 0,1-2 0 0,-2 1 24 15,2-2-6-15,-4 1-22 0,4 1-2 16,-1-1 5-16,0 1 10 0,-2-2 25 0,3 1-25 15,-2 0 5-15,1 1-24 0,1-1 0 0,-3 1 2 16,3-2 8-16,-3 3 21 0,0-2-21 16,2-1-6-16,-2 1 2 0,-1 0-13 0,4 1 31 15,-4 0 2-15,1 1 12 0,3-2-22 16,-3 0-9-16,2-1-7 0,-1 1 18 0,0 1-19 16,1-1 4-16,-1 3 3 0,0-4 25 15,-1 2-34-15,1-2 9 0,1 1-6 0,-3 1 1 16,4 3 26-16,-4-5-29 0,3 2 5 0,-1-1-20 15,-2 0 8-15,1 3 6 0,0-2 18 16,3-2-15-16,-4 0 15 0,1 2-15 0,2 1 5 16,-3 0-4-16,1-1 25 0,3 1-26 0,-3 3 6 15,2-3-9-15,-1 0 12 0,-1 1-5 0,2-1 11 16,-2 1-3-16,3 0-15 0,-3 0 12 16,3 1 7-16,-4 0-20 0,4-1 10 0,-2-4-1 15,1 4 11-15,-2-1-14 0,0 0-4 16,3-1 9-16,-3 4 14 0,1-5-18 0,-1 2 17 15,-1 0-13-15,2-2-11 0,-2 3 28 0,0-4 0 16,4 0-15-16,-3 5-9 0,-1-4 9 16,0 1 18-16,4-2-28 0,-4 1 23 0,1 0-4 15,-1 3-2-15,0-4-9 0,0 2 14 0,1-2 13 16,-1 2-16-16,2-2-14 0,-1 0 4 16,-1 1 3-16,0-1 17 0,0 0-12 0,2 2-9 15,-2-2 0-15,0 0 17 0,0 0-11 16,0 0 18-16,0 2-24 0,0-2 14 0,3 1 3 15,-3-1 9-15,-3 0-21 0,3-1-3 0,3 2-1 16,-4 0 12-16,1-1-2 0,1-1-4 0,-1 1-5 16,-3-1 23-16,3 2-15 0,0-2-5 15,0 1 0-15,2 0 6 0,-2-2-3 0,1 2 2 16,-1 0 14-16,0 0 0 0,0 0 3 16,0 0-8-16,0 0 8 0,0 0-12 0,0 0-20 15,0 0 16-15,0 0 13 0,0 0-17 0,0 0-2 16,2 0-4-16,0 0-4 0,-2 2 32 15,1-2-20-15,-1-2-3 0,1 4-12 0,2-2 19 16,-3 0-8-16,0 0 4 0,0-2 1 0,2 2-7 16,-2 0 1-16,2-2 8 0,-1 2 10 15,0 2-22-15,0-4 11 0,3 2 14 0,-4-1-10 16,0 2-12-16,1-1 3 0,1 0 13 16,-2-1-12-16,2 1-3 0,-4 0 1 0,2 0 8 15,0 3 6-15,2-3-7 0,-2 0-16 0,2 0 5 16,-2 2 16-16,2-4-7 0,-2 2-9 15,1 0 18-15,-1 0-18 0,0 0 10 0,0 0-19 16,0 0 2-16,0 0 22 0,0 3-7 16,0-6-12-16,0 3 19 0,0 0-20 0,0 0-2 15,0 0 16-15,0 0-27 0,0 0 26 0,0 0-18 16,0 0 20-16,0-2-10 0,0 4-4 16,0-4-10-16,0 2 22 0,0 0-23 0,0 0 15 15,0 0 3-15,0-1 7 0,0-1-16 0,-1 2 20 16,1 0-15-16,0-2 13 0,0 2-6 15,0 0 0-15,0-1 6 0,1-2 2 16,-2 3-5-16,-1-1-20 0,4 0 27 0,-2-1-12 16,0 4 4-16,0-5-17 0,0 3 15 0,1-2 11 15,-1 2 12-15,0-3-11 0,0 3-4 16,0 0-10-16,0-2-14 0,0 2 2 0,0-2 17 16,0 2 0-16,0-1 0 0,0 0 6 0,0-1 2 15,0 0-19-15,0 2 18 0,0 0-7 16,0-1 6-16,0 0 5 0,0 0-12 0,0 1 8 15,0 0-1-15,0 0-7 0,0 0-7 0,0-2 14 16,0 2-29-16,0 0 30 0,0 0-4 16,0 0-3-16,0 0-7 0,0 0 13 0,0 0-3 15,0 0-3-15,3 0-10 0,-6 0 13 0,3 2-7 16,3-4 8-16,-6 2 5 0,6 0 0 16,-6 0-18-16,3 0-7 0,0 2 19 0,0-2-4 15,0 0-4-15,0 0 13 0,3-2-19 0,-6 2 2 16,6 2 7-16,-6-2 1 0,3 0 8 0,0 0-12 15,0 0-16-15,0 0 24 0,0 0-20 16,0 0 25-16,0 0-10 0,0-2 8 16,0 4-10-16,0-2 1 0,0-2 15 0,0 2-11 15,0 0-2-15,0 0-4 0,0 0 18 16,0 0-10-16,0 0-7 0,0 0 5 0,0-3-4 16,3 3 1-16,-3 0 1 0,0 0-6 0,0-2-12 15,0 2 30-15,0 0-12 0,0 0 3 16,0 0-16-16,0 2 19 0,-3-4-8 0,3 2 19 15,0 0-22-15,0 0-19 0,0 2 23 16,0-4-8-16,0 2 2 0,0 0-4 0,0 0 20 16,0 0-18-16,0 0 31 0,0 0-22 0,0 0 11 15,0 0 3-15,0 0-4 0,0 0-8 0,0 0-5 16,0 0-7-16,0 0 27 0,0 0 11 16,0 0-35-16,0 0 1 0,0 0 17 0,0 0 2 15,0 0-23-15,0 0-1 0,0 0 26 0,0 0 3 16,0 0-26-16,0 0 25 0,0 0-16 15,0 0 10-15,0 0-4 0,0 0-2 0,0 0 4 16,0 0-24-16,0 0 12 0,0 0 0 16,0 0 5-16,0 0-17 0,0 0 13 0,0 0-12 15,0 0 6-15,0 0 9 0,0 0-9 0,0 0 24 16,0 0-1-16,0 0-16 0,0 0 19 16,0 0-3-16,0 0-7 0,0 0-5 0,0 0-7 15,0 0 6-15,0 0 23 0,0 0-22 0,0 0-1 16,0 0 4-16,0 0-4 0,0 0 1 15,0 0 4-15,0 0-3 0,0 0 3 0,0 0-6 16,0 0 4-16,0 0-9 0,0 0 7 16,0 0-9-16,0 0 29 0,0 0-26 0,0 0 8 15,0 0 31-15,0 0-31 0,0 0 2 0,0 0 24 16,0 0 7-16,0 0 16 0,0 0-35 16,0 0 9-16,0 0 8 0,0 0 34 15,0 0-43-15,0 0-5 0,0 0 26 0,0 0-29 16,0 0 2-16,0 0 8 0,0 0-15 0,0 0 42 15,0 0-11-15,0 0 15 0,0 0-16 16,0 0 1-16,0 0-5 0,0 0 24 0,0 0-7 16,0 0 36-16,0 0-17 0,0 0 4 0,0 0-14 15,0 0-1-15,0 0 6 0,0 0-16 16,0 0 2-16,0 0-5 0,0 0 8 16,0 0-5-16,0 0-9 0,0 0 4 0,0 0-5 15,0 0-38-15,0 0 32 0,0 0-9 0,0 0-4 16,0 0 10-16,0 0-11 0,0 0-25 0,0 0 42 15,0 0-47-15,0 0 32 0,0 0 9 16,0 0-13-16,0 0-24 0,0 0 13 0,0 0 0 16,0 0-7-16,0 0 13 0,0 0-11 0,0 0-2 15,0 0 13-15,0 0-5 0,0 0-16 16,0 0 15-16,0 0 1 0,0 0-23 0,0 0-13 16,0 0-37-16,0 0 7 0,0 0 4 15,0 0 5-15,0 0-106 0,0 0-36 0,0 0-40 16,0 0-37-16,0 0 23 0,0 0-142 0,0 0-99 15,0 0 42-15,0 0 34 0,0 0 66 16,0 0 0-16,0 0 63 0,25-19 6 0,-16 18-10 16,1-5 28-16</inkml:trace>
  <inkml:trace contextRef="#ctx0" brushRef="#br1" timeOffset="1">36 29 333 0,'0'0'24'0,"0"0"27"15,0 0-34-15,0 0 0 0,0 0 14 16,0 0 26-16,0 0-40 0,0 0 25 0,0 0-18 16,0 0-12-16,0 0 40 0,0 0-42 0,0 0-8 15,0 0 12-15,0 0 3 0,0 0-17 16,0 0 4-16,0 0 15 0,0 0-26 0,0 0 45 16,0 0-31-16,0 0 35 0,0 0-49 15,0 0 26-15,0 0-3 0,0 0-1 0,0 0 19 16,0 0-13-16,0 0 7 0,0 0-34 15,0 0 33-15,0 0-22 0,0 0-21 0,0 0 52 16,0 0-34-16,0 0-6 0,0 0 18 0,0 0-3 16,0 0 1-16,0 0 0 0,0 0 28 0,0 0-11 15,0 0-35-15,0 0-1 0,0 0-10 16,0 0 15-16,0 0 1 0,0 0 31 0,0 0-5 16,0 0-63-16,0 0 36 0,0 0 1 15,0 0 44-15,0 0-4 0,0 0-22 0,0 0-21 16,0 0-1-16,0 0 0 0,0 0 3 0,0 0-3 15,0 0 9-15,0 0 4 0,0 0 2 16,0 0-2-16,0 0 0 0,0 0 54 0,0 0-37 16,0 0 12-16,0 10-11 0,0-9-3 15,3 3-44-15,-1-3-7 0,2 1 37 0,-3 1 0 16,1-1-1-16,-2 1-28 0,2-3-15 0,2 4 6 16,-3-4 2-16,3 0 2 0,-4 0 53 15,2 3 3-15,0-1-4 0,-2 1-42 0,3-2 0 16,-3 4 3-16,3-4 2 0,-2 0 41 0,0 1-6 15,1 1-5-15,0 0-15 0,1-2-10 16,0-1 1-16,-1 3 2 0,3 1-2 0,-3-2-11 16,2-1 9-16,0 2 1 0,-2-2 30 0,2 3 0 15,-3-2-5-15,1-2-2 0,0 1-2 16,2 2-3-16,-3 1 0 0,4-4-1 0,0 0-10 16,-4 3-2-16,2 0-2 0,3-1-3 0,-5 0 0 15,-1-2 1-15,4 3 0 0,-4-3-9 16,0 0 1-16,0 0 0 0,0 0 2 0,0 0 30 15,0 0 5-15,9 0-4 0,-9 0-25 0,7 0 2 16,-7 7 1-16,0-7-2 0,15 11 14 16,-13-7-2-16,0 0-1 0,2-4-1 0,-3 1 34 15,0 2-5-15,2 2-3 0,-1-4-12 16,1 0-10-16,-1 2-2 0,1-1-47 0,-3 1 3 16,1-3 47-16,0 1-8 0,1 0-2 0,0 2-27 15,1 1 3-15,0-3 24 0,-1 0 2 16,-1 1-2-16,4 0-1 0,-5 0 3 15,4 0 32-15,-1-2-34 0,0 3-1 0,-2-3 0 16,2 1 0-16,-3-1-23 0,0 0 5 0,0 0-10 16,0 0 5-16,8 0 2 0,-8 0 1 15,7 0 4-15,-7 0 46 0,8 0-2 16,-8 0-72-16,0 0 5 0,7 0 72 0,-7 0-4 16,0 0-62-16,7 0 22 0,-7 0 1 0,0 0 38 15,8 0-8-15,-8 0-2 0,0 0-1 0,7 0-4 16,-7 0-17-16,0 0 2 0,0 0-41 15,8 7 4-15,-8-7 63 0,0 0-12 0,0 0 26 16,7 0-45-16,-7 0 21 0,0 0 0 16,0 0-2-16,8 0-22 0,-8 0 20 0,0 0-18 15,0 0 31-15,7 0-2 0,-7 0-12 0,0 0 0 16,0 9-2-16,7-9-4 0,-7 0 1 16,0 0-2-16,16 11-18 0,-14-9 19 0,-2 2 18 15,3-3-4-15,-2 0-1 0,0 0-19 16,1-1 1-16,1 5-1 0,-2-3 2 0,0-1-3 15,-1-1 6-15,0 0 9 0,0 0 24 0,0 0-26 16,0 0 0-16,0 0-1 0,13 10 4 16,-11-8 6-16,-2-1-34 0,2 3 40 0,0-3 8 15,0 0-18-15,-1 2-17 0,0 0 7 16,1-1 19-16,-2-1-18 0,0 1-42 16,2-1 65-16,-1-1-23 0,2 0-22 0,-3 4 54 15,4-2-22-15,-4-1-6 0,2 0-2 0,1 1-36 16,-3-2 59-16,2 3-8 0,1 0-26 15,-1-2 28-15,-2 1-65 0,3 2 54 0,-2-3 1 16,2 1-49-16,-1-1 46 0,-1 2-6 0,1-1-15 16,0 0 18-16,3 0 3 0,-1 0-2 0,-4-1 2 15,2 4 9-15,3-4 12 0,-2 1-37 16,-1 2 8-16,0-3 27 0,3 1-63 0,-2 1 37 16,-3-3-20-16,3 2 47 0,2 0-19 0,-4-2-11 15,3 1-24-15,-2 1 5 0,1 0 37 16,-3-2-5-16,2 2-25 0,2 2 10 0,0-4 16 15,0 2-9-15,-2 0-27 0,3-2 35 16,-1 3 4-16,-2-3-13 0,0 3-18 0,4 0 14 16,-5-1 17-16,1 0-7 0,1-2-14 0,0 2 5 15,0 1 16-15,-1-2-8 0,4 2 12 16,-1 0 2-16,-5-3-3 0,0 0-7 0,4 3 4 16,-2-2-18-16,0 2 18 0,0-2-11 0,1-1 15 15,-3 2 1-15,5-1-10 0,-3 1-11 16,2 1 16-16,-2-1-23 0,3 0-5 0,-2-1-25 15,-2 1 24-15,3 1 36 0,-4-3-32 0,4 2 37 16,-2-2-30-16,1 2 14 0,-1-1-23 16,2-1 6-16,-4 1 0 0,4 3 6 0,-1-4-15 15,1 2 28-15,-4 0-15 0,2-1-6 0,0 1 16 16,2 1-4-16,-2-3 5 0,-1 2 6 0,3-1-41 16,0 1 32-16,-3 2-30 0,3-4 28 15,0 1 18-15,1 0-13 0,-4 3-4 0,3-1-27 16,-2-3-2-16,3 1 42 0,-5 0-5 0,3 1-27 15,1 2 26-15,-1-4-31 0,0 3 28 16,0-2-27-16,-1 2 9 0,3 0 17 0,-4-2 2 16,3 2-20-16,-2 1 5 0,1-2 12 15,1 0 5-15,1 0-11 0,-3 2 17 0,2 0-19 16,-4-4-7-16,4 7 11 0,-2-6-7 0,0 1 4 16,-1 2 7-16,5 0-17 0,-4-2 13 15,1 2-11-15,1-1 19 0,-2-2-7 0,1 1-9 16,-2 2 14-16,3-2-6 0,-2 1 4 0,1-2 0 15,-1 4 6-15,1-3-11 0,0 0 0 16,0-1 3-16,1 4-20 0,-4-5 16 0,5 1-9 16,-4 2 31-16,3 1-36 0,-3-3 8 0,3 1 27 15,-2 1-5-15,1-1-7 0,-3 1-6 16,5 1 9-16,-2-3 5 0,0 3-38 0,-1-3 27 16,0 0-27-16,-1 0 21 0,3 2-21 0,-1-1 25 15,-1 0-6-15,2-2 3 0,-1 3-19 16,0-3 27-16,-2 2-4 0,4-1 4 0,-1 1-22 15,-4 0 27-15,4-2-3 0,-2 3-18 0,3-1 4 16,-4-2 15-16,4 3-10 0,-2-2-11 16,2 0-5-16,-1-1 24 0,-3 2-16 0,3-1-1 15,2 3 1-15,-3-4 0 0,-1 1-3 16,2 0-12-16,2-1 13 0,-4 2-1 0,2-2-16 16,-1 3 26-16,1-2 0 0,-1 0-10 0,1 1-13 15,-3-2 26-15,3 1-6 0,0-1-20 16,-3 1 24-16,3-1 1 0,-4 0-4 0,2 2 5 15,0 0-2-15,3-1 4 0,-4 0-19 0,4 1-3 16,-3-1 15-16,2 0 11 0,0 1-31 16,-1 1-5-16,0-2 29 0,0 0-2 0,2 1 4 15,-3-1-22-15,2 2 19 0,2 0-13 16,-3-1 14-16,-1-2-5 0,2 2 5 0,0 3-3 16,0-4-1-16,-2 1-13 0,3-2 19 0,-2 3-21 15,1-2-1-15,0 1 9 0,0 0 22 16,-3-2-17-16,3 2 9 0,-1 1 0 0,0-1-8 15,0-1-15-15,-1 1 10 0,2-1 2 16,-1-1 15-16,-1 0-29 0,3 2 11 0,-4 1 12 16,2-2-5-16,-1 0-5 0,1-1 16 0,2 0-20 15,-3 2 10-15,2-1 3 0,1 2-12 16,-2-2-14-16,0 1 18 0,-1-2 4 0,4 0 1 16,-2 1-5-16,-1 1 4 0,0-2-10 0,1 0 1 15,-1 1-12-15,1-1 33 0,1 2-12 16,-2-2 6-16,1 0-18 0,0 0 18 0,-4 0 2 15,0 0-10-15,0 0-9 0,0 0 12 16,7 0-6-16,-7 0 11 0,9 0-23 0,-9 0 19 16,8 0-11-16,-8 0 15 0,9 0 5 0,-9 0-28 15,6 0 12-15,-6 0-5 0,0 0 19 16,8 0 7-16,-8 0-16 0,0 0-9 0,7 0-3 16,-7 0 34-16,0 0-18 0,8 0 6 0,-8 0-10 15,0 0 7-15,7 0 0 0,-7 0 0 16,0 0 1-16,0 0-10 0,8 0-8 0,-8 0 19 15,0 0 1-15,0 0-8 0,8 0-15 0,-8-6 27 16,0 6 4-16,7 0-18 0,-7 0-14 16,11-14 5-16,-10 12-6 0,0 1 13 0,0 1 17 15,1-2-16-15,-2 1-5 0,5-1-7 16,-3-1 22-16,0 3 1 0,-2-2 5 0,3 2-14 16,-2-2 6-16,0 0-6 0,1 1-19 0,-2-2 11 15,3 3-8-15,-3-2 4 0,0 2-4 16,4-1 15-16,-4-2-1 0,0 3 14 0,3-2-5 15,-1 0-11-15,-2 2-6 0,4-2 8 16,-3-1-8-16,1 2 3 0,0-2 0 0,0 1 14 16,1 2 12-16,-1-1-28 0,2-1 13 0,-3 0-15 15,3 0 14-15,-4 1-12 0,2 0-14 16,2 1 37-16,-1-3-24 0,0 2 7 0,1-3-5 16,-3 3-5-16,3 0-3 0,-1-1 9 0,-1 0 9 15,3-1 1-15,-3 2-4 0,1 0-1 16,1 0 7-16,-1-2-23 0,3 1 9 0,-4 1 6 15,1-2 16-15,-1 0-14 0,3 2-8 16,-4-2 0-16,1 1-11 0,3 0 13 0,-3-1 3 16,3 0-2-16,2 1 8 0,-4 0 0 0,1-1-26 15,1 1 19-15,-2 0-10 0,0-1 0 16,1 1 6-16,1-1 2 0,-2 2 21 0,-1 1-8 16,3-2-17-16,-2 0 15 0,-2 0-11 15,4 0-4-15,-3 1-1 0,0 0 24 0,0 0-34 16,1-2 23-16,-1 1-17 0,-1-1 11 0,3 3 7 15,-4-2-10-15,3-2 2 0,-1 3-11 16,-1 0 14-16,-1-2 10 0,3 1-17 0,-2-1 17 16,3 2-8-16,-2-2-7 0,1 3-7 15,-1-2 18-15,1 1 5 0,-2-2-3 0,2 1-23 16,0 1 28-16,-1 0-25 0,-1-1 7 16,0 0 6-16,2 0 3 0,-1 2 8 0,2 0-7 15,-1-2-6-15,-1 1 6 0,0 0-22 0,1-3 10 16,1 2 13-16,-4 2-24 0,2-2 22 0,3 2-7 15,-2 0-5-15,-3-1 16 0,3-2-14 16,-1 3 0-16,0-2 5 0,2 0-10 16,-3 2 22-16,3 0-28 0,-2 0 12 0,1-2-4 15,-3 2 16-15,3-2-29 0,-2 0 19 0,1 2-12 16,1 0 17-16,-3 0-8 0,0 0-1 0,0 0 18 16,0 0-6-16,0 0 1 0,0 0-13 15,0 0 19-15,6 0-9 0,-6 0-13 0,0 0 11 16,9 0-16-16,-9 0 13 0,0 0 0 0,7 0-2 15,-7 0-11-15,0 0 23 0,0 0-5 16,0 0-2-16,8 0-18 0,-8 0 15 0,0 0 7 16,0-7-4-16,5 7-18 0,-5 0 28 0,0 0 7 15,0 0-23-15,9 0 17 0,-9 0-27 16,0 0 4-16,6 0 10 0,-6 0 2 0,0 0-7 16,0 0 12-16,0 0-14 0,9 0 14 0,-9 0-4 15,0 0-12-15,6 0 8 0,-6 0-17 16,0 0 13-16,0 0 10 0,8 0-17 0,-8 0-1 15,7 0 12-15,-7 0 10 0,0 0-12 16,0 0-11-16,10 0 14 0,-6-15 9 0,0 14-10 16,-2 2-2-16,-2-1 12 0,0 0-10 15,3 0-1-15,2 0 8 0,-4-1 2 0,0 1 2 16,3 0-24-16,-4 0 30 0,0 0-33 0,2 0 13 16,0 0 12-16,-2 0-11 0,1 0 10 0,0 0-3 15,-1 0 0-15,0-1 3 0,0 2-11 16,3-2-16-16,-3-1 20 0,1 2 2 0,-1 0-13 15,2 0 8-15,0 0-5 0,0 0 1 0,-1 0-12 16,1 0 16-16,0 0 8 0,-2-3 3 16,1 6-28-16,1-6 23 0,0 3 4 15,0 3-11-15,-2-3 11 0,3 0-8 0,-3 0-15 16,3-3 35-16,-2 6-21 0,0-3-5 0,1 0-7 16,-2 0 7-16,0 0 5 0,0 0-3 0,0 0-13 15,0 0 1-15,0 0 23 0,0 0-16 16,7 0 21-16,-7 0-7 0,0 0-17 15,0 0 14-15,9 0 6 0,-9 0-22 0,0 0 22 16,0 0-13-16,7 0-8 0,-7 0 7 0,0 0 18 16,8 0-15-16,-8 0-10 0,0 0 21 15,0 0-18-15,17 10 6 0,-17-9 17 0,4-1-10 16,-4 0-3-16,5 2-3 0,-4-1 13 16,-1 1-10-16,2 0 5 0,-1-2-10 0,3 2-2 15,-2 0 0-15,1-1 20 0,-1 0-13 0,-2 1-12 16,3 2 11-16,0-2-1 0,0-2-6 15,-2 2 4-15,-1 0 7 0,4 1-16 0,-3-2 15 16,1 1 2-16,0 0-13 0,0 0 10 16,1 1 4-16,1-2 6 0,-2 1-11 15,-1 0 2-15,1 0 0 0,0 1-6 0,1-2 13 0,0 1-10 16,0 1 7-16,-2 0-18 0,1-3-1 0,1 3 22 16,-1 1-3-16,0-2-22 0,-2 0 20 15,4-1-6-15,-2 1 11 0,3 2-18 0,-5-2 18 16,3 0-17-16,-1 1 8 0,3 0 9 15,-5-1-16-15,4-1 14 0,-1 5-7 0,-1-4-18 16,1 1 25-16,-1 2 8 0,-2-4-31 0,4 1 23 16,-2 1-13-16,0 1 3 0,1-1 8 0,0 0 3 15,-2 1-28-15,1-2 17 0,0 1 6 16,0 0 5-16,2 1-14 0,-4-1-7 0,3 1 14 16,-1-3 18-16,0 3-15 0,0 0-21 15,2-3 18-15,-3 2 4 0,1 0-13 0,0 0 18 16,0 1-5-16,-1-1-2 0,0-1 7 0,2 0-25 15,-1 1 14-15,0-2 3 0,-2 4-10 16,2-5 16-16,2 5-6 0,-4-2 3 0,3-1-2 16,-2 2 4-16,0-2-1 0,3 0-2 0,-4 0-16 15,0 1 21-15,4 0-13 0,-2 0 9 0,-1-1-13 16,1 2 12-16,-1-3 1 0,0 2 7 16,3 2-22-16,-4-3 10 0,4 3-2 0,-3-1 1 15,3-3-4-15,-2 4-1 0,0-1 9 16,1-1-18-16,-2-2 5 0,2 5 16 0,-1-4-8 15,1 3 1-15,-3-4 15 0,3 2-25 0,-1 0 27 16,-1 1-17-16,1 1 8 0,0-2-8 0,0-1-3 16,1 3 1-16,-2-1 4 0,3-1-16 15,-3 1 21-15,1 0-3 0,0 0 7 0,-2 1-12 16,3-1 2-16,-1 1-15 0,1-3 22 0,-1 4 6 16,-1-4 0-16,1 3-18 0,0-1 10 15,-2 0-2-15,4 1-3 0,-3-3 2 0,3 4-18 16,-4-2 13-16,0 2-1 0,4-3 4 0,-2 3-10 15,-1-5-10-15,0 4 35 0,0-1-15 16,0-1 7-16,-1 1-16 0,4-1 24 0,-3 1-30 16,0 2 28-16,-1-2-9 0,0 0-27 15,3 1 12-15,-3-2 10 0,2 0 6 0,-2 4-4 16,0-1 1-16,0-2 10 0,3-2-6 16,-3 2 1-16,1-1-7 0,-1-3-2 0,0 0 6 15,0 0 4-15,0 7-9 0,0-7 4 0,0 8 8 16,0-8-6-16,0 0-16 0,0 6 6 15,0-6 7-15,0 0 4 0,0 8-15 0,0-8 10 16,0 8-3-16,0-8-4 0,0 0 6 16,0 6 8-16,0-6 5 0,7 0-11 0,1 16-6 15,-6-13 14-15,-2 0-1 0,2 0-11 0,-2-1 6 16,1 1-19-16,-1 1 6 0,1 0 10 16,2-2-11-16,-1 2 6 0,-2-3 6 0,0 1 3 15,2 1-6-15,-1-1-17 0,-1 1 44 0,2-1-24 16,-2 1-3-16,3-1-3 0,-2 0 1 0,0-2 8 15,-1 0-17-15,0 0 13 0,0 0 4 16,0 0 6-16,0 0-23 0,0 0 28 0,0 0-22 16,0 0 6-16,9 15-3 0,-6-13 9 0,-2-1-12 15,0 1 26-15,-1-1-13 0,2-1 5 16,0 2-5-16,0 1-7 0,-2-2 7 0,0 0-19 16,2-1 27-16,1 3-19 0,-3-1 6 0,0 0 11 15,3 0-1-15,-2 0-28 0,2-1 24 16,-3 0-4-16,3 1-12 0,-3 1 2 15,0-2 12-15,2 0 0 0,-2-1-1 0,0 0 6 16,1 2-13-16,-1-1-14 0,0 2 27 0,4-1-2 16,-4-1-14-16,1 0-14 0,0 1 26 0,-1 1-13 15,3-2-1-15,-1 1 20 0,-1 0-16 16,2 1 13-16,-1 2 8 0,1-4-7 0,-2 0-15 16,-1 4 10-16,4-4-15 0,-2 2 5 0,0-2-10 15,-1 3 22-15,-1-2-15 0,4-2 4 16,-3 2 9-16,-1 0-12 0,0-1-4 0,4 1 6 15,-4 0-5-15,2 0 16 0,-2-1 1 0,0 1-16 16,2 1 14-16,-2-1-19 0,0 1 5 16,1-3 8-16,1 1 3 0,-2 3 2 0,3-2-12 15,-2 0 6-15,-1-1-8 0,2 2 18 16,-2-1-11-16,0-2-8 0,0 0 5 0,0 0 0 16,0 0 11-16,0 0-23 0,0 8 29 0,0-8-16 15,0 6 6-15,0-6-3 0,0 0 3 16,0 9-8-16,0-9 8 0,0 8 5 0,0-8 7 15,0 6 13-15,0-6-27 0,0 0-18 0,0 6 18 16,0-6 13-16,0 9-15 0,0-9 13 0,0 0 2 16,0 0 2-16,0 7-26 0,0-7-2 15,0 0 12-15,0 0 17 0,0 8-17 16,0-8-7-16,0 0 1 0,0 0 1 0,0 5 7 16,0-5 7-16,0 0 4 0,0 0-1 0,0 8-8 15,0-8 7-15,0 0-9 0,0 0-3 16,0 7 14-16,0-7-2 0,0 0-19 0,0 0-6 15,0 9 10-15,0-9 2 0,0 0-7 16,0 0 10-16,0 0 0 0,0 6 11 0,0-6-27 16,0 0 19-16,0 0 11 0,0 0-24 0,0 7 24 15,0-7-6-15,0 0 11 0,0 0-15 0,0 7 14 16,0-7-19-16,0 0 10 0,0 0 7 16,0 0-25-16,0 8 15 0,0-8 13 15,0 0-31-15,7 13 10 0,-5-11-5 0,-2-1 12 0,2 1 12 16,-2 0-26-16,2 1 2 0,-2-1 1 15,0-1 9-15,5-1-4 0,-4 3 12 0,1-2-18 16,-2 3 25-16,1-1-18 0,1-2-4 16,0 1-5-16,-1 3-4 0,0-3 11 0,3-1 17 15,-3 4 13-15,0-3-32 0,2 0 4 0,-3-1-1 16,1 0-7-16,2 3 22 0,-1-2-4 16,-2 0-9-16,3-1 24 0,-2 1-8 0,0-2-12 15,-1 3-9-15,4-2 8 0,-2 0 7 0,0 2-3 16,1-3-5-16,-3 2 11 0,3 1-20 15,-1 0 29-15,-2-3-27 0,3 2 9 0,-2 0 6 16,2 2 11-16,-1-3-30 0,1 0-6 16,-1 1 10-16,0 3-8 0,1-5 1 0,-2 1 30 15,4 1-1-15,-3 2-23 0,0 0-13 16,1-3 12-16,2 2 16 0,-3 0-16 0,2-1 15 16,0-2 9-16,-2 5-32 0,0-2 18 0,0-1-9 15,3-2-9-15,0 3 3 16,-5 3 2-16,5-5 3 0,-1 3 1 0,1 1 7 15,-3-2-2-15,2 2-5 0,0-3 6 0,7 8 1 16,-6-2 3-16,0-2 24 0,0-1-21 16,0 0-14-16,-1 0-1 0,-3-3 1 0,4 3-9 15,-2-3 13-15,-1-1-11 0,2 6 11 16,-1-5-5-16,0-1 10 0,0 2 4 0,-1 1 22 16,-1-2-43-16,2-1 23 0,-3 1 15 0,2 2-30 15,1-3-9-15,0 2 23 0,-2-3-11 0,1 4 17 16,1-2-17-16,-1-2 10 0,0 2 15 15,1 0-17-15,-1 2-9 0,0-1 8 0,0-1-11 16,1 1 11-16,-3-1-11 0,4 2 0 16,-2-1 28-16,1 0-15 0,-1 0-25 0,1-1 6 15,-1 1 29-15,1 1-26 0,1-2 4 0,-2 2 1 16,3 0 33-16,-2-1-19 0,-1 0-11 16,2-1 20-16,-2 0-32 0,1 3 1 0,-1-5 3 15,1 4-9-15,-1 2 14 0,3-2-13 16,-3 0 11-16,0-2 28 0,1 2-11 0,-1 0-8 15,1-1 23-15,-2 2-32 0,1-3-11 16,1 1 15-16,1 2-1 0,-2-3-5 0,2 1 25 16,-2 1-6-16,0-3 13 0,0 4-26 15,0-3-11-15,-1 0 16 0,1-1-15 0,1 1 2 16,-3 1 0-16,2 0 7 0,-2-2 15 0,4 2 3 16,-3-2-2-16,3 2-10 0,-2 0-7 15,-2-3 17-15,2 3-26 0,-1-2 26 16,0 2-13-16,2 0 5 0,-1-3-9 0,0 1-13 15,-1 3 13-15,2-2 3 0,1 1 6 16,-2-2 7-16,-2-1-13 0,3 3-11 0,-3-1 28 16,0-1-27-16,2 1 9 0,0 2 3 0,0-3 20 15,0 1-34-15,-2 1 4 0,2-3 16 16,-2 2 0-16,3 0 6 0,-3 1 0 0,2-2-8 16,2 0 13-16,-4 0-33 0,3-1 10 15,-2 4-5-15,0-1 5 0,-1-2-6 0,4-1 14 16,-2 2 0-16,0-1 21 0,-1 4-19 15,1-4-11-15,1-1-1 0,-2 1-3 0,1 0 17 16,0 3 4-16,0-3-16 0,0 2-14 0,0-2 35 16,1-1-29-16,-1 1 10 0,0 2 10 0,1 0-17 15,-2-2 14-15,4 0-3 0,-3 2 7 16,0 1 1-16,-2-3-21 0,3 0 11 0,0 1 8 16,-1-1 7-16,2 3-20 0,-3-3 29 15,1 0-31-15,2 0 5 0,-3 1-1 0,3 0 2 16,-2 3 17-16,2-5-6 0,0 1-22 0,-1 1 37 15,0 1-37-15,2 0 1 0,-1-2 20 16,1 1-16-16,-2 2 25 0,1-1-9 0,-1-2-10 16,0 1 23-16,3-2-38 0,-1 4 4 0,-1-1 8 15,-1 0 14-15,1 1 10 0,2-2-12 16,-2-2-15-16,1 2 29 0,0 0-9 0,-1 3-28 16,0-5 16-16,-1 1 5 0,1 1 2 0,0-1-25 15,-1 2 7-15,0 0 31 0,0-2-12 0,1 1-30 16,-1-2 22-16,3 4 4 0,-4-4-19 15,2 3 23-15,-2-2-25 0,2 1 42 0,-2-1-30 16,3 2-7-16,-2-1 13 0,-1 0 1 0,2-2 8 16,0 4-2-16,0-4-11 0,-2 0 27 15,3 2-12-15,-2 0-26 0,0-2 26 16,1 0 8-16,-1 2-20 0,0-1-14 0,1 1 21 16,-1-1-10-16,-1 1 26 0,3 0-29 15,-1 0 18-15,0 0-30 0,1-1 4 0,-2 2-12 16,1-1 48-16,-1-2-36 0,2 2 21 15,-1 1-14-15,1 0-9 0,-1-1 14 0,0 1-2 16,1-1-14-16,-3 1 13 0,2-2-1 16,0 3 6-16,0-3 11 0,-3 1-17 0,5-2 19 15,-3 3-18-15,1 1 6 0,0-2-16 16,-2-1 17-16,1 0-2 0,-1 1-12 0,2 0 8 16,0-1 2-16,-1 2 10 0,3-2-5 0,-4 1 26 15,0 2-46-15,0-3 19 0,0 1 16 0,2 1-32 16,-1-2 11-16,-1 2 2 0,2-2 10 15,-1 1 1-15,-1-1 0 0,3 1-18 0,-4-1 28 16,1 2 2-16,0-3-34 0,0 1 4 0,1 1 2 16,-3 0 0-16,2 0 21 0,1 1-8 15,-2-3 13-15,2 1-6 0,-1 1-18 0,2-1 7 16,-3 1-2-16,0 1 13 0,3-2-5 16,-1 0-29-16,-2 0 39 0,1 2-3 0,-2 1-32 15,3-3 5-15,1 2-1 0,-3-2 26 0,1 0-24 16,-2 3 1-16,4-4-6 0,-1 3 7 15,-2-1 12-15,2 2-3 0,1-3 13 0,-4 4-19 16,3-2 25-16,0-1-23 0,-1-2 4 0,0 4 15 16,1-2-24-16,1 2 3 0,-4-4-6 15,3 4-5-15,-1-2 20 0,0 1-7 0,1-3-11 16,-2 5 26-16,1-3-17 0,-2 0-2 16,3 1 1-16,-2 1 4 0,1-3 11 15,1 1 15-15,-3 0-32 0,4 1 27 0,-2-1-23 0,1 2 25 16,0-2-7-16,-3 2 10 0,1-3-33 15,2 1 25-15,-1 3-29 0,0-2-2 0,0-1 22 16,0 1-10-16,-1 0 22 0,-1-1-16 16,3 1 4-16,-1 1-25 0,0-3 1 0,-1 1 6 15,1 1 17-15,1 0 13 0,-2 1 2 0,0-1-26 16,2 0-17-16,-1 1 15 0,-1 1 27 16,1-5-10-16,0 3-8 0,-2 0 18 0,4 1-35 15,-2-2 12-15,-2 2-7 0,2-1 16 0,0 0-2 16,0 0 17-16,1 1-30 0,0-1 26 15,-1 0-14-15,-2 1-24 0,4-1 13 0,-1 0-4 16,-2 0 0-16,1 1 10 0,1-1 1 16,-2 0-14-16,-1 1 26 0,6-1-18 0,-4 0 13 15,-1-1-13-15,1 2-1 0,1-2 29 16,1-1-29-16,-4 0 1 0,2 3-6 0,-1-2 14 16,2 1 23-16,1-2-31 0,-4 5-1 15,2-4 9-15,-2-1 26 0,3 1-16 0,-2 1 10 16,2-1-34-16,-3-1 34 0,2 1-33 0,0 2 1 15,-2-2 9-15,2-1 20 0,0 2-36 16,1-1 14-16,-1 2 20 0,0-1-25 0,-2-2 27 16,1 3-20-16,1-4 1 0,1 3 17 15,-2-2-27-15,-1 1 0 0,3 0 13 0,-3-1 26 16,1 2-39-16,0-2 8 0,0-1 15 0,1 2-22 16,1 1-1-16,-1-3 9 0,-2 1 2 15,1 1 21-15,0-1-33 0,1 0 22 0,-2-1 10 16,4 2-32-16,-2 0 0 0,-1-1 15 15,-1 0 4-15,0 1 15 0,3-2-43 0,-3 2 34 16,2 0 8-16,-1-1-34 0,3 4 4 0,-4-5 7 16,4 1-9-16,-4 0 26 0,0-1-4 15,0 2-14-15,3-1-16 0,-1 2 12 0,-2-1-7 16,2-1 14-16,1-1-6 0,-3 1-2 0,2 1 5 16,2 0 14-16,-4 0-11 0,4-1 15 15,-1 1-14-15,-3-1-2 0,4 2 23 0,-2-1-31 16,0-1 7-16,0 0 7 0,-2 1-7 0,0 0 0 15,4-2 2-15,-3 4 15 0,1-3 0 16,-1 0-17-16,2 3-7 0,-1-2 7 0,-1 0 1 16,0-2-1-16,2 3 1 0,0-1 15 0,-3-1 7 15,2 3-8-15,-1-3-6 0,3-1-18 16,-1 2 0-16,-1 0 3 0,-2 1 19 0,2-1-26 16,2 0 28-16,0-1 6 0,-2 2-20 15,1-1 23-15,0 0-15 0,-2 1-19 0,3-1 2 16,-1 1 28-16,1-2-35 0,-1 2 24 0,-2-2-5 15,1 2 5-15,2 1-19 0,1-3 8 16,-4 0-4-16,-1 2-3 0,3-2 4 16,1 0 5-16,-4 2 30 0,1-2-40 0,1-1 18 15,0 1-1-15,3 2-5 0,-4-2-9 0,2 2 38 16,0-3-32-16,-2 0 6 0,2 1 17 16,-2 0-16-16,1-1-4 0,-2 0-10 15,2 0-7-15,-2 4 6 0,4-3 11 0,1 2-7 16,-5-3 3-16,0 1 6 0,0 0 15 0,2 0-1 15,3 2 14-15,-1-2-37 0,-1 2 13 16,2-3-23-16,-2 2 8 0,1 0 4 0,2-1 1 16,-3-1 2-16,0 3 11 0,1-3-11 0,0 2-4 15,-2 0-3-15,4 0 9 16,-1-1 9-16,1 4 1 0,-2-4-19 0,-1 0 7 16,1 1-8-16,0-1 6 0,-2 2 18 0,5-2-22 15,-5-1 0-15,3 1 7 0,-2 3 0 0,2-4 31 16,-1 0-38-16,1 2-4 0,-1 1 8 15,3-2 5-15,-5 0-11 0,2 0 27 0,0 1 17 16,-2-2-34-16,-1 3 24 0,5-2-35 16,-1 0 6-16,-3-1 4 0,2 1-13 0,-2-1 32 15,1 2 12-15,-1-2-32 0,5 3 25 0,-5-3-15 16,-1 1-3-16,-1-1-15 0,0 0-2 16,0 0 38-16,0 0-33 0,9 0 19 15,-9 0-32-15,8 0 7 0,-8 0 10 0,0 0-4 16,8 0 19-16,-8 0-11 0,0 0-4 0,9 0-4 15,-9 0-9-15,0 0 12 0,9 6 1 16,-9-6-7-16,7 0 7 0,-7 0-3 0,0 0 6 16,7 0-2-16,-7 0 31 0,15 15-38 0,-11-15 0 15,-4 0 29-15,0 0-28 0,0 0 22 16,0 0-25-16,9 0 30 0,-9 0 3 0,0 0-39 16,6 0 18-16,-6 0-3 0,8 0-6 0,-8 0 7 15,0 0 0-15,14 12 2 0,-10-12 22 16,-4 1-35-16,4-1 11 0,-2 0-6 0,1 0-6 15,-1 3 12-15,1-3 2 0,-2 1 8 0,1-1 7 16,-2 2 3-16,4 0-22 0,-1-2-5 16,-1 0 12-16,1 0-8 0,-2 0-2 0,3 0 35 15,-3 1-16-15,-1-1-17 0,0 0 14 0,0 0-20 16,0 0-5-16,0 0 12 0,0 0 16 16,9 0 11-16,-9 0-26 0,0 0-10 0,7 0 21 15,-7 0-20-15,8 0 5 0,-8 0-3 16,0 0 3-16,0 0 33 0,17 10-34 0,-14-8 4 15,-2-2-6-15,2 2 24 0,3-2-4 16,-5 0-5-16,3 0-18 0,1 3 42 16,-1-1-39-16,-1-2 13 0,1 0-13 0,1 1 20 0,-2 1-16 15,2 0-6-15,-3-1 24 0,3 1-10 16,-1-1-12-16,-4-1 33 0,0 0-33 0,0 0 11 16,0 0-1-16,10 0-2 0,-10 0 29 0,0 0-34 15,6 0 4-15,-6 0-10 0,0 0 24 16,8 0-21-16,2 12 8 0,-10-12 1 0,0 0-5 15,0 0-8-15,0 0 16 0,0 0 11 16,7 0-11-16,-7 0-7 0,0 0 5 0,7 0-2 16,-7 0 25-16,0 0-16 0,8 0-7 0,-8 0 4 15,0 0 25-15,7 0-4 0,-7 0-33 16,0 0 2-16,8 0-1 0,-8 0 9 0,7 0-4 16,-7 0 17-16,0 0-17 0,0 0 19 0,8 0-2 15,-8 0 0-15,16-10 3 0,-14 10-33 16,-1-2 3-16,2 2 5 0,-1-1 17 0,1-1-28 15,-3 2 24-15,2-1-16 0,0-1-2 0,1 0 5 16,0 1-7-16,-2-1 9 0,3 0 9 16,-2 1-16-16,2-1 9 0,-3 2-12 0,2-3 41 15,-1 3-33-15,1 0 7 0,-1-2-11 16,1 2 30-16,-1-2 9 0,2 2-33 0,-2-3 9 16,-2 3 11-16,0 0-30 0,0 0 6 0,7 0 14 15,-7 0 12-15,0 0-28 0,7 0 4 16,-7 0 20-16,9 0-27 0,-9 0 5 0,7 0-6 15,-7 0 3-15,7 0 3 0,7-11 8 16,-11 11 6-16,1-1 6 0,-1 1-22 16,3-1 7-16,-2 1 5 0,-4 0 9 0,0 0-12 15,0 0 0-15,0 0 21 0,0 0-31 0,7 0 7 16,-7 0 2-16,9 0 7 0,-9 0-14 16,0 0 4-16,7 0-2 0,-7 0 1 0,7 0 15 15,-7 0-9-15,7 0 26 0,-7 0-23 16,8 0-15-16,-8 0 10 0,7 0 3 0,-7 0 19 15,8 0-30-15,-8 0 6 0,7 0 9 16,-7 0 5-16,9 0-19 0,-9 0-5 0,19-11-9 16,-15 10 32-16,1-1-15 0,0 0-8 0,0 2 32 15,0-2-28-15,-3 1 6 0,4 0 14 16,-1 1-17-16,0-2-7 0,-1 0 8 0,-1 0-1 16,2 2 28-16,0 0-31 0,-3 0 19 15,0 0-17-15,-2 0 30 0,0 0-22 0,0 0-24 16,9 0 14-16,-9 0-2 0,0 0 4 0,7 0 26 15,-7 0-6-15,0 0-1 0,10 0-18 16,-10 0-7-16,7 0 34 0,-7 0-13 16,8 0-18-16,-8 0-4 0,8 0 9 0,-8 0-9 15,8 0 6-15,-8 0 15 0,15 14-21 0,-11-11 1 16,0 1 10-16,1-1-5 0,-3-1 27 0,11 8-34 16,-3-4 10-16,-3-1 23 0,0 0-19 15,-1 0-1-15,1 0 0 0,-4-2-13 0,1-1 6 16,-3 2 26-16,4 0-21 0,-3-2-3 15,3 0 10-15,-2 3-7 0,2-3 12 0,-4-1-13 16,0 3 1-16,2 0 20 0,2-1-9 16,-3-2-17-16,1 3 32 0,-3-3-32 0,2 2 31 0,1 1-27 15,-1-1-5-15,0-1 21 0,0 1-4 16,2-2-8-16,-4 3 1 0,2-4-6 0,0 2 4 16,-1-1 9-16,4 2 15 0,-4 1-11 15,2-4 10-15,-2 2-4 0,3 2-24 0,-2-2 15 16,-2-2-12-16,3 1 7 0,-1 2-6 15,1-2-7-15,-2 2 21 0,2 0-16 0,-2-1 12 16,1-1-17-16,1 3-2 0,-1-1 3 16,0-2 19-16,0 1-14 0,2 1-6 0,-3 1 17 15,0-4-8-15,2 0-2 0,-1 0-9 0,1 1 1 16,-3 0 22-16,2-1-11 0,1 0-5 0,-3 2-3 16,1 3 15-16,3-5-2 0,-4 0 8 15,0 0-9-15,2 0-5 0,-2 0 1 0,0 0 18 16,0 0-26-16,0 0 8 0,0 0 20 15,0 0-22-15,0 0 21 0,0 0-22 0,13 9 7 16,-13-8-4-16,1-1-14 0,0 0 14 0,2 5 13 16,-3-5-27-16,3 2 26 0,-1-2-11 15,-1 2-3-15,-1-1 22 0,2-1-37 16,0 0 18-16,0 2 1 0,-2-2-11 0,2 3 12 16,-1-3-9-16,1 0 20 0,-2 2-18 0,2 0 10 15,-1-2-15-15,-1 0-1 0,2 1 29 16,0 1-21-16,0 0-9 0,-1 1 24 0,2-1-3 15,-1-1-11-15,1 5-1 0,-3-3-3 0,1 1-7 16,2-1 26-16,-3 0-2 0,2 0-24 16,0 1 32-16,0-2-29 0,-2 4 29 0,4-3-4 15,-4 4-20-15,3-5 5 0,0 4 10 0,-2-2 1 16,0-2 0-16,1 4-7 0,1-2 4 16,0 1-3-16,-3-3-6 0,1 1 5 0,2 1 11 15,-3-1-27-15,1 0 9 0,0 0-10 16,3 0 23-16,-3-2-15 0,2 1 2 15,-3 2 25-15,3-4-21 0,-1 1-5 0,-1 0-4 16,0 1 17-16,2 0 9 0,-3 2-9 0,3-4-13 16,-1 3-4-16,-1-1 4 0,2-1 7 15,-1 1 16-15,-1-2-3 0,2 2 5 16,-1-2-21-16,3 1-6 0,-5 1 6 0,0 0 0 16,4-1 4-16,-4 2 10 0,1-3 1 0,3 0-7 15,-3 0-12-15,2 2 19 0,-2 0-32 16,0 0 19-16,-1-2 2 0,4 1 13 0,-3 1-24 15,3-2-2-15,-2 1 20 0,0-1-18 0,0 4 9 16,2-3-4-16,-3 0-3 0,3 0 14 16,-3-1 8-16,3 2-19 0,-3-2-9 0,2 0 21 15,-1 1 3-15,2 1-6 0,0 0-16 16,-4-2 6-16,3 2-8 0,1-1 8 0,-4-1-2 16,4 0 15-16,-3 2 3 0,3-2-17 15,-3 1 19-15,4-1-25 0,-5 2 2 0,4 0 11 0,-1-2-15 16,-1 2 9-16,2-1 17 0,-2-1-21 15,2 2 22-15,-1-1-9 0,-1 1-15 16,1 1 17-16,0-1-24 0,0 1 31 0,1 0-5 16,2 0-8-16,-3 0-20 0,1 1 19 0,1-2 11 15,-2 3-24-15,2-1-2 0,0-1 29 16,1 2-13-16,-2-3-6 0,1 3 17 0,-3 0-23 16,2-2 14-16,0 2-6 0,1-3 13 15,-1 1 0-15,-1 1-10 0,0-1-1 0,2-2-1 16,-4 5-15-16,2-4 16 0,1 0-6 0,-2 2 15 15,2 0 4-15,1-3-18 0,-5 5-8 16,3-5 21-16,1 1-15 0,1 2 5 16,-4-1 16-16,1-1-22 0,2 0 2 0,-1 3 5 15,0-4 0-15,-2 3-15 0,4 1 20 0,-4-3-2 16,2 0 4-16,2 4-11 0,-3-3 6 16,2 1 19-16,-1-1-12 0,3 0 12 0,-1 3-27 15,-3-4-8-15,3 4 21 0,-2-2 6 16,2 0-6-16,0 0-22 0,-3-1 9 15,3 2 9-15,-1-2-1 0,0 4-3 0,0-5 9 16,-1 2-4-16,0 0-12 0,2-2 31 0,-1 3-41 16,-1-2 18-16,1-2-4 0,-1 4 25 0,3-1-12 15,-2-1-16-15,0 0 5 0,-1-1 17 16,1 2-4-16,0 0-2 0,1-3 0 0,-1 2-23 16,-1 2 12-16,2-2 10 0,-2-2 10 15,3 0-2-15,-3 2-17 0,1 0 5 0,-2-1-2 16,3 0-10-16,-2 2 28 0,0-3-14 15,1 0 14-15,0 2-15 0,-1 1-13 0,1-2 25 0,0 1-11 16,-2-2 10-16,1 2-11 0,1-2-4 16,0 1 14-16,-3-1-17 0,5 1 15 0,-3-2-12 15,1 4-1-15,-1-3-11 0,0 0 19 16,2-1-3-16,-2 2 20 0,0 0-29 0,3 1 10 16,-3-2 11-16,-2-1-13 0,3 0-3 0,-1 1 8 15,0-1-5-15,-1 0 23 0,1 0-8 16,-1 0-12-16,-2 0 10 0,0 0-13 0,0 0-4 15,0 0 17-15,0 0 10 0,8 0-2 0,-8 0-12 16,0 0-18-16,0 0 30 0,0 0-8 16,0 0-16-16,6 0-10 0,-6 0 23 0,0 0 12 15,0 0-36-15,0 0 19 0,0 0-7 16,10 0-13-16,-10 0 23 0,0 0-17 0,5 0-9 16,-5 0 39-16,0 0-36 0,13 11 4 0,-8-9 11 15,-4-1 7-15,2 1-4 0,-1 0-17 16,0 0-2-16,1-1-5 0,-2 0 23 0,1 3-9 15,0-2 4-15,3-2 20 0,-1 3-9 0,-2-1-23 16,1 1 2-16,-1-1 2 0,2 4 21 16,0-3-31-16,2-3 36 0,-5 6-26 0,3-3 7 15,2 1 2-15,-3 0-2 0,7 8-21 16,4-2 10-16,-3 0 10 0,-5-3-1 0,-2 1-1 16,1-3-7-16,0-1 12 0,1 0-13 15,-5-2 11-15,4 2-4 0,-2-2 32 0,-2 1-7 16,4 1-22-16,-2-3 8 0,-3 0 17 15,5 0-22-15,-4 1-8 0,3-1 2 0,-3 1 23 16,2 0-11-16,-1-2-4 0,-2 2 7 0,2-1 6 16,1-1-1-16,-3 0-13 0,0 0-9 15,0 0 2-15,0 0 3 0,0 0 0 0,0 0 5 16,0 0-2-16,0 0 31 0,0 0-24 16,8 0 7-16,-8 0-5 0,0 0 7 0,0 0-23 15,0 0 35-15,0 0-42 0,0 0 6 0,6 0 6 16,-6 0 10-16,0 0-22 0,9 0 28 15,1-10-19-15,-9 9 32 0,3-1-32 0,-2-2 10 16,2 1 10-16,1 1-11 0,0 1-20 0,-1-4 31 16,-1 2-7-16,1-2 12 0,1 3-33 15,0-1 9-15,-1 0 13 0,1-1 10 0,-1 1-13 16,-2 0-15-16,4 1 18 0,-2-1-9 16,1 0-11-16,-1-1 6 0,2 4 10 0,-2-2 8 15,0-3-9-15,2 4-18 0,-2 0 36 16,0 0-6-16,-1-2-32 0,2 2 12 0,-1-3 1 15,-1 4 12-15,-1-1-24 0,3 1 12 0,0-1 15 16,-1 1-30-16,0-2 5 0,-2 1 14 0,3-2-11 16,-3 1-4-16,0 1 28 15,-2 1-30-15,5-1 43 0,-4 1-29 0,2-3-6 16,2 3 19-16,-3-2-20 0,2 1-2 0,0-2 11 16,-2 3 4-16,-2 0-11 0,2 0 24 15,3 0-20-15,-3-1 14 0,-1 1-14 0,2-2 9 16,1 2-10-16,-1 0-11 0,-3-3 4 0,4 3 28 15,-4 0 15-15,0 0-18 0,0 0-25 0,0 0 16 16,0 0-12-16,0 0-10 0,8 0 28 16,-8 0-28-16,0 0 15 0,6 0 7 0,-6 0-12 15,0 0 25-15,9 0-19 0,-9 0-14 0,0 0 32 16,8 0-8-16,-8 0-11 0,7 0-14 16,-7 0 8-16,0 0 17 0,10 0-8 0,1-13-8 15,-6 13 21-15,-3-2-28 0,1 0 16 16,3 0 7-16,-5 1-13 0,2 1 3 0,2-1 6 15,-3 1 9-15,1 0 11 0,-1-2 7 0,2 2-38 16,-2-2 35-16,0 2-34 0,1 0-3 0,-2-2 9 16,-1 2 10-16,0 0 8 0,0 0-8 15,0 0-16-15,0 0-6 0,10 0 29 0,-10 0-11 16,0 0-17-16,0 0 19 0,6 0 7 0,-6 0 10 16,0 0-33-16,13-11-6 0,-11 11 14 15,1-2-10-15,-3 2 3 0,0 0 34 0,0 0-1 16,0 0-34-16,0 0-15 0,0 0 24 0,0 0 20 15,0 0-15-15,0 0-24 0,7 0 4 16,-7 0 44-16,0 0-49 0,0 0 42 16,9 0-40-16,-9 0 3 0,0 0 28 0,5-8-34 15,-5 8 18-15,15-8 15 0,-12 6-12 0,-1 1-8 16,2 1-12-16,-2 0 6 0,0 0 15 0,0-2-11 16,2 0-4-16,-2 0 26 0,3 1-22 15,-2-1 7-15,-2 2 11 0,2-1-3 0,-1-1 28 16,3 1-43-16,-2-2 5 0,-1 2 20 15,0-1-8-15,1 1-28 0,0 0 44 0,0-3-20 16,1 4-13-16,-3-2 14 0,3 0 7 0,-1 2-32 16,-1-1 15-16,1 1 8 0,-1-2 16 0,2 1-1 15,-3-1-33-15,3 2 17 0,-2-1 10 16,3 0-17-16,-3 1 4 0,0-2 11 0,1 1-38 16,-1 1 31-16,2 0-15 0,1-2-1 15,1 1-2-15,-3-1 16 0,2 2 0 0,-3-1-9 16,3-1 29-16,-2 2-16 0,0 0-16 0,4-1-8 15,-5 0 26-15,2 1 1 0,1 0-19 0,0-2 18 16,-3 1-22-16,1 1-5 0,2-2 13 16,1 2-1-16,1 0 10 0,-1 0-14 0,-4 0 23 15,0 0-18-15,-2 0 5 0,0 0-16 16,0 0 18-16,7 0 2 0,-7 0-11 0,8 0 28 16,-8 0-23-16,0 0-6 0,10 0-2 0,-10 0 26 15,7 0-19-15,-7 0 32 0,0 0-37 16,8 0 0-16,-8 0 26 0,0 0-12 0,6 0-15 15,-6 0 25-15,0 0-9 0,9 0-15 0,-9 0 21 16,0 0-13-16,0 0-16 0,6 0 27 16,-6 0 3-16,0 0-19 0,0 0-6 0,0 0-4 15,9 0 15-15,-9-7 8 0,0 7 6 16,15-10-31-16,-14 7 18 0,0 3-7 0,2 0 3 16,-3 0-6-16,1-2 21 0,0 1-24 15,2-1 38-15,-2 0-8 0,-1 2-16 0,4-2 26 16,-2 1-39-16,-2 1 3 0,0 0 22 0,0 0-19 15,3 0 18-15,-2 0-22 0,-1 0 3 16,3 0 3-16,-1 0 9 0,-2-4 10 0,3 4 12 16,-1-2-22-16,-2 1 7 0,4 1-6 15,-3 0-25-15,1 0 6 0,-2 0 4 0,0 0-6 16,0 0 10-16,0 0 3 0,0 0-10 0,0 0 25 16,8 0-30-16,-8 0 20 0,0 0-8 0,0 0 14 15,8 0 1-15,-8 0-13 0,9 0-9 16,-9 0 32-16,8 0-20 0,-8 0-2 0,7 0 24 15,-7 0-5-15,8 0-18 0,-8 0-13 16,9 0-1-16,-9 0 12 0,8 0 2 0,-8 0-4 16,7 0 23-16,7-15-18 0,-13 15 12 0,4 0-17 15,-4 0-3-15,4-2 21 0,-1 2-4 16,-4 0 14-16,0 0 7 0,0 0-41 0,0 0 19 16,0 0 3-16,8 0-32 0,-8 0 29 15,7 0-4-15,-7 0 8 0,0 0-27 0,7 0 3 16,-7 0 22-16,0 0-24 0,0 0 0 0,7 0 30 15,-7 0-6-15,6 0 17 0,-6 0-33 0,10 0 6 16,-10 0-11-16,7 0-3 0,-7 0 16 16,0 0-1-16,7 0 19 0,-7 0-1 0,9 0 3 15,-9 0-29-15,7-6-5 0,-7 6 32 0,12-9-15 16,-10 9-12-16,2-1 11 0,-2 1 22 16,2 0-46-16,-3-4 14 0,2 2-3 0,-1 2 25 15,1 0-4-15,0 0-17 0,-1 0 4 0,-2 0 27 16,5-2-8-16,-3 2-27 0,1-1 14 15,0 1-7-15,0-4 12 0,1 3 7 0,-2 0-25 16,0 1 36-16,0-1-36 0,3 0 14 16,-2 1 8-16,0-3-30 0,0 0 10 0,1 2 1 15,-2 1-2-15,2-1 10 0,-2 1-7 16,2-1 2-16,0 1-8 0,-1 0-1 0,-1 0 47 16,5-1-36-16,-4 1-2 0,2-2 26 0,-3 2-30 15,2-3 4-15,0 1 17 0,-1 2 1 0,0-1 19 16,1-1-48-16,0 2 2 0,-2 0 33 0,1 0-19 15,-1 0-11-15,-1 0-5 0,3 0 30 16,-2-1-31-16,0 1 4 0,-2 0 27 0,4-3-25 16,-2 2 8-16,-2 1-7 0,0 0-6 15,0 0 41-15,0 0-38 0,8 0-10 0,-8 0 5 16,7 0 0-16,-7 0 3 0,8 0 11 16,-8 0 1-16,9 0-3 0,-9 0 13 0,7 0-12 15,-7 0 1-15,8 0 21 0,-8 0-29 0,9 0 6 16,-1 0 38-16,-8 0-44 0,9 0 4 15,-9 0 22-15,6 0-6 0,-6 0-4 0,9 0-15 16,-9 0 1-16,8 0-7 0,-8 0 39 16,8 0 6-16,-8 0-30 0,0 0-13 0,7 0 21 15,-7 0-24-15,7 0 35 0,-7 0-20 16,0 0-9-16,9 0-9 0,-9 0 46 0,7 0 2 16,-7 0-42-16,0 0 39 0,8 0-34 0,-8 0-8 15,9 0 5-15,-9 0 17 0,7 0 14 16,-7 0 4-16,7 0-23 0,-7 0-20 0,8 0 3 15,-8 0-6-15,0 0 26 0,8 0-17 16,0 0-5-16,-8 0 5 0,7 0 7 0,-7-5 16 16,7 5-29-16,-7 0 2 0,9 0 17 0,-3 0 2 15,-6 0 17-15,9 0 8 0,1 0-34 16,-5 0-6-16,-5 0 13 0,11 0-15 0,-2-8 4 16,-1 8 19-16,0 0 3 0,19-16-10 0,-11 16 0 15,3-4-16-15,-5 4 5 0,4-6-4 16,2 5 24-16,-3-2 10 0,0-4-37 0,-2 0 28 15,3 3-25-15,-4 0-2 0,-1 2 2 16,0 0 3-16,-3 1-1 0,10 0 29 0,-1-3-3 16,-3 0-20-16,0 3-4 0,-1-6 0 0,0 5 6 15,-3 1 17-15,-1-3-2 0,-1 1-17 16,-2 1 2-16,1 2-8 0,2 0 3 16,-11 0 3-16,5 0 6 0,-5 0-9 0,10 0-8 15,1 0 30-15,-4 0-25 0,0 0 12 0,-7 0-10 16,7 0 7-16,3 0 5 0,-10 0-6 15,7 0 11-15,-7 0 5 0,7 0-15 0,-7 0-5 16,9 0 34-16,-9 0-10 0,7 0-18 0,-7 0 27 16,0 0-29-16,9 0 11 0,-9 0-13 15,0 0-6-15,6 0-6 0,-6 0 13 0,0 0 11 16,10 0-20-16,-10 0 24 0,5 0-11 16,-5 0 21-16,14 14-28 0,-10-11-5 0,-2-1 20 15,1-1-7-15,1 3 19 0,-3-1-11 0,3-3-1 16,0 2 8-16,-3-2-33 0,0 3 14 15,3-1-9-15,-2 1 20 0,1-2 7 0,-3 1-6 16,4 0-20-16,-2 0 30 0,-2 0-12 0,2-2-31 16,-2 2 12-16,3 0 27 0,-1-2-25 15,0 3 0-15,-1 0 5 0,1-1-7 0,-2-2 31 16,0 1-21-16,1 2 0 0,1-1 17 16,1 0-14-16,-2 0 2 0,2-2 5 0,-1 1-24 15,-1 0-1-15,2 4 8 0,-3-5 8 0,1 1 22 16,2 1-15-16,-1-2-7 0,-1 0 17 15,1 2-34-15,0 2 7 0,0-3 19 0,0 0-25 16,-2-1 8-16,3 1 3 0,0 1-2 16,0 2-1-16,-1-3 0 0,0 0 10 0,1 0-3 15,-3 0 16-15,4 2 7 0,-4 0-28 16,2-3 5-16,0 1-8 0,-2-1 18 0,0 0-1 16,0 0-12-16,0 0 12 0,0 0-18 15,0 0 5-15,0 0 4 0,0 0 4 16,7 0-6-16,-7 0-5 0,0 0 4 0,9 0 3 15,-9 0 13-15,0 0 12 0,0 0-8 0,6 0-21 16,-6 0 0-16,0 0 35 0,9 5-21 16,-9-5 13-16,0 0-39 0,6 0 34 0,-6 0-32 15,0 0 21-15,7 0 13 0,-7 0-9 0,13 15-33 16,-9-14 20-16,-4-1 19 0,0 0-28 16,0 0 17-16,0 0-11 0,0 0-3 0,0 0 29 15,6 0-33-15,-6 0 2 0,0 0 28 0,8 0-26 16,-8 0 0-16,0 0 13 0,7 0-12 15,-7 0 16-15,0 0-23 0,7 0 10 0,-7 0-2 16,0 0 7-16,8 0-4 0,-8 0 4 0,8 0 4 16,-8 0 21-16,0 0-22 0,8 0 2 15,-8 0 5-15,8 0-7 0,-8 0-7 0,0 0 9 16,9 0 24-16,-9 0-5 0,5 0 10 0,-5 0-18 16,10 0-8-16,-10 0 2 0,0 0-1 15,5 0-16-15,-5 0-9 0,0 0 7 0,7 0 24 16,-7 0 1-16,8 0-5 0,-8 0-14 15,0 0 10-15,0 0-6 0,9 0 19 0,-9 0-1 16,0 0-28-16,6 0-4 0,-6 0 20 0,0 0-24 16,8 0 7-16,-8 0-2 0,0 0 6 15,0 0 0-15,7 0 32 0,-7 0-35 0,0 0 20 16,0 0-18-16,7 0-6 0,-7 0 8 16,0 0 24-16,9 0-9 0,-9 0-21 15,0 0 5-15,0 0 36 0,0 0-22 0,8 0 6 16,-8 0-10-16,0 0 4 0,0 0-20 0,6 0 6 15,-6 0-2-15,0 0-10 0,0 0 16 16,9 0 20-16,-9 0-17 0,7 0-2 16,-7 0 31-16,8 0-40 0,-8 0 14 0,7 0 18 15,-7 0 4-15,9 0-2 0,-9 0-25 0,9 0 13 16,-9 0-14-16,6 0-3 0,-6 0 8 16,10 0 3-16,-10 0-13 0,9 0 28 0,-9 0-21 15,0 0 0-15,6 0 15 0,-6 0-23 16,0 0 5-16,7 0 34 0,-7 0-44 0,0 0 10 15,8 0 1-15,-8 0 4 0,0 0-10 0,9 0 8 16,-9 0 28-16,0 0-33 0,0 0 2 16,6 0 3-16,-6 0-10 0,0 0 38 0,0 0-12 15,0 0-5-15,0 0 16 0,0 0-6 0,7 0-36 16,-7 0-1-16,0 0 40 0,0 0-24 16,7 0-6-16,-7 0-9 0,0 0 0 15,0 0 3-15,0 0 10 0,9 0-1 0,-9 0-8 16,0-9 37-16,0 9-18 0,0 0 22 0,7 0-48 15,-7 0 46-15,0 0-36 0,8 0 33 16,-8 0-40-16,0 0 8 0,0 0 9 16,6 0 17-16,-6 0-34 0,9 0-2 0,-9 0 40 15,7 0-25-15,-7 0 23 0,7 0-40 16,-7 0 10-16,8 0 28 0,-8-8-28 0,9 8-1 16,-9 0-7-16,9 0 16 0,-9 0 29 0,7 0-34 15,-7 0 22-15,9 0-1 0,-9 0-29 16,9 0 5-16,-9 0-3 0,6 0 11 0,-6 0-14 15,9 0 36-15,-9 0 8 0,9 0-20 16,-9 0-19-16,7-5-2 0,-7 5 8 0,7 0 17 16,-7 0-19-16,0 0 18 0,9 0-15 0,-9 0-9 15,0 0-4-15,7 0 19 0,-7 0-13 0,0 0 23 16,7 0-19-16,-7 0-4 0,0 0 1 16,7 0 5-16,-7 0 23 0,0-8-9 0,9 8-16 15,-9 0 25-15,0 0-5 0,7 0-16 16,4-9 30-16,-7 9-35 0,-2-1 22 0,0 1-2 15,0-1-23-15,3 1 8 0,-1 0 0 0,-4-4-9 16,1 4 45-16,2 0-35 0,0 0-17 16,-3-2 14-16,2 2-3 0,-2 0 24 0,2 0-4 15,0 0 7-15,4 0-28 0,-5 0 6 16,3-2 4-16,-3 2 16 0,0 0 3 0,2 0-23 16,-3-1-8-16,0 1-4 0,2 0 33 0,2 0-22 15,-4-5-8-15,0 7 5 0,2-2 29 16,0 0-1-16,-1-2-7 0,2 2-24 0,-1 0 1 15,1 0 23-15,-1 0-3 0,0 0-3 16,0-1-15-16,0 2 36 0,1-1-13 0,-1 0-16 16,1 0-11-16,1-1 31 0,-3 1-20 0,4 0-18 15,-5 0 10-15,4 0 3 0,-4-1-6 16,4 1 11-16,-2 0 27 0,-2 0-26 0,0 0 30 16,0 0-53-16,0 0 36 0,7 0 1 15,-7 0-33-15,0 0 37 0,7 0-39 0,-7 0-1 16,0 0 49-16,7 0-38 0,-7 0-1 0,0 0 27 15,8 0-21-15,-8 0-4 0,0 0-3 16,11 0 33-16,-11 0-16 0,0 0-15 0,5 0 7 16,-5 0 21-16,0 0-29 0,10 0 5 15,-10 0-8-15,6 0-5 0,-6 0 50 0,9 0-38 16,-9 0 34-16,0 0-14 0,6 0-9 0,-6 0 10 16,0 0-14-16,0 0-4 0,7 0-16 0,-7 0 29 15,0 0-6-15,0 0-6 0,0 0 10 16,9 0-22-16,-9 0-5 0,0 0 7 0,0 0 34 15,8 0-36-15,-2 0 6 0,-6 0-8 16,4 0 12-16,-3 0-1 0,1 0 13 0,0 0-19 16,-1 0 5-16,1 0 4 0,-1 0 35 0,0 0-15 15,3 1-24-15,-3-2 3 0,0 1 17 0,2 0-5 16,-3 0-12-16,2 0-4 0,1 1 29 16,-1-1-21-16,0 0-10 0,-1 1-8 0,1-1 4 15,1 0 11-15,-1 0-6 0,0-1 33 0,0 1-17 16,1 1 6-16,-1-1-18 0,-2 0 17 15,4 0-26-15,-2 2 49 0,0-4-46 0,-2 2 11 16,0 0 14-16,0 0-6 0,0 0-19 16,0 0-6-16,0 0 49 0,0 0-29 0,6 0-10 15,-6 0 36-15,0 0-30 0,0 0-14 0,9 0 8 16,-9 0 0-16,0 0 31 0,7 0-45 16,-7 0 18-16,8 0 21 0,-8 0-37 0,6 0 6 15,-6 0 8-15,9 0-9 0,-9 0 43 0,7 0-43 16,5-10 12-16,-7 9 16 0,1 1-23 15,-4-1 9-15,3 1-14 0,-1-2 1 0,-1 2 17 16,3 0 14-16,-4-4-19 0,1 4 16 0,2-2 6 16,-4 1-37-16,3 1 34 0,0-1 3 15,2 1 9-15,-5 0-24 0,3-2-18 16,-2 2-3-16,0 0 21 0,3 0-17 0,-4-2 29 16,-1-2 10-16,0 4-42 0,0 0-5 0,0 0 20 15,0 0-17-15,0 0 12 0,0 0 25 16,9 0-4-16,-9 0 1 0,0 0-23 0,6 0-3 15,-6 0 0-15,0 0-5 0,9 0 10 16,-9 0-2-16,0 0-4 0,7 0 28 0,-7 0-9 16,8 0-16-16,-8 0-4 0,0 0 15 0,7 0-10 15,-7 0 2-15,0 0 13 0,7 0-23 16,-7 0 7-16,9 0 5 0,-9 0-19 0,7 0 12 16,-7 0-2-16,7 0 38 0,-7 0-37 0,7 0 10 15,-7 0 13-15,7 0-12 0,-7-6-7 0,9 6 19 16,-9 0-1-16,6 0 15 0,-6 0-46 15,0 0 6-15,9 0 6 0,-9 0 15 16,6 0-24-16,-6 0 6 0,0 0 7 0,10 0 18 16,-10 0 4-16,0 0-8 0,8 0-29 0,-8 0 6 15,0 0 28-15,6 0-25 0,-6 0 29 0,0 0-35 16,0 0 16-16,9 0-3 0,-9 0-4 16,0 0 18-16,0 0-22 0,6 0-6 15,-6 0 43-15,0 0-14 0,0 0-17 0,0-7-5 16,8 7 27-16,-8 0-28 0,0 0 10 15,0 0-3-15,7 0-4 0,-7 0 17 16,0 0-17-16,9 0 33 0,-9 0-9 0,0 0 3 16,7 0-15-16,-7 0-17 0,7 0 4 0,-7 0-1 15,0 0 16-15,8 0 16 0,-8 0-8 0,9 0-32 16,-9 0 6-16,8 0 11 0,-8 0-14 0,0 0 20 16,6 0-6-16,-6 0 8 0,0 0-11 15,9 0 18-15,-9 0-17 0,0 0 22 0,6 0-39 16,-6 0 22-16,0 0 16 0,0 0-11 15,10 0-15-15,-10 0 14 0,0 0-14 0,0 0-6 16,0 0-12-16,0 0 42 0,5-8-36 0,-5 8 5 16,0 0 16-16,0 0-28 0,0 0 38 15,7 0-35-15,-7 0 48 0,0 0-21 0,0 0 13 16,0 0-20-16,0 0 0 0,7 0-17 16,-7 0 35-16,0 0-8 0,0 0-3 0,0 0-3 15,9 0 21-15,-9 0-29 0,0 0-7 16,0 0 32-16,5 0-15 0,-5 0-27 0,0 0 7 15,0 0 7-15,9 0-4 0,-9 0 32 16,0 0-47-16,0 0 18 0,7 0-3 0,-7 0 4 16,0 0 18-16,0 0 17 0,7 0-23 0,-7 0-19 15,0 0 9-15,8 0 12 0,-8 0 11 0,12 5-10 16,-9-5-16-16,-1 0-2 0,0 1-8 16,-1 1 8-16,1-2 7 0,1 1 21 0,-2 0-22 15,1-1-5-15,0 0-2 0,1 1 34 16,-2 1-23-16,2-2 12 0,0 2-20 0,-2-2 4 15,3 3 21-15,-3-2-37 0,2 0 7 16,-2 0 35-16,3 1-31 0,-3 2 7 0,1-4-3 16,-1 2 28-16,4 0-32 0,-4 0 3 15,4 2-11-15,-5-4 9 0,2 2 0 0,1 0 4 16,1 0 7-16,-2 2-2 0,0-4 10 16,1 2 0-16,-3-1-7 0,2 0-1 0,0 1-4 15,-1 1 14-15,0-3 10 0,1 1-39 0,0-1 10 16,-2 2 3-16,4-2 5 0,-4 2 25 15,3 2-32-15,-1-4 2 0,-2 1-8 0,1 0 20 16,0 2 16-16,2-3-36 0,-3 4-4 16,2-3 6-16,1 0-1 0,-3 0 33 0,0 2-12 15,3 1-7-15,-1-3 23 0,-2 1-40 16,1 0 4-16,2 2 5 0,-3-2 10 0,3-1 5 16,0 0-21-16,-3 1 8 0,1 1-12 0,3 0 0 15,-4-2 13-15,2 1 1 0,1-1-11 0,-1 3 31 16,1-3 12-16,-1-1-33 0,0 2 8 15,-2 4 5-15,2-4-20 0,2-2 2 16,-3 2-2-16,4-1 8 0,-5 2-5 0,4 0 13 16,-1-3 0-16,-1 1 15 0,0 2-6 0,1 0-25 15,-3-3 47-15,3 2-37 0,-2-2 18 16,0 2 0-16,0-1 17 0,2 0-44 0,-1 3 27 16,1-2-21-16,-3-1-1 0,2-1 16 15,-1 1 20-15,1-1-43 0,-2 1 25 0,1 2-3 16,0-1-19-16,3-2 32 0,-3 2-37 15,3-1 16-15,-4 0 4 0,2 0-7 0,-1-1 18 0,0 2-29 16,3 0 4-16,-4-2 21 0,3 3-30 16,0-3 8-16,-1 0 2 0,0 0 0 0,-1 0 4 15,1 1-6-15,-2-1 0 0,0 0 0 16,3 0 41-16,-1 2-13 0,0-2-2 0,0 2-6 16,-2-1 6-16,0 1-30 0,0-2 44 15,3 0-41-15,-3 0 22 0,0 2-21 0,0-2 14 16,3 0 18-16,-3 0-2 0,3 0-46 15,-3 0 21-15,0 0-9 0,0 0 11 0,0 0 2 16,0 0 41-16,0 0-3 0,0 0-48 0,0 0 21 16,0 0-27-16,12 8 50 0,-9-8-47 15,-3 2 13-15,2-2 2 0,2 0 16 16,-1 0-18-16,0 0 34 0,-1 0-19 0,-1 2-35 16,-1-2 15-16,4 1 23 0,-4 2-40 0,4-3 17 15,-3 1 1-15,0-1 0 0,4 2 25 16,-1-2-7-16,-2 1-2 0,2 2-19 0,0-1 14 15,2-2-26-15,-3 1 40 0,0 1-13 16,1 0-19-16,1 0 33 0,-1 1-5 0,1-2-25 16,0 1 18-16,0 0-7 0,-3 2 12 0,2-3 10 15,1 0-13-15,-4 1-32 0,2-1 29 0,1 0-8 16,-2 2 2-16,3-1-21 0,-1-1 0 16,-2 1-9-16,3-1 23 0,-2-1-10 0,1 3 38 15,-3-2-44-15,4-1 8 0,-1 2-1 0,-2-2 3 16,0 1 18-16,0-1-22 0,-2 2-2 15,2 2 30-15,-2-3-30 0,2 0 4 0,-1 1-6 16,1 0-9-16,0-1 11 0,0 1 5 16,-2 0-13-16,0-1 25 0,3 2-23 0,-3 1 14 15,2-2-4-15,1-1 21 0,-3-1 9 16,0 0-7-16,0 0-9 0,0 0-14 0,0 7-3 16,0-7-4-16,0 8 25 0,0-8-10 0,16 14 27 15,-16-10-33-15,5-1-1 0,-5 0-4 0,2 3 13 16,0-5 23-16,1 2-41 0,-2 0 52 0,1 0-6 15,-2-2-20-15,4 2-24 0,-4-1 3 16,1 2 8-16,1-3 19 0,-2 0-8 0,2 0 3 16,0 3 4-16,2-3-5 0,-3-1-21 15,-1 2 1-15,3-2-1 0,0 0 22 0,-1 4 1 16,-2-4 2-16,1 3-15 0,2-2-2 0,0 1-4 16,0-2 7-16,-2 0 39 0,3 0-49 0,-3 0 24 15,3 0-10-15,-4 2 0 0,2-2 17 16,2 0 17-16,-4 0-36 0,3 3 6 0,-2-3 24 15,0 0-28-15,2 0 28 0,-2 2-30 16,2-2-6-16,-2 0 30 0,4 0-21 0,-4 0-14 16,4 1 4-16,-5-1 25 0,4 0-7 0,-3 0-2 15,4 0 11-15,-5 0-45 0,4 0 9 16,-4 0 3-16,0 0 39 0,0 0-34 0,0 0 33 16,0 0-20-16,0 0 21 0,0 0-12 0,7 0-36 15,-7 0 5-15,0 0 18 0,0 0 23 0,0 0-18 16,7 0-10-16,-7 0-11 0,0 0 35 15,0 0-46-15,0 0 40 0,7 0-10 0,-7 0 19 16,0 0-19-16,0 0-15 0,0 0-15 16,0 0 22-16,0 0 27 0,0 0-32 0,0 0 1 15,8 0-11-15,-8 0 29 0,0 0 2 16,6-8 13-16,-4 8-40 0,0 0 23 0,-1-2-22 16,-1 2-2-16,0 0 24 0,0 0 12 0,0 2-9 15,2-4 16-15,-2 1-15 0,-2 1 4 16,2 1-40-16,0-1 18 0,0 0 24 0,0 0-3 15,4 0-11-15,-4 0 9 0,0 0-37 16,1 0 9-16,0 0-12 0,-1 0 46 0,-1 0-47 16,2-1 16-16,-1 2 23 0,0-1-21 0,0 2 42 15,0-4-42-15,0 4-16 0,0-2 47 16,0 0-10-16,0 0-25 0,0 0 7 0,-1 0 28 16,0 0-27-16,1 0-17 0,0 0 36 0,0 0-21 15,-2 0-10-15,4 2-2 0,-6-2 36 0,4 0 1 16,0 0-39-16,-1 3 25 0,-1-3 24 15,2 0-40-15,-2 0 29 0,2-3-33 0,-4 3 18 16,2 0 14-16,-1 0 0 0,3 0-36 16,0 0 38-16,0 0-38 0,-5 0 27 0,5-2-23 15,0 2 30-15,0 0-7 0,-2 0-6 0,0-2-15 16,1 1 14-16,-1-1-26 0,0 1 7 0,1-1 13 16,0 0 7-16,1 2 12 0,-1 0-22 15,-1-2-1-15,0 1 15 0,2 1-7 0,0-4 13 16,-3 3-19-16,2 1 15 0,1-1-14 15,0 1-1-15,-1 0 5 0,1-1-11 0,-2 2 4 16,2-2 6-16,2-2 27 0,-4 3-15 16,4 0 22-16,-2-1-40 0,0 1 5 0,0 0 13 15,0-2 12-15,0 2-38 0,0 0 3 16,0 0 20-16,1 0 14 0,-1-2-23 0,0 2-10 16,1 0 19-16,-2-1 2 0,1 1 9 15,0 0-32-15,1 0-4 0,-1 0 15 0,3 0-6 16,-3 0 2-16,0 0-1 0,0 0 6 0,0 0 18 15,0-1-30-15,0 1 19 0,0 1 8 16,0-1 3-16,0 0-14 0,0 0 9 16,0 0-22-16,0 0 5 0,0 0 2 0,0 1 14 15,0-2-21-15,0 2 2 0,0-1 28 0,0 0-16 16,0 0-11-16,0 0 4 0,0 0 40 16,0 0-33-16,0 0 2 0,0 2 7 0,0-2-14 15,0 0 0-15,2 0 18 0,-4 0 12 0,2 0-1 16,0-2-36-16,0 2 29 0,0 0-8 15,0 0-16-15,0 2 11 0,0-2-17 0,0 0 31 16,0-2-30-16,-4 1 7 0,4 2-4 0,0-2 12 16,1 1 21-16,-1 0-36 0,0 0 31 0,0 0-12 15,3 1-10-15,-6-1 10 0,3 0 7 16,0 0-24-16,0 0 32 0,-1 0-17 0,2-1-19 16,-1 2 20-16,0-1-11 0,0-1 31 15,3 2-32-15,-3-1-1 0,0 0 23 0,0 0-21 16,0 0 3-16,0 0 13 0,0 0-16 0,0 0 40 15,0 2-32-15,0-2 27 0,0 0-12 16,0-2 2-16,0 4 9 0,0-2-37 0,0-2 30 16,0 2-3-16,0 0-29 0,0 0 13 15,2 2 38-15,-4-2-6 0,2 2-44 0,2-2-2 16,-2 0-6-16,0 0 9 0,0-2 21 0,0 4-15 16,-2-2-7-16,4 1 22 0,-2-1-21 15,0 0-41-15,2 0-15 0,-2-1-48 0,0 1 10 16,1 0-284-16,-1 0-10 0,2 0 10 0,0 1 51 15,3-4 18-15,2 1 44 0,-2 1 1 16,15-3 34-16</inkml:trace>
</inkml:ink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Subtítu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s-ES" smtClean="0"/>
              <a:t>Haga clic para editar el estilo de subtítulo del patrón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9037934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381470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vertical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vertical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20763970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609611" y="273352"/>
            <a:ext cx="10972581" cy="1144682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5325" b="0" strike="noStrike" spc="-1"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609611" y="1604515"/>
            <a:ext cx="10972581" cy="3977484"/>
          </a:xfrm>
          <a:prstGeom prst="rect">
            <a:avLst/>
          </a:prstGeom>
          <a:noFill/>
          <a:ln w="0">
            <a:noFill/>
          </a:ln>
        </p:spPr>
        <p:txBody>
          <a:bodyPr lIns="0" tIns="0" rIns="0" bIns="0" anchor="ctr">
            <a:noAutofit/>
          </a:bodyPr>
          <a:lstStyle/>
          <a:p>
            <a:pPr algn="ctr">
              <a:buNone/>
            </a:pPr>
            <a:endParaRPr lang="en-US" sz="2903" b="0" strike="noStrike" spc="-1">
              <a:latin typeface="Arial"/>
            </a:endParaRPr>
          </a:p>
        </p:txBody>
      </p:sp>
    </p:spTree>
    <p:extLst>
      <p:ext uri="{BB962C8B-B14F-4D97-AF65-F5344CB8AC3E}">
        <p14:creationId xmlns:p14="http://schemas.microsoft.com/office/powerpoint/2010/main" val="15301948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50019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6823692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7661090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4" name="Marcador de contenid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Marcador de tex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6" name="Marcador de contenid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Marcador de fech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8" name="Marcador de pie de pá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Marcador de número de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97828281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fech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4" name="Marcador de pie de pá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Marcador de número de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4748584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fech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3" name="Marcador de pie de pá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Marcador de número de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044615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contenid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2822978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ítu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posición de imagen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Marcador de tex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s-ES" smtClean="0"/>
              <a:t>Editar el estilo de texto del patrón</a:t>
            </a:r>
          </a:p>
        </p:txBody>
      </p:sp>
      <p:sp>
        <p:nvSpPr>
          <p:cNvPr id="5" name="Marcador de fech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6" name="Marcador de pie de pá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Marcador de número de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6959956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rcador de títu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Marcador de tex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" smtClean="0"/>
              <a:t>Edit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Marcador de fech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8DCE1C5-598C-4206-8852-0B30E13B2F84}" type="datetimeFigureOut">
              <a:rPr lang="es-ES" smtClean="0"/>
              <a:t>11/02/2025</a:t>
            </a:fld>
            <a:endParaRPr lang="es-ES"/>
          </a:p>
        </p:txBody>
      </p:sp>
      <p:sp>
        <p:nvSpPr>
          <p:cNvPr id="5" name="Marcador de pie de pá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Marcador de número de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24F986-3929-4ED6-A08D-1DB9920F3E63}" type="slidenum">
              <a:rPr lang="es-ES" smtClean="0"/>
              <a:t>‹Nº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34525233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7" Type="http://schemas.openxmlformats.org/officeDocument/2006/relationships/image" Target="../media/image4.emf"/><Relationship Id="rId2" Type="http://schemas.openxmlformats.org/officeDocument/2006/relationships/customXml" Target="../ink/ink1.xml"/><Relationship Id="rId1" Type="http://schemas.openxmlformats.org/officeDocument/2006/relationships/slideLayout" Target="../slideLayouts/slideLayout7.xml"/><Relationship Id="rId6" Type="http://schemas.openxmlformats.org/officeDocument/2006/relationships/customXml" Target="../ink/ink3.xml"/><Relationship Id="rId5" Type="http://schemas.openxmlformats.org/officeDocument/2006/relationships/image" Target="../media/image3.emf"/><Relationship Id="rId4" Type="http://schemas.openxmlformats.org/officeDocument/2006/relationships/customXml" Target="../ink/ink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3.ti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tif"/><Relationship Id="rId2" Type="http://schemas.openxmlformats.org/officeDocument/2006/relationships/image" Target="../media/image4.tif"/><Relationship Id="rId1" Type="http://schemas.openxmlformats.org/officeDocument/2006/relationships/slideLayout" Target="../slideLayouts/slideLayout12.xml"/><Relationship Id="rId5" Type="http://schemas.openxmlformats.org/officeDocument/2006/relationships/image" Target="../media/image7.tif"/><Relationship Id="rId4" Type="http://schemas.openxmlformats.org/officeDocument/2006/relationships/image" Target="../media/image6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o 2"/>
          <p:cNvGrpSpPr/>
          <p:nvPr/>
        </p:nvGrpSpPr>
        <p:grpSpPr>
          <a:xfrm>
            <a:off x="108426" y="1040886"/>
            <a:ext cx="12083574" cy="3177532"/>
            <a:chOff x="69472" y="307235"/>
            <a:chExt cx="12083574" cy="3177532"/>
          </a:xfrm>
        </p:grpSpPr>
        <p:sp>
          <p:nvSpPr>
            <p:cNvPr id="24" name="CuadroTexto 23"/>
            <p:cNvSpPr txBox="1"/>
            <p:nvPr/>
          </p:nvSpPr>
          <p:spPr>
            <a:xfrm>
              <a:off x="69472" y="307235"/>
              <a:ext cx="3896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25" name="Grupo 24"/>
            <p:cNvGrpSpPr/>
            <p:nvPr/>
          </p:nvGrpSpPr>
          <p:grpSpPr>
            <a:xfrm>
              <a:off x="4054564" y="925766"/>
              <a:ext cx="4089106" cy="2559001"/>
              <a:chOff x="-36851" y="3774719"/>
              <a:chExt cx="5621697" cy="3150230"/>
            </a:xfrm>
          </p:grpSpPr>
          <p:cxnSp>
            <p:nvCxnSpPr>
              <p:cNvPr id="26" name="Conector recto 25"/>
              <p:cNvCxnSpPr/>
              <p:nvPr/>
            </p:nvCxnSpPr>
            <p:spPr>
              <a:xfrm>
                <a:off x="800855" y="3774719"/>
                <a:ext cx="316" cy="2520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7" name="Conector recto 26"/>
              <p:cNvCxnSpPr/>
              <p:nvPr/>
            </p:nvCxnSpPr>
            <p:spPr>
              <a:xfrm>
                <a:off x="813201" y="6284581"/>
                <a:ext cx="436353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8" name="CuadroTexto 27"/>
              <p:cNvSpPr txBox="1"/>
              <p:nvPr/>
            </p:nvSpPr>
            <p:spPr>
              <a:xfrm>
                <a:off x="645807" y="4134755"/>
                <a:ext cx="300789" cy="252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29" name="CuadroTexto 28"/>
              <p:cNvSpPr txBox="1"/>
              <p:nvPr/>
            </p:nvSpPr>
            <p:spPr>
              <a:xfrm>
                <a:off x="636178" y="5586711"/>
                <a:ext cx="300789" cy="252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0" name="CuadroTexto 29"/>
              <p:cNvSpPr txBox="1"/>
              <p:nvPr/>
            </p:nvSpPr>
            <p:spPr>
              <a:xfrm rot="16200000">
                <a:off x="1272053" y="6140976"/>
                <a:ext cx="3007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1" name="CuadroTexto 30"/>
              <p:cNvSpPr txBox="1"/>
              <p:nvPr/>
            </p:nvSpPr>
            <p:spPr>
              <a:xfrm rot="16200000">
                <a:off x="4993140" y="6137152"/>
                <a:ext cx="3007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2" name="CuadroTexto 31"/>
              <p:cNvSpPr txBox="1"/>
              <p:nvPr/>
            </p:nvSpPr>
            <p:spPr>
              <a:xfrm rot="16200000">
                <a:off x="2423070" y="6141920"/>
                <a:ext cx="3007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3" name="CuadroTexto 32"/>
              <p:cNvSpPr txBox="1"/>
              <p:nvPr/>
            </p:nvSpPr>
            <p:spPr>
              <a:xfrm rot="16200000">
                <a:off x="3686392" y="6141920"/>
                <a:ext cx="300790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4" name="CuadroTexto 33"/>
              <p:cNvSpPr txBox="1"/>
              <p:nvPr/>
            </p:nvSpPr>
            <p:spPr>
              <a:xfrm>
                <a:off x="248405" y="4137690"/>
                <a:ext cx="810928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2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5" name="CuadroTexto 34"/>
              <p:cNvSpPr txBox="1"/>
              <p:nvPr/>
            </p:nvSpPr>
            <p:spPr>
              <a:xfrm>
                <a:off x="246927" y="5595734"/>
                <a:ext cx="683390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4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6" name="CuadroTexto 35"/>
              <p:cNvSpPr txBox="1"/>
              <p:nvPr/>
            </p:nvSpPr>
            <p:spPr>
              <a:xfrm>
                <a:off x="1164092" y="6362741"/>
                <a:ext cx="664895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7" name="CuadroTexto 36"/>
              <p:cNvSpPr txBox="1"/>
              <p:nvPr/>
            </p:nvSpPr>
            <p:spPr>
              <a:xfrm>
                <a:off x="2340925" y="6367762"/>
                <a:ext cx="616318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8" name="CuadroTexto 37"/>
              <p:cNvSpPr txBox="1"/>
              <p:nvPr/>
            </p:nvSpPr>
            <p:spPr>
              <a:xfrm>
                <a:off x="3612637" y="6351667"/>
                <a:ext cx="642139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39" name="CuadroTexto 38"/>
              <p:cNvSpPr txBox="1"/>
              <p:nvPr/>
            </p:nvSpPr>
            <p:spPr>
              <a:xfrm>
                <a:off x="4890521" y="6339785"/>
                <a:ext cx="694325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0" name="CuadroTexto 39"/>
              <p:cNvSpPr txBox="1"/>
              <p:nvPr/>
            </p:nvSpPr>
            <p:spPr>
              <a:xfrm>
                <a:off x="2464731" y="6621841"/>
                <a:ext cx="1808395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avelength (nm)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1" name="CuadroTexto 40"/>
              <p:cNvSpPr txBox="1"/>
              <p:nvPr/>
            </p:nvSpPr>
            <p:spPr>
              <a:xfrm rot="16200000">
                <a:off x="-269525" y="4976576"/>
                <a:ext cx="803851" cy="3385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2" name="CuadroTexto 41"/>
              <p:cNvSpPr txBox="1"/>
              <p:nvPr/>
            </p:nvSpPr>
            <p:spPr>
              <a:xfrm>
                <a:off x="643183" y="6089033"/>
                <a:ext cx="300789" cy="252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3" name="CuadroTexto 42"/>
              <p:cNvSpPr txBox="1"/>
              <p:nvPr/>
            </p:nvSpPr>
            <p:spPr>
              <a:xfrm>
                <a:off x="253195" y="6071964"/>
                <a:ext cx="609634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4" name="CuadroTexto 43"/>
              <p:cNvSpPr txBox="1"/>
              <p:nvPr/>
            </p:nvSpPr>
            <p:spPr>
              <a:xfrm>
                <a:off x="640676" y="5118020"/>
                <a:ext cx="300789" cy="252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5" name="CuadroTexto 44"/>
              <p:cNvSpPr txBox="1"/>
              <p:nvPr/>
            </p:nvSpPr>
            <p:spPr>
              <a:xfrm>
                <a:off x="253945" y="5125058"/>
                <a:ext cx="589206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6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6" name="CuadroTexto 45"/>
              <p:cNvSpPr txBox="1"/>
              <p:nvPr/>
            </p:nvSpPr>
            <p:spPr>
              <a:xfrm>
                <a:off x="636178" y="4637828"/>
                <a:ext cx="300789" cy="25245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47" name="CuadroTexto 46"/>
              <p:cNvSpPr txBox="1"/>
              <p:nvPr/>
            </p:nvSpPr>
            <p:spPr>
              <a:xfrm>
                <a:off x="253945" y="4644865"/>
                <a:ext cx="592082" cy="30310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8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p14="http://schemas.microsoft.com/office/powerpoint/2010/main">
            <mc:Choice Requires="p14">
              <p:contentPart p14:bwMode="auto" r:id="rId2">
                <p14:nvContentPartPr>
                  <p14:cNvPr id="48" name="Entrada de lápiz 47"/>
                  <p14:cNvContentPartPr/>
                  <p14:nvPr/>
                </p14:nvContentPartPr>
                <p14:xfrm>
                  <a:off x="806545" y="3966142"/>
                  <a:ext cx="4370186" cy="2024280"/>
                </p14:xfrm>
              </p:contentPart>
            </mc:Choice>
            <mc:Fallback xmlns="">
              <p:pic>
                <p:nvPicPr>
                  <p:cNvPr id="48" name="Entrada de lápiz 47"/>
                  <p:cNvPicPr/>
                  <p:nvPr/>
                </p:nvPicPr>
                <p:blipFill>
                  <a:blip r:embed="rId3"/>
                  <a:stretch>
                    <a:fillRect/>
                  </a:stretch>
                </p:blipFill>
                <p:spPr>
                  <a:xfrm>
                    <a:off x="801505" y="3961101"/>
                    <a:ext cx="4384946" cy="2039043"/>
                  </a:xfrm>
                  <a:prstGeom prst="rect">
                    <a:avLst/>
                  </a:prstGeom>
                </p:spPr>
              </p:pic>
            </mc:Fallback>
          </mc:AlternateContent>
        </p:grpSp>
        <p:sp>
          <p:nvSpPr>
            <p:cNvPr id="49" name="CuadroTexto 48"/>
            <p:cNvSpPr txBox="1"/>
            <p:nvPr/>
          </p:nvSpPr>
          <p:spPr>
            <a:xfrm>
              <a:off x="4094062" y="307235"/>
              <a:ext cx="38961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en-GB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1" name="Grupo 70"/>
            <p:cNvGrpSpPr/>
            <p:nvPr/>
          </p:nvGrpSpPr>
          <p:grpSpPr>
            <a:xfrm>
              <a:off x="88767" y="867487"/>
              <a:ext cx="4217312" cy="2617280"/>
              <a:chOff x="392564" y="779131"/>
              <a:chExt cx="5414837" cy="3711364"/>
            </a:xfrm>
          </p:grpSpPr>
          <p:sp>
            <p:nvSpPr>
              <p:cNvPr id="52" name="CuadroTexto 51"/>
              <p:cNvSpPr txBox="1"/>
              <p:nvPr/>
            </p:nvSpPr>
            <p:spPr>
              <a:xfrm rot="16200000">
                <a:off x="181958" y="2222689"/>
                <a:ext cx="737350" cy="31613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cxnSp>
            <p:nvCxnSpPr>
              <p:cNvPr id="53" name="Conector recto 52"/>
              <p:cNvCxnSpPr/>
              <p:nvPr/>
            </p:nvCxnSpPr>
            <p:spPr>
              <a:xfrm>
                <a:off x="1223095" y="779131"/>
                <a:ext cx="301" cy="300185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4" name="Conector recto 53"/>
              <p:cNvCxnSpPr/>
              <p:nvPr/>
            </p:nvCxnSpPr>
            <p:spPr>
              <a:xfrm>
                <a:off x="1234848" y="3780987"/>
                <a:ext cx="4153829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5" name="CuadroTexto 54"/>
              <p:cNvSpPr txBox="1"/>
              <p:nvPr/>
            </p:nvSpPr>
            <p:spPr>
              <a:xfrm>
                <a:off x="1052591" y="1264750"/>
                <a:ext cx="286334" cy="265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6" name="CuadroTexto 55"/>
              <p:cNvSpPr txBox="1"/>
              <p:nvPr/>
            </p:nvSpPr>
            <p:spPr>
              <a:xfrm>
                <a:off x="1058247" y="2220456"/>
                <a:ext cx="286334" cy="265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7" name="CuadroTexto 56"/>
              <p:cNvSpPr txBox="1"/>
              <p:nvPr/>
            </p:nvSpPr>
            <p:spPr>
              <a:xfrm>
                <a:off x="1059314" y="3140841"/>
                <a:ext cx="286334" cy="26540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8" name="CuadroTexto 57"/>
              <p:cNvSpPr txBox="1"/>
              <p:nvPr/>
            </p:nvSpPr>
            <p:spPr>
              <a:xfrm rot="16200000">
                <a:off x="1676862" y="3694249"/>
                <a:ext cx="275906" cy="2713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59" name="CuadroTexto 58"/>
              <p:cNvSpPr txBox="1"/>
              <p:nvPr/>
            </p:nvSpPr>
            <p:spPr>
              <a:xfrm rot="16200000">
                <a:off x="5210832" y="3688423"/>
                <a:ext cx="275906" cy="2713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0" name="CuadroTexto 59"/>
              <p:cNvSpPr txBox="1"/>
              <p:nvPr/>
            </p:nvSpPr>
            <p:spPr>
              <a:xfrm rot="16200000">
                <a:off x="2772566" y="3696323"/>
                <a:ext cx="275906" cy="2713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1" name="CuadroTexto 60"/>
              <p:cNvSpPr txBox="1"/>
              <p:nvPr/>
            </p:nvSpPr>
            <p:spPr>
              <a:xfrm rot="16200000">
                <a:off x="3975175" y="3690566"/>
                <a:ext cx="275906" cy="271361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8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8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2" name="CuadroTexto 61"/>
              <p:cNvSpPr txBox="1"/>
              <p:nvPr/>
            </p:nvSpPr>
            <p:spPr>
              <a:xfrm>
                <a:off x="782842" y="1268973"/>
                <a:ext cx="492496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3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3" name="CuadroTexto 62"/>
              <p:cNvSpPr txBox="1"/>
              <p:nvPr/>
            </p:nvSpPr>
            <p:spPr>
              <a:xfrm>
                <a:off x="714534" y="2222978"/>
                <a:ext cx="716994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25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4" name="CuadroTexto 63"/>
              <p:cNvSpPr txBox="1"/>
              <p:nvPr/>
            </p:nvSpPr>
            <p:spPr>
              <a:xfrm>
                <a:off x="807826" y="3150393"/>
                <a:ext cx="492496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2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5" name="CuadroTexto 64"/>
              <p:cNvSpPr txBox="1"/>
              <p:nvPr/>
            </p:nvSpPr>
            <p:spPr>
              <a:xfrm>
                <a:off x="1581551" y="3859705"/>
                <a:ext cx="645542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6" name="CuadroTexto 65"/>
              <p:cNvSpPr txBox="1"/>
              <p:nvPr/>
            </p:nvSpPr>
            <p:spPr>
              <a:xfrm>
                <a:off x="2682714" y="3860691"/>
                <a:ext cx="659823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7" name="CuadroTexto 66"/>
              <p:cNvSpPr txBox="1"/>
              <p:nvPr/>
            </p:nvSpPr>
            <p:spPr>
              <a:xfrm>
                <a:off x="3901368" y="3858503"/>
                <a:ext cx="637671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8" name="CuadroTexto 67"/>
              <p:cNvSpPr txBox="1"/>
              <p:nvPr/>
            </p:nvSpPr>
            <p:spPr>
              <a:xfrm>
                <a:off x="5119508" y="3852771"/>
                <a:ext cx="687893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69" name="CuadroTexto 68"/>
              <p:cNvSpPr txBox="1"/>
              <p:nvPr/>
            </p:nvSpPr>
            <p:spPr>
              <a:xfrm>
                <a:off x="2734724" y="4141348"/>
                <a:ext cx="1721488" cy="34914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avelength (nm)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p14="http://schemas.microsoft.com/office/powerpoint/2010/main">
            <mc:Choice Requires="p14">
              <p:contentPart p14:bwMode="auto" r:id="rId4">
                <p14:nvContentPartPr>
                  <p14:cNvPr id="70" name="Entrada de lápiz 69"/>
                  <p14:cNvContentPartPr/>
                  <p14:nvPr/>
                </p14:nvContentPartPr>
                <p14:xfrm>
                  <a:off x="1218666" y="1317138"/>
                  <a:ext cx="4136723" cy="1389888"/>
                </p14:xfrm>
              </p:contentPart>
            </mc:Choice>
            <mc:Fallback xmlns="">
              <p:pic>
                <p:nvPicPr>
                  <p:cNvPr id="70" name="Entrada de lápiz 69"/>
                  <p:cNvPicPr/>
                  <p:nvPr/>
                </p:nvPicPr>
                <p:blipFill>
                  <a:blip r:embed="rId5"/>
                  <a:stretch>
                    <a:fillRect/>
                  </a:stretch>
                </p:blipFill>
                <p:spPr>
                  <a:xfrm>
                    <a:off x="1212186" y="1310658"/>
                    <a:ext cx="4154003" cy="1406807"/>
                  </a:xfrm>
                  <a:prstGeom prst="rect">
                    <a:avLst/>
                  </a:prstGeom>
                </p:spPr>
              </p:pic>
            </mc:Fallback>
          </mc:AlternateContent>
        </p:grpSp>
        <p:sp>
          <p:nvSpPr>
            <p:cNvPr id="2" name="Rectángulo 1"/>
            <p:cNvSpPr/>
            <p:nvPr/>
          </p:nvSpPr>
          <p:spPr>
            <a:xfrm>
              <a:off x="700914" y="368718"/>
              <a:ext cx="3552063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Arabidopsis recombinant 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2 protein </a:t>
              </a:r>
              <a:endParaRPr lang="en-GB" sz="1400" b="1" dirty="0"/>
            </a:p>
          </p:txBody>
        </p:sp>
        <p:sp>
          <p:nvSpPr>
            <p:cNvPr id="72" name="Rectángulo 71"/>
            <p:cNvSpPr/>
            <p:nvPr/>
          </p:nvSpPr>
          <p:spPr>
            <a:xfrm>
              <a:off x="5422450" y="364486"/>
              <a:ext cx="2260042" cy="30777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r>
                <a:rPr lang="en-US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ovine liver CAT protein</a:t>
              </a:r>
              <a:endParaRPr lang="en-GB" sz="1400" b="1" dirty="0"/>
            </a:p>
          </p:txBody>
        </p:sp>
        <p:grpSp>
          <p:nvGrpSpPr>
            <p:cNvPr id="51" name="Grupo 50"/>
            <p:cNvGrpSpPr/>
            <p:nvPr/>
          </p:nvGrpSpPr>
          <p:grpSpPr>
            <a:xfrm>
              <a:off x="8007745" y="888603"/>
              <a:ext cx="4145301" cy="2550514"/>
              <a:chOff x="6482823" y="3573751"/>
              <a:chExt cx="5630300" cy="3075811"/>
            </a:xfrm>
          </p:grpSpPr>
          <p:cxnSp>
            <p:nvCxnSpPr>
              <p:cNvPr id="73" name="Conector recto 72"/>
              <p:cNvCxnSpPr/>
              <p:nvPr/>
            </p:nvCxnSpPr>
            <p:spPr>
              <a:xfrm>
                <a:off x="7277624" y="3696513"/>
                <a:ext cx="316" cy="241200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4" name="Conector recto 73"/>
              <p:cNvCxnSpPr/>
              <p:nvPr/>
            </p:nvCxnSpPr>
            <p:spPr>
              <a:xfrm>
                <a:off x="7289970" y="6093158"/>
                <a:ext cx="442800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5" name="CuadroTexto 74"/>
              <p:cNvSpPr txBox="1"/>
              <p:nvPr/>
            </p:nvSpPr>
            <p:spPr>
              <a:xfrm>
                <a:off x="7106653" y="4300401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6" name="CuadroTexto 75"/>
              <p:cNvSpPr txBox="1"/>
              <p:nvPr/>
            </p:nvSpPr>
            <p:spPr>
              <a:xfrm>
                <a:off x="7112947" y="5491087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7" name="CuadroTexto 76"/>
              <p:cNvSpPr txBox="1"/>
              <p:nvPr/>
            </p:nvSpPr>
            <p:spPr>
              <a:xfrm rot="16200000">
                <a:off x="7792367" y="5927298"/>
                <a:ext cx="300790" cy="334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8" name="CuadroTexto 77"/>
              <p:cNvSpPr txBox="1"/>
              <p:nvPr/>
            </p:nvSpPr>
            <p:spPr>
              <a:xfrm rot="16200000">
                <a:off x="11539580" y="5927856"/>
                <a:ext cx="300790" cy="334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79" name="CuadroTexto 78"/>
              <p:cNvSpPr txBox="1"/>
              <p:nvPr/>
            </p:nvSpPr>
            <p:spPr>
              <a:xfrm rot="16200000">
                <a:off x="8943384" y="5927912"/>
                <a:ext cx="300790" cy="334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0" name="CuadroTexto 79"/>
              <p:cNvSpPr txBox="1"/>
              <p:nvPr/>
            </p:nvSpPr>
            <p:spPr>
              <a:xfrm rot="16200000">
                <a:off x="10206705" y="5927912"/>
                <a:ext cx="300790" cy="334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1" name="CuadroTexto 80"/>
              <p:cNvSpPr txBox="1"/>
              <p:nvPr/>
            </p:nvSpPr>
            <p:spPr>
              <a:xfrm>
                <a:off x="6716418" y="4312584"/>
                <a:ext cx="735427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4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2" name="CuadroTexto 81"/>
              <p:cNvSpPr txBox="1"/>
              <p:nvPr/>
            </p:nvSpPr>
            <p:spPr>
              <a:xfrm>
                <a:off x="6708509" y="5507399"/>
                <a:ext cx="748644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8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3" name="CuadroTexto 82"/>
              <p:cNvSpPr txBox="1"/>
              <p:nvPr/>
            </p:nvSpPr>
            <p:spPr>
              <a:xfrm>
                <a:off x="7689865" y="6096755"/>
                <a:ext cx="9306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4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4" name="CuadroTexto 83"/>
              <p:cNvSpPr txBox="1"/>
              <p:nvPr/>
            </p:nvSpPr>
            <p:spPr>
              <a:xfrm>
                <a:off x="8848309" y="6096755"/>
                <a:ext cx="864443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5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5" name="CuadroTexto 84"/>
              <p:cNvSpPr txBox="1"/>
              <p:nvPr/>
            </p:nvSpPr>
            <p:spPr>
              <a:xfrm>
                <a:off x="10095111" y="6087340"/>
                <a:ext cx="843625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6</a:t>
                </a:r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6" name="CuadroTexto 85"/>
              <p:cNvSpPr txBox="1"/>
              <p:nvPr/>
            </p:nvSpPr>
            <p:spPr>
              <a:xfrm>
                <a:off x="11431063" y="6108512"/>
                <a:ext cx="68206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70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7" name="CuadroTexto 86"/>
              <p:cNvSpPr txBox="1"/>
              <p:nvPr/>
            </p:nvSpPr>
            <p:spPr>
              <a:xfrm>
                <a:off x="8989889" y="6352630"/>
                <a:ext cx="1808394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Wavelength (nm)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8" name="CuadroTexto 87"/>
              <p:cNvSpPr txBox="1"/>
              <p:nvPr/>
            </p:nvSpPr>
            <p:spPr>
              <a:xfrm rot="16200000">
                <a:off x="6248110" y="4577740"/>
                <a:ext cx="803851" cy="33442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Abs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9" name="CuadroTexto 88"/>
              <p:cNvSpPr txBox="1"/>
              <p:nvPr/>
            </p:nvSpPr>
            <p:spPr>
              <a:xfrm>
                <a:off x="7109337" y="5897610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0" name="CuadroTexto 89"/>
              <p:cNvSpPr txBox="1"/>
              <p:nvPr/>
            </p:nvSpPr>
            <p:spPr>
              <a:xfrm>
                <a:off x="6705574" y="5894407"/>
                <a:ext cx="684731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06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1" name="CuadroTexto 90"/>
              <p:cNvSpPr txBox="1"/>
              <p:nvPr/>
            </p:nvSpPr>
            <p:spPr>
              <a:xfrm>
                <a:off x="7112137" y="5092068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2" name="CuadroTexto 91"/>
              <p:cNvSpPr txBox="1"/>
              <p:nvPr/>
            </p:nvSpPr>
            <p:spPr>
              <a:xfrm>
                <a:off x="6711875" y="5117718"/>
                <a:ext cx="672132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0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3" name="CuadroTexto 92"/>
              <p:cNvSpPr txBox="1"/>
              <p:nvPr/>
            </p:nvSpPr>
            <p:spPr>
              <a:xfrm>
                <a:off x="7112948" y="4698966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4" name="CuadroTexto 93"/>
              <p:cNvSpPr txBox="1"/>
              <p:nvPr/>
            </p:nvSpPr>
            <p:spPr>
              <a:xfrm>
                <a:off x="6713169" y="4725716"/>
                <a:ext cx="670837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2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mc:AlternateContent xmlns:mc="http://schemas.openxmlformats.org/markup-compatibility/2006" xmlns:p14="http://schemas.microsoft.com/office/powerpoint/2010/main">
            <mc:Choice Requires="p14">
              <p:contentPart p14:bwMode="auto" r:id="rId6">
                <p14:nvContentPartPr>
                  <p14:cNvPr id="95" name="Entrada de lápiz 94"/>
                  <p14:cNvContentPartPr/>
                  <p14:nvPr/>
                </p14:nvContentPartPr>
                <p14:xfrm>
                  <a:off x="7280435" y="4134755"/>
                  <a:ext cx="4450816" cy="1448640"/>
                </p14:xfrm>
              </p:contentPart>
            </mc:Choice>
            <mc:Fallback xmlns="">
              <p:pic>
                <p:nvPicPr>
                  <p:cNvPr id="25" name="Entrada de lápiz 24"/>
                  <p:cNvPicPr/>
                  <p:nvPr/>
                </p:nvPicPr>
                <p:blipFill>
                  <a:blip r:embed="rId7"/>
                  <a:stretch>
                    <a:fillRect/>
                  </a:stretch>
                </p:blipFill>
                <p:spPr>
                  <a:xfrm>
                    <a:off x="7273595" y="4127915"/>
                    <a:ext cx="4461976" cy="1465920"/>
                  </a:xfrm>
                  <a:prstGeom prst="rect">
                    <a:avLst/>
                  </a:prstGeom>
                </p:spPr>
              </p:pic>
            </mc:Fallback>
          </mc:AlternateContent>
          <p:sp>
            <p:nvSpPr>
              <p:cNvPr id="96" name="CuadroTexto 95"/>
              <p:cNvSpPr txBox="1"/>
              <p:nvPr/>
            </p:nvSpPr>
            <p:spPr>
              <a:xfrm>
                <a:off x="7105696" y="3895449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CuadroTexto 96"/>
              <p:cNvSpPr txBox="1"/>
              <p:nvPr/>
            </p:nvSpPr>
            <p:spPr>
              <a:xfrm>
                <a:off x="6718248" y="3908561"/>
                <a:ext cx="607516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6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CuadroTexto 97"/>
              <p:cNvSpPr txBox="1"/>
              <p:nvPr/>
            </p:nvSpPr>
            <p:spPr>
              <a:xfrm>
                <a:off x="7107606" y="3573751"/>
                <a:ext cx="30079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-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CuadroTexto 98"/>
              <p:cNvSpPr txBox="1"/>
              <p:nvPr/>
            </p:nvSpPr>
            <p:spPr>
              <a:xfrm>
                <a:off x="6713169" y="3610934"/>
                <a:ext cx="590730" cy="2969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000" b="1" dirty="0" smtClean="0">
                    <a:latin typeface="Arial" panose="020B0604020202020204" pitchFamily="34" charset="0"/>
                    <a:cs typeface="Arial" panose="020B0604020202020204" pitchFamily="34" charset="0"/>
                  </a:rPr>
                  <a:t>0.18</a:t>
                </a:r>
                <a:endParaRPr lang="en-GB" sz="1000" b="1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00" name="CuadroTexto 99"/>
            <p:cNvSpPr txBox="1"/>
            <p:nvPr/>
          </p:nvSpPr>
          <p:spPr>
            <a:xfrm>
              <a:off x="7886965" y="307235"/>
              <a:ext cx="296440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b="1" dirty="0" smtClean="0">
                  <a:latin typeface="HELVETICA" panose="020B0604020202020204" pitchFamily="34" charset="0"/>
                  <a:cs typeface="HELVETICA" panose="020B0604020202020204" pitchFamily="34" charset="0"/>
                </a:rPr>
                <a:t>C</a:t>
              </a:r>
              <a:endParaRPr lang="en-GB" b="1" dirty="0">
                <a:latin typeface="HELVETICA" panose="020B0604020202020204" pitchFamily="34" charset="0"/>
                <a:cs typeface="HELVETICA" panose="020B0604020202020204" pitchFamily="34" charset="0"/>
              </a:endParaRPr>
            </a:p>
          </p:txBody>
        </p:sp>
        <p:sp>
          <p:nvSpPr>
            <p:cNvPr id="101" name="Rectángulo 100"/>
            <p:cNvSpPr/>
            <p:nvPr/>
          </p:nvSpPr>
          <p:spPr>
            <a:xfrm>
              <a:off x="9347033" y="307235"/>
              <a:ext cx="1895543" cy="30777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ea typeface="Calibri" panose="020F0502020204030204" pitchFamily="34" charset="0"/>
                </a:rPr>
                <a:t>Commercial </a:t>
              </a:r>
              <a:r>
                <a:rPr lang="en-GB" sz="1400" b="1" dirty="0" err="1">
                  <a:latin typeface="Arial" panose="020B0604020202020204" pitchFamily="34" charset="0"/>
                  <a:ea typeface="Calibri" panose="020F0502020204030204" pitchFamily="34" charset="0"/>
                </a:rPr>
                <a:t>heme</a:t>
              </a:r>
              <a:r>
                <a:rPr lang="en-GB" sz="1400" b="1" dirty="0">
                  <a:latin typeface="Arial" panose="020B0604020202020204" pitchFamily="34" charset="0"/>
                  <a:ea typeface="Calibri" panose="020F0502020204030204" pitchFamily="34" charset="0"/>
                </a:rPr>
                <a:t> </a:t>
              </a:r>
              <a:endParaRPr lang="en-GB" sz="1400" b="1" dirty="0"/>
            </a:p>
          </p:txBody>
        </p:sp>
      </p:grpSp>
      <p:sp>
        <p:nvSpPr>
          <p:cNvPr id="102" name="Rectángulo 101"/>
          <p:cNvSpPr/>
          <p:nvPr/>
        </p:nvSpPr>
        <p:spPr>
          <a:xfrm>
            <a:off x="582273" y="5016409"/>
            <a:ext cx="11358644" cy="95410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upplementary Figure S1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en-US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Ln treatment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did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t modulate either the 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em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group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f Arabidopsis recombinant CAT2 protein 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(A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and th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bovine liver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CAT protein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r the commercial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4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m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(Sigma)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(C).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The samples were treated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with control vehicle (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eOH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(black line) and with </a:t>
            </a:r>
            <a:r>
              <a:rPr lang="nn-NO" sz="1400" dirty="0">
                <a:latin typeface="Arial" panose="020B0604020202020204" pitchFamily="34" charset="0"/>
                <a:cs typeface="Arial" panose="020B0604020202020204" pitchFamily="34" charset="0"/>
              </a:rPr>
              <a:t>10 µM </a:t>
            </a:r>
            <a:r>
              <a:rPr lang="nn-N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nn-NO" sz="1400" baseline="-25000" dirty="0" smtClean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nn-N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Ln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(red line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nn-N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for </a:t>
            </a:r>
            <a:r>
              <a:rPr lang="nn-NO" sz="1400" dirty="0">
                <a:latin typeface="Arial" panose="020B0604020202020204" pitchFamily="34" charset="0"/>
                <a:cs typeface="Arial" panose="020B0604020202020204" pitchFamily="34" charset="0"/>
              </a:rPr>
              <a:t>60 </a:t>
            </a:r>
            <a:r>
              <a:rPr lang="nn-NO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minutes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. The analysis of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spectrum of pyridin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hemochromoge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was carried out by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spectrophotometer in scan mode from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350 nm to 700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m.</a:t>
            </a:r>
          </a:p>
        </p:txBody>
      </p:sp>
    </p:spTree>
    <p:extLst>
      <p:ext uri="{BB962C8B-B14F-4D97-AF65-F5344CB8AC3E}">
        <p14:creationId xmlns:p14="http://schemas.microsoft.com/office/powerpoint/2010/main" val="35187077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ángulo 1"/>
          <p:cNvSpPr/>
          <p:nvPr/>
        </p:nvSpPr>
        <p:spPr>
          <a:xfrm>
            <a:off x="581963" y="4944765"/>
            <a:ext cx="11014291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2. 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ffect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H₂O₂ treatment on His108 </a:t>
            </a:r>
            <a:r>
              <a:rPr lang="en-US" sz="14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itroalkylation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of 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rabidopsis recombinant </a:t>
            </a:r>
            <a:r>
              <a:rPr lang="en-US" sz="14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AT2 protein by mass 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pectrometry.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The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occurrence of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troalkylatio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in the recombinant CAT2 protein by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NO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₂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Ln was examined through targeted mass spectrometry techniques before and after treatment with 1.5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mM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₂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en-US" sz="14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₂</a:t>
            </a:r>
            <a:r>
              <a:rPr lang="en-US" sz="14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for 200 minutes. The relative percentage of peptide spectral matches of the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troalkylate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and non-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troalkylated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 peptide (FSTVIHER) was determined, with His 108 serving as the target residue for </a:t>
            </a:r>
            <a:r>
              <a:rPr lang="en-US" sz="1400" dirty="0" err="1">
                <a:latin typeface="Arial" panose="020B0604020202020204" pitchFamily="34" charset="0"/>
                <a:cs typeface="Arial" panose="020B0604020202020204" pitchFamily="34" charset="0"/>
              </a:rPr>
              <a:t>nitroalkylation</a:t>
            </a:r>
            <a:r>
              <a:rPr lang="en-US" sz="14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en-GB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upo 7"/>
          <p:cNvGrpSpPr/>
          <p:nvPr/>
        </p:nvGrpSpPr>
        <p:grpSpPr>
          <a:xfrm>
            <a:off x="2283213" y="1013734"/>
            <a:ext cx="5423873" cy="3830806"/>
            <a:chOff x="3030583" y="914400"/>
            <a:chExt cx="6974029" cy="3830806"/>
          </a:xfrm>
        </p:grpSpPr>
        <p:grpSp>
          <p:nvGrpSpPr>
            <p:cNvPr id="4" name="Grupo 3"/>
            <p:cNvGrpSpPr/>
            <p:nvPr/>
          </p:nvGrpSpPr>
          <p:grpSpPr>
            <a:xfrm>
              <a:off x="3030583" y="914400"/>
              <a:ext cx="6974029" cy="3779010"/>
              <a:chOff x="3030583" y="914400"/>
              <a:chExt cx="6476488" cy="3779010"/>
            </a:xfrm>
          </p:grpSpPr>
          <p:graphicFrame>
            <p:nvGraphicFramePr>
              <p:cNvPr id="6" name="Gráfico 5"/>
              <p:cNvGraphicFramePr>
                <a:graphicFrameLocks/>
              </p:cNvGraphicFramePr>
              <p:nvPr>
                <p:extLst/>
              </p:nvPr>
            </p:nvGraphicFramePr>
            <p:xfrm>
              <a:off x="3030583" y="914400"/>
              <a:ext cx="6476488" cy="3644153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2"/>
              </a:graphicData>
            </a:graphic>
          </p:graphicFrame>
          <p:sp>
            <p:nvSpPr>
              <p:cNvPr id="3" name="CuadroTexto 2"/>
              <p:cNvSpPr txBox="1"/>
              <p:nvPr/>
            </p:nvSpPr>
            <p:spPr>
              <a:xfrm>
                <a:off x="4083122" y="4263104"/>
                <a:ext cx="4371408" cy="43030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endParaRPr lang="es-ES" dirty="0"/>
              </a:p>
            </p:txBody>
          </p:sp>
        </p:grpSp>
        <p:sp>
          <p:nvSpPr>
            <p:cNvPr id="5" name="CuadroTexto 4"/>
            <p:cNvSpPr txBox="1"/>
            <p:nvPr/>
          </p:nvSpPr>
          <p:spPr>
            <a:xfrm>
              <a:off x="4694249" y="4327966"/>
              <a:ext cx="1531204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2-NO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n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7" name="CuadroTexto 6"/>
            <p:cNvSpPr txBox="1"/>
            <p:nvPr/>
          </p:nvSpPr>
          <p:spPr>
            <a:xfrm>
              <a:off x="7635387" y="4283541"/>
              <a:ext cx="1512617" cy="46166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CAT2-NO</a:t>
              </a:r>
              <a:r>
                <a:rPr lang="en-US" sz="1200" b="1" baseline="-25000" dirty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  <a:r>
                <a:rPr lang="es-ES" sz="12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n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pPr algn="ctr"/>
              <a:r>
                <a:rPr lang="es-ES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+ H</a:t>
              </a:r>
              <a:r>
                <a:rPr lang="en-US" sz="12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r>
                <a:rPr lang="es-E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O</a:t>
              </a:r>
              <a:r>
                <a:rPr lang="en-US" sz="12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</a:t>
              </a:r>
              <a:endParaRPr lang="es-E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2" name="CuadroTexto 11"/>
          <p:cNvSpPr txBox="1"/>
          <p:nvPr/>
        </p:nvSpPr>
        <p:spPr>
          <a:xfrm>
            <a:off x="8164287" y="2127252"/>
            <a:ext cx="2873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08-NO</a:t>
            </a:r>
            <a:r>
              <a:rPr lang="en-US" sz="1200" b="1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n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itroalkylation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CuadroTexto 12"/>
          <p:cNvSpPr txBox="1"/>
          <p:nvPr/>
        </p:nvSpPr>
        <p:spPr>
          <a:xfrm>
            <a:off x="8164287" y="2558811"/>
            <a:ext cx="287382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is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08 (</a:t>
            </a:r>
            <a:r>
              <a:rPr lang="es-ES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ot-nitroalkylation</a:t>
            </a:r>
            <a:r>
              <a:rPr lang="es-ES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es-E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Rectángulo 13"/>
          <p:cNvSpPr/>
          <p:nvPr/>
        </p:nvSpPr>
        <p:spPr>
          <a:xfrm>
            <a:off x="7876287" y="2127252"/>
            <a:ext cx="288000" cy="288000"/>
          </a:xfrm>
          <a:prstGeom prst="rect">
            <a:avLst/>
          </a:prstGeom>
          <a:solidFill>
            <a:srgbClr val="0066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15" name="Rectángulo 14"/>
          <p:cNvSpPr/>
          <p:nvPr/>
        </p:nvSpPr>
        <p:spPr>
          <a:xfrm>
            <a:off x="7876287" y="2547810"/>
            <a:ext cx="288000" cy="288000"/>
          </a:xfrm>
          <a:prstGeom prst="rect">
            <a:avLst/>
          </a:prstGeom>
          <a:solidFill>
            <a:srgbClr val="D6DCE5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06267567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o 5"/>
          <p:cNvGrpSpPr/>
          <p:nvPr/>
        </p:nvGrpSpPr>
        <p:grpSpPr>
          <a:xfrm>
            <a:off x="456381" y="1198155"/>
            <a:ext cx="11197959" cy="2880000"/>
            <a:chOff x="482507" y="910772"/>
            <a:chExt cx="11197959" cy="2880000"/>
          </a:xfrm>
        </p:grpSpPr>
        <p:pic>
          <p:nvPicPr>
            <p:cNvPr id="2" name="Image1"/>
            <p:cNvPicPr/>
            <p:nvPr/>
          </p:nvPicPr>
          <p:blipFill>
            <a:blip r:embed="rId2"/>
            <a:stretch>
              <a:fillRect/>
            </a:stretch>
          </p:blipFill>
          <p:spPr bwMode="auto">
            <a:xfrm>
              <a:off x="482507" y="910772"/>
              <a:ext cx="3600000" cy="2880000"/>
            </a:xfrm>
            <a:prstGeom prst="rect">
              <a:avLst/>
            </a:prstGeom>
          </p:spPr>
        </p:pic>
        <p:pic>
          <p:nvPicPr>
            <p:cNvPr id="3" name="Image3"/>
            <p:cNvPicPr/>
            <p:nvPr/>
          </p:nvPicPr>
          <p:blipFill>
            <a:blip r:embed="rId3"/>
            <a:stretch>
              <a:fillRect/>
            </a:stretch>
          </p:blipFill>
          <p:spPr bwMode="auto">
            <a:xfrm>
              <a:off x="8080466" y="910772"/>
              <a:ext cx="3600000" cy="2880000"/>
            </a:xfrm>
            <a:prstGeom prst="rect">
              <a:avLst/>
            </a:prstGeom>
          </p:spPr>
        </p:pic>
        <p:pic>
          <p:nvPicPr>
            <p:cNvPr id="4" name="Image4"/>
            <p:cNvPicPr/>
            <p:nvPr/>
          </p:nvPicPr>
          <p:blipFill>
            <a:blip r:embed="rId4"/>
            <a:stretch>
              <a:fillRect/>
            </a:stretch>
          </p:blipFill>
          <p:spPr bwMode="auto">
            <a:xfrm>
              <a:off x="4294549" y="910772"/>
              <a:ext cx="3600000" cy="2880000"/>
            </a:xfrm>
            <a:prstGeom prst="rect">
              <a:avLst/>
            </a:prstGeom>
          </p:spPr>
        </p:pic>
      </p:grpSp>
      <p:sp>
        <p:nvSpPr>
          <p:cNvPr id="5" name="Rectángulo 4"/>
          <p:cNvSpPr/>
          <p:nvPr/>
        </p:nvSpPr>
        <p:spPr>
          <a:xfrm>
            <a:off x="346364" y="5002461"/>
            <a:ext cx="11307976" cy="12003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spc="-1" dirty="0">
                <a:latin typeface="Arial" panose="020B0604020202020204" pitchFamily="34" charset="0"/>
                <a:cs typeface="Arial" panose="020B0604020202020204" pitchFamily="34" charset="0"/>
              </a:rPr>
              <a:t>Supplementary Figure </a:t>
            </a:r>
            <a:r>
              <a:rPr lang="en-US" b="1" spc="-1" dirty="0" smtClean="0">
                <a:latin typeface="Arial" panose="020B0604020202020204" pitchFamily="34" charset="0"/>
                <a:cs typeface="Arial" panose="020B0604020202020204" pitchFamily="34" charset="0"/>
              </a:rPr>
              <a:t>S3.</a:t>
            </a:r>
            <a:r>
              <a:rPr lang="en-US" spc="-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kern="100" dirty="0" smtClean="0">
                <a:effectLst>
                  <a:outerShdw blurRad="50800" dist="38100" algn="tr" rotWithShape="0">
                    <a:prstClr val="black">
                      <a:alpha val="40000"/>
                    </a:prstClr>
                  </a:outerShdw>
                </a:effectLst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L</a:t>
            </a:r>
            <a:r>
              <a:rPr lang="en-US" kern="100" dirty="0" smtClean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ocation </a:t>
            </a:r>
            <a:r>
              <a:rPr lang="en-US" kern="100" dirty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of </a:t>
            </a:r>
            <a:r>
              <a:rPr lang="en-US" kern="100" dirty="0" smtClean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His 108 of Arabidopsis catalase shown </a:t>
            </a:r>
            <a:r>
              <a:rPr lang="en-US" kern="100" dirty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as blue spheres (A) and surface of the area surrounding </a:t>
            </a:r>
            <a:r>
              <a:rPr lang="en-US" kern="100" dirty="0" smtClean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His 108 </a:t>
            </a:r>
            <a:r>
              <a:rPr lang="en-US" kern="100" dirty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(shown in green) colored by </a:t>
            </a:r>
            <a:r>
              <a:rPr lang="en-US" kern="100" dirty="0" err="1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i</a:t>
            </a:r>
            <a:r>
              <a:rPr lang="en-US" kern="100" dirty="0">
                <a:latin typeface="Arial" panose="020B0604020202020204" pitchFamily="34" charset="0"/>
                <a:ea typeface="Source Han Sans CN Regular"/>
                <a:cs typeface="Arial" panose="020B0604020202020204" pitchFamily="34" charset="0"/>
              </a:rPr>
              <a:t>) the </a:t>
            </a:r>
            <a:r>
              <a:rPr lang="en-US" kern="100" dirty="0" err="1"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Kyte</a:t>
            </a:r>
            <a:r>
              <a:rPr lang="en-US" kern="100" dirty="0"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-Doolittle scale coloring </a:t>
            </a:r>
            <a:r>
              <a:rPr lang="en-US" kern="100" dirty="0" smtClean="0"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(</a:t>
            </a:r>
            <a:r>
              <a:rPr lang="en-US" kern="100" dirty="0" smtClean="0">
                <a:effectLst>
                  <a:outerShdw blurRad="50800" dist="38100" algn="tr" rotWithShape="0">
                    <a:prstClr val="black">
                      <a:alpha val="40000"/>
                    </a:prstClr>
                  </a:outerShdw>
                </a:effectLst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B</a:t>
            </a:r>
            <a:r>
              <a:rPr lang="en-US" kern="100" dirty="0" smtClean="0"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) </a:t>
            </a:r>
            <a:r>
              <a:rPr lang="en-US" kern="100" dirty="0">
                <a:latin typeface="Arial" panose="020B0604020202020204" pitchFamily="34" charset="0"/>
                <a:ea typeface="DejaVu Sans"/>
                <a:cs typeface="Arial" panose="020B0604020202020204" pitchFamily="34" charset="0"/>
              </a:rPr>
              <a:t>from orange for the most hydrophobic to blue for the most hydrophilic and ii) Surface potential coloring (C) from blue (+10) to red (-10).  </a:t>
            </a:r>
            <a:endParaRPr lang="es-ES" sz="2400" kern="100" dirty="0">
              <a:effectLst/>
              <a:latin typeface="Arial" panose="020B0604020202020204" pitchFamily="34" charset="0"/>
              <a:ea typeface="Source Han Sans CN Regular"/>
              <a:cs typeface="Arial" panose="020B0604020202020204" pitchFamily="34" charset="0"/>
            </a:endParaRPr>
          </a:p>
        </p:txBody>
      </p:sp>
      <p:sp>
        <p:nvSpPr>
          <p:cNvPr id="8" name="CuadroTexto 7"/>
          <p:cNvSpPr txBox="1"/>
          <p:nvPr/>
        </p:nvSpPr>
        <p:spPr>
          <a:xfrm>
            <a:off x="462354" y="1198155"/>
            <a:ext cx="360876" cy="338996"/>
          </a:xfrm>
          <a:prstGeom prst="rect">
            <a:avLst/>
          </a:prstGeom>
          <a:noFill/>
          <a:ln w="0">
            <a:noFill/>
          </a:ln>
        </p:spPr>
        <p:txBody>
          <a:bodyPr lIns="81646" tIns="40823" rIns="81646" bIns="40823" anchor="t">
            <a:noAutofit/>
          </a:bodyPr>
          <a:lstStyle/>
          <a:p>
            <a:r>
              <a:rPr lang="en-US" sz="1814" b="1" spc="-1" dirty="0">
                <a:solidFill>
                  <a:srgbClr val="FFFFFF"/>
                </a:solidFill>
                <a:latin typeface="Arial"/>
              </a:rPr>
              <a:t>A</a:t>
            </a:r>
          </a:p>
        </p:txBody>
      </p:sp>
      <p:sp>
        <p:nvSpPr>
          <p:cNvPr id="9" name="CuadroTexto 8"/>
          <p:cNvSpPr txBox="1"/>
          <p:nvPr/>
        </p:nvSpPr>
        <p:spPr>
          <a:xfrm>
            <a:off x="4268423" y="1198155"/>
            <a:ext cx="360876" cy="338996"/>
          </a:xfrm>
          <a:prstGeom prst="rect">
            <a:avLst/>
          </a:prstGeom>
          <a:solidFill>
            <a:schemeClr val="tx1"/>
          </a:solidFill>
          <a:ln w="0">
            <a:noFill/>
          </a:ln>
        </p:spPr>
        <p:txBody>
          <a:bodyPr lIns="81646" tIns="40823" rIns="81646" bIns="40823" anchor="t">
            <a:noAutofit/>
          </a:bodyPr>
          <a:lstStyle/>
          <a:p>
            <a:r>
              <a:rPr lang="en-US" sz="1814" b="1" spc="-1" dirty="0">
                <a:solidFill>
                  <a:srgbClr val="FFFFFF"/>
                </a:solidFill>
                <a:latin typeface="Arial"/>
              </a:rPr>
              <a:t>B</a:t>
            </a:r>
          </a:p>
        </p:txBody>
      </p:sp>
      <p:sp>
        <p:nvSpPr>
          <p:cNvPr id="10" name="CuadroTexto 9"/>
          <p:cNvSpPr txBox="1"/>
          <p:nvPr/>
        </p:nvSpPr>
        <p:spPr>
          <a:xfrm>
            <a:off x="8054340" y="1198155"/>
            <a:ext cx="360876" cy="338996"/>
          </a:xfrm>
          <a:prstGeom prst="rect">
            <a:avLst/>
          </a:prstGeom>
          <a:solidFill>
            <a:schemeClr val="tx1"/>
          </a:solidFill>
          <a:ln w="0">
            <a:noFill/>
          </a:ln>
        </p:spPr>
        <p:txBody>
          <a:bodyPr lIns="81646" tIns="40823" rIns="81646" bIns="40823" anchor="t">
            <a:noAutofit/>
          </a:bodyPr>
          <a:lstStyle/>
          <a:p>
            <a:r>
              <a:rPr lang="en-US" sz="1814" b="1" spc="-1" dirty="0">
                <a:solidFill>
                  <a:srgbClr val="FFFFFF"/>
                </a:solidFill>
                <a:latin typeface="Arial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6824387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CuadroTexto 40"/>
          <p:cNvSpPr txBox="1"/>
          <p:nvPr/>
        </p:nvSpPr>
        <p:spPr>
          <a:xfrm>
            <a:off x="1770461" y="6399443"/>
            <a:ext cx="8710034" cy="236774"/>
          </a:xfrm>
          <a:prstGeom prst="rect">
            <a:avLst/>
          </a:prstGeom>
          <a:noFill/>
          <a:ln w="0">
            <a:noFill/>
          </a:ln>
        </p:spPr>
        <p:txBody>
          <a:bodyPr lIns="81646" tIns="40823" rIns="81646" bIns="40823" anchor="t">
            <a:noAutofit/>
          </a:bodyPr>
          <a:lstStyle/>
          <a:p>
            <a:r>
              <a:rPr lang="en-US" sz="1089" b="1" spc="-1" dirty="0" smtClean="0">
                <a:latin typeface="Arial"/>
              </a:rPr>
              <a:t>Supplementary Figure S4.</a:t>
            </a:r>
            <a:r>
              <a:rPr lang="en-US" sz="1089" spc="-1" dirty="0" smtClean="0">
                <a:latin typeface="Arial"/>
              </a:rPr>
              <a:t> </a:t>
            </a:r>
            <a:r>
              <a:rPr lang="en-US" sz="1089" spc="-1" dirty="0">
                <a:latin typeface="Arial"/>
              </a:rPr>
              <a:t>Model of the quaternary structure of catalase 2 from </a:t>
            </a:r>
            <a:r>
              <a:rPr lang="en-US" sz="1089" i="1" spc="-1" dirty="0">
                <a:latin typeface="Arial"/>
              </a:rPr>
              <a:t> A. thaliana </a:t>
            </a:r>
            <a:r>
              <a:rPr lang="en-US" sz="1089" spc="-1" dirty="0">
                <a:latin typeface="Arial"/>
              </a:rPr>
              <a:t>(A) and, in color,  the truncated </a:t>
            </a:r>
            <a:r>
              <a:rPr lang="en-US" sz="1089" spc="-1" dirty="0" err="1">
                <a:latin typeface="Arial"/>
              </a:rPr>
              <a:t>tcatA</a:t>
            </a:r>
            <a:r>
              <a:rPr lang="en-US" sz="1089" spc="-1" dirty="0">
                <a:latin typeface="Arial"/>
              </a:rPr>
              <a:t> (B) </a:t>
            </a:r>
            <a:r>
              <a:rPr lang="en-US" sz="1089" spc="-1" dirty="0" err="1">
                <a:latin typeface="Arial"/>
              </a:rPr>
              <a:t>tcatAB</a:t>
            </a:r>
            <a:r>
              <a:rPr lang="en-US" sz="1089" spc="-1" dirty="0">
                <a:latin typeface="Arial"/>
              </a:rPr>
              <a:t> (C), </a:t>
            </a:r>
            <a:r>
              <a:rPr lang="en-US" sz="1089" spc="-1" dirty="0" err="1">
                <a:latin typeface="Arial"/>
              </a:rPr>
              <a:t>tcatAD</a:t>
            </a:r>
            <a:r>
              <a:rPr lang="en-US" sz="1089" spc="-1" dirty="0">
                <a:latin typeface="Arial"/>
              </a:rPr>
              <a:t> (D). </a:t>
            </a:r>
          </a:p>
        </p:txBody>
      </p:sp>
      <p:grpSp>
        <p:nvGrpSpPr>
          <p:cNvPr id="42" name="Grupo 41"/>
          <p:cNvGrpSpPr/>
          <p:nvPr/>
        </p:nvGrpSpPr>
        <p:grpSpPr>
          <a:xfrm>
            <a:off x="1922323" y="238408"/>
            <a:ext cx="8306701" cy="6015704"/>
            <a:chOff x="745200" y="262800"/>
            <a:chExt cx="9156600" cy="6631200"/>
          </a:xfrm>
        </p:grpSpPr>
        <p:grpSp>
          <p:nvGrpSpPr>
            <p:cNvPr id="43" name="Grupo 42"/>
            <p:cNvGrpSpPr/>
            <p:nvPr/>
          </p:nvGrpSpPr>
          <p:grpSpPr>
            <a:xfrm>
              <a:off x="5329800" y="262800"/>
              <a:ext cx="4572000" cy="6631200"/>
              <a:chOff x="5329800" y="262800"/>
              <a:chExt cx="4572000" cy="6631200"/>
            </a:xfrm>
          </p:grpSpPr>
          <p:grpSp>
            <p:nvGrpSpPr>
              <p:cNvPr id="44" name="Grupo 43"/>
              <p:cNvGrpSpPr/>
              <p:nvPr/>
            </p:nvGrpSpPr>
            <p:grpSpPr>
              <a:xfrm>
                <a:off x="5329800" y="262800"/>
                <a:ext cx="4572000" cy="6631200"/>
                <a:chOff x="5329800" y="262800"/>
                <a:chExt cx="4572000" cy="6631200"/>
              </a:xfrm>
            </p:grpSpPr>
            <p:pic>
              <p:nvPicPr>
                <p:cNvPr id="45" name="Imagen 44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5329800" y="3583800"/>
                  <a:ext cx="4572000" cy="3310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46" name="Imagen 45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5329800" y="262800"/>
                  <a:ext cx="4572000" cy="33102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47" name="Grupo 46"/>
              <p:cNvGrpSpPr/>
              <p:nvPr/>
            </p:nvGrpSpPr>
            <p:grpSpPr>
              <a:xfrm>
                <a:off x="5353560" y="298800"/>
                <a:ext cx="398160" cy="3685680"/>
                <a:chOff x="5353560" y="298800"/>
                <a:chExt cx="398160" cy="3685680"/>
              </a:xfrm>
            </p:grpSpPr>
            <p:sp>
              <p:nvSpPr>
                <p:cNvPr id="48" name="CuadroTexto 47"/>
                <p:cNvSpPr txBox="1"/>
                <p:nvPr/>
              </p:nvSpPr>
              <p:spPr>
                <a:xfrm>
                  <a:off x="5353560" y="298800"/>
                  <a:ext cx="397800" cy="37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txBody>
                <a:bodyPr lIns="81646" tIns="40823" rIns="81646" bIns="40823" anchor="t">
                  <a:noAutofit/>
                </a:bodyPr>
                <a:lstStyle/>
                <a:p>
                  <a:r>
                    <a:rPr lang="en-US" sz="1814" b="1" spc="-1" dirty="0">
                      <a:solidFill>
                        <a:srgbClr val="FFFFFF"/>
                      </a:solidFill>
                      <a:latin typeface="Arial"/>
                    </a:rPr>
                    <a:t>B</a:t>
                  </a:r>
                </a:p>
              </p:txBody>
            </p:sp>
            <p:sp>
              <p:nvSpPr>
                <p:cNvPr id="49" name="CuadroTexto 48"/>
                <p:cNvSpPr txBox="1"/>
                <p:nvPr/>
              </p:nvSpPr>
              <p:spPr>
                <a:xfrm>
                  <a:off x="5353920" y="3610800"/>
                  <a:ext cx="397800" cy="37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txBody>
                <a:bodyPr lIns="81646" tIns="40823" rIns="81646" bIns="40823" anchor="t">
                  <a:noAutofit/>
                </a:bodyPr>
                <a:lstStyle/>
                <a:p>
                  <a:r>
                    <a:rPr lang="en-US" sz="1814" b="1" spc="-1" dirty="0">
                      <a:solidFill>
                        <a:srgbClr val="FFFFFF"/>
                      </a:solidFill>
                      <a:latin typeface="Arial"/>
                    </a:rPr>
                    <a:t>D</a:t>
                  </a:r>
                </a:p>
              </p:txBody>
            </p:sp>
          </p:grpSp>
        </p:grpSp>
        <p:grpSp>
          <p:nvGrpSpPr>
            <p:cNvPr id="50" name="Grupo 49"/>
            <p:cNvGrpSpPr/>
            <p:nvPr/>
          </p:nvGrpSpPr>
          <p:grpSpPr>
            <a:xfrm>
              <a:off x="745200" y="262800"/>
              <a:ext cx="4572000" cy="6631200"/>
              <a:chOff x="745200" y="262800"/>
              <a:chExt cx="4572000" cy="6631200"/>
            </a:xfrm>
          </p:grpSpPr>
          <p:grpSp>
            <p:nvGrpSpPr>
              <p:cNvPr id="51" name="Grupo 50"/>
              <p:cNvGrpSpPr/>
              <p:nvPr/>
            </p:nvGrpSpPr>
            <p:grpSpPr>
              <a:xfrm>
                <a:off x="745200" y="262800"/>
                <a:ext cx="4572000" cy="6631200"/>
                <a:chOff x="745200" y="262800"/>
                <a:chExt cx="4572000" cy="6631200"/>
              </a:xfrm>
            </p:grpSpPr>
            <p:pic>
              <p:nvPicPr>
                <p:cNvPr id="52" name="Imagen 51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745200" y="3583800"/>
                  <a:ext cx="4572000" cy="3310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53" name="Imagen 52"/>
                <p:cNvPicPr/>
                <p:nvPr/>
              </p:nvPicPr>
              <p:blipFill>
                <a:blip r:embed="rId5"/>
                <a:stretch/>
              </p:blipFill>
              <p:spPr>
                <a:xfrm>
                  <a:off x="745200" y="262800"/>
                  <a:ext cx="4572000" cy="33102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54" name="Grupo 53"/>
              <p:cNvGrpSpPr/>
              <p:nvPr/>
            </p:nvGrpSpPr>
            <p:grpSpPr>
              <a:xfrm>
                <a:off x="781200" y="262800"/>
                <a:ext cx="398160" cy="3685680"/>
                <a:chOff x="781200" y="262800"/>
                <a:chExt cx="398160" cy="3685680"/>
              </a:xfrm>
            </p:grpSpPr>
            <p:sp>
              <p:nvSpPr>
                <p:cNvPr id="55" name="CuadroTexto 54"/>
                <p:cNvSpPr txBox="1"/>
                <p:nvPr/>
              </p:nvSpPr>
              <p:spPr>
                <a:xfrm>
                  <a:off x="781200" y="262800"/>
                  <a:ext cx="397800" cy="37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txBody>
                <a:bodyPr lIns="81646" tIns="40823" rIns="81646" bIns="40823" anchor="t">
                  <a:noAutofit/>
                </a:bodyPr>
                <a:lstStyle/>
                <a:p>
                  <a:r>
                    <a:rPr lang="en-US" sz="1814" b="1" spc="-1" dirty="0">
                      <a:solidFill>
                        <a:srgbClr val="FFFFFF"/>
                      </a:solidFill>
                      <a:latin typeface="Arial"/>
                    </a:rPr>
                    <a:t>A</a:t>
                  </a:r>
                </a:p>
              </p:txBody>
            </p:sp>
            <p:sp>
              <p:nvSpPr>
                <p:cNvPr id="56" name="CuadroTexto 55"/>
                <p:cNvSpPr txBox="1"/>
                <p:nvPr/>
              </p:nvSpPr>
              <p:spPr>
                <a:xfrm>
                  <a:off x="781560" y="3574800"/>
                  <a:ext cx="397800" cy="3736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txBody>
                <a:bodyPr lIns="81646" tIns="40823" rIns="81646" bIns="40823" anchor="t">
                  <a:noAutofit/>
                </a:bodyPr>
                <a:lstStyle/>
                <a:p>
                  <a:r>
                    <a:rPr lang="en-US" sz="1814" b="1" spc="-1" dirty="0">
                      <a:solidFill>
                        <a:srgbClr val="FFFFFF"/>
                      </a:solidFill>
                      <a:latin typeface="Arial"/>
                    </a:rPr>
                    <a:t>C</a:t>
                  </a:r>
                </a:p>
              </p:txBody>
            </p:sp>
          </p:grpSp>
        </p:grpSp>
      </p:grpSp>
    </p:spTree>
    <p:extLst>
      <p:ext uri="{BB962C8B-B14F-4D97-AF65-F5344CB8AC3E}">
        <p14:creationId xmlns:p14="http://schemas.microsoft.com/office/powerpoint/2010/main" val="1944681942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:p15="http://schemas.microsoft.com/office/powerpoint/2012/main" xmlns="">
      <p:transition spd="slow"/>
    </mc:Fallback>
  </mc:AlternateContent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59</TotalTime>
  <Words>408</Words>
  <Application>Microsoft Office PowerPoint</Application>
  <PresentationFormat>Panorámica</PresentationFormat>
  <Paragraphs>83</Paragraphs>
  <Slides>4</Slides>
  <Notes>0</Notes>
  <HiddenSlides>0</HiddenSlides>
  <MMClips>0</MMClips>
  <ScaleCrop>false</ScaleCrop>
  <HeadingPairs>
    <vt:vector size="6" baseType="variant">
      <vt:variant>
        <vt:lpstr>Fuentes usadas</vt:lpstr>
      </vt:variant>
      <vt:variant>
        <vt:i4>6</vt:i4>
      </vt:variant>
      <vt:variant>
        <vt:lpstr>Tema</vt:lpstr>
      </vt:variant>
      <vt:variant>
        <vt:i4>1</vt:i4>
      </vt:variant>
      <vt:variant>
        <vt:lpstr>Títulos de diapositiva</vt:lpstr>
      </vt:variant>
      <vt:variant>
        <vt:i4>4</vt:i4>
      </vt:variant>
    </vt:vector>
  </HeadingPairs>
  <TitlesOfParts>
    <vt:vector size="11" baseType="lpstr">
      <vt:lpstr>Arial</vt:lpstr>
      <vt:lpstr>Calibri</vt:lpstr>
      <vt:lpstr>Calibri Light</vt:lpstr>
      <vt:lpstr>DejaVu Sans</vt:lpstr>
      <vt:lpstr>HELVETICA</vt:lpstr>
      <vt:lpstr>Source Han Sans CN Regular</vt:lpstr>
      <vt:lpstr>Tema de Office</vt:lpstr>
      <vt:lpstr>Presentación de PowerPoint</vt:lpstr>
      <vt:lpstr>Presentación de PowerPoint</vt:lpstr>
      <vt:lpstr>Presentación de PowerPoint</vt:lpstr>
      <vt:lpstr>Presentación de PowerPoint</vt:lpstr>
    </vt:vector>
  </TitlesOfParts>
  <Company>Universidad de Jaé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ción de PowerPoint</dc:title>
  <dc:creator>Windows8</dc:creator>
  <cp:lastModifiedBy>Usuario de Windows</cp:lastModifiedBy>
  <cp:revision>19</cp:revision>
  <dcterms:created xsi:type="dcterms:W3CDTF">2025-01-06T17:58:38Z</dcterms:created>
  <dcterms:modified xsi:type="dcterms:W3CDTF">2025-02-11T17:51:56Z</dcterms:modified>
</cp:coreProperties>
</file>